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tiff" ContentType="image/tiff"/>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drawings/drawing1.xml" ContentType="application/vnd.openxmlformats-officedocument.drawingml.chartshapes+xml"/>
  <Override PartName="/ppt/comments/comment1.xml" ContentType="application/vnd.openxmlformats-officedocument.presentationml.comments+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1.xml" ContentType="application/vnd.openxmlformats-officedocument.themeOverrid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theme/themeOverride2.xml" ContentType="application/vnd.openxmlformats-officedocument.themeOverrid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theme/themeOverride3.xml" ContentType="application/vnd.openxmlformats-officedocument.themeOverrid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theme/themeOverride4.xml" ContentType="application/vnd.openxmlformats-officedocument.themeOverrid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theme/themeOverride5.xml" ContentType="application/vnd.openxmlformats-officedocument.themeOverrid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theme/themeOverride6.xml" ContentType="application/vnd.openxmlformats-officedocument.themeOverride+xml"/>
  <Override PartName="/ppt/drawings/drawing2.xml" ContentType="application/vnd.openxmlformats-officedocument.drawingml.chartshape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92" r:id="rId2"/>
    <p:sldId id="261" r:id="rId3"/>
    <p:sldId id="258" r:id="rId4"/>
    <p:sldId id="298" r:id="rId5"/>
    <p:sldId id="293" r:id="rId6"/>
    <p:sldId id="297" r:id="rId7"/>
    <p:sldId id="301" r:id="rId8"/>
    <p:sldId id="302"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Oral, Ebru" initials="OE" lastIdx="2" clrIdx="0">
    <p:extLst>
      <p:ext uri="{19B8F6BF-5375-455C-9EA6-DF929625EA0E}">
        <p15:presenceInfo xmlns:p15="http://schemas.microsoft.com/office/powerpoint/2012/main" userId="S::eoral@mgh.harvard.edu::650210b2-d667-4706-abbf-5862d40cbdb6" providerId="AD"/>
      </p:ext>
    </p:extLst>
  </p:cmAuthor>
  <p:cmAuthor id="2" name="Yingfang" initials="Y" lastIdx="1" clrIdx="1">
    <p:extLst>
      <p:ext uri="{19B8F6BF-5375-455C-9EA6-DF929625EA0E}">
        <p15:presenceInfo xmlns:p15="http://schemas.microsoft.com/office/powerpoint/2012/main" userId="Yingfang"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6" autoAdjust="0"/>
    <p:restoredTop sz="94660"/>
  </p:normalViewPr>
  <p:slideViewPr>
    <p:cSldViewPr snapToGrid="0">
      <p:cViewPr varScale="1">
        <p:scale>
          <a:sx n="114" d="100"/>
          <a:sy n="114" d="100"/>
        </p:scale>
        <p:origin x="474" y="10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oleObject" Target="file:///\\rfawin.partners.org\MGH-HOL\Manuscripts\CurrentManuscripts\MS%20199%20-%202020%20Tibia%20fracture%20model%20with%20gait%20analysis\031.2w4w6w8w_Trauma1&amp;2_fracture%20and%20plate%20repair%20BEFORE%20JAMIE%20-%20EO%20revised%20with%20full%20group%20for%20weight%20bearing%20and%20von%20Frey_YF%20weight.xlsx" TargetMode="Externa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chartUserShapes" Target="../drawings/drawing1.xml"/></Relationships>
</file>

<file path=ppt/charts/_rels/chart2.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oleObject" Target="file:///\\Cifs2\holrat$\04%20-%20Results%20by%20Protocol\2019N000031%20(Trauma)\Micro-CT\data%20summary.xlsx" TargetMode="External"/></Relationships>
</file>

<file path=ppt/charts/_rels/chart3.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3.xml"/><Relationship Id="rId1" Type="http://schemas.microsoft.com/office/2011/relationships/chartStyle" Target="style3.xml"/><Relationship Id="rId4" Type="http://schemas.openxmlformats.org/officeDocument/2006/relationships/oleObject" Target="file:///\\Cifs2\holrat$\04%20-%20Results%20by%20Protocol\2019N000031%20(Trauma)\Micro-CT\data%20summary.xlsx" TargetMode="External"/></Relationships>
</file>

<file path=ppt/charts/_rels/chart4.xml.rels><?xml version="1.0" encoding="UTF-8" standalone="yes"?>
<Relationships xmlns="http://schemas.openxmlformats.org/package/2006/relationships"><Relationship Id="rId3" Type="http://schemas.openxmlformats.org/officeDocument/2006/relationships/themeOverride" Target="../theme/themeOverride3.xml"/><Relationship Id="rId2" Type="http://schemas.microsoft.com/office/2011/relationships/chartColorStyle" Target="colors4.xml"/><Relationship Id="rId1" Type="http://schemas.microsoft.com/office/2011/relationships/chartStyle" Target="style4.xml"/><Relationship Id="rId4" Type="http://schemas.openxmlformats.org/officeDocument/2006/relationships/oleObject" Target="file:///\\Cifs2\holrat$\04%20-%20Results%20by%20Protocol\2019N000031%20(Trauma)\Micro-CT\data%20summary.xlsx" TargetMode="External"/></Relationships>
</file>

<file path=ppt/charts/_rels/chart5.xml.rels><?xml version="1.0" encoding="UTF-8" standalone="yes"?>
<Relationships xmlns="http://schemas.openxmlformats.org/package/2006/relationships"><Relationship Id="rId3" Type="http://schemas.openxmlformats.org/officeDocument/2006/relationships/themeOverride" Target="../theme/themeOverride4.xml"/><Relationship Id="rId2" Type="http://schemas.microsoft.com/office/2011/relationships/chartColorStyle" Target="colors5.xml"/><Relationship Id="rId1" Type="http://schemas.microsoft.com/office/2011/relationships/chartStyle" Target="style5.xml"/><Relationship Id="rId4" Type="http://schemas.openxmlformats.org/officeDocument/2006/relationships/oleObject" Target="file:///\\Cifs2\holrat$\04%20-%20Results%20by%20Protocol\2019N000031%20(Trauma)\Micro-CT\data%20summary.xlsx" TargetMode="External"/></Relationships>
</file>

<file path=ppt/charts/_rels/chart6.xml.rels><?xml version="1.0" encoding="UTF-8" standalone="yes"?>
<Relationships xmlns="http://schemas.openxmlformats.org/package/2006/relationships"><Relationship Id="rId3" Type="http://schemas.openxmlformats.org/officeDocument/2006/relationships/themeOverride" Target="../theme/themeOverride5.xml"/><Relationship Id="rId2" Type="http://schemas.microsoft.com/office/2011/relationships/chartColorStyle" Target="colors6.xml"/><Relationship Id="rId1" Type="http://schemas.microsoft.com/office/2011/relationships/chartStyle" Target="style6.xml"/><Relationship Id="rId4" Type="http://schemas.openxmlformats.org/officeDocument/2006/relationships/oleObject" Target="file:///\\Cifs2\holrat$\04%20-%20Results%20by%20Protocol\2019N000031%20(Trauma)\Micro-CT\data%20summary.xlsx" TargetMode="External"/></Relationships>
</file>

<file path=ppt/charts/_rels/chart7.xml.rels><?xml version="1.0" encoding="UTF-8" standalone="yes"?>
<Relationships xmlns="http://schemas.openxmlformats.org/package/2006/relationships"><Relationship Id="rId3" Type="http://schemas.openxmlformats.org/officeDocument/2006/relationships/themeOverride" Target="../theme/themeOverride6.xml"/><Relationship Id="rId2" Type="http://schemas.microsoft.com/office/2011/relationships/chartColorStyle" Target="colors7.xml"/><Relationship Id="rId1" Type="http://schemas.microsoft.com/office/2011/relationships/chartStyle" Target="style7.xml"/><Relationship Id="rId5" Type="http://schemas.openxmlformats.org/officeDocument/2006/relationships/chartUserShapes" Target="../drawings/drawing2.xml"/><Relationship Id="rId4" Type="http://schemas.openxmlformats.org/officeDocument/2006/relationships/package" Target="../embeddings/Microsoft_Excel_Worksheet.xlsx"/></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3443694836474795"/>
          <c:y val="2.2961984590635847E-2"/>
          <c:w val="0.81540400528692858"/>
          <c:h val="0.84527919010123753"/>
        </c:manualLayout>
      </c:layout>
      <c:scatterChart>
        <c:scatterStyle val="lineMarker"/>
        <c:varyColors val="0"/>
        <c:ser>
          <c:idx val="1"/>
          <c:order val="0"/>
          <c:tx>
            <c:strRef>
              <c:f>'Body Weight'!$C$32</c:f>
              <c:strCache>
                <c:ptCount val="1"/>
                <c:pt idx="0">
                  <c:v>Osteotomy Model</c:v>
                </c:pt>
              </c:strCache>
            </c:strRef>
          </c:tx>
          <c:spPr>
            <a:ln w="19050" cap="rnd">
              <a:solidFill>
                <a:schemeClr val="accent2"/>
              </a:solidFill>
              <a:round/>
            </a:ln>
            <a:effectLst/>
          </c:spPr>
          <c:marker>
            <c:symbol val="circle"/>
            <c:size val="5"/>
            <c:spPr>
              <a:solidFill>
                <a:schemeClr val="accent2"/>
              </a:solidFill>
              <a:ln w="9525">
                <a:solidFill>
                  <a:schemeClr val="accent2"/>
                </a:solidFill>
              </a:ln>
              <a:effectLst/>
            </c:spPr>
          </c:marker>
          <c:errBars>
            <c:errDir val="y"/>
            <c:errBarType val="both"/>
            <c:errValType val="cust"/>
            <c:noEndCap val="0"/>
            <c:plus>
              <c:numRef>
                <c:f>'Body Weight'!$D$30:$P$30</c:f>
                <c:numCache>
                  <c:formatCode>General</c:formatCode>
                  <c:ptCount val="13"/>
                  <c:pt idx="0">
                    <c:v>11.345513063174657</c:v>
                  </c:pt>
                  <c:pt idx="1">
                    <c:v>9.9645517544276299</c:v>
                  </c:pt>
                  <c:pt idx="2">
                    <c:v>10.496362465159059</c:v>
                  </c:pt>
                  <c:pt idx="3">
                    <c:v>14.7214069106377</c:v>
                  </c:pt>
                  <c:pt idx="4">
                    <c:v>14.199396365439526</c:v>
                  </c:pt>
                  <c:pt idx="5">
                    <c:v>10.159443179342349</c:v>
                  </c:pt>
                  <c:pt idx="6">
                    <c:v>28.054066104577419</c:v>
                  </c:pt>
                  <c:pt idx="7">
                    <c:v>30.260091587058071</c:v>
                  </c:pt>
                  <c:pt idx="8">
                    <c:v>29.233840469076732</c:v>
                  </c:pt>
                  <c:pt idx="9">
                    <c:v>27.496593728436011</c:v>
                  </c:pt>
                  <c:pt idx="10">
                    <c:v>35.986810715240459</c:v>
                  </c:pt>
                  <c:pt idx="11">
                    <c:v>38.230464198818517</c:v>
                  </c:pt>
                  <c:pt idx="12">
                    <c:v>38.318924828340364</c:v>
                  </c:pt>
                </c:numCache>
              </c:numRef>
            </c:plus>
            <c:minus>
              <c:numRef>
                <c:f>'Body Weight'!$D$30:$P$30</c:f>
                <c:numCache>
                  <c:formatCode>General</c:formatCode>
                  <c:ptCount val="13"/>
                  <c:pt idx="0">
                    <c:v>11.345513063174657</c:v>
                  </c:pt>
                  <c:pt idx="1">
                    <c:v>9.9645517544276299</c:v>
                  </c:pt>
                  <c:pt idx="2">
                    <c:v>10.496362465159059</c:v>
                  </c:pt>
                  <c:pt idx="3">
                    <c:v>14.7214069106377</c:v>
                  </c:pt>
                  <c:pt idx="4">
                    <c:v>14.199396365439526</c:v>
                  </c:pt>
                  <c:pt idx="5">
                    <c:v>10.159443179342349</c:v>
                  </c:pt>
                  <c:pt idx="6">
                    <c:v>28.054066104577419</c:v>
                  </c:pt>
                  <c:pt idx="7">
                    <c:v>30.260091587058071</c:v>
                  </c:pt>
                  <c:pt idx="8">
                    <c:v>29.233840469076732</c:v>
                  </c:pt>
                  <c:pt idx="9">
                    <c:v>27.496593728436011</c:v>
                  </c:pt>
                  <c:pt idx="10">
                    <c:v>35.986810715240459</c:v>
                  </c:pt>
                  <c:pt idx="11">
                    <c:v>38.230464198818517</c:v>
                  </c:pt>
                  <c:pt idx="12">
                    <c:v>38.318924828340364</c:v>
                  </c:pt>
                </c:numCache>
              </c:numRef>
            </c:minus>
            <c:spPr>
              <a:noFill/>
              <a:ln w="9525" cap="flat" cmpd="sng" algn="ctr">
                <a:solidFill>
                  <a:schemeClr val="tx1">
                    <a:lumMod val="65000"/>
                    <a:lumOff val="35000"/>
                  </a:schemeClr>
                </a:solidFill>
                <a:round/>
              </a:ln>
              <a:effectLst/>
            </c:spPr>
          </c:errBars>
          <c:xVal>
            <c:numRef>
              <c:f>'Body Weight'!$D$4:$P$4</c:f>
              <c:numCache>
                <c:formatCode>0</c:formatCode>
                <c:ptCount val="13"/>
                <c:pt idx="0">
                  <c:v>75</c:v>
                </c:pt>
                <c:pt idx="1">
                  <c:v>76</c:v>
                </c:pt>
                <c:pt idx="2">
                  <c:v>77</c:v>
                </c:pt>
                <c:pt idx="3">
                  <c:v>78</c:v>
                </c:pt>
                <c:pt idx="4">
                  <c:v>81</c:v>
                </c:pt>
                <c:pt idx="5">
                  <c:v>84</c:v>
                </c:pt>
                <c:pt idx="6">
                  <c:v>83</c:v>
                </c:pt>
                <c:pt idx="7">
                  <c:v>85</c:v>
                </c:pt>
                <c:pt idx="8">
                  <c:v>89</c:v>
                </c:pt>
                <c:pt idx="9">
                  <c:v>96</c:v>
                </c:pt>
                <c:pt idx="10">
                  <c:v>110</c:v>
                </c:pt>
                <c:pt idx="11">
                  <c:v>124</c:v>
                </c:pt>
                <c:pt idx="12">
                  <c:v>138</c:v>
                </c:pt>
              </c:numCache>
            </c:numRef>
          </c:xVal>
          <c:yVal>
            <c:numRef>
              <c:f>'Body Weight'!$D$29:$P$29</c:f>
              <c:numCache>
                <c:formatCode>0</c:formatCode>
                <c:ptCount val="13"/>
                <c:pt idx="0">
                  <c:v>371.22500000000002</c:v>
                </c:pt>
                <c:pt idx="1">
                  <c:v>379.88125000000002</c:v>
                </c:pt>
                <c:pt idx="2">
                  <c:v>385.41874999999999</c:v>
                </c:pt>
                <c:pt idx="3">
                  <c:v>389.9375</c:v>
                </c:pt>
                <c:pt idx="4">
                  <c:v>407.35</c:v>
                </c:pt>
                <c:pt idx="5">
                  <c:v>436.15000000000003</c:v>
                </c:pt>
                <c:pt idx="6">
                  <c:v>439.44375000000002</c:v>
                </c:pt>
                <c:pt idx="7">
                  <c:v>427.9799999999999</c:v>
                </c:pt>
                <c:pt idx="8">
                  <c:v>416.32</c:v>
                </c:pt>
                <c:pt idx="9">
                  <c:v>462.04666666666668</c:v>
                </c:pt>
                <c:pt idx="10">
                  <c:v>500.66363636363627</c:v>
                </c:pt>
                <c:pt idx="11">
                  <c:v>533.43750000000011</c:v>
                </c:pt>
                <c:pt idx="12">
                  <c:v>549</c:v>
                </c:pt>
              </c:numCache>
            </c:numRef>
          </c:yVal>
          <c:smooth val="0"/>
          <c:extLst>
            <c:ext xmlns:c16="http://schemas.microsoft.com/office/drawing/2014/chart" uri="{C3380CC4-5D6E-409C-BE32-E72D297353CC}">
              <c16:uniqueId val="{00000000-185F-4CBB-B8A7-E359C7C52051}"/>
            </c:ext>
          </c:extLst>
        </c:ser>
        <c:ser>
          <c:idx val="4"/>
          <c:order val="1"/>
          <c:tx>
            <c:v>Vendor Upper Limit</c:v>
          </c:tx>
          <c:spPr>
            <a:ln w="19050" cap="rnd">
              <a:solidFill>
                <a:schemeClr val="tx1"/>
              </a:solidFill>
              <a:round/>
            </a:ln>
            <a:effectLst/>
          </c:spPr>
          <c:marker>
            <c:symbol val="circle"/>
            <c:size val="5"/>
            <c:spPr>
              <a:solidFill>
                <a:schemeClr val="tx1"/>
              </a:solidFill>
              <a:ln w="9525">
                <a:solidFill>
                  <a:schemeClr val="tx1"/>
                </a:solidFill>
              </a:ln>
              <a:effectLst/>
            </c:spPr>
          </c:marker>
          <c:xVal>
            <c:numRef>
              <c:f>'Vendor Weights'!$B$2:$N$2</c:f>
              <c:numCache>
                <c:formatCode>General</c:formatCode>
                <c:ptCount val="13"/>
                <c:pt idx="0">
                  <c:v>21</c:v>
                </c:pt>
                <c:pt idx="1">
                  <c:v>28</c:v>
                </c:pt>
                <c:pt idx="2">
                  <c:v>35</c:v>
                </c:pt>
                <c:pt idx="3">
                  <c:v>42</c:v>
                </c:pt>
                <c:pt idx="4">
                  <c:v>49</c:v>
                </c:pt>
                <c:pt idx="5">
                  <c:v>56</c:v>
                </c:pt>
                <c:pt idx="6">
                  <c:v>63</c:v>
                </c:pt>
                <c:pt idx="7">
                  <c:v>70</c:v>
                </c:pt>
                <c:pt idx="8">
                  <c:v>77</c:v>
                </c:pt>
                <c:pt idx="9">
                  <c:v>84</c:v>
                </c:pt>
                <c:pt idx="10">
                  <c:v>91</c:v>
                </c:pt>
                <c:pt idx="11">
                  <c:v>98</c:v>
                </c:pt>
                <c:pt idx="12">
                  <c:v>105</c:v>
                </c:pt>
              </c:numCache>
            </c:numRef>
          </c:xVal>
          <c:yVal>
            <c:numRef>
              <c:f>'Vendor Weights'!$B$5:$N$5</c:f>
              <c:numCache>
                <c:formatCode>General</c:formatCode>
                <c:ptCount val="13"/>
                <c:pt idx="0">
                  <c:v>52.990746045230111</c:v>
                </c:pt>
                <c:pt idx="1">
                  <c:v>84.810077694218947</c:v>
                </c:pt>
                <c:pt idx="2">
                  <c:v>135.16025365717252</c:v>
                </c:pt>
                <c:pt idx="3">
                  <c:v>187.08056019686717</c:v>
                </c:pt>
                <c:pt idx="4">
                  <c:v>235.44434580132352</c:v>
                </c:pt>
                <c:pt idx="5">
                  <c:v>288.51311764044306</c:v>
                </c:pt>
                <c:pt idx="6">
                  <c:v>332.11066915816832</c:v>
                </c:pt>
                <c:pt idx="7">
                  <c:v>370.30988518374699</c:v>
                </c:pt>
                <c:pt idx="8">
                  <c:v>402.51534826052108</c:v>
                </c:pt>
                <c:pt idx="9">
                  <c:v>425.94533300811645</c:v>
                </c:pt>
                <c:pt idx="10">
                  <c:v>446.64208158350834</c:v>
                </c:pt>
                <c:pt idx="11">
                  <c:v>469.2736209851397</c:v>
                </c:pt>
                <c:pt idx="12">
                  <c:v>484.00401031643042</c:v>
                </c:pt>
              </c:numCache>
            </c:numRef>
          </c:yVal>
          <c:smooth val="0"/>
          <c:extLst>
            <c:ext xmlns:c16="http://schemas.microsoft.com/office/drawing/2014/chart" uri="{C3380CC4-5D6E-409C-BE32-E72D297353CC}">
              <c16:uniqueId val="{00000001-185F-4CBB-B8A7-E359C7C52051}"/>
            </c:ext>
          </c:extLst>
        </c:ser>
        <c:ser>
          <c:idx val="5"/>
          <c:order val="2"/>
          <c:tx>
            <c:v>Vendor Lower Limit</c:v>
          </c:tx>
          <c:spPr>
            <a:ln w="19050" cap="rnd">
              <a:solidFill>
                <a:schemeClr val="tx1"/>
              </a:solidFill>
              <a:round/>
            </a:ln>
            <a:effectLst/>
          </c:spPr>
          <c:marker>
            <c:symbol val="circle"/>
            <c:size val="5"/>
            <c:spPr>
              <a:solidFill>
                <a:schemeClr val="tx1"/>
              </a:solidFill>
              <a:ln w="9525">
                <a:solidFill>
                  <a:schemeClr val="tx1"/>
                </a:solidFill>
              </a:ln>
              <a:effectLst/>
            </c:spPr>
          </c:marker>
          <c:xVal>
            <c:numRef>
              <c:f>'Vendor Weights'!$B$2:$N$2</c:f>
              <c:numCache>
                <c:formatCode>General</c:formatCode>
                <c:ptCount val="13"/>
                <c:pt idx="0">
                  <c:v>21</c:v>
                </c:pt>
                <c:pt idx="1">
                  <c:v>28</c:v>
                </c:pt>
                <c:pt idx="2">
                  <c:v>35</c:v>
                </c:pt>
                <c:pt idx="3">
                  <c:v>42</c:v>
                </c:pt>
                <c:pt idx="4">
                  <c:v>49</c:v>
                </c:pt>
                <c:pt idx="5">
                  <c:v>56</c:v>
                </c:pt>
                <c:pt idx="6">
                  <c:v>63</c:v>
                </c:pt>
                <c:pt idx="7">
                  <c:v>70</c:v>
                </c:pt>
                <c:pt idx="8">
                  <c:v>77</c:v>
                </c:pt>
                <c:pt idx="9">
                  <c:v>84</c:v>
                </c:pt>
                <c:pt idx="10">
                  <c:v>91</c:v>
                </c:pt>
                <c:pt idx="11">
                  <c:v>98</c:v>
                </c:pt>
                <c:pt idx="12">
                  <c:v>105</c:v>
                </c:pt>
              </c:numCache>
            </c:numRef>
          </c:xVal>
          <c:yVal>
            <c:numRef>
              <c:f>'Vendor Weights'!$B$6:$N$6</c:f>
              <c:numCache>
                <c:formatCode>General</c:formatCode>
                <c:ptCount val="13"/>
                <c:pt idx="0">
                  <c:v>41.793869339385267</c:v>
                </c:pt>
                <c:pt idx="1">
                  <c:v>66.944032384408658</c:v>
                </c:pt>
                <c:pt idx="2">
                  <c:v>103.3790882598518</c:v>
                </c:pt>
                <c:pt idx="3">
                  <c:v>142.05759298853013</c:v>
                </c:pt>
                <c:pt idx="4">
                  <c:v>179.97011375486832</c:v>
                </c:pt>
                <c:pt idx="5">
                  <c:v>220.27828020901933</c:v>
                </c:pt>
                <c:pt idx="6">
                  <c:v>255.62247287913442</c:v>
                </c:pt>
                <c:pt idx="7">
                  <c:v>288.78480635140369</c:v>
                </c:pt>
                <c:pt idx="8">
                  <c:v>316.13073932023991</c:v>
                </c:pt>
                <c:pt idx="9">
                  <c:v>335.70265549763064</c:v>
                </c:pt>
                <c:pt idx="10">
                  <c:v>352.44059275150244</c:v>
                </c:pt>
                <c:pt idx="11">
                  <c:v>368.37098333140705</c:v>
                </c:pt>
                <c:pt idx="12">
                  <c:v>379.17728464759836</c:v>
                </c:pt>
              </c:numCache>
            </c:numRef>
          </c:yVal>
          <c:smooth val="0"/>
          <c:extLst>
            <c:ext xmlns:c16="http://schemas.microsoft.com/office/drawing/2014/chart" uri="{C3380CC4-5D6E-409C-BE32-E72D297353CC}">
              <c16:uniqueId val="{00000002-185F-4CBB-B8A7-E359C7C52051}"/>
            </c:ext>
          </c:extLst>
        </c:ser>
        <c:dLbls>
          <c:showLegendKey val="0"/>
          <c:showVal val="0"/>
          <c:showCatName val="0"/>
          <c:showSerName val="0"/>
          <c:showPercent val="0"/>
          <c:showBubbleSize val="0"/>
        </c:dLbls>
        <c:axId val="415362072"/>
        <c:axId val="415364816"/>
      </c:scatterChart>
      <c:valAx>
        <c:axId val="415362072"/>
        <c:scaling>
          <c:orientation val="minMax"/>
          <c:max val="130"/>
          <c:min val="0"/>
        </c:scaling>
        <c:delete val="0"/>
        <c:axPos val="b"/>
        <c:title>
          <c:tx>
            <c:rich>
              <a:bodyPr rot="0" spcFirstLastPara="1" vertOverflow="ellipsis" vert="horz" wrap="square" anchor="ctr" anchorCtr="1"/>
              <a:lstStyle/>
              <a:p>
                <a:pPr>
                  <a:defRPr sz="1800" b="0"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a:t>Age (days)</a:t>
                </a:r>
              </a:p>
            </c:rich>
          </c:tx>
          <c:overlay val="0"/>
          <c:spPr>
            <a:noFill/>
            <a:ln>
              <a:noFill/>
            </a:ln>
            <a:effectLst/>
          </c:spPr>
          <c:txPr>
            <a:bodyPr rot="0" spcFirstLastPara="1" vertOverflow="ellipsis" vert="horz" wrap="square" anchor="ctr" anchorCtr="1"/>
            <a:lstStyle/>
            <a:p>
              <a:pPr>
                <a:defRPr sz="18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0"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8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415364816"/>
        <c:crosses val="autoZero"/>
        <c:crossBetween val="midCat"/>
      </c:valAx>
      <c:valAx>
        <c:axId val="415364816"/>
        <c:scaling>
          <c:orientation val="minMax"/>
        </c:scaling>
        <c:delete val="0"/>
        <c:axPos val="l"/>
        <c:title>
          <c:tx>
            <c:rich>
              <a:bodyPr rot="-5400000" spcFirstLastPara="1" vertOverflow="ellipsis" vert="horz" wrap="square" anchor="ctr" anchorCtr="1"/>
              <a:lstStyle/>
              <a:p>
                <a:pPr>
                  <a:defRPr sz="1800" b="0"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a:t>Weight (g)</a:t>
                </a:r>
              </a:p>
            </c:rich>
          </c:tx>
          <c:layout>
            <c:manualLayout>
              <c:xMode val="edge"/>
              <c:yMode val="edge"/>
              <c:x val="2.8272539918190415E-3"/>
              <c:y val="0.35601049868766405"/>
            </c:manualLayout>
          </c:layout>
          <c:overlay val="0"/>
          <c:spPr>
            <a:noFill/>
            <a:ln>
              <a:noFill/>
            </a:ln>
            <a:effectLst/>
          </c:spPr>
          <c:txPr>
            <a:bodyPr rot="-5400000" spcFirstLastPara="1" vertOverflow="ellipsis" vert="horz" wrap="square" anchor="ctr" anchorCtr="1"/>
            <a:lstStyle/>
            <a:p>
              <a:pPr>
                <a:defRPr sz="18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0"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8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415362072"/>
        <c:crosses val="autoZero"/>
        <c:crossBetween val="midCat"/>
      </c:valAx>
      <c:spPr>
        <a:noFill/>
        <a:ln>
          <a:noFill/>
        </a:ln>
        <a:effectLst/>
      </c:spPr>
    </c:plotArea>
    <c:legend>
      <c:legendPos val="r"/>
      <c:layout>
        <c:manualLayout>
          <c:xMode val="edge"/>
          <c:yMode val="edge"/>
          <c:x val="0.1470641885754734"/>
          <c:y val="2.7548715501471394E-2"/>
          <c:w val="0.21223660884871492"/>
          <c:h val="0.18484234821624487"/>
        </c:manualLayout>
      </c:layout>
      <c:overlay val="0"/>
      <c:spPr>
        <a:noFill/>
        <a:ln>
          <a:noFill/>
        </a:ln>
        <a:effectLst/>
      </c:spPr>
      <c:txPr>
        <a:bodyPr rot="0" spcFirstLastPara="1" vertOverflow="ellipsis" vert="horz" wrap="square" anchor="ctr" anchorCtr="1"/>
        <a:lstStyle/>
        <a:p>
          <a:pPr>
            <a:defRPr sz="12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800">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userShapes r:id="rId4"/>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7960849726704956"/>
          <c:y val="0.11135835001219847"/>
          <c:w val="0.64159504040955273"/>
          <c:h val="0.58238683273350356"/>
        </c:manualLayout>
      </c:layout>
      <c:barChart>
        <c:barDir val="col"/>
        <c:grouping val="clustered"/>
        <c:varyColors val="0"/>
        <c:ser>
          <c:idx val="2"/>
          <c:order val="0"/>
          <c:spPr>
            <a:solidFill>
              <a:srgbClr val="70AD47">
                <a:lumMod val="40000"/>
                <a:lumOff val="60000"/>
              </a:srgbClr>
            </a:solidFill>
            <a:ln w="25400">
              <a:solidFill>
                <a:srgbClr val="FF0000"/>
              </a:solidFill>
            </a:ln>
            <a:effectLst/>
          </c:spPr>
          <c:invertIfNegative val="0"/>
          <c:errBars>
            <c:errBarType val="plus"/>
            <c:errValType val="cust"/>
            <c:noEndCap val="0"/>
            <c:plus>
              <c:numRef>
                <c:f>Sheet1!$E$23:$E$26</c:f>
                <c:numCache>
                  <c:formatCode>General</c:formatCode>
                  <c:ptCount val="4"/>
                  <c:pt idx="0">
                    <c:v>15.442059517060862</c:v>
                  </c:pt>
                  <c:pt idx="1">
                    <c:v>29.008065899385919</c:v>
                  </c:pt>
                  <c:pt idx="2">
                    <c:v>13.480034354257086</c:v>
                  </c:pt>
                  <c:pt idx="3">
                    <c:v>19.482069393424972</c:v>
                  </c:pt>
                </c:numCache>
              </c:numRef>
            </c:plus>
            <c:minus>
              <c:numRef>
                <c:f>Sheet1!$E$23:$E$26</c:f>
                <c:numCache>
                  <c:formatCode>General</c:formatCode>
                  <c:ptCount val="4"/>
                  <c:pt idx="0">
                    <c:v>15.442059517060862</c:v>
                  </c:pt>
                  <c:pt idx="1">
                    <c:v>29.008065899385919</c:v>
                  </c:pt>
                  <c:pt idx="2">
                    <c:v>13.480034354257086</c:v>
                  </c:pt>
                  <c:pt idx="3">
                    <c:v>19.482069393424972</c:v>
                  </c:pt>
                </c:numCache>
              </c:numRef>
            </c:minus>
            <c:spPr>
              <a:noFill/>
              <a:ln w="9525" cap="flat" cmpd="sng" algn="ctr">
                <a:solidFill>
                  <a:schemeClr val="tx1">
                    <a:lumMod val="65000"/>
                    <a:lumOff val="35000"/>
                  </a:schemeClr>
                </a:solidFill>
                <a:round/>
              </a:ln>
              <a:effectLst/>
            </c:spPr>
          </c:errBars>
          <c:cat>
            <c:strRef>
              <c:f>Sheet1!$B$18:$B$21</c:f>
              <c:strCache>
                <c:ptCount val="4"/>
                <c:pt idx="0">
                  <c:v>Week 2</c:v>
                </c:pt>
                <c:pt idx="1">
                  <c:v>Week 4</c:v>
                </c:pt>
                <c:pt idx="2">
                  <c:v>Week 6</c:v>
                </c:pt>
                <c:pt idx="3">
                  <c:v>Week 8</c:v>
                </c:pt>
              </c:strCache>
            </c:strRef>
          </c:cat>
          <c:val>
            <c:numRef>
              <c:f>Sheet1!$E$18:$E$21</c:f>
              <c:numCache>
                <c:formatCode>0.00</c:formatCode>
                <c:ptCount val="4"/>
                <c:pt idx="0">
                  <c:v>123.88965999999999</c:v>
                </c:pt>
                <c:pt idx="1">
                  <c:v>131.30318075</c:v>
                </c:pt>
                <c:pt idx="2">
                  <c:v>101.98064725</c:v>
                </c:pt>
                <c:pt idx="3">
                  <c:v>90.419977750000001</c:v>
                </c:pt>
              </c:numCache>
            </c:numRef>
          </c:val>
          <c:extLst>
            <c:ext xmlns:c16="http://schemas.microsoft.com/office/drawing/2014/chart" uri="{C3380CC4-5D6E-409C-BE32-E72D297353CC}">
              <c16:uniqueId val="{00000000-2CAB-45AB-892E-66E5BC57FC2C}"/>
            </c:ext>
          </c:extLst>
        </c:ser>
        <c:dLbls>
          <c:showLegendKey val="0"/>
          <c:showVal val="0"/>
          <c:showCatName val="0"/>
          <c:showSerName val="0"/>
          <c:showPercent val="0"/>
          <c:showBubbleSize val="0"/>
        </c:dLbls>
        <c:gapWidth val="219"/>
        <c:overlap val="-27"/>
        <c:axId val="503266624"/>
        <c:axId val="503265840"/>
      </c:barChart>
      <c:catAx>
        <c:axId val="503266624"/>
        <c:scaling>
          <c:orientation val="minMax"/>
        </c:scaling>
        <c:delete val="0"/>
        <c:axPos val="b"/>
        <c:numFmt formatCode="General" sourceLinked="1"/>
        <c:majorTickMark val="none"/>
        <c:minorTickMark val="none"/>
        <c:tickLblPos val="low"/>
        <c:spPr>
          <a:noFill/>
          <a:ln w="9525" cap="flat" cmpd="sng" algn="ctr">
            <a:solidFill>
              <a:sysClr val="windowText" lastClr="000000"/>
            </a:solidFill>
            <a:round/>
          </a:ln>
          <a:effectLst/>
        </c:spPr>
        <c:txPr>
          <a:bodyPr rot="-600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503265840"/>
        <c:crosses val="autoZero"/>
        <c:auto val="1"/>
        <c:lblAlgn val="ctr"/>
        <c:lblOffset val="100"/>
        <c:tickMarkSkip val="7"/>
        <c:noMultiLvlLbl val="0"/>
      </c:catAx>
      <c:valAx>
        <c:axId val="503265840"/>
        <c:scaling>
          <c:orientation val="minMax"/>
          <c:min val="0"/>
        </c:scaling>
        <c:delete val="0"/>
        <c:axPos val="l"/>
        <c:title>
          <c:tx>
            <c:rich>
              <a:bodyPr rot="-54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400" b="0" i="0" u="none" strike="noStrike" baseline="0" dirty="0">
                    <a:effectLst/>
                  </a:rPr>
                  <a:t>Total tissue </a:t>
                </a:r>
              </a:p>
              <a:p>
                <a:pPr>
                  <a:defRPr/>
                </a:pPr>
                <a:r>
                  <a:rPr lang="en-US" sz="1400" b="0" i="0" u="none" strike="noStrike" baseline="0" dirty="0">
                    <a:effectLst/>
                  </a:rPr>
                  <a:t>Volume (mm</a:t>
                </a:r>
                <a:r>
                  <a:rPr lang="en-US" sz="1400" b="0" i="0" u="none" strike="noStrike" baseline="30000" dirty="0">
                    <a:effectLst/>
                  </a:rPr>
                  <a:t>3</a:t>
                </a:r>
                <a:r>
                  <a:rPr lang="en-US" sz="1400" b="0" i="0" u="none" strike="noStrike" baseline="0" dirty="0">
                    <a:effectLst/>
                  </a:rPr>
                  <a:t>) (TV)</a:t>
                </a:r>
                <a:r>
                  <a:rPr lang="en-US" sz="1400" b="0" i="0" u="none" strike="noStrike" baseline="0" dirty="0"/>
                  <a:t> </a:t>
                </a:r>
                <a:endParaRPr lang="en-US" sz="1400" dirty="0"/>
              </a:p>
            </c:rich>
          </c:tx>
          <c:layout>
            <c:manualLayout>
              <c:xMode val="edge"/>
              <c:yMode val="edge"/>
              <c:x val="0"/>
              <c:y val="0.11274082041291231"/>
            </c:manualLayout>
          </c:layout>
          <c:overlay val="0"/>
          <c:spPr>
            <a:noFill/>
            <a:ln>
              <a:noFill/>
            </a:ln>
            <a:effectLst/>
          </c:spPr>
          <c:txPr>
            <a:bodyPr rot="-54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0"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503266624"/>
        <c:crosses val="autoZero"/>
        <c:crossBetween val="between"/>
      </c:valAx>
      <c:spPr>
        <a:noFill/>
        <a:ln>
          <a:noFill/>
        </a:ln>
        <a:effectLst/>
      </c:spPr>
    </c:plotArea>
    <c:plotVisOnly val="1"/>
    <c:dispBlanksAs val="gap"/>
    <c:showDLblsOverMax val="0"/>
  </c:chart>
  <c:spPr>
    <a:noFill/>
    <a:ln>
      <a:noFill/>
    </a:ln>
    <a:effectLst/>
  </c:spPr>
  <c:txPr>
    <a:bodyPr/>
    <a:lstStyle/>
    <a:p>
      <a:pPr>
        <a:defRPr sz="1400">
          <a:solidFill>
            <a:sysClr val="windowText" lastClr="000000"/>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9587426210288842"/>
          <c:y val="0.11135835001219847"/>
          <c:w val="0.6562697464559154"/>
          <c:h val="0.58238683273350356"/>
        </c:manualLayout>
      </c:layout>
      <c:barChart>
        <c:barDir val="col"/>
        <c:grouping val="clustered"/>
        <c:varyColors val="0"/>
        <c:ser>
          <c:idx val="2"/>
          <c:order val="0"/>
          <c:spPr>
            <a:solidFill>
              <a:srgbClr val="FF0000"/>
            </a:solidFill>
            <a:ln w="25400">
              <a:solidFill>
                <a:srgbClr val="FF0000"/>
              </a:solidFill>
            </a:ln>
            <a:effectLst/>
          </c:spPr>
          <c:invertIfNegative val="0"/>
          <c:errBars>
            <c:errBarType val="plus"/>
            <c:errValType val="cust"/>
            <c:noEndCap val="0"/>
            <c:plus>
              <c:numRef>
                <c:f>Sheet1!$G$23:$G$26</c:f>
                <c:numCache>
                  <c:formatCode>General</c:formatCode>
                  <c:ptCount val="4"/>
                  <c:pt idx="0">
                    <c:v>14.959123263179951</c:v>
                  </c:pt>
                  <c:pt idx="1">
                    <c:v>15.676064220353251</c:v>
                  </c:pt>
                  <c:pt idx="2">
                    <c:v>12.547280186477767</c:v>
                  </c:pt>
                  <c:pt idx="3">
                    <c:v>16.998237380917445</c:v>
                  </c:pt>
                </c:numCache>
              </c:numRef>
            </c:plus>
            <c:minus>
              <c:numRef>
                <c:f>Sheet1!$G$23:$G$26</c:f>
                <c:numCache>
                  <c:formatCode>General</c:formatCode>
                  <c:ptCount val="4"/>
                  <c:pt idx="0">
                    <c:v>14.959123263179951</c:v>
                  </c:pt>
                  <c:pt idx="1">
                    <c:v>15.676064220353251</c:v>
                  </c:pt>
                  <c:pt idx="2">
                    <c:v>12.547280186477767</c:v>
                  </c:pt>
                  <c:pt idx="3">
                    <c:v>16.998237380917445</c:v>
                  </c:pt>
                </c:numCache>
              </c:numRef>
            </c:minus>
            <c:spPr>
              <a:noFill/>
              <a:ln w="9525" cap="flat" cmpd="sng" algn="ctr">
                <a:solidFill>
                  <a:schemeClr val="tx1">
                    <a:lumMod val="65000"/>
                    <a:lumOff val="35000"/>
                  </a:schemeClr>
                </a:solidFill>
                <a:round/>
              </a:ln>
              <a:effectLst/>
            </c:spPr>
          </c:errBars>
          <c:cat>
            <c:strRef>
              <c:f>Sheet1!$B$23:$B$26</c:f>
              <c:strCache>
                <c:ptCount val="4"/>
                <c:pt idx="0">
                  <c:v>Week 2</c:v>
                </c:pt>
                <c:pt idx="1">
                  <c:v>Week 4</c:v>
                </c:pt>
                <c:pt idx="2">
                  <c:v>Week 6</c:v>
                </c:pt>
                <c:pt idx="3">
                  <c:v>Week 8</c:v>
                </c:pt>
              </c:strCache>
            </c:strRef>
          </c:cat>
          <c:val>
            <c:numRef>
              <c:f>Sheet1!$G$18:$G$21</c:f>
              <c:numCache>
                <c:formatCode>0.00</c:formatCode>
                <c:ptCount val="4"/>
                <c:pt idx="0">
                  <c:v>87.028297499999994</c:v>
                </c:pt>
                <c:pt idx="1">
                  <c:v>103.5715275</c:v>
                </c:pt>
                <c:pt idx="2">
                  <c:v>79.148870499999987</c:v>
                </c:pt>
                <c:pt idx="3">
                  <c:v>68.180922499999994</c:v>
                </c:pt>
              </c:numCache>
            </c:numRef>
          </c:val>
          <c:extLst>
            <c:ext xmlns:c16="http://schemas.microsoft.com/office/drawing/2014/chart" uri="{C3380CC4-5D6E-409C-BE32-E72D297353CC}">
              <c16:uniqueId val="{00000000-3266-41B6-8EF5-21A2515DE210}"/>
            </c:ext>
          </c:extLst>
        </c:ser>
        <c:dLbls>
          <c:showLegendKey val="0"/>
          <c:showVal val="0"/>
          <c:showCatName val="0"/>
          <c:showSerName val="0"/>
          <c:showPercent val="0"/>
          <c:showBubbleSize val="0"/>
        </c:dLbls>
        <c:gapWidth val="219"/>
        <c:overlap val="-27"/>
        <c:axId val="503266624"/>
        <c:axId val="503265840"/>
      </c:barChart>
      <c:catAx>
        <c:axId val="503266624"/>
        <c:scaling>
          <c:orientation val="minMax"/>
        </c:scaling>
        <c:delete val="0"/>
        <c:axPos val="b"/>
        <c:numFmt formatCode="General" sourceLinked="1"/>
        <c:majorTickMark val="none"/>
        <c:minorTickMark val="none"/>
        <c:tickLblPos val="low"/>
        <c:spPr>
          <a:noFill/>
          <a:ln w="9525" cap="flat" cmpd="sng" algn="ctr">
            <a:solidFill>
              <a:sysClr val="windowText" lastClr="000000"/>
            </a:solidFill>
            <a:round/>
          </a:ln>
          <a:effectLst/>
        </c:spPr>
        <c:txPr>
          <a:bodyPr rot="-600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503265840"/>
        <c:crosses val="autoZero"/>
        <c:auto val="1"/>
        <c:lblAlgn val="ctr"/>
        <c:lblOffset val="100"/>
        <c:tickMarkSkip val="7"/>
        <c:noMultiLvlLbl val="0"/>
      </c:catAx>
      <c:valAx>
        <c:axId val="503265840"/>
        <c:scaling>
          <c:orientation val="minMax"/>
          <c:max val="200"/>
          <c:min val="0"/>
        </c:scaling>
        <c:delete val="0"/>
        <c:axPos val="l"/>
        <c:title>
          <c:tx>
            <c:rich>
              <a:bodyPr rot="-54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400" b="0" i="0" u="none" strike="noStrike" baseline="0" dirty="0">
                    <a:effectLst/>
                  </a:rPr>
                  <a:t>Total bone Volume (mm</a:t>
                </a:r>
                <a:r>
                  <a:rPr lang="en-US" sz="1400" b="0" i="0" u="none" strike="noStrike" baseline="30000" dirty="0">
                    <a:effectLst/>
                  </a:rPr>
                  <a:t>3</a:t>
                </a:r>
                <a:r>
                  <a:rPr lang="en-US" sz="1400" b="0" i="0" u="none" strike="noStrike" baseline="0" dirty="0">
                    <a:effectLst/>
                  </a:rPr>
                  <a:t>) (BV)</a:t>
                </a:r>
                <a:r>
                  <a:rPr lang="en-US" sz="1400" b="0" i="0" u="none" strike="noStrike" baseline="0" dirty="0"/>
                  <a:t> </a:t>
                </a:r>
                <a:endParaRPr lang="en-US" sz="1400" dirty="0"/>
              </a:p>
            </c:rich>
          </c:tx>
          <c:layout>
            <c:manualLayout>
              <c:xMode val="edge"/>
              <c:yMode val="edge"/>
              <c:x val="0"/>
              <c:y val="0.11274098934354519"/>
            </c:manualLayout>
          </c:layout>
          <c:overlay val="0"/>
          <c:spPr>
            <a:noFill/>
            <a:ln>
              <a:noFill/>
            </a:ln>
            <a:effectLst/>
          </c:spPr>
          <c:txPr>
            <a:bodyPr rot="-54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0"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503266624"/>
        <c:crosses val="autoZero"/>
        <c:crossBetween val="between"/>
      </c:valAx>
      <c:spPr>
        <a:noFill/>
        <a:ln>
          <a:noFill/>
        </a:ln>
        <a:effectLst/>
      </c:spPr>
    </c:plotArea>
    <c:plotVisOnly val="1"/>
    <c:dispBlanksAs val="gap"/>
    <c:showDLblsOverMax val="0"/>
  </c:chart>
  <c:spPr>
    <a:noFill/>
    <a:ln>
      <a:noFill/>
    </a:ln>
    <a:effectLst/>
  </c:spPr>
  <c:txPr>
    <a:bodyPr/>
    <a:lstStyle/>
    <a:p>
      <a:pPr>
        <a:defRPr sz="1400">
          <a:solidFill>
            <a:sysClr val="windowText" lastClr="000000"/>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9846011649123927"/>
          <c:y val="0.11135835001219847"/>
          <c:w val="0.65368413504059664"/>
          <c:h val="0.58238683273350356"/>
        </c:manualLayout>
      </c:layout>
      <c:barChart>
        <c:barDir val="col"/>
        <c:grouping val="clustered"/>
        <c:varyColors val="0"/>
        <c:ser>
          <c:idx val="2"/>
          <c:order val="0"/>
          <c:spPr>
            <a:solidFill>
              <a:srgbClr val="00B0F0"/>
            </a:solidFill>
            <a:ln w="25400">
              <a:solidFill>
                <a:srgbClr val="00B0F0"/>
              </a:solidFill>
            </a:ln>
            <a:effectLst/>
          </c:spPr>
          <c:invertIfNegative val="0"/>
          <c:errBars>
            <c:errBarType val="plus"/>
            <c:errValType val="cust"/>
            <c:noEndCap val="0"/>
            <c:plus>
              <c:numRef>
                <c:f>Sheet1!$H$23:$H$26</c:f>
                <c:numCache>
                  <c:formatCode>General</c:formatCode>
                  <c:ptCount val="4"/>
                  <c:pt idx="0">
                    <c:v>3.344740444919863E-2</c:v>
                  </c:pt>
                  <c:pt idx="1">
                    <c:v>5.4186904955794653E-2</c:v>
                  </c:pt>
                  <c:pt idx="2">
                    <c:v>6.3841448325957534E-2</c:v>
                  </c:pt>
                  <c:pt idx="3">
                    <c:v>5.3934014030188729E-2</c:v>
                  </c:pt>
                </c:numCache>
              </c:numRef>
            </c:plus>
            <c:minus>
              <c:numRef>
                <c:f>Sheet1!$H$23:$H$26</c:f>
                <c:numCache>
                  <c:formatCode>General</c:formatCode>
                  <c:ptCount val="4"/>
                  <c:pt idx="0">
                    <c:v>3.344740444919863E-2</c:v>
                  </c:pt>
                  <c:pt idx="1">
                    <c:v>5.4186904955794653E-2</c:v>
                  </c:pt>
                  <c:pt idx="2">
                    <c:v>6.3841448325957534E-2</c:v>
                  </c:pt>
                  <c:pt idx="3">
                    <c:v>5.3934014030188729E-2</c:v>
                  </c:pt>
                </c:numCache>
              </c:numRef>
            </c:minus>
            <c:spPr>
              <a:noFill/>
              <a:ln w="9525" cap="flat" cmpd="sng" algn="ctr">
                <a:solidFill>
                  <a:schemeClr val="tx1">
                    <a:lumMod val="65000"/>
                    <a:lumOff val="35000"/>
                  </a:schemeClr>
                </a:solidFill>
                <a:round/>
              </a:ln>
              <a:effectLst/>
            </c:spPr>
          </c:errBars>
          <c:cat>
            <c:strRef>
              <c:f>Sheet1!$B$23:$B$26</c:f>
              <c:strCache>
                <c:ptCount val="4"/>
                <c:pt idx="0">
                  <c:v>Week 2</c:v>
                </c:pt>
                <c:pt idx="1">
                  <c:v>Week 4</c:v>
                </c:pt>
                <c:pt idx="2">
                  <c:v>Week 6</c:v>
                </c:pt>
                <c:pt idx="3">
                  <c:v>Week 8</c:v>
                </c:pt>
              </c:strCache>
            </c:strRef>
          </c:cat>
          <c:val>
            <c:numRef>
              <c:f>Sheet1!$H$18:$H$21</c:f>
              <c:numCache>
                <c:formatCode>0.00</c:formatCode>
                <c:ptCount val="4"/>
                <c:pt idx="0">
                  <c:v>0.70038168717956073</c:v>
                </c:pt>
                <c:pt idx="1">
                  <c:v>0.7968236665406796</c:v>
                </c:pt>
                <c:pt idx="2">
                  <c:v>0.77594029715165358</c:v>
                </c:pt>
                <c:pt idx="3">
                  <c:v>0.74908767799807463</c:v>
                </c:pt>
              </c:numCache>
            </c:numRef>
          </c:val>
          <c:extLst>
            <c:ext xmlns:c16="http://schemas.microsoft.com/office/drawing/2014/chart" uri="{C3380CC4-5D6E-409C-BE32-E72D297353CC}">
              <c16:uniqueId val="{00000000-E30C-4EB2-B3BE-381C46CE3C68}"/>
            </c:ext>
          </c:extLst>
        </c:ser>
        <c:dLbls>
          <c:showLegendKey val="0"/>
          <c:showVal val="0"/>
          <c:showCatName val="0"/>
          <c:showSerName val="0"/>
          <c:showPercent val="0"/>
          <c:showBubbleSize val="0"/>
        </c:dLbls>
        <c:gapWidth val="219"/>
        <c:overlap val="-27"/>
        <c:axId val="503266624"/>
        <c:axId val="503265840"/>
      </c:barChart>
      <c:catAx>
        <c:axId val="503266624"/>
        <c:scaling>
          <c:orientation val="minMax"/>
        </c:scaling>
        <c:delete val="0"/>
        <c:axPos val="b"/>
        <c:numFmt formatCode="General" sourceLinked="1"/>
        <c:majorTickMark val="none"/>
        <c:minorTickMark val="none"/>
        <c:tickLblPos val="low"/>
        <c:spPr>
          <a:noFill/>
          <a:ln w="9525" cap="flat" cmpd="sng" algn="ctr">
            <a:solidFill>
              <a:sysClr val="windowText" lastClr="000000"/>
            </a:solidFill>
            <a:round/>
          </a:ln>
          <a:effectLst/>
        </c:spPr>
        <c:txPr>
          <a:bodyPr rot="-600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503265840"/>
        <c:crosses val="autoZero"/>
        <c:auto val="1"/>
        <c:lblAlgn val="ctr"/>
        <c:lblOffset val="100"/>
        <c:tickMarkSkip val="7"/>
        <c:noMultiLvlLbl val="0"/>
      </c:catAx>
      <c:valAx>
        <c:axId val="503265840"/>
        <c:scaling>
          <c:orientation val="minMax"/>
          <c:min val="0"/>
        </c:scaling>
        <c:delete val="0"/>
        <c:axPos val="l"/>
        <c:title>
          <c:tx>
            <c:rich>
              <a:bodyPr rot="-54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400" b="0" i="0" u="none" strike="noStrike" baseline="0" dirty="0">
                    <a:effectLst/>
                  </a:rPr>
                  <a:t>Bone Volume</a:t>
                </a:r>
              </a:p>
              <a:p>
                <a:pPr>
                  <a:defRPr/>
                </a:pPr>
                <a:r>
                  <a:rPr lang="en-US" sz="1400" b="0" i="0" u="none" strike="noStrike" baseline="0" dirty="0">
                    <a:effectLst/>
                  </a:rPr>
                  <a:t>Fraction(BV/TV)</a:t>
                </a:r>
                <a:r>
                  <a:rPr lang="en-US" sz="1400" b="0" i="0" u="none" strike="noStrike" baseline="0" dirty="0"/>
                  <a:t> </a:t>
                </a:r>
                <a:endParaRPr lang="en-US" sz="1400" dirty="0"/>
              </a:p>
            </c:rich>
          </c:tx>
          <c:layout>
            <c:manualLayout>
              <c:xMode val="edge"/>
              <c:yMode val="edge"/>
              <c:x val="0"/>
              <c:y val="0.11274098934354519"/>
            </c:manualLayout>
          </c:layout>
          <c:overlay val="0"/>
          <c:spPr>
            <a:noFill/>
            <a:ln>
              <a:noFill/>
            </a:ln>
            <a:effectLst/>
          </c:spPr>
          <c:txPr>
            <a:bodyPr rot="-54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0.00"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503266624"/>
        <c:crosses val="autoZero"/>
        <c:crossBetween val="between"/>
        <c:majorUnit val="0.25"/>
      </c:valAx>
      <c:spPr>
        <a:noFill/>
        <a:ln>
          <a:noFill/>
        </a:ln>
        <a:effectLst/>
      </c:spPr>
    </c:plotArea>
    <c:plotVisOnly val="1"/>
    <c:dispBlanksAs val="gap"/>
    <c:showDLblsOverMax val="0"/>
  </c:chart>
  <c:spPr>
    <a:noFill/>
    <a:ln>
      <a:noFill/>
    </a:ln>
    <a:effectLst/>
  </c:spPr>
  <c:txPr>
    <a:bodyPr/>
    <a:lstStyle/>
    <a:p>
      <a:pPr>
        <a:defRPr sz="1400">
          <a:solidFill>
            <a:sysClr val="windowText" lastClr="000000"/>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6467216924620723"/>
          <c:y val="0.15352194623146315"/>
          <c:w val="0.68747218834279444"/>
          <c:h val="0.54022306862954228"/>
        </c:manualLayout>
      </c:layout>
      <c:barChart>
        <c:barDir val="col"/>
        <c:grouping val="clustered"/>
        <c:varyColors val="0"/>
        <c:ser>
          <c:idx val="2"/>
          <c:order val="0"/>
          <c:spPr>
            <a:solidFill>
              <a:srgbClr val="70AD47">
                <a:lumMod val="40000"/>
                <a:lumOff val="60000"/>
              </a:srgbClr>
            </a:solidFill>
            <a:ln w="25400">
              <a:solidFill>
                <a:srgbClr val="70AD47"/>
              </a:solidFill>
            </a:ln>
            <a:effectLst/>
          </c:spPr>
          <c:invertIfNegative val="0"/>
          <c:errBars>
            <c:errBarType val="plus"/>
            <c:errValType val="cust"/>
            <c:noEndCap val="0"/>
            <c:plus>
              <c:numRef>
                <c:f>Sheet1!$O$23:$O$26</c:f>
                <c:numCache>
                  <c:formatCode>General</c:formatCode>
                  <c:ptCount val="4"/>
                  <c:pt idx="0">
                    <c:v>7.2348754616883655</c:v>
                  </c:pt>
                  <c:pt idx="1">
                    <c:v>10.47034060455195</c:v>
                  </c:pt>
                  <c:pt idx="2">
                    <c:v>7.6378090418856068</c:v>
                  </c:pt>
                  <c:pt idx="3">
                    <c:v>6.7393760121949127</c:v>
                  </c:pt>
                </c:numCache>
              </c:numRef>
            </c:plus>
            <c:minus>
              <c:numRef>
                <c:f>Sheet1!$O$23:$O$26</c:f>
                <c:numCache>
                  <c:formatCode>General</c:formatCode>
                  <c:ptCount val="4"/>
                  <c:pt idx="0">
                    <c:v>7.2348754616883655</c:v>
                  </c:pt>
                  <c:pt idx="1">
                    <c:v>10.47034060455195</c:v>
                  </c:pt>
                  <c:pt idx="2">
                    <c:v>7.6378090418856068</c:v>
                  </c:pt>
                  <c:pt idx="3">
                    <c:v>6.7393760121949127</c:v>
                  </c:pt>
                </c:numCache>
              </c:numRef>
            </c:minus>
            <c:spPr>
              <a:noFill/>
              <a:ln w="9525" cap="flat" cmpd="sng" algn="ctr">
                <a:solidFill>
                  <a:schemeClr val="tx1">
                    <a:lumMod val="65000"/>
                    <a:lumOff val="35000"/>
                  </a:schemeClr>
                </a:solidFill>
                <a:round/>
              </a:ln>
              <a:effectLst/>
            </c:spPr>
          </c:errBars>
          <c:cat>
            <c:strRef>
              <c:f>Sheet1!$B$18:$B$21</c:f>
              <c:strCache>
                <c:ptCount val="4"/>
                <c:pt idx="0">
                  <c:v>Week 2</c:v>
                </c:pt>
                <c:pt idx="1">
                  <c:v>Week 4</c:v>
                </c:pt>
                <c:pt idx="2">
                  <c:v>Week 6</c:v>
                </c:pt>
                <c:pt idx="3">
                  <c:v>Week 8</c:v>
                </c:pt>
              </c:strCache>
            </c:strRef>
          </c:cat>
          <c:val>
            <c:numRef>
              <c:f>Sheet1!$O$18:$O$21</c:f>
              <c:numCache>
                <c:formatCode>0.00</c:formatCode>
                <c:ptCount val="4"/>
                <c:pt idx="0">
                  <c:v>25.843885499999999</c:v>
                </c:pt>
                <c:pt idx="1">
                  <c:v>27.215952000000001</c:v>
                </c:pt>
                <c:pt idx="2">
                  <c:v>32.915632500000001</c:v>
                </c:pt>
                <c:pt idx="3">
                  <c:v>31.684410250000003</c:v>
                </c:pt>
              </c:numCache>
            </c:numRef>
          </c:val>
          <c:extLst>
            <c:ext xmlns:c16="http://schemas.microsoft.com/office/drawing/2014/chart" uri="{C3380CC4-5D6E-409C-BE32-E72D297353CC}">
              <c16:uniqueId val="{00000000-F3B6-4D4A-8B11-7F0E804C5231}"/>
            </c:ext>
          </c:extLst>
        </c:ser>
        <c:dLbls>
          <c:showLegendKey val="0"/>
          <c:showVal val="0"/>
          <c:showCatName val="0"/>
          <c:showSerName val="0"/>
          <c:showPercent val="0"/>
          <c:showBubbleSize val="0"/>
        </c:dLbls>
        <c:gapWidth val="219"/>
        <c:overlap val="-27"/>
        <c:axId val="503266624"/>
        <c:axId val="503265840"/>
      </c:barChart>
      <c:catAx>
        <c:axId val="503266624"/>
        <c:scaling>
          <c:orientation val="minMax"/>
        </c:scaling>
        <c:delete val="0"/>
        <c:axPos val="b"/>
        <c:numFmt formatCode="General" sourceLinked="1"/>
        <c:majorTickMark val="none"/>
        <c:minorTickMark val="none"/>
        <c:tickLblPos val="low"/>
        <c:spPr>
          <a:noFill/>
          <a:ln w="9525" cap="flat" cmpd="sng" algn="ctr">
            <a:solidFill>
              <a:sysClr val="windowText" lastClr="000000"/>
            </a:solidFill>
            <a:round/>
          </a:ln>
          <a:effectLst/>
        </c:spPr>
        <c:txPr>
          <a:bodyPr rot="-600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503265840"/>
        <c:crosses val="autoZero"/>
        <c:auto val="1"/>
        <c:lblAlgn val="ctr"/>
        <c:lblOffset val="100"/>
        <c:tickMarkSkip val="7"/>
        <c:noMultiLvlLbl val="0"/>
      </c:catAx>
      <c:valAx>
        <c:axId val="503265840"/>
        <c:scaling>
          <c:orientation val="minMax"/>
          <c:max val="50"/>
          <c:min val="0"/>
        </c:scaling>
        <c:delete val="0"/>
        <c:axPos val="l"/>
        <c:title>
          <c:tx>
            <c:rich>
              <a:bodyPr rot="-54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400" b="0" i="0" u="none" strike="noStrike" baseline="0">
                    <a:effectLst/>
                  </a:rPr>
                  <a:t>Cortical Volume</a:t>
                </a:r>
                <a:r>
                  <a:rPr lang="en-US" sz="1400" b="0" i="0" u="none" strike="noStrike" baseline="0"/>
                  <a:t> </a:t>
                </a:r>
                <a:endParaRPr lang="en-US" sz="1400"/>
              </a:p>
            </c:rich>
          </c:tx>
          <c:layout>
            <c:manualLayout>
              <c:xMode val="edge"/>
              <c:yMode val="edge"/>
              <c:x val="4.2899762733910676E-2"/>
              <c:y val="0.17071605893274658"/>
            </c:manualLayout>
          </c:layout>
          <c:overlay val="0"/>
          <c:spPr>
            <a:noFill/>
            <a:ln>
              <a:noFill/>
            </a:ln>
            <a:effectLst/>
          </c:spPr>
          <c:txPr>
            <a:bodyPr rot="-54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0"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503266624"/>
        <c:crosses val="autoZero"/>
        <c:crossBetween val="between"/>
      </c:valAx>
      <c:spPr>
        <a:noFill/>
        <a:ln>
          <a:noFill/>
        </a:ln>
        <a:effectLst/>
      </c:spPr>
    </c:plotArea>
    <c:plotVisOnly val="1"/>
    <c:dispBlanksAs val="gap"/>
    <c:showDLblsOverMax val="0"/>
  </c:chart>
  <c:spPr>
    <a:noFill/>
    <a:ln>
      <a:noFill/>
    </a:ln>
    <a:effectLst/>
  </c:spPr>
  <c:txPr>
    <a:bodyPr/>
    <a:lstStyle/>
    <a:p>
      <a:pPr>
        <a:defRPr sz="1400">
          <a:solidFill>
            <a:sysClr val="windowText" lastClr="000000"/>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9679990428284159"/>
          <c:y val="0.17077887024420441"/>
          <c:w val="0.65534434966925059"/>
          <c:h val="0.52296614150316745"/>
        </c:manualLayout>
      </c:layout>
      <c:barChart>
        <c:barDir val="col"/>
        <c:grouping val="clustered"/>
        <c:varyColors val="0"/>
        <c:ser>
          <c:idx val="2"/>
          <c:order val="0"/>
          <c:spPr>
            <a:solidFill>
              <a:srgbClr val="70AD47">
                <a:lumMod val="40000"/>
                <a:lumOff val="60000"/>
              </a:srgbClr>
            </a:solidFill>
            <a:ln w="25400">
              <a:solidFill>
                <a:srgbClr val="70AD47"/>
              </a:solidFill>
            </a:ln>
            <a:effectLst/>
          </c:spPr>
          <c:invertIfNegative val="0"/>
          <c:errBars>
            <c:errBarType val="plus"/>
            <c:errValType val="cust"/>
            <c:noEndCap val="0"/>
            <c:plus>
              <c:numRef>
                <c:f>Sheet1!$P$23:$P$26</c:f>
                <c:numCache>
                  <c:formatCode>General</c:formatCode>
                  <c:ptCount val="4"/>
                  <c:pt idx="0">
                    <c:v>48.237509393933394</c:v>
                  </c:pt>
                  <c:pt idx="1">
                    <c:v>209.21817159828419</c:v>
                  </c:pt>
                  <c:pt idx="2">
                    <c:v>42.210819761452775</c:v>
                  </c:pt>
                  <c:pt idx="3">
                    <c:v>63.509587485735956</c:v>
                  </c:pt>
                </c:numCache>
              </c:numRef>
            </c:plus>
            <c:minus>
              <c:numRef>
                <c:f>Sheet1!$P$23:$P$26</c:f>
                <c:numCache>
                  <c:formatCode>General</c:formatCode>
                  <c:ptCount val="4"/>
                  <c:pt idx="0">
                    <c:v>48.237509393933394</c:v>
                  </c:pt>
                  <c:pt idx="1">
                    <c:v>209.21817159828419</c:v>
                  </c:pt>
                  <c:pt idx="2">
                    <c:v>42.210819761452775</c:v>
                  </c:pt>
                  <c:pt idx="3">
                    <c:v>63.509587485735956</c:v>
                  </c:pt>
                </c:numCache>
              </c:numRef>
            </c:minus>
            <c:spPr>
              <a:noFill/>
              <a:ln w="9525" cap="flat" cmpd="sng" algn="ctr">
                <a:solidFill>
                  <a:schemeClr val="tx1">
                    <a:lumMod val="65000"/>
                    <a:lumOff val="35000"/>
                  </a:schemeClr>
                </a:solidFill>
                <a:round/>
              </a:ln>
              <a:effectLst/>
            </c:spPr>
          </c:errBars>
          <c:cat>
            <c:strRef>
              <c:f>Sheet1!$B$18:$B$21</c:f>
              <c:strCache>
                <c:ptCount val="4"/>
                <c:pt idx="0">
                  <c:v>Week 2</c:v>
                </c:pt>
                <c:pt idx="1">
                  <c:v>Week 4</c:v>
                </c:pt>
                <c:pt idx="2">
                  <c:v>Week 6</c:v>
                </c:pt>
                <c:pt idx="3">
                  <c:v>Week 8</c:v>
                </c:pt>
              </c:strCache>
            </c:strRef>
          </c:cat>
          <c:val>
            <c:numRef>
              <c:f>Sheet1!$P$18:$P$21</c:f>
              <c:numCache>
                <c:formatCode>0.00</c:formatCode>
                <c:ptCount val="4"/>
                <c:pt idx="0">
                  <c:v>1889.4849239999999</c:v>
                </c:pt>
                <c:pt idx="1">
                  <c:v>1716.7630007499999</c:v>
                </c:pt>
                <c:pt idx="2">
                  <c:v>1917.1350402500002</c:v>
                </c:pt>
                <c:pt idx="3">
                  <c:v>1876.7880552500001</c:v>
                </c:pt>
              </c:numCache>
            </c:numRef>
          </c:val>
          <c:extLst>
            <c:ext xmlns:c16="http://schemas.microsoft.com/office/drawing/2014/chart" uri="{C3380CC4-5D6E-409C-BE32-E72D297353CC}">
              <c16:uniqueId val="{00000000-A1DE-48B0-A8C2-95B34EAF073B}"/>
            </c:ext>
          </c:extLst>
        </c:ser>
        <c:dLbls>
          <c:showLegendKey val="0"/>
          <c:showVal val="0"/>
          <c:showCatName val="0"/>
          <c:showSerName val="0"/>
          <c:showPercent val="0"/>
          <c:showBubbleSize val="0"/>
        </c:dLbls>
        <c:gapWidth val="219"/>
        <c:overlap val="-27"/>
        <c:axId val="503266624"/>
        <c:axId val="503265840"/>
      </c:barChart>
      <c:catAx>
        <c:axId val="503266624"/>
        <c:scaling>
          <c:orientation val="minMax"/>
        </c:scaling>
        <c:delete val="0"/>
        <c:axPos val="b"/>
        <c:numFmt formatCode="General" sourceLinked="1"/>
        <c:majorTickMark val="none"/>
        <c:minorTickMark val="none"/>
        <c:tickLblPos val="low"/>
        <c:spPr>
          <a:noFill/>
          <a:ln w="9525" cap="flat" cmpd="sng" algn="ctr">
            <a:solidFill>
              <a:sysClr val="windowText" lastClr="000000"/>
            </a:solidFill>
            <a:round/>
          </a:ln>
          <a:effectLst/>
        </c:spPr>
        <c:txPr>
          <a:bodyPr rot="-600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503265840"/>
        <c:crosses val="autoZero"/>
        <c:auto val="1"/>
        <c:lblAlgn val="ctr"/>
        <c:lblOffset val="100"/>
        <c:tickMarkSkip val="7"/>
        <c:noMultiLvlLbl val="0"/>
      </c:catAx>
      <c:valAx>
        <c:axId val="503265840"/>
        <c:scaling>
          <c:orientation val="minMax"/>
          <c:min val="0"/>
        </c:scaling>
        <c:delete val="0"/>
        <c:axPos val="l"/>
        <c:title>
          <c:tx>
            <c:rich>
              <a:bodyPr rot="-54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400" b="0" i="0" u="none" strike="noStrike" baseline="0" dirty="0">
                    <a:effectLst/>
                  </a:rPr>
                  <a:t>Mean Cortical Bone Density (Hounsfield units)</a:t>
                </a:r>
                <a:r>
                  <a:rPr lang="en-US" sz="1400" b="0" i="0" u="none" strike="noStrike" baseline="0" dirty="0"/>
                  <a:t> </a:t>
                </a:r>
                <a:endParaRPr lang="en-US" sz="1400" dirty="0"/>
              </a:p>
            </c:rich>
          </c:tx>
          <c:layout>
            <c:manualLayout>
              <c:xMode val="edge"/>
              <c:yMode val="edge"/>
              <c:x val="1.9035578355494225E-2"/>
              <c:y val="0.11193882457064104"/>
            </c:manualLayout>
          </c:layout>
          <c:overlay val="0"/>
          <c:spPr>
            <a:noFill/>
            <a:ln>
              <a:noFill/>
            </a:ln>
            <a:effectLst/>
          </c:spPr>
          <c:txPr>
            <a:bodyPr rot="-54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0"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503266624"/>
        <c:crosses val="autoZero"/>
        <c:crossBetween val="between"/>
      </c:valAx>
      <c:spPr>
        <a:noFill/>
        <a:ln>
          <a:noFill/>
        </a:ln>
        <a:effectLst/>
      </c:spPr>
    </c:plotArea>
    <c:plotVisOnly val="1"/>
    <c:dispBlanksAs val="gap"/>
    <c:showDLblsOverMax val="0"/>
  </c:chart>
  <c:spPr>
    <a:noFill/>
    <a:ln>
      <a:noFill/>
    </a:ln>
    <a:effectLst/>
  </c:spPr>
  <c:txPr>
    <a:bodyPr/>
    <a:lstStyle/>
    <a:p>
      <a:pPr>
        <a:defRPr sz="1400">
          <a:solidFill>
            <a:sysClr val="windowText" lastClr="000000"/>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3913849556193925"/>
          <c:y val="6.4192689133783065E-2"/>
          <c:w val="0.78883120197682866"/>
          <c:h val="0.72025529941287469"/>
        </c:manualLayout>
      </c:layout>
      <c:barChart>
        <c:barDir val="col"/>
        <c:grouping val="clustered"/>
        <c:varyColors val="0"/>
        <c:ser>
          <c:idx val="2"/>
          <c:order val="0"/>
          <c:tx>
            <c:v>Trauma</c:v>
          </c:tx>
          <c:spPr>
            <a:solidFill>
              <a:schemeClr val="accent3"/>
            </a:solidFill>
            <a:ln>
              <a:noFill/>
            </a:ln>
            <a:effectLst/>
          </c:spPr>
          <c:invertIfNegative val="0"/>
          <c:errBars>
            <c:errBarType val="both"/>
            <c:errValType val="cust"/>
            <c:noEndCap val="0"/>
            <c:plus>
              <c:numRef>
                <c:f>'Weight Bearing Ratio_Hind'!$K$21:$R$21</c:f>
                <c:numCache>
                  <c:formatCode>General</c:formatCode>
                  <c:ptCount val="8"/>
                  <c:pt idx="0">
                    <c:v>0.37607317657904266</c:v>
                  </c:pt>
                  <c:pt idx="1">
                    <c:v>0.19854047264567037</c:v>
                  </c:pt>
                  <c:pt idx="2">
                    <c:v>0.52631497262702553</c:v>
                  </c:pt>
                  <c:pt idx="3">
                    <c:v>0.42386713359553918</c:v>
                  </c:pt>
                  <c:pt idx="4">
                    <c:v>0.18284910934145715</c:v>
                  </c:pt>
                  <c:pt idx="5">
                    <c:v>0.27868251937355482</c:v>
                  </c:pt>
                  <c:pt idx="6">
                    <c:v>0.1818804460081142</c:v>
                  </c:pt>
                  <c:pt idx="7">
                    <c:v>0.30424956178675527</c:v>
                  </c:pt>
                </c:numCache>
              </c:numRef>
            </c:plus>
            <c:minus>
              <c:numRef>
                <c:f>'Weight Bearing Ratio_Hind'!$K$21:$R$21</c:f>
                <c:numCache>
                  <c:formatCode>General</c:formatCode>
                  <c:ptCount val="8"/>
                  <c:pt idx="0">
                    <c:v>0.37607317657904266</c:v>
                  </c:pt>
                  <c:pt idx="1">
                    <c:v>0.19854047264567037</c:v>
                  </c:pt>
                  <c:pt idx="2">
                    <c:v>0.52631497262702553</c:v>
                  </c:pt>
                  <c:pt idx="3">
                    <c:v>0.42386713359553918</c:v>
                  </c:pt>
                  <c:pt idx="4">
                    <c:v>0.18284910934145715</c:v>
                  </c:pt>
                  <c:pt idx="5">
                    <c:v>0.27868251937355482</c:v>
                  </c:pt>
                  <c:pt idx="6">
                    <c:v>0.1818804460081142</c:v>
                  </c:pt>
                  <c:pt idx="7">
                    <c:v>0.30424956178675527</c:v>
                  </c:pt>
                </c:numCache>
              </c:numRef>
            </c:minus>
            <c:spPr>
              <a:noFill/>
              <a:ln w="9525" cap="flat" cmpd="sng" algn="ctr">
                <a:solidFill>
                  <a:sysClr val="windowText" lastClr="000000"/>
                </a:solidFill>
                <a:round/>
              </a:ln>
              <a:effectLst/>
            </c:spPr>
          </c:errBars>
          <c:cat>
            <c:numRef>
              <c:f>'Weight Bearing Ratio_Hind'!$B$2:$I$2</c:f>
              <c:numCache>
                <c:formatCode>General</c:formatCode>
                <c:ptCount val="8"/>
                <c:pt idx="0">
                  <c:v>-4</c:v>
                </c:pt>
                <c:pt idx="1">
                  <c:v>1</c:v>
                </c:pt>
                <c:pt idx="2">
                  <c:v>3</c:v>
                </c:pt>
                <c:pt idx="3">
                  <c:v>7</c:v>
                </c:pt>
                <c:pt idx="4">
                  <c:v>14</c:v>
                </c:pt>
                <c:pt idx="5">
                  <c:v>28</c:v>
                </c:pt>
                <c:pt idx="6">
                  <c:v>42</c:v>
                </c:pt>
                <c:pt idx="7">
                  <c:v>56</c:v>
                </c:pt>
              </c:numCache>
            </c:numRef>
          </c:cat>
          <c:val>
            <c:numRef>
              <c:f>'Weight Bearing Ratio_Hind'!$K$20:$R$20</c:f>
              <c:numCache>
                <c:formatCode>0.000</c:formatCode>
                <c:ptCount val="8"/>
                <c:pt idx="0">
                  <c:v>0.98266731906504357</c:v>
                </c:pt>
                <c:pt idx="1">
                  <c:v>0.41142572833672836</c:v>
                </c:pt>
                <c:pt idx="2">
                  <c:v>0.5780998021118543</c:v>
                </c:pt>
                <c:pt idx="3">
                  <c:v>0.59372566389180548</c:v>
                </c:pt>
                <c:pt idx="4">
                  <c:v>0.40381125120108385</c:v>
                </c:pt>
                <c:pt idx="5">
                  <c:v>0.64508786709762622</c:v>
                </c:pt>
                <c:pt idx="6">
                  <c:v>0.80108837916060338</c:v>
                </c:pt>
                <c:pt idx="7">
                  <c:v>0.68252492868952852</c:v>
                </c:pt>
              </c:numCache>
            </c:numRef>
          </c:val>
          <c:extLst>
            <c:ext xmlns:c16="http://schemas.microsoft.com/office/drawing/2014/chart" uri="{C3380CC4-5D6E-409C-BE32-E72D297353CC}">
              <c16:uniqueId val="{00000000-1562-45FC-B201-F79BDD14EDF9}"/>
            </c:ext>
          </c:extLst>
        </c:ser>
        <c:dLbls>
          <c:showLegendKey val="0"/>
          <c:showVal val="0"/>
          <c:showCatName val="0"/>
          <c:showSerName val="0"/>
          <c:showPercent val="0"/>
          <c:showBubbleSize val="0"/>
        </c:dLbls>
        <c:gapWidth val="219"/>
        <c:overlap val="-27"/>
        <c:axId val="599261296"/>
        <c:axId val="480339936"/>
      </c:barChart>
      <c:catAx>
        <c:axId val="599261296"/>
        <c:scaling>
          <c:orientation val="minMax"/>
        </c:scaling>
        <c:delete val="0"/>
        <c:axPos val="b"/>
        <c:title>
          <c:tx>
            <c:rich>
              <a:bodyPr rot="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a:t>Day Relative to Operation</a:t>
                </a:r>
              </a:p>
            </c:rich>
          </c:tx>
          <c:layout>
            <c:manualLayout>
              <c:xMode val="edge"/>
              <c:yMode val="edge"/>
              <c:x val="0.40042053283441881"/>
              <c:y val="0.86870957029846496"/>
            </c:manualLayout>
          </c:layout>
          <c:overlay val="0"/>
          <c:spPr>
            <a:noFill/>
            <a:ln>
              <a:noFill/>
            </a:ln>
            <a:effectLst/>
          </c:spPr>
          <c:txPr>
            <a:bodyPr rot="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low"/>
        <c:spPr>
          <a:noFill/>
          <a:ln w="9525" cap="flat" cmpd="sng" algn="ctr">
            <a:solidFill>
              <a:sysClr val="windowText" lastClr="000000"/>
            </a:solidFill>
            <a:round/>
          </a:ln>
          <a:effectLst/>
        </c:spPr>
        <c:txPr>
          <a:bodyPr rot="-600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480339936"/>
        <c:crosses val="autoZero"/>
        <c:auto val="1"/>
        <c:lblAlgn val="ctr"/>
        <c:lblOffset val="100"/>
        <c:tickMarkSkip val="7"/>
        <c:noMultiLvlLbl val="0"/>
      </c:catAx>
      <c:valAx>
        <c:axId val="480339936"/>
        <c:scaling>
          <c:orientation val="minMax"/>
          <c:max val="2"/>
          <c:min val="0"/>
        </c:scaling>
        <c:delete val="0"/>
        <c:axPos val="l"/>
        <c:title>
          <c:tx>
            <c:rich>
              <a:bodyPr rot="-54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400" b="0" i="0" baseline="0">
                    <a:effectLst/>
                  </a:rPr>
                  <a:t>Hindlimb Surgical/Non-Surgical Weight Bearing Ratio</a:t>
                </a:r>
                <a:endParaRPr lang="en-US" sz="1400">
                  <a:effectLst/>
                </a:endParaRPr>
              </a:p>
            </c:rich>
          </c:tx>
          <c:layout>
            <c:manualLayout>
              <c:xMode val="edge"/>
              <c:yMode val="edge"/>
              <c:x val="2.0174949984379988E-3"/>
              <c:y val="5.0136282760355914E-2"/>
            </c:manualLayout>
          </c:layout>
          <c:overlay val="0"/>
          <c:spPr>
            <a:noFill/>
            <a:ln>
              <a:noFill/>
            </a:ln>
            <a:effectLst/>
          </c:spPr>
          <c:txPr>
            <a:bodyPr rot="-54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0.0"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4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599261296"/>
        <c:crosses val="autoZero"/>
        <c:crossBetween val="between"/>
      </c:valAx>
      <c:spPr>
        <a:noFill/>
        <a:ln>
          <a:noFill/>
        </a:ln>
        <a:effectLst/>
      </c:spPr>
    </c:plotArea>
    <c:plotVisOnly val="1"/>
    <c:dispBlanksAs val="gap"/>
    <c:showDLblsOverMax val="0"/>
  </c:chart>
  <c:spPr>
    <a:noFill/>
    <a:ln>
      <a:noFill/>
    </a:ln>
    <a:effectLst/>
  </c:spPr>
  <c:txPr>
    <a:bodyPr/>
    <a:lstStyle/>
    <a:p>
      <a:pPr>
        <a:defRPr sz="1400">
          <a:solidFill>
            <a:sysClr val="windowText" lastClr="000000"/>
          </a:solidFill>
          <a:latin typeface="Arial" panose="020B0604020202020204" pitchFamily="34" charset="0"/>
          <a:cs typeface="Arial" panose="020B0604020202020204" pitchFamily="34" charset="0"/>
        </a:defRPr>
      </a:pPr>
      <a:endParaRPr lang="en-US"/>
    </a:p>
  </c:txPr>
  <c:externalData r:id="rId4">
    <c:autoUpdate val="0"/>
  </c:externalData>
  <c:userShapes r:id="rId5"/>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omments/comment1.xml><?xml version="1.0" encoding="utf-8"?>
<p:cmLst xmlns:a="http://schemas.openxmlformats.org/drawingml/2006/main" xmlns:r="http://schemas.openxmlformats.org/officeDocument/2006/relationships" xmlns:p="http://schemas.openxmlformats.org/presentationml/2006/main">
  <p:cm authorId="1" dt="2020-10-22T13:35:13.823" idx="2">
    <p:pos x="10" y="10"/>
    <p:text>Please put all animals in one data group. Trauma 1 and 2 do not mean anything to the reader.</p:text>
    <p:extLst>
      <p:ext uri="{C676402C-5697-4E1C-873F-D02D1690AC5C}">
        <p15:threadingInfo xmlns:p15="http://schemas.microsoft.com/office/powerpoint/2012/main" timeZoneBias="240"/>
      </p:ext>
    </p:extLst>
  </p:cm>
</p:cmLst>
</file>

<file path=ppt/drawings/drawing1.xml><?xml version="1.0" encoding="utf-8"?>
<c:userShapes xmlns:c="http://schemas.openxmlformats.org/drawingml/2006/chart">
  <cdr:relSizeAnchor xmlns:cdr="http://schemas.openxmlformats.org/drawingml/2006/chartDrawing">
    <cdr:from>
      <cdr:x>0.14496</cdr:x>
      <cdr:y>0.2339</cdr:y>
    </cdr:from>
    <cdr:to>
      <cdr:x>0.4775</cdr:x>
      <cdr:y>0.27422</cdr:y>
    </cdr:to>
    <cdr:sp macro="" textlink="">
      <cdr:nvSpPr>
        <cdr:cNvPr id="6" name="TextBox 1">
          <a:extLst xmlns:a="http://schemas.openxmlformats.org/drawingml/2006/main">
            <a:ext uri="{FF2B5EF4-FFF2-40B4-BE49-F238E27FC236}">
              <a16:creationId xmlns:a16="http://schemas.microsoft.com/office/drawing/2014/main" id="{59F6C578-476E-4C66-B762-AA5531E4FE43}"/>
            </a:ext>
          </a:extLst>
        </cdr:cNvPr>
        <cdr:cNvSpPr txBox="1"/>
      </cdr:nvSpPr>
      <cdr:spPr>
        <a:xfrm xmlns:a="http://schemas.openxmlformats.org/drawingml/2006/main">
          <a:off x="1131137" y="1266362"/>
          <a:ext cx="2594782" cy="218296"/>
        </a:xfrm>
        <a:prstGeom xmlns:a="http://schemas.openxmlformats.org/drawingml/2006/main" prst="rect">
          <a:avLst/>
        </a:prstGeom>
        <a:noFill xmlns:a="http://schemas.openxmlformats.org/drawingml/2006/main"/>
        <a:ln xmlns:a="http://schemas.openxmlformats.org/drawingml/2006/main" w="9525" cmpd="sng">
          <a:noFill/>
        </a:ln>
      </cdr:spPr>
      <cdr:style>
        <a:lnRef xmlns:a="http://schemas.openxmlformats.org/drawingml/2006/main" idx="0">
          <a:scrgbClr r="0" g="0" b="0"/>
        </a:lnRef>
        <a:fillRef xmlns:a="http://schemas.openxmlformats.org/drawingml/2006/main" idx="0">
          <a:scrgbClr r="0" g="0" b="0"/>
        </a:fillRef>
        <a:effectRef xmlns:a="http://schemas.openxmlformats.org/drawingml/2006/main" idx="0">
          <a:scrgbClr r="0" g="0" b="0"/>
        </a:effectRef>
        <a:fontRef xmlns:a="http://schemas.openxmlformats.org/drawingml/2006/main" idx="minor">
          <a:schemeClr val="dk1"/>
        </a:fontRef>
      </cdr:style>
      <cdr:txBody>
        <a:bodyPr xmlns:a="http://schemas.openxmlformats.org/drawingml/2006/main" wrap="square" rtlCol="0" anchor="t"/>
        <a:lstStyle xmlns:a="http://schemas.openxmlformats.org/drawingml/2006/main">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xmlns:a="http://schemas.openxmlformats.org/drawingml/2006/main">
          <a:r>
            <a:rPr lang="en-US" sz="1800" b="1" dirty="0">
              <a:solidFill>
                <a:srgbClr val="92D050"/>
              </a:solidFill>
            </a:rPr>
            <a:t>*  </a:t>
          </a:r>
          <a:endParaRPr lang="en-US" sz="1200" b="0" dirty="0">
            <a:solidFill>
              <a:sysClr val="windowText" lastClr="000000"/>
            </a:solidFill>
            <a:latin typeface="Arial" panose="020B0604020202020204" pitchFamily="34" charset="0"/>
            <a:cs typeface="Arial" panose="020B0604020202020204" pitchFamily="34" charset="0"/>
          </a:endParaRPr>
        </a:p>
      </cdr:txBody>
    </cdr:sp>
  </cdr:relSizeAnchor>
  <cdr:relSizeAnchor xmlns:cdr="http://schemas.openxmlformats.org/drawingml/2006/chartDrawing">
    <cdr:from>
      <cdr:x>0.17097</cdr:x>
      <cdr:y>0.2339</cdr:y>
    </cdr:from>
    <cdr:to>
      <cdr:x>0.41441</cdr:x>
      <cdr:y>0.29842</cdr:y>
    </cdr:to>
    <cdr:sp macro="" textlink="">
      <cdr:nvSpPr>
        <cdr:cNvPr id="7" name="TextBox 6">
          <a:extLst xmlns:a="http://schemas.openxmlformats.org/drawingml/2006/main">
            <a:ext uri="{FF2B5EF4-FFF2-40B4-BE49-F238E27FC236}">
              <a16:creationId xmlns:a16="http://schemas.microsoft.com/office/drawing/2014/main" id="{E6D9DA8D-61CA-4FB3-8A00-BD220FB2F7BC}"/>
            </a:ext>
          </a:extLst>
        </cdr:cNvPr>
        <cdr:cNvSpPr txBox="1"/>
      </cdr:nvSpPr>
      <cdr:spPr>
        <a:xfrm xmlns:a="http://schemas.openxmlformats.org/drawingml/2006/main">
          <a:off x="1334093" y="1266362"/>
          <a:ext cx="1899542" cy="349317"/>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r>
            <a:rPr lang="en-US" sz="1200" b="0" dirty="0">
              <a:effectLst/>
              <a:latin typeface="Arial" panose="020B0604020202020204" pitchFamily="34" charset="0"/>
              <a:ea typeface="+mn-ea"/>
              <a:cs typeface="Arial" panose="020B0604020202020204" pitchFamily="34" charset="0"/>
            </a:rPr>
            <a:t>Diet</a:t>
          </a:r>
          <a:r>
            <a:rPr lang="en-US" sz="1200" b="0" baseline="0" dirty="0">
              <a:effectLst/>
              <a:latin typeface="Arial" panose="020B0604020202020204" pitchFamily="34" charset="0"/>
              <a:ea typeface="+mn-ea"/>
              <a:cs typeface="Arial" panose="020B0604020202020204" pitchFamily="34" charset="0"/>
            </a:rPr>
            <a:t> Supplementation</a:t>
          </a:r>
          <a:endParaRPr lang="en-US" sz="1200" dirty="0">
            <a:latin typeface="Arial" panose="020B0604020202020204" pitchFamily="34" charset="0"/>
            <a:cs typeface="Arial" panose="020B0604020202020204" pitchFamily="34" charset="0"/>
          </a:endParaRPr>
        </a:p>
      </cdr:txBody>
    </cdr:sp>
  </cdr:relSizeAnchor>
</c:userShapes>
</file>

<file path=ppt/drawings/drawing2.xml><?xml version="1.0" encoding="utf-8"?>
<c:userShapes xmlns:c="http://schemas.openxmlformats.org/drawingml/2006/chart">
  <cdr:relSizeAnchor xmlns:cdr="http://schemas.openxmlformats.org/drawingml/2006/chartDrawing">
    <cdr:from>
      <cdr:x>0.13662</cdr:x>
      <cdr:y>0.28026</cdr:y>
    </cdr:from>
    <cdr:to>
      <cdr:x>0.92727</cdr:x>
      <cdr:y>0.57007</cdr:y>
    </cdr:to>
    <cdr:sp macro="" textlink="">
      <cdr:nvSpPr>
        <cdr:cNvPr id="2" name="Rectangle 1">
          <a:extLst xmlns:a="http://schemas.openxmlformats.org/drawingml/2006/main">
            <a:ext uri="{FF2B5EF4-FFF2-40B4-BE49-F238E27FC236}">
              <a16:creationId xmlns:a16="http://schemas.microsoft.com/office/drawing/2014/main" id="{5C29AD6D-4959-4F4D-9FF1-056306098F84}"/>
            </a:ext>
          </a:extLst>
        </cdr:cNvPr>
        <cdr:cNvSpPr/>
      </cdr:nvSpPr>
      <cdr:spPr>
        <a:xfrm xmlns:a="http://schemas.openxmlformats.org/drawingml/2006/main">
          <a:off x="923925" y="1400141"/>
          <a:ext cx="5346971" cy="1447834"/>
        </a:xfrm>
        <a:prstGeom xmlns:a="http://schemas.openxmlformats.org/drawingml/2006/main" prst="rect">
          <a:avLst/>
        </a:prstGeom>
        <a:solidFill xmlns:a="http://schemas.openxmlformats.org/drawingml/2006/main">
          <a:schemeClr val="accent1">
            <a:alpha val="40000"/>
          </a:schemeClr>
        </a:solidFill>
        <a:ln xmlns:a="http://schemas.openxmlformats.org/drawingml/2006/main">
          <a:solidFill>
            <a:schemeClr val="accent1">
              <a:shade val="50000"/>
              <a:alpha val="35000"/>
            </a:schemeClr>
          </a:solidFill>
        </a:ln>
      </cdr:spPr>
      <cdr:style>
        <a:lnRef xmlns:a="http://schemas.openxmlformats.org/drawingml/2006/main" idx="2">
          <a:schemeClr val="accent1">
            <a:shade val="50000"/>
          </a:schemeClr>
        </a:lnRef>
        <a:fillRef xmlns:a="http://schemas.openxmlformats.org/drawingml/2006/main" idx="1">
          <a:schemeClr val="accent1"/>
        </a:fillRef>
        <a:effectRef xmlns:a="http://schemas.openxmlformats.org/drawingml/2006/main" idx="0">
          <a:schemeClr val="accent1"/>
        </a:effectRef>
        <a:fontRef xmlns:a="http://schemas.openxmlformats.org/drawingml/2006/main" idx="minor">
          <a:schemeClr val="lt1"/>
        </a:fontRef>
      </cdr:style>
      <cdr:txBody>
        <a:bodyPr xmlns:a="http://schemas.openxmlformats.org/drawingml/2006/main" vertOverflow="clip"/>
        <a:lstStyle xmlns:a="http://schemas.openxmlformats.org/drawingml/2006/main"/>
        <a:p xmlns:a="http://schemas.openxmlformats.org/drawingml/2006/main">
          <a:endParaRPr lang="en-US"/>
        </a:p>
      </cdr:txBody>
    </cdr:sp>
  </cdr:relSizeAnchor>
  <cdr:relSizeAnchor xmlns:cdr="http://schemas.openxmlformats.org/drawingml/2006/chartDrawing">
    <cdr:from>
      <cdr:x>0.27056</cdr:x>
      <cdr:y>0.4652</cdr:y>
    </cdr:from>
    <cdr:to>
      <cdr:x>0.30504</cdr:x>
      <cdr:y>0.52431</cdr:y>
    </cdr:to>
    <cdr:sp macro="" textlink="">
      <cdr:nvSpPr>
        <cdr:cNvPr id="3" name="TextBox 2">
          <a:extLst xmlns:a="http://schemas.openxmlformats.org/drawingml/2006/main">
            <a:ext uri="{FF2B5EF4-FFF2-40B4-BE49-F238E27FC236}">
              <a16:creationId xmlns:a16="http://schemas.microsoft.com/office/drawing/2014/main" id="{CD51B50D-9DE0-477A-83AB-87D79076FC5D}"/>
            </a:ext>
          </a:extLst>
        </cdr:cNvPr>
        <cdr:cNvSpPr txBox="1"/>
      </cdr:nvSpPr>
      <cdr:spPr>
        <a:xfrm xmlns:a="http://schemas.openxmlformats.org/drawingml/2006/main">
          <a:off x="1943100" y="2324100"/>
          <a:ext cx="247650" cy="295275"/>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r>
            <a:rPr lang="en-US" sz="1100"/>
            <a:t>*</a:t>
          </a:r>
        </a:p>
      </cdr:txBody>
    </cdr:sp>
  </cdr:relSizeAnchor>
  <cdr:relSizeAnchor xmlns:cdr="http://schemas.openxmlformats.org/drawingml/2006/chartDrawing">
    <cdr:from>
      <cdr:x>0.36649</cdr:x>
      <cdr:y>0.30187</cdr:y>
    </cdr:from>
    <cdr:to>
      <cdr:x>0.40097</cdr:x>
      <cdr:y>0.36098</cdr:y>
    </cdr:to>
    <cdr:sp macro="" textlink="">
      <cdr:nvSpPr>
        <cdr:cNvPr id="4" name="TextBox 1">
          <a:extLst xmlns:a="http://schemas.openxmlformats.org/drawingml/2006/main">
            <a:ext uri="{FF2B5EF4-FFF2-40B4-BE49-F238E27FC236}">
              <a16:creationId xmlns:a16="http://schemas.microsoft.com/office/drawing/2014/main" id="{A9D3B8C5-804F-4774-B84A-4427D73E17EC}"/>
            </a:ext>
          </a:extLst>
        </cdr:cNvPr>
        <cdr:cNvSpPr txBox="1"/>
      </cdr:nvSpPr>
      <cdr:spPr>
        <a:xfrm xmlns:a="http://schemas.openxmlformats.org/drawingml/2006/main">
          <a:off x="2632075" y="1508125"/>
          <a:ext cx="247650" cy="295275"/>
        </a:xfrm>
        <a:prstGeom xmlns:a="http://schemas.openxmlformats.org/drawingml/2006/main" prst="rect">
          <a:avLst/>
        </a:prstGeom>
      </cdr:spPr>
      <cdr:txBody>
        <a:bodyPr xmlns:a="http://schemas.openxmlformats.org/drawingml/2006/main" wrap="non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sz="1100"/>
            <a:t>*</a:t>
          </a:r>
        </a:p>
      </cdr:txBody>
    </cdr:sp>
  </cdr:relSizeAnchor>
  <cdr:relSizeAnchor xmlns:cdr="http://schemas.openxmlformats.org/drawingml/2006/chartDrawing">
    <cdr:from>
      <cdr:x>0.46596</cdr:x>
      <cdr:y>0.29806</cdr:y>
    </cdr:from>
    <cdr:to>
      <cdr:x>0.50044</cdr:x>
      <cdr:y>0.35717</cdr:y>
    </cdr:to>
    <cdr:sp macro="" textlink="">
      <cdr:nvSpPr>
        <cdr:cNvPr id="5" name="TextBox 1">
          <a:extLst xmlns:a="http://schemas.openxmlformats.org/drawingml/2006/main">
            <a:ext uri="{FF2B5EF4-FFF2-40B4-BE49-F238E27FC236}">
              <a16:creationId xmlns:a16="http://schemas.microsoft.com/office/drawing/2014/main" id="{A9D3B8C5-804F-4774-B84A-4427D73E17EC}"/>
            </a:ext>
          </a:extLst>
        </cdr:cNvPr>
        <cdr:cNvSpPr txBox="1"/>
      </cdr:nvSpPr>
      <cdr:spPr>
        <a:xfrm xmlns:a="http://schemas.openxmlformats.org/drawingml/2006/main">
          <a:off x="3346450" y="1489075"/>
          <a:ext cx="247650" cy="295275"/>
        </a:xfrm>
        <a:prstGeom xmlns:a="http://schemas.openxmlformats.org/drawingml/2006/main" prst="rect">
          <a:avLst/>
        </a:prstGeom>
      </cdr:spPr>
      <cdr:txBody>
        <a:bodyPr xmlns:a="http://schemas.openxmlformats.org/drawingml/2006/main" wrap="non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sz="1100"/>
            <a:t>*</a:t>
          </a:r>
        </a:p>
      </cdr:txBody>
    </cdr:sp>
  </cdr:relSizeAnchor>
  <cdr:relSizeAnchor xmlns:cdr="http://schemas.openxmlformats.org/drawingml/2006/chartDrawing">
    <cdr:from>
      <cdr:x>0.5641</cdr:x>
      <cdr:y>0.46584</cdr:y>
    </cdr:from>
    <cdr:to>
      <cdr:x>0.59859</cdr:x>
      <cdr:y>0.52494</cdr:y>
    </cdr:to>
    <cdr:sp macro="" textlink="">
      <cdr:nvSpPr>
        <cdr:cNvPr id="6" name="TextBox 1">
          <a:extLst xmlns:a="http://schemas.openxmlformats.org/drawingml/2006/main">
            <a:ext uri="{FF2B5EF4-FFF2-40B4-BE49-F238E27FC236}">
              <a16:creationId xmlns:a16="http://schemas.microsoft.com/office/drawing/2014/main" id="{A9D3B8C5-804F-4774-B84A-4427D73E17EC}"/>
            </a:ext>
          </a:extLst>
        </cdr:cNvPr>
        <cdr:cNvSpPr txBox="1"/>
      </cdr:nvSpPr>
      <cdr:spPr>
        <a:xfrm xmlns:a="http://schemas.openxmlformats.org/drawingml/2006/main">
          <a:off x="4051300" y="2327275"/>
          <a:ext cx="247650" cy="295275"/>
        </a:xfrm>
        <a:prstGeom xmlns:a="http://schemas.openxmlformats.org/drawingml/2006/main" prst="rect">
          <a:avLst/>
        </a:prstGeom>
      </cdr:spPr>
      <cdr:txBody>
        <a:bodyPr xmlns:a="http://schemas.openxmlformats.org/drawingml/2006/main" wrap="non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sz="1100"/>
            <a:t>*</a:t>
          </a:r>
        </a:p>
      </cdr:txBody>
    </cdr:sp>
  </cdr:relSizeAnchor>
  <cdr:relSizeAnchor xmlns:cdr="http://schemas.openxmlformats.org/drawingml/2006/chartDrawing">
    <cdr:from>
      <cdr:x>0.66092</cdr:x>
      <cdr:y>0.29425</cdr:y>
    </cdr:from>
    <cdr:to>
      <cdr:x>0.6954</cdr:x>
      <cdr:y>0.35335</cdr:y>
    </cdr:to>
    <cdr:sp macro="" textlink="">
      <cdr:nvSpPr>
        <cdr:cNvPr id="7" name="TextBox 1">
          <a:extLst xmlns:a="http://schemas.openxmlformats.org/drawingml/2006/main">
            <a:ext uri="{FF2B5EF4-FFF2-40B4-BE49-F238E27FC236}">
              <a16:creationId xmlns:a16="http://schemas.microsoft.com/office/drawing/2014/main" id="{A9D3B8C5-804F-4774-B84A-4427D73E17EC}"/>
            </a:ext>
          </a:extLst>
        </cdr:cNvPr>
        <cdr:cNvSpPr txBox="1"/>
      </cdr:nvSpPr>
      <cdr:spPr>
        <a:xfrm xmlns:a="http://schemas.openxmlformats.org/drawingml/2006/main">
          <a:off x="4746625" y="1470025"/>
          <a:ext cx="247650" cy="295275"/>
        </a:xfrm>
        <a:prstGeom xmlns:a="http://schemas.openxmlformats.org/drawingml/2006/main" prst="rect">
          <a:avLst/>
        </a:prstGeom>
      </cdr:spPr>
      <cdr:txBody>
        <a:bodyPr xmlns:a="http://schemas.openxmlformats.org/drawingml/2006/main" wrap="non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sz="1100"/>
            <a:t>*</a:t>
          </a:r>
        </a:p>
      </cdr:txBody>
    </cdr: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1F87BE0-0C16-4449-8019-893676F37711}" type="datetimeFigureOut">
              <a:rPr lang="en-US" smtClean="0"/>
              <a:t>8/23/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6AD2A94-E567-4398-9787-08636BE6B706}" type="slidenum">
              <a:rPr lang="en-US" smtClean="0"/>
              <a:t>‹#›</a:t>
            </a:fld>
            <a:endParaRPr lang="en-US"/>
          </a:p>
        </p:txBody>
      </p:sp>
    </p:spTree>
    <p:extLst>
      <p:ext uri="{BB962C8B-B14F-4D97-AF65-F5344CB8AC3E}">
        <p14:creationId xmlns:p14="http://schemas.microsoft.com/office/powerpoint/2010/main" val="348240304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42CEEE2A-344E-4133-AB93-250A8B880318}" type="slidenum">
              <a:rPr lang="en-US" smtClean="0"/>
              <a:t>1</a:t>
            </a:fld>
            <a:endParaRPr lang="en-US"/>
          </a:p>
        </p:txBody>
      </p:sp>
    </p:spTree>
    <p:extLst>
      <p:ext uri="{BB962C8B-B14F-4D97-AF65-F5344CB8AC3E}">
        <p14:creationId xmlns:p14="http://schemas.microsoft.com/office/powerpoint/2010/main" val="223189908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Total tissue volume is the total volume of the sample at the region of interest length of 4.89 mm centered on the fracture.  The total bone volume was found by using a threshold of 3 standard deviation above the mean of the soft tissue of the sample within the 4.89 mm region of interest.  We chose 4.89 mm because that was the smallest sample distance between the inserted screws.  Cortex was similarly found using a threshold of 3 standard deviations below the mean of a cortex sample within the 4.89 mm region of interest. Total tissue volume is soft tissue and bone tissue which includes the callus.</a:t>
            </a:r>
            <a:endParaRPr lang="en-US" dirty="0"/>
          </a:p>
        </p:txBody>
      </p:sp>
      <p:sp>
        <p:nvSpPr>
          <p:cNvPr id="4" name="Slide Number Placeholder 3"/>
          <p:cNvSpPr>
            <a:spLocks noGrp="1"/>
          </p:cNvSpPr>
          <p:nvPr>
            <p:ph type="sldNum" sz="quarter" idx="5"/>
          </p:nvPr>
        </p:nvSpPr>
        <p:spPr/>
        <p:txBody>
          <a:bodyPr/>
          <a:lstStyle/>
          <a:p>
            <a:fld id="{6DF55424-320B-4FA3-8D4F-27F3136EA79B}" type="slidenum">
              <a:rPr lang="en-US" smtClean="0"/>
              <a:t>4</a:t>
            </a:fld>
            <a:endParaRPr lang="en-US"/>
          </a:p>
        </p:txBody>
      </p:sp>
    </p:spTree>
    <p:extLst>
      <p:ext uri="{BB962C8B-B14F-4D97-AF65-F5344CB8AC3E}">
        <p14:creationId xmlns:p14="http://schemas.microsoft.com/office/powerpoint/2010/main" val="94303073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Total tissue volume is the total volume of the sample at the region of interest length of 4.89 mm centered on the fracture.  The total bone volume was found by using a threshold of 3 standard deviation above the mean of the soft tissue of the sample within the 4.89 mm region of interest.  We chose 4.89 mm because that was the smallest sample distance between the inserted screws.  Cortex was similarly found using a threshold of 3 standard deviations below the mean of a cortex sample within the 4.89 mm region of interest. </a:t>
            </a:r>
            <a:endParaRPr lang="en-US" dirty="0"/>
          </a:p>
          <a:p>
            <a:endParaRPr lang="en-US" dirty="0"/>
          </a:p>
        </p:txBody>
      </p:sp>
      <p:sp>
        <p:nvSpPr>
          <p:cNvPr id="4" name="Slide Number Placeholder 3"/>
          <p:cNvSpPr>
            <a:spLocks noGrp="1"/>
          </p:cNvSpPr>
          <p:nvPr>
            <p:ph type="sldNum" sz="quarter" idx="5"/>
          </p:nvPr>
        </p:nvSpPr>
        <p:spPr/>
        <p:txBody>
          <a:bodyPr/>
          <a:lstStyle/>
          <a:p>
            <a:fld id="{6DF55424-320B-4FA3-8D4F-27F3136EA79B}" type="slidenum">
              <a:rPr lang="en-US" smtClean="0"/>
              <a:t>5</a:t>
            </a:fld>
            <a:endParaRPr lang="en-US"/>
          </a:p>
        </p:txBody>
      </p:sp>
    </p:spTree>
    <p:extLst>
      <p:ext uri="{BB962C8B-B14F-4D97-AF65-F5344CB8AC3E}">
        <p14:creationId xmlns:p14="http://schemas.microsoft.com/office/powerpoint/2010/main" val="289356159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DF2CD9-C4B7-47AA-A76D-819663B6280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4D70470-173E-411A-B5AC-475D7C3925D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A7AEE81C-0A16-4660-B2EC-0ACB8E8AB683}"/>
              </a:ext>
            </a:extLst>
          </p:cNvPr>
          <p:cNvSpPr>
            <a:spLocks noGrp="1"/>
          </p:cNvSpPr>
          <p:nvPr>
            <p:ph type="dt" sz="half" idx="10"/>
          </p:nvPr>
        </p:nvSpPr>
        <p:spPr/>
        <p:txBody>
          <a:bodyPr/>
          <a:lstStyle/>
          <a:p>
            <a:fld id="{D53D62F8-510A-461B-A98A-EA3FDADF92F4}" type="datetimeFigureOut">
              <a:rPr lang="en-US" smtClean="0"/>
              <a:t>8/23/2023</a:t>
            </a:fld>
            <a:endParaRPr lang="en-US"/>
          </a:p>
        </p:txBody>
      </p:sp>
      <p:sp>
        <p:nvSpPr>
          <p:cNvPr id="5" name="Footer Placeholder 4">
            <a:extLst>
              <a:ext uri="{FF2B5EF4-FFF2-40B4-BE49-F238E27FC236}">
                <a16:creationId xmlns:a16="http://schemas.microsoft.com/office/drawing/2014/main" id="{12D53FA2-6866-4735-AFD2-A2EF3ED175C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F34E2F4-507E-4B41-B947-628FDE2F8F96}"/>
              </a:ext>
            </a:extLst>
          </p:cNvPr>
          <p:cNvSpPr>
            <a:spLocks noGrp="1"/>
          </p:cNvSpPr>
          <p:nvPr>
            <p:ph type="sldNum" sz="quarter" idx="12"/>
          </p:nvPr>
        </p:nvSpPr>
        <p:spPr/>
        <p:txBody>
          <a:bodyPr/>
          <a:lstStyle/>
          <a:p>
            <a:fld id="{A73B7274-0A28-48EB-8DF1-D5CC5988BD3B}" type="slidenum">
              <a:rPr lang="en-US" smtClean="0"/>
              <a:t>‹#›</a:t>
            </a:fld>
            <a:endParaRPr lang="en-US"/>
          </a:p>
        </p:txBody>
      </p:sp>
    </p:spTree>
    <p:extLst>
      <p:ext uri="{BB962C8B-B14F-4D97-AF65-F5344CB8AC3E}">
        <p14:creationId xmlns:p14="http://schemas.microsoft.com/office/powerpoint/2010/main" val="4314990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FB1737-15EB-4046-A43A-7927010FB29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EEFFF3C-5298-4CBC-89C8-A11CC769BB9D}"/>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CFFA45B-D80A-40C7-BCFA-48C52345A8B7}"/>
              </a:ext>
            </a:extLst>
          </p:cNvPr>
          <p:cNvSpPr>
            <a:spLocks noGrp="1"/>
          </p:cNvSpPr>
          <p:nvPr>
            <p:ph type="dt" sz="half" idx="10"/>
          </p:nvPr>
        </p:nvSpPr>
        <p:spPr/>
        <p:txBody>
          <a:bodyPr/>
          <a:lstStyle/>
          <a:p>
            <a:fld id="{D53D62F8-510A-461B-A98A-EA3FDADF92F4}" type="datetimeFigureOut">
              <a:rPr lang="en-US" smtClean="0"/>
              <a:t>8/23/2023</a:t>
            </a:fld>
            <a:endParaRPr lang="en-US"/>
          </a:p>
        </p:txBody>
      </p:sp>
      <p:sp>
        <p:nvSpPr>
          <p:cNvPr id="5" name="Footer Placeholder 4">
            <a:extLst>
              <a:ext uri="{FF2B5EF4-FFF2-40B4-BE49-F238E27FC236}">
                <a16:creationId xmlns:a16="http://schemas.microsoft.com/office/drawing/2014/main" id="{CA3100B0-B70F-4B55-828A-97B91C07DC7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91AD282-06B7-41B6-B52E-B5860491652A}"/>
              </a:ext>
            </a:extLst>
          </p:cNvPr>
          <p:cNvSpPr>
            <a:spLocks noGrp="1"/>
          </p:cNvSpPr>
          <p:nvPr>
            <p:ph type="sldNum" sz="quarter" idx="12"/>
          </p:nvPr>
        </p:nvSpPr>
        <p:spPr/>
        <p:txBody>
          <a:bodyPr/>
          <a:lstStyle/>
          <a:p>
            <a:fld id="{A73B7274-0A28-48EB-8DF1-D5CC5988BD3B}" type="slidenum">
              <a:rPr lang="en-US" smtClean="0"/>
              <a:t>‹#›</a:t>
            </a:fld>
            <a:endParaRPr lang="en-US"/>
          </a:p>
        </p:txBody>
      </p:sp>
    </p:spTree>
    <p:extLst>
      <p:ext uri="{BB962C8B-B14F-4D97-AF65-F5344CB8AC3E}">
        <p14:creationId xmlns:p14="http://schemas.microsoft.com/office/powerpoint/2010/main" val="30030007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E51F2AA-75A4-4A44-AB4E-DBCDFAF854A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4D84FC9-74D0-42FE-B80E-3DE12A0BD89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A1636CE-A082-41E0-ACD8-B0C3A82490B2}"/>
              </a:ext>
            </a:extLst>
          </p:cNvPr>
          <p:cNvSpPr>
            <a:spLocks noGrp="1"/>
          </p:cNvSpPr>
          <p:nvPr>
            <p:ph type="dt" sz="half" idx="10"/>
          </p:nvPr>
        </p:nvSpPr>
        <p:spPr/>
        <p:txBody>
          <a:bodyPr/>
          <a:lstStyle/>
          <a:p>
            <a:fld id="{D53D62F8-510A-461B-A98A-EA3FDADF92F4}" type="datetimeFigureOut">
              <a:rPr lang="en-US" smtClean="0"/>
              <a:t>8/23/2023</a:t>
            </a:fld>
            <a:endParaRPr lang="en-US"/>
          </a:p>
        </p:txBody>
      </p:sp>
      <p:sp>
        <p:nvSpPr>
          <p:cNvPr id="5" name="Footer Placeholder 4">
            <a:extLst>
              <a:ext uri="{FF2B5EF4-FFF2-40B4-BE49-F238E27FC236}">
                <a16:creationId xmlns:a16="http://schemas.microsoft.com/office/drawing/2014/main" id="{257B5B81-1573-42F0-AC6A-9BC73443110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49488C4-AFDA-4696-AAE9-2D26F493A37A}"/>
              </a:ext>
            </a:extLst>
          </p:cNvPr>
          <p:cNvSpPr>
            <a:spLocks noGrp="1"/>
          </p:cNvSpPr>
          <p:nvPr>
            <p:ph type="sldNum" sz="quarter" idx="12"/>
          </p:nvPr>
        </p:nvSpPr>
        <p:spPr/>
        <p:txBody>
          <a:bodyPr/>
          <a:lstStyle/>
          <a:p>
            <a:fld id="{A73B7274-0A28-48EB-8DF1-D5CC5988BD3B}" type="slidenum">
              <a:rPr lang="en-US" smtClean="0"/>
              <a:t>‹#›</a:t>
            </a:fld>
            <a:endParaRPr lang="en-US"/>
          </a:p>
        </p:txBody>
      </p:sp>
    </p:spTree>
    <p:extLst>
      <p:ext uri="{BB962C8B-B14F-4D97-AF65-F5344CB8AC3E}">
        <p14:creationId xmlns:p14="http://schemas.microsoft.com/office/powerpoint/2010/main" val="19178617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E8E8F6F-2656-49DB-9F51-DBAD7D3A6C1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321F095-2599-4E8D-AF97-7EA47B7A168A}"/>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75F55F2-8709-4C54-A541-701676BD3DBC}"/>
              </a:ext>
            </a:extLst>
          </p:cNvPr>
          <p:cNvSpPr>
            <a:spLocks noGrp="1"/>
          </p:cNvSpPr>
          <p:nvPr>
            <p:ph type="dt" sz="half" idx="10"/>
          </p:nvPr>
        </p:nvSpPr>
        <p:spPr/>
        <p:txBody>
          <a:bodyPr/>
          <a:lstStyle/>
          <a:p>
            <a:fld id="{D53D62F8-510A-461B-A98A-EA3FDADF92F4}" type="datetimeFigureOut">
              <a:rPr lang="en-US" smtClean="0"/>
              <a:t>8/23/2023</a:t>
            </a:fld>
            <a:endParaRPr lang="en-US"/>
          </a:p>
        </p:txBody>
      </p:sp>
      <p:sp>
        <p:nvSpPr>
          <p:cNvPr id="5" name="Footer Placeholder 4">
            <a:extLst>
              <a:ext uri="{FF2B5EF4-FFF2-40B4-BE49-F238E27FC236}">
                <a16:creationId xmlns:a16="http://schemas.microsoft.com/office/drawing/2014/main" id="{39C33B12-D62B-4516-8C54-D6B57A1DF19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83F7409-23EA-4055-8AF4-C544927AD693}"/>
              </a:ext>
            </a:extLst>
          </p:cNvPr>
          <p:cNvSpPr>
            <a:spLocks noGrp="1"/>
          </p:cNvSpPr>
          <p:nvPr>
            <p:ph type="sldNum" sz="quarter" idx="12"/>
          </p:nvPr>
        </p:nvSpPr>
        <p:spPr/>
        <p:txBody>
          <a:bodyPr/>
          <a:lstStyle/>
          <a:p>
            <a:fld id="{A73B7274-0A28-48EB-8DF1-D5CC5988BD3B}" type="slidenum">
              <a:rPr lang="en-US" smtClean="0"/>
              <a:t>‹#›</a:t>
            </a:fld>
            <a:endParaRPr lang="en-US"/>
          </a:p>
        </p:txBody>
      </p:sp>
    </p:spTree>
    <p:extLst>
      <p:ext uri="{BB962C8B-B14F-4D97-AF65-F5344CB8AC3E}">
        <p14:creationId xmlns:p14="http://schemas.microsoft.com/office/powerpoint/2010/main" val="284313778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A10F05-B8B9-4A82-BE55-38FDAF2BB28A}"/>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C2CD5366-9BA0-40E9-95A0-2454D792717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F3AE2A1-0F37-4D82-8012-1E1BB4F019C8}"/>
              </a:ext>
            </a:extLst>
          </p:cNvPr>
          <p:cNvSpPr>
            <a:spLocks noGrp="1"/>
          </p:cNvSpPr>
          <p:nvPr>
            <p:ph type="dt" sz="half" idx="10"/>
          </p:nvPr>
        </p:nvSpPr>
        <p:spPr/>
        <p:txBody>
          <a:bodyPr/>
          <a:lstStyle/>
          <a:p>
            <a:fld id="{D53D62F8-510A-461B-A98A-EA3FDADF92F4}" type="datetimeFigureOut">
              <a:rPr lang="en-US" smtClean="0"/>
              <a:t>8/23/2023</a:t>
            </a:fld>
            <a:endParaRPr lang="en-US"/>
          </a:p>
        </p:txBody>
      </p:sp>
      <p:sp>
        <p:nvSpPr>
          <p:cNvPr id="5" name="Footer Placeholder 4">
            <a:extLst>
              <a:ext uri="{FF2B5EF4-FFF2-40B4-BE49-F238E27FC236}">
                <a16:creationId xmlns:a16="http://schemas.microsoft.com/office/drawing/2014/main" id="{8C27A33E-E91A-47B6-9DAC-5C42A312B3B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A605D87-E18D-46BB-A831-09C9A7C05A3D}"/>
              </a:ext>
            </a:extLst>
          </p:cNvPr>
          <p:cNvSpPr>
            <a:spLocks noGrp="1"/>
          </p:cNvSpPr>
          <p:nvPr>
            <p:ph type="sldNum" sz="quarter" idx="12"/>
          </p:nvPr>
        </p:nvSpPr>
        <p:spPr/>
        <p:txBody>
          <a:bodyPr/>
          <a:lstStyle/>
          <a:p>
            <a:fld id="{A73B7274-0A28-48EB-8DF1-D5CC5988BD3B}" type="slidenum">
              <a:rPr lang="en-US" smtClean="0"/>
              <a:t>‹#›</a:t>
            </a:fld>
            <a:endParaRPr lang="en-US"/>
          </a:p>
        </p:txBody>
      </p:sp>
    </p:spTree>
    <p:extLst>
      <p:ext uri="{BB962C8B-B14F-4D97-AF65-F5344CB8AC3E}">
        <p14:creationId xmlns:p14="http://schemas.microsoft.com/office/powerpoint/2010/main" val="3775795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1FF700-9642-4376-9C63-88883AA6F9F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98D3307-C832-4F2D-B81D-1A34DD382B91}"/>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DB310227-FD43-4B45-8CD9-3520B75EDBB2}"/>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1B920265-3900-494D-8973-91E47E24EE49}"/>
              </a:ext>
            </a:extLst>
          </p:cNvPr>
          <p:cNvSpPr>
            <a:spLocks noGrp="1"/>
          </p:cNvSpPr>
          <p:nvPr>
            <p:ph type="dt" sz="half" idx="10"/>
          </p:nvPr>
        </p:nvSpPr>
        <p:spPr/>
        <p:txBody>
          <a:bodyPr/>
          <a:lstStyle/>
          <a:p>
            <a:fld id="{D53D62F8-510A-461B-A98A-EA3FDADF92F4}" type="datetimeFigureOut">
              <a:rPr lang="en-US" smtClean="0"/>
              <a:t>8/23/2023</a:t>
            </a:fld>
            <a:endParaRPr lang="en-US"/>
          </a:p>
        </p:txBody>
      </p:sp>
      <p:sp>
        <p:nvSpPr>
          <p:cNvPr id="6" name="Footer Placeholder 5">
            <a:extLst>
              <a:ext uri="{FF2B5EF4-FFF2-40B4-BE49-F238E27FC236}">
                <a16:creationId xmlns:a16="http://schemas.microsoft.com/office/drawing/2014/main" id="{493A8A10-6FDC-4A1C-B1A8-56D0F921DB0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7EF19FA-5FCB-48CA-9865-B64E0B239E7F}"/>
              </a:ext>
            </a:extLst>
          </p:cNvPr>
          <p:cNvSpPr>
            <a:spLocks noGrp="1"/>
          </p:cNvSpPr>
          <p:nvPr>
            <p:ph type="sldNum" sz="quarter" idx="12"/>
          </p:nvPr>
        </p:nvSpPr>
        <p:spPr/>
        <p:txBody>
          <a:bodyPr/>
          <a:lstStyle/>
          <a:p>
            <a:fld id="{A73B7274-0A28-48EB-8DF1-D5CC5988BD3B}" type="slidenum">
              <a:rPr lang="en-US" smtClean="0"/>
              <a:t>‹#›</a:t>
            </a:fld>
            <a:endParaRPr lang="en-US"/>
          </a:p>
        </p:txBody>
      </p:sp>
    </p:spTree>
    <p:extLst>
      <p:ext uri="{BB962C8B-B14F-4D97-AF65-F5344CB8AC3E}">
        <p14:creationId xmlns:p14="http://schemas.microsoft.com/office/powerpoint/2010/main" val="7375151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AB3B5C-8E5C-43B7-8045-18BA06CBB11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57153D7-F167-4951-85A8-563F949A6CA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1120D674-7981-4FBD-98C0-0A31605C55B6}"/>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A2E1A07C-A85A-4641-BA55-349723C0E2D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BE33205-6CAF-452E-8313-6231B30D439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D1A27E6-02D8-407C-B73E-F1A87826E6D0}"/>
              </a:ext>
            </a:extLst>
          </p:cNvPr>
          <p:cNvSpPr>
            <a:spLocks noGrp="1"/>
          </p:cNvSpPr>
          <p:nvPr>
            <p:ph type="dt" sz="half" idx="10"/>
          </p:nvPr>
        </p:nvSpPr>
        <p:spPr/>
        <p:txBody>
          <a:bodyPr/>
          <a:lstStyle/>
          <a:p>
            <a:fld id="{D53D62F8-510A-461B-A98A-EA3FDADF92F4}" type="datetimeFigureOut">
              <a:rPr lang="en-US" smtClean="0"/>
              <a:t>8/23/2023</a:t>
            </a:fld>
            <a:endParaRPr lang="en-US"/>
          </a:p>
        </p:txBody>
      </p:sp>
      <p:sp>
        <p:nvSpPr>
          <p:cNvPr id="8" name="Footer Placeholder 7">
            <a:extLst>
              <a:ext uri="{FF2B5EF4-FFF2-40B4-BE49-F238E27FC236}">
                <a16:creationId xmlns:a16="http://schemas.microsoft.com/office/drawing/2014/main" id="{9C8C2CF3-95FA-4450-A143-78BE269BED22}"/>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6B32976D-BF39-4259-9EB3-2EF7A23230C4}"/>
              </a:ext>
            </a:extLst>
          </p:cNvPr>
          <p:cNvSpPr>
            <a:spLocks noGrp="1"/>
          </p:cNvSpPr>
          <p:nvPr>
            <p:ph type="sldNum" sz="quarter" idx="12"/>
          </p:nvPr>
        </p:nvSpPr>
        <p:spPr/>
        <p:txBody>
          <a:bodyPr/>
          <a:lstStyle/>
          <a:p>
            <a:fld id="{A73B7274-0A28-48EB-8DF1-D5CC5988BD3B}" type="slidenum">
              <a:rPr lang="en-US" smtClean="0"/>
              <a:t>‹#›</a:t>
            </a:fld>
            <a:endParaRPr lang="en-US"/>
          </a:p>
        </p:txBody>
      </p:sp>
    </p:spTree>
    <p:extLst>
      <p:ext uri="{BB962C8B-B14F-4D97-AF65-F5344CB8AC3E}">
        <p14:creationId xmlns:p14="http://schemas.microsoft.com/office/powerpoint/2010/main" val="12784619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23DFCF-34F3-4FFD-B752-F78621988E5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DB620EDA-AE05-41D3-B681-7CE10B83DCA2}"/>
              </a:ext>
            </a:extLst>
          </p:cNvPr>
          <p:cNvSpPr>
            <a:spLocks noGrp="1"/>
          </p:cNvSpPr>
          <p:nvPr>
            <p:ph type="dt" sz="half" idx="10"/>
          </p:nvPr>
        </p:nvSpPr>
        <p:spPr/>
        <p:txBody>
          <a:bodyPr/>
          <a:lstStyle/>
          <a:p>
            <a:fld id="{D53D62F8-510A-461B-A98A-EA3FDADF92F4}" type="datetimeFigureOut">
              <a:rPr lang="en-US" smtClean="0"/>
              <a:t>8/23/2023</a:t>
            </a:fld>
            <a:endParaRPr lang="en-US"/>
          </a:p>
        </p:txBody>
      </p:sp>
      <p:sp>
        <p:nvSpPr>
          <p:cNvPr id="4" name="Footer Placeholder 3">
            <a:extLst>
              <a:ext uri="{FF2B5EF4-FFF2-40B4-BE49-F238E27FC236}">
                <a16:creationId xmlns:a16="http://schemas.microsoft.com/office/drawing/2014/main" id="{3117420C-9319-4142-8539-4485F3BDC589}"/>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9FF23427-0E3B-49BD-99BA-77AB94E99D92}"/>
              </a:ext>
            </a:extLst>
          </p:cNvPr>
          <p:cNvSpPr>
            <a:spLocks noGrp="1"/>
          </p:cNvSpPr>
          <p:nvPr>
            <p:ph type="sldNum" sz="quarter" idx="12"/>
          </p:nvPr>
        </p:nvSpPr>
        <p:spPr/>
        <p:txBody>
          <a:bodyPr/>
          <a:lstStyle/>
          <a:p>
            <a:fld id="{A73B7274-0A28-48EB-8DF1-D5CC5988BD3B}" type="slidenum">
              <a:rPr lang="en-US" smtClean="0"/>
              <a:t>‹#›</a:t>
            </a:fld>
            <a:endParaRPr lang="en-US"/>
          </a:p>
        </p:txBody>
      </p:sp>
    </p:spTree>
    <p:extLst>
      <p:ext uri="{BB962C8B-B14F-4D97-AF65-F5344CB8AC3E}">
        <p14:creationId xmlns:p14="http://schemas.microsoft.com/office/powerpoint/2010/main" val="66637808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56D79A3-51D0-45EC-AAE8-C1AF798EDCFE}"/>
              </a:ext>
            </a:extLst>
          </p:cNvPr>
          <p:cNvSpPr>
            <a:spLocks noGrp="1"/>
          </p:cNvSpPr>
          <p:nvPr>
            <p:ph type="dt" sz="half" idx="10"/>
          </p:nvPr>
        </p:nvSpPr>
        <p:spPr/>
        <p:txBody>
          <a:bodyPr/>
          <a:lstStyle/>
          <a:p>
            <a:fld id="{D53D62F8-510A-461B-A98A-EA3FDADF92F4}" type="datetimeFigureOut">
              <a:rPr lang="en-US" smtClean="0"/>
              <a:t>8/23/2023</a:t>
            </a:fld>
            <a:endParaRPr lang="en-US"/>
          </a:p>
        </p:txBody>
      </p:sp>
      <p:sp>
        <p:nvSpPr>
          <p:cNvPr id="3" name="Footer Placeholder 2">
            <a:extLst>
              <a:ext uri="{FF2B5EF4-FFF2-40B4-BE49-F238E27FC236}">
                <a16:creationId xmlns:a16="http://schemas.microsoft.com/office/drawing/2014/main" id="{71E2FC34-BC08-4A9F-98BF-1A7D91AF6FBF}"/>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02856ED-931A-4A5A-A88F-8F7A416F1492}"/>
              </a:ext>
            </a:extLst>
          </p:cNvPr>
          <p:cNvSpPr>
            <a:spLocks noGrp="1"/>
          </p:cNvSpPr>
          <p:nvPr>
            <p:ph type="sldNum" sz="quarter" idx="12"/>
          </p:nvPr>
        </p:nvSpPr>
        <p:spPr/>
        <p:txBody>
          <a:bodyPr/>
          <a:lstStyle/>
          <a:p>
            <a:fld id="{A73B7274-0A28-48EB-8DF1-D5CC5988BD3B}" type="slidenum">
              <a:rPr lang="en-US" smtClean="0"/>
              <a:t>‹#›</a:t>
            </a:fld>
            <a:endParaRPr lang="en-US"/>
          </a:p>
        </p:txBody>
      </p:sp>
    </p:spTree>
    <p:extLst>
      <p:ext uri="{BB962C8B-B14F-4D97-AF65-F5344CB8AC3E}">
        <p14:creationId xmlns:p14="http://schemas.microsoft.com/office/powerpoint/2010/main" val="18733502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E54173E-371F-4A65-80FF-2EB09E1C5E8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ACC529B9-6196-4B03-8A42-597827872BC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59EE871-6191-4523-915C-7DC3B734930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83B4C25-0D71-403A-BBB5-640F4FC8B08B}"/>
              </a:ext>
            </a:extLst>
          </p:cNvPr>
          <p:cNvSpPr>
            <a:spLocks noGrp="1"/>
          </p:cNvSpPr>
          <p:nvPr>
            <p:ph type="dt" sz="half" idx="10"/>
          </p:nvPr>
        </p:nvSpPr>
        <p:spPr/>
        <p:txBody>
          <a:bodyPr/>
          <a:lstStyle/>
          <a:p>
            <a:fld id="{D53D62F8-510A-461B-A98A-EA3FDADF92F4}" type="datetimeFigureOut">
              <a:rPr lang="en-US" smtClean="0"/>
              <a:t>8/23/2023</a:t>
            </a:fld>
            <a:endParaRPr lang="en-US"/>
          </a:p>
        </p:txBody>
      </p:sp>
      <p:sp>
        <p:nvSpPr>
          <p:cNvPr id="6" name="Footer Placeholder 5">
            <a:extLst>
              <a:ext uri="{FF2B5EF4-FFF2-40B4-BE49-F238E27FC236}">
                <a16:creationId xmlns:a16="http://schemas.microsoft.com/office/drawing/2014/main" id="{DF84682B-9A91-4170-B296-28D1E2D28B7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B936FA0-370C-40CE-A65D-0D889B3ADDEA}"/>
              </a:ext>
            </a:extLst>
          </p:cNvPr>
          <p:cNvSpPr>
            <a:spLocks noGrp="1"/>
          </p:cNvSpPr>
          <p:nvPr>
            <p:ph type="sldNum" sz="quarter" idx="12"/>
          </p:nvPr>
        </p:nvSpPr>
        <p:spPr/>
        <p:txBody>
          <a:bodyPr/>
          <a:lstStyle/>
          <a:p>
            <a:fld id="{A73B7274-0A28-48EB-8DF1-D5CC5988BD3B}" type="slidenum">
              <a:rPr lang="en-US" smtClean="0"/>
              <a:t>‹#›</a:t>
            </a:fld>
            <a:endParaRPr lang="en-US"/>
          </a:p>
        </p:txBody>
      </p:sp>
    </p:spTree>
    <p:extLst>
      <p:ext uri="{BB962C8B-B14F-4D97-AF65-F5344CB8AC3E}">
        <p14:creationId xmlns:p14="http://schemas.microsoft.com/office/powerpoint/2010/main" val="36682670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10B755-FD54-402B-AC0D-ECA4C1956F0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FFFE2F5-8303-4A0B-BB58-AA1AE99B3AD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AC363661-AA4F-45D9-9DC6-803AD2E8B35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3FEB727-7744-45A4-93F3-D78343973718}"/>
              </a:ext>
            </a:extLst>
          </p:cNvPr>
          <p:cNvSpPr>
            <a:spLocks noGrp="1"/>
          </p:cNvSpPr>
          <p:nvPr>
            <p:ph type="dt" sz="half" idx="10"/>
          </p:nvPr>
        </p:nvSpPr>
        <p:spPr/>
        <p:txBody>
          <a:bodyPr/>
          <a:lstStyle/>
          <a:p>
            <a:fld id="{D53D62F8-510A-461B-A98A-EA3FDADF92F4}" type="datetimeFigureOut">
              <a:rPr lang="en-US" smtClean="0"/>
              <a:t>8/23/2023</a:t>
            </a:fld>
            <a:endParaRPr lang="en-US"/>
          </a:p>
        </p:txBody>
      </p:sp>
      <p:sp>
        <p:nvSpPr>
          <p:cNvPr id="6" name="Footer Placeholder 5">
            <a:extLst>
              <a:ext uri="{FF2B5EF4-FFF2-40B4-BE49-F238E27FC236}">
                <a16:creationId xmlns:a16="http://schemas.microsoft.com/office/drawing/2014/main" id="{B730D1EB-E9BB-4959-A627-A7EB0487110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4026D99-4354-4003-B523-00F37FF0CA0E}"/>
              </a:ext>
            </a:extLst>
          </p:cNvPr>
          <p:cNvSpPr>
            <a:spLocks noGrp="1"/>
          </p:cNvSpPr>
          <p:nvPr>
            <p:ph type="sldNum" sz="quarter" idx="12"/>
          </p:nvPr>
        </p:nvSpPr>
        <p:spPr/>
        <p:txBody>
          <a:bodyPr/>
          <a:lstStyle/>
          <a:p>
            <a:fld id="{A73B7274-0A28-48EB-8DF1-D5CC5988BD3B}" type="slidenum">
              <a:rPr lang="en-US" smtClean="0"/>
              <a:t>‹#›</a:t>
            </a:fld>
            <a:endParaRPr lang="en-US"/>
          </a:p>
        </p:txBody>
      </p:sp>
    </p:spTree>
    <p:extLst>
      <p:ext uri="{BB962C8B-B14F-4D97-AF65-F5344CB8AC3E}">
        <p14:creationId xmlns:p14="http://schemas.microsoft.com/office/powerpoint/2010/main" val="38996158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BA28507-74E6-4162-8F84-87450FB09A0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2019C864-E030-4729-92A9-0CEB67E2DB6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9749BC3-F022-4B75-A180-4F6F8CEDF0A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53D62F8-510A-461B-A98A-EA3FDADF92F4}" type="datetimeFigureOut">
              <a:rPr lang="en-US" smtClean="0"/>
              <a:t>8/23/2023</a:t>
            </a:fld>
            <a:endParaRPr lang="en-US"/>
          </a:p>
        </p:txBody>
      </p:sp>
      <p:sp>
        <p:nvSpPr>
          <p:cNvPr id="5" name="Footer Placeholder 4">
            <a:extLst>
              <a:ext uri="{FF2B5EF4-FFF2-40B4-BE49-F238E27FC236}">
                <a16:creationId xmlns:a16="http://schemas.microsoft.com/office/drawing/2014/main" id="{3ABF944A-4DCF-4014-99D4-3755303634A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98BB8EE6-AA68-445F-8D8C-CA968E7FDDB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73B7274-0A28-48EB-8DF1-D5CC5988BD3B}" type="slidenum">
              <a:rPr lang="en-US" smtClean="0"/>
              <a:t>‹#›</a:t>
            </a:fld>
            <a:endParaRPr lang="en-US"/>
          </a:p>
        </p:txBody>
      </p:sp>
    </p:spTree>
    <p:extLst>
      <p:ext uri="{BB962C8B-B14F-4D97-AF65-F5344CB8AC3E}">
        <p14:creationId xmlns:p14="http://schemas.microsoft.com/office/powerpoint/2010/main" val="165685598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3" Type="http://schemas.openxmlformats.org/officeDocument/2006/relationships/comments" Target="../comments/comment1.xml"/><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image" Target="../media/image1.jpg"/><Relationship Id="rId1" Type="http://schemas.openxmlformats.org/officeDocument/2006/relationships/slideLayout" Target="../slideLayouts/slideLayout2.xml"/><Relationship Id="rId5" Type="http://schemas.openxmlformats.org/officeDocument/2006/relationships/image" Target="../media/image4.jpg"/><Relationship Id="rId4" Type="http://schemas.openxmlformats.org/officeDocument/2006/relationships/image" Target="../media/image3.jpg"/></Relationships>
</file>

<file path=ppt/slides/_rels/slide4.xml.rels><?xml version="1.0" encoding="UTF-8" standalone="yes"?>
<Relationships xmlns="http://schemas.openxmlformats.org/package/2006/relationships"><Relationship Id="rId3" Type="http://schemas.openxmlformats.org/officeDocument/2006/relationships/image" Target="../media/image5.tiff"/><Relationship Id="rId2" Type="http://schemas.openxmlformats.org/officeDocument/2006/relationships/notesSlide" Target="../notesSlides/notesSlide2.xml"/><Relationship Id="rId1" Type="http://schemas.openxmlformats.org/officeDocument/2006/relationships/slideLayout" Target="../slideLayouts/slideLayout2.xml"/><Relationship Id="rId5" Type="http://schemas.openxmlformats.org/officeDocument/2006/relationships/image" Target="../media/image7.tiff"/><Relationship Id="rId4" Type="http://schemas.openxmlformats.org/officeDocument/2006/relationships/image" Target="../media/image6.tiff"/></Relationships>
</file>

<file path=ppt/slides/_rels/slide5.xml.rels><?xml version="1.0" encoding="UTF-8" standalone="yes"?>
<Relationships xmlns="http://schemas.openxmlformats.org/package/2006/relationships"><Relationship Id="rId3" Type="http://schemas.openxmlformats.org/officeDocument/2006/relationships/image" Target="../media/image6.tiff"/><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chart" Target="../charts/chart4.xml"/><Relationship Id="rId5" Type="http://schemas.openxmlformats.org/officeDocument/2006/relationships/chart" Target="../charts/chart3.xml"/><Relationship Id="rId4" Type="http://schemas.openxmlformats.org/officeDocument/2006/relationships/chart" Target="../charts/chart2.xml"/></Relationships>
</file>

<file path=ppt/slides/_rels/slide6.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chart" Target="../charts/chart5.xml"/><Relationship Id="rId1" Type="http://schemas.openxmlformats.org/officeDocument/2006/relationships/slideLayout" Target="../slideLayouts/slideLayout2.xml"/><Relationship Id="rId4" Type="http://schemas.openxmlformats.org/officeDocument/2006/relationships/image" Target="../media/image7.tiff"/></Relationships>
</file>

<file path=ppt/slides/_rels/slide7.xml.rels><?xml version="1.0" encoding="UTF-8" standalone="yes"?>
<Relationships xmlns="http://schemas.openxmlformats.org/package/2006/relationships"><Relationship Id="rId2" Type="http://schemas.openxmlformats.org/officeDocument/2006/relationships/chart" Target="../charts/chart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8.JP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3" name="Table 52">
            <a:extLst>
              <a:ext uri="{FF2B5EF4-FFF2-40B4-BE49-F238E27FC236}">
                <a16:creationId xmlns:a16="http://schemas.microsoft.com/office/drawing/2014/main" id="{2BE5A3C9-4C71-43FB-A077-AB2F2B0A85B7}"/>
              </a:ext>
            </a:extLst>
          </p:cNvPr>
          <p:cNvGraphicFramePr>
            <a:graphicFrameLocks noGrp="1"/>
          </p:cNvGraphicFramePr>
          <p:nvPr/>
        </p:nvGraphicFramePr>
        <p:xfrm>
          <a:off x="985441" y="1168944"/>
          <a:ext cx="10215363" cy="2514606"/>
        </p:xfrm>
        <a:graphic>
          <a:graphicData uri="http://schemas.openxmlformats.org/drawingml/2006/table">
            <a:tbl>
              <a:tblPr>
                <a:tableStyleId>{1FECB4D8-DB02-4DC6-A0A2-4F2EBAE1DC90}</a:tableStyleId>
              </a:tblPr>
              <a:tblGrid>
                <a:gridCol w="1059873">
                  <a:extLst>
                    <a:ext uri="{9D8B030D-6E8A-4147-A177-3AD203B41FA5}">
                      <a16:colId xmlns:a16="http://schemas.microsoft.com/office/drawing/2014/main" val="746903786"/>
                    </a:ext>
                  </a:extLst>
                </a:gridCol>
                <a:gridCol w="150090">
                  <a:extLst>
                    <a:ext uri="{9D8B030D-6E8A-4147-A177-3AD203B41FA5}">
                      <a16:colId xmlns:a16="http://schemas.microsoft.com/office/drawing/2014/main" val="1367383587"/>
                    </a:ext>
                  </a:extLst>
                </a:gridCol>
                <a:gridCol w="150090">
                  <a:extLst>
                    <a:ext uri="{9D8B030D-6E8A-4147-A177-3AD203B41FA5}">
                      <a16:colId xmlns:a16="http://schemas.microsoft.com/office/drawing/2014/main" val="3505898766"/>
                    </a:ext>
                  </a:extLst>
                </a:gridCol>
                <a:gridCol w="150090">
                  <a:extLst>
                    <a:ext uri="{9D8B030D-6E8A-4147-A177-3AD203B41FA5}">
                      <a16:colId xmlns:a16="http://schemas.microsoft.com/office/drawing/2014/main" val="4132034139"/>
                    </a:ext>
                  </a:extLst>
                </a:gridCol>
                <a:gridCol w="150090">
                  <a:extLst>
                    <a:ext uri="{9D8B030D-6E8A-4147-A177-3AD203B41FA5}">
                      <a16:colId xmlns:a16="http://schemas.microsoft.com/office/drawing/2014/main" val="2275003437"/>
                    </a:ext>
                  </a:extLst>
                </a:gridCol>
                <a:gridCol w="150090">
                  <a:extLst>
                    <a:ext uri="{9D8B030D-6E8A-4147-A177-3AD203B41FA5}">
                      <a16:colId xmlns:a16="http://schemas.microsoft.com/office/drawing/2014/main" val="991926460"/>
                    </a:ext>
                  </a:extLst>
                </a:gridCol>
                <a:gridCol w="150090">
                  <a:extLst>
                    <a:ext uri="{9D8B030D-6E8A-4147-A177-3AD203B41FA5}">
                      <a16:colId xmlns:a16="http://schemas.microsoft.com/office/drawing/2014/main" val="1131202128"/>
                    </a:ext>
                  </a:extLst>
                </a:gridCol>
                <a:gridCol w="150090">
                  <a:extLst>
                    <a:ext uri="{9D8B030D-6E8A-4147-A177-3AD203B41FA5}">
                      <a16:colId xmlns:a16="http://schemas.microsoft.com/office/drawing/2014/main" val="3501421876"/>
                    </a:ext>
                  </a:extLst>
                </a:gridCol>
                <a:gridCol w="150090">
                  <a:extLst>
                    <a:ext uri="{9D8B030D-6E8A-4147-A177-3AD203B41FA5}">
                      <a16:colId xmlns:a16="http://schemas.microsoft.com/office/drawing/2014/main" val="3082066304"/>
                    </a:ext>
                  </a:extLst>
                </a:gridCol>
                <a:gridCol w="150090">
                  <a:extLst>
                    <a:ext uri="{9D8B030D-6E8A-4147-A177-3AD203B41FA5}">
                      <a16:colId xmlns:a16="http://schemas.microsoft.com/office/drawing/2014/main" val="2695980051"/>
                    </a:ext>
                  </a:extLst>
                </a:gridCol>
                <a:gridCol w="150090">
                  <a:extLst>
                    <a:ext uri="{9D8B030D-6E8A-4147-A177-3AD203B41FA5}">
                      <a16:colId xmlns:a16="http://schemas.microsoft.com/office/drawing/2014/main" val="400656331"/>
                    </a:ext>
                  </a:extLst>
                </a:gridCol>
                <a:gridCol w="150090">
                  <a:extLst>
                    <a:ext uri="{9D8B030D-6E8A-4147-A177-3AD203B41FA5}">
                      <a16:colId xmlns:a16="http://schemas.microsoft.com/office/drawing/2014/main" val="2249752151"/>
                    </a:ext>
                  </a:extLst>
                </a:gridCol>
                <a:gridCol w="150090">
                  <a:extLst>
                    <a:ext uri="{9D8B030D-6E8A-4147-A177-3AD203B41FA5}">
                      <a16:colId xmlns:a16="http://schemas.microsoft.com/office/drawing/2014/main" val="2927147643"/>
                    </a:ext>
                  </a:extLst>
                </a:gridCol>
                <a:gridCol w="150090">
                  <a:extLst>
                    <a:ext uri="{9D8B030D-6E8A-4147-A177-3AD203B41FA5}">
                      <a16:colId xmlns:a16="http://schemas.microsoft.com/office/drawing/2014/main" val="728993540"/>
                    </a:ext>
                  </a:extLst>
                </a:gridCol>
                <a:gridCol w="150090">
                  <a:extLst>
                    <a:ext uri="{9D8B030D-6E8A-4147-A177-3AD203B41FA5}">
                      <a16:colId xmlns:a16="http://schemas.microsoft.com/office/drawing/2014/main" val="2410285084"/>
                    </a:ext>
                  </a:extLst>
                </a:gridCol>
                <a:gridCol w="150090">
                  <a:extLst>
                    <a:ext uri="{9D8B030D-6E8A-4147-A177-3AD203B41FA5}">
                      <a16:colId xmlns:a16="http://schemas.microsoft.com/office/drawing/2014/main" val="959900498"/>
                    </a:ext>
                  </a:extLst>
                </a:gridCol>
                <a:gridCol w="150090">
                  <a:extLst>
                    <a:ext uri="{9D8B030D-6E8A-4147-A177-3AD203B41FA5}">
                      <a16:colId xmlns:a16="http://schemas.microsoft.com/office/drawing/2014/main" val="918738281"/>
                    </a:ext>
                  </a:extLst>
                </a:gridCol>
                <a:gridCol w="150090">
                  <a:extLst>
                    <a:ext uri="{9D8B030D-6E8A-4147-A177-3AD203B41FA5}">
                      <a16:colId xmlns:a16="http://schemas.microsoft.com/office/drawing/2014/main" val="1533308392"/>
                    </a:ext>
                  </a:extLst>
                </a:gridCol>
                <a:gridCol w="150090">
                  <a:extLst>
                    <a:ext uri="{9D8B030D-6E8A-4147-A177-3AD203B41FA5}">
                      <a16:colId xmlns:a16="http://schemas.microsoft.com/office/drawing/2014/main" val="519941497"/>
                    </a:ext>
                  </a:extLst>
                </a:gridCol>
                <a:gridCol w="150090">
                  <a:extLst>
                    <a:ext uri="{9D8B030D-6E8A-4147-A177-3AD203B41FA5}">
                      <a16:colId xmlns:a16="http://schemas.microsoft.com/office/drawing/2014/main" val="1021826670"/>
                    </a:ext>
                  </a:extLst>
                </a:gridCol>
                <a:gridCol w="150090">
                  <a:extLst>
                    <a:ext uri="{9D8B030D-6E8A-4147-A177-3AD203B41FA5}">
                      <a16:colId xmlns:a16="http://schemas.microsoft.com/office/drawing/2014/main" val="3865472755"/>
                    </a:ext>
                  </a:extLst>
                </a:gridCol>
                <a:gridCol w="150090">
                  <a:extLst>
                    <a:ext uri="{9D8B030D-6E8A-4147-A177-3AD203B41FA5}">
                      <a16:colId xmlns:a16="http://schemas.microsoft.com/office/drawing/2014/main" val="3521348582"/>
                    </a:ext>
                  </a:extLst>
                </a:gridCol>
                <a:gridCol w="150090">
                  <a:extLst>
                    <a:ext uri="{9D8B030D-6E8A-4147-A177-3AD203B41FA5}">
                      <a16:colId xmlns:a16="http://schemas.microsoft.com/office/drawing/2014/main" val="2628901056"/>
                    </a:ext>
                  </a:extLst>
                </a:gridCol>
                <a:gridCol w="150090">
                  <a:extLst>
                    <a:ext uri="{9D8B030D-6E8A-4147-A177-3AD203B41FA5}">
                      <a16:colId xmlns:a16="http://schemas.microsoft.com/office/drawing/2014/main" val="1459261434"/>
                    </a:ext>
                  </a:extLst>
                </a:gridCol>
                <a:gridCol w="150090">
                  <a:extLst>
                    <a:ext uri="{9D8B030D-6E8A-4147-A177-3AD203B41FA5}">
                      <a16:colId xmlns:a16="http://schemas.microsoft.com/office/drawing/2014/main" val="3653337383"/>
                    </a:ext>
                  </a:extLst>
                </a:gridCol>
                <a:gridCol w="150090">
                  <a:extLst>
                    <a:ext uri="{9D8B030D-6E8A-4147-A177-3AD203B41FA5}">
                      <a16:colId xmlns:a16="http://schemas.microsoft.com/office/drawing/2014/main" val="1247049050"/>
                    </a:ext>
                  </a:extLst>
                </a:gridCol>
                <a:gridCol w="150090">
                  <a:extLst>
                    <a:ext uri="{9D8B030D-6E8A-4147-A177-3AD203B41FA5}">
                      <a16:colId xmlns:a16="http://schemas.microsoft.com/office/drawing/2014/main" val="244327283"/>
                    </a:ext>
                  </a:extLst>
                </a:gridCol>
                <a:gridCol w="150090">
                  <a:extLst>
                    <a:ext uri="{9D8B030D-6E8A-4147-A177-3AD203B41FA5}">
                      <a16:colId xmlns:a16="http://schemas.microsoft.com/office/drawing/2014/main" val="2828372978"/>
                    </a:ext>
                  </a:extLst>
                </a:gridCol>
                <a:gridCol w="150090">
                  <a:extLst>
                    <a:ext uri="{9D8B030D-6E8A-4147-A177-3AD203B41FA5}">
                      <a16:colId xmlns:a16="http://schemas.microsoft.com/office/drawing/2014/main" val="3973407750"/>
                    </a:ext>
                  </a:extLst>
                </a:gridCol>
                <a:gridCol w="150090">
                  <a:extLst>
                    <a:ext uri="{9D8B030D-6E8A-4147-A177-3AD203B41FA5}">
                      <a16:colId xmlns:a16="http://schemas.microsoft.com/office/drawing/2014/main" val="465619331"/>
                    </a:ext>
                  </a:extLst>
                </a:gridCol>
                <a:gridCol w="150090">
                  <a:extLst>
                    <a:ext uri="{9D8B030D-6E8A-4147-A177-3AD203B41FA5}">
                      <a16:colId xmlns:a16="http://schemas.microsoft.com/office/drawing/2014/main" val="1944272352"/>
                    </a:ext>
                  </a:extLst>
                </a:gridCol>
                <a:gridCol w="150090">
                  <a:extLst>
                    <a:ext uri="{9D8B030D-6E8A-4147-A177-3AD203B41FA5}">
                      <a16:colId xmlns:a16="http://schemas.microsoft.com/office/drawing/2014/main" val="1034914331"/>
                    </a:ext>
                  </a:extLst>
                </a:gridCol>
                <a:gridCol w="150090">
                  <a:extLst>
                    <a:ext uri="{9D8B030D-6E8A-4147-A177-3AD203B41FA5}">
                      <a16:colId xmlns:a16="http://schemas.microsoft.com/office/drawing/2014/main" val="4196284636"/>
                    </a:ext>
                  </a:extLst>
                </a:gridCol>
                <a:gridCol w="150090">
                  <a:extLst>
                    <a:ext uri="{9D8B030D-6E8A-4147-A177-3AD203B41FA5}">
                      <a16:colId xmlns:a16="http://schemas.microsoft.com/office/drawing/2014/main" val="3978533829"/>
                    </a:ext>
                  </a:extLst>
                </a:gridCol>
                <a:gridCol w="150090">
                  <a:extLst>
                    <a:ext uri="{9D8B030D-6E8A-4147-A177-3AD203B41FA5}">
                      <a16:colId xmlns:a16="http://schemas.microsoft.com/office/drawing/2014/main" val="4176001547"/>
                    </a:ext>
                  </a:extLst>
                </a:gridCol>
                <a:gridCol w="150090">
                  <a:extLst>
                    <a:ext uri="{9D8B030D-6E8A-4147-A177-3AD203B41FA5}">
                      <a16:colId xmlns:a16="http://schemas.microsoft.com/office/drawing/2014/main" val="2427391511"/>
                    </a:ext>
                  </a:extLst>
                </a:gridCol>
                <a:gridCol w="150090">
                  <a:extLst>
                    <a:ext uri="{9D8B030D-6E8A-4147-A177-3AD203B41FA5}">
                      <a16:colId xmlns:a16="http://schemas.microsoft.com/office/drawing/2014/main" val="135872308"/>
                    </a:ext>
                  </a:extLst>
                </a:gridCol>
                <a:gridCol w="150090">
                  <a:extLst>
                    <a:ext uri="{9D8B030D-6E8A-4147-A177-3AD203B41FA5}">
                      <a16:colId xmlns:a16="http://schemas.microsoft.com/office/drawing/2014/main" val="299421135"/>
                    </a:ext>
                  </a:extLst>
                </a:gridCol>
                <a:gridCol w="150090">
                  <a:extLst>
                    <a:ext uri="{9D8B030D-6E8A-4147-A177-3AD203B41FA5}">
                      <a16:colId xmlns:a16="http://schemas.microsoft.com/office/drawing/2014/main" val="3244355455"/>
                    </a:ext>
                  </a:extLst>
                </a:gridCol>
                <a:gridCol w="150090">
                  <a:extLst>
                    <a:ext uri="{9D8B030D-6E8A-4147-A177-3AD203B41FA5}">
                      <a16:colId xmlns:a16="http://schemas.microsoft.com/office/drawing/2014/main" val="15728152"/>
                    </a:ext>
                  </a:extLst>
                </a:gridCol>
                <a:gridCol w="150090">
                  <a:extLst>
                    <a:ext uri="{9D8B030D-6E8A-4147-A177-3AD203B41FA5}">
                      <a16:colId xmlns:a16="http://schemas.microsoft.com/office/drawing/2014/main" val="3980350569"/>
                    </a:ext>
                  </a:extLst>
                </a:gridCol>
                <a:gridCol w="150090">
                  <a:extLst>
                    <a:ext uri="{9D8B030D-6E8A-4147-A177-3AD203B41FA5}">
                      <a16:colId xmlns:a16="http://schemas.microsoft.com/office/drawing/2014/main" val="684797467"/>
                    </a:ext>
                  </a:extLst>
                </a:gridCol>
                <a:gridCol w="150090">
                  <a:extLst>
                    <a:ext uri="{9D8B030D-6E8A-4147-A177-3AD203B41FA5}">
                      <a16:colId xmlns:a16="http://schemas.microsoft.com/office/drawing/2014/main" val="237873631"/>
                    </a:ext>
                  </a:extLst>
                </a:gridCol>
                <a:gridCol w="150090">
                  <a:extLst>
                    <a:ext uri="{9D8B030D-6E8A-4147-A177-3AD203B41FA5}">
                      <a16:colId xmlns:a16="http://schemas.microsoft.com/office/drawing/2014/main" val="1129609933"/>
                    </a:ext>
                  </a:extLst>
                </a:gridCol>
                <a:gridCol w="150090">
                  <a:extLst>
                    <a:ext uri="{9D8B030D-6E8A-4147-A177-3AD203B41FA5}">
                      <a16:colId xmlns:a16="http://schemas.microsoft.com/office/drawing/2014/main" val="1623474296"/>
                    </a:ext>
                  </a:extLst>
                </a:gridCol>
                <a:gridCol w="150090">
                  <a:extLst>
                    <a:ext uri="{9D8B030D-6E8A-4147-A177-3AD203B41FA5}">
                      <a16:colId xmlns:a16="http://schemas.microsoft.com/office/drawing/2014/main" val="105147265"/>
                    </a:ext>
                  </a:extLst>
                </a:gridCol>
                <a:gridCol w="150090">
                  <a:extLst>
                    <a:ext uri="{9D8B030D-6E8A-4147-A177-3AD203B41FA5}">
                      <a16:colId xmlns:a16="http://schemas.microsoft.com/office/drawing/2014/main" val="92733131"/>
                    </a:ext>
                  </a:extLst>
                </a:gridCol>
                <a:gridCol w="150090">
                  <a:extLst>
                    <a:ext uri="{9D8B030D-6E8A-4147-A177-3AD203B41FA5}">
                      <a16:colId xmlns:a16="http://schemas.microsoft.com/office/drawing/2014/main" val="2220291368"/>
                    </a:ext>
                  </a:extLst>
                </a:gridCol>
                <a:gridCol w="150090">
                  <a:extLst>
                    <a:ext uri="{9D8B030D-6E8A-4147-A177-3AD203B41FA5}">
                      <a16:colId xmlns:a16="http://schemas.microsoft.com/office/drawing/2014/main" val="1705465416"/>
                    </a:ext>
                  </a:extLst>
                </a:gridCol>
                <a:gridCol w="150090">
                  <a:extLst>
                    <a:ext uri="{9D8B030D-6E8A-4147-A177-3AD203B41FA5}">
                      <a16:colId xmlns:a16="http://schemas.microsoft.com/office/drawing/2014/main" val="1092011240"/>
                    </a:ext>
                  </a:extLst>
                </a:gridCol>
                <a:gridCol w="150090">
                  <a:extLst>
                    <a:ext uri="{9D8B030D-6E8A-4147-A177-3AD203B41FA5}">
                      <a16:colId xmlns:a16="http://schemas.microsoft.com/office/drawing/2014/main" val="3853985935"/>
                    </a:ext>
                  </a:extLst>
                </a:gridCol>
                <a:gridCol w="150090">
                  <a:extLst>
                    <a:ext uri="{9D8B030D-6E8A-4147-A177-3AD203B41FA5}">
                      <a16:colId xmlns:a16="http://schemas.microsoft.com/office/drawing/2014/main" val="3174159542"/>
                    </a:ext>
                  </a:extLst>
                </a:gridCol>
                <a:gridCol w="150090">
                  <a:extLst>
                    <a:ext uri="{9D8B030D-6E8A-4147-A177-3AD203B41FA5}">
                      <a16:colId xmlns:a16="http://schemas.microsoft.com/office/drawing/2014/main" val="1118944979"/>
                    </a:ext>
                  </a:extLst>
                </a:gridCol>
                <a:gridCol w="150090">
                  <a:extLst>
                    <a:ext uri="{9D8B030D-6E8A-4147-A177-3AD203B41FA5}">
                      <a16:colId xmlns:a16="http://schemas.microsoft.com/office/drawing/2014/main" val="2442941580"/>
                    </a:ext>
                  </a:extLst>
                </a:gridCol>
                <a:gridCol w="150090">
                  <a:extLst>
                    <a:ext uri="{9D8B030D-6E8A-4147-A177-3AD203B41FA5}">
                      <a16:colId xmlns:a16="http://schemas.microsoft.com/office/drawing/2014/main" val="4104174948"/>
                    </a:ext>
                  </a:extLst>
                </a:gridCol>
                <a:gridCol w="150090">
                  <a:extLst>
                    <a:ext uri="{9D8B030D-6E8A-4147-A177-3AD203B41FA5}">
                      <a16:colId xmlns:a16="http://schemas.microsoft.com/office/drawing/2014/main" val="852650323"/>
                    </a:ext>
                  </a:extLst>
                </a:gridCol>
                <a:gridCol w="150090">
                  <a:extLst>
                    <a:ext uri="{9D8B030D-6E8A-4147-A177-3AD203B41FA5}">
                      <a16:colId xmlns:a16="http://schemas.microsoft.com/office/drawing/2014/main" val="3951186622"/>
                    </a:ext>
                  </a:extLst>
                </a:gridCol>
                <a:gridCol w="150090">
                  <a:extLst>
                    <a:ext uri="{9D8B030D-6E8A-4147-A177-3AD203B41FA5}">
                      <a16:colId xmlns:a16="http://schemas.microsoft.com/office/drawing/2014/main" val="3456839029"/>
                    </a:ext>
                  </a:extLst>
                </a:gridCol>
                <a:gridCol w="150090">
                  <a:extLst>
                    <a:ext uri="{9D8B030D-6E8A-4147-A177-3AD203B41FA5}">
                      <a16:colId xmlns:a16="http://schemas.microsoft.com/office/drawing/2014/main" val="170910245"/>
                    </a:ext>
                  </a:extLst>
                </a:gridCol>
                <a:gridCol w="150090">
                  <a:extLst>
                    <a:ext uri="{9D8B030D-6E8A-4147-A177-3AD203B41FA5}">
                      <a16:colId xmlns:a16="http://schemas.microsoft.com/office/drawing/2014/main" val="3667696465"/>
                    </a:ext>
                  </a:extLst>
                </a:gridCol>
                <a:gridCol w="150090">
                  <a:extLst>
                    <a:ext uri="{9D8B030D-6E8A-4147-A177-3AD203B41FA5}">
                      <a16:colId xmlns:a16="http://schemas.microsoft.com/office/drawing/2014/main" val="3508715493"/>
                    </a:ext>
                  </a:extLst>
                </a:gridCol>
                <a:gridCol w="150090">
                  <a:extLst>
                    <a:ext uri="{9D8B030D-6E8A-4147-A177-3AD203B41FA5}">
                      <a16:colId xmlns:a16="http://schemas.microsoft.com/office/drawing/2014/main" val="3295366460"/>
                    </a:ext>
                  </a:extLst>
                </a:gridCol>
              </a:tblGrid>
              <a:tr h="353291">
                <a:tc>
                  <a:txBody>
                    <a:bodyPr/>
                    <a:lstStyle/>
                    <a:p>
                      <a:r>
                        <a:rPr lang="en-US" sz="1000" dirty="0">
                          <a:latin typeface="Arial" panose="020B0604020202020204" pitchFamily="34" charset="0"/>
                          <a:cs typeface="Arial" panose="020B0604020202020204" pitchFamily="34" charset="0"/>
                        </a:rPr>
                        <a:t>Day relative to surgery</a:t>
                      </a:r>
                    </a:p>
                  </a:txBody>
                  <a:tcPr marL="31173" marR="31173" marT="31173" marB="31173">
                    <a:lnR w="12700" cap="flat" cmpd="sng" algn="ctr">
                      <a:solidFill>
                        <a:schemeClr val="bg2">
                          <a:lumMod val="90000"/>
                        </a:schemeClr>
                      </a:solidFill>
                      <a:prstDash val="solid"/>
                      <a:round/>
                      <a:headEnd type="none" w="med" len="med"/>
                      <a:tailEnd type="none" w="med" len="med"/>
                    </a:lnR>
                  </a:tcPr>
                </a:tc>
                <a:tc>
                  <a:txBody>
                    <a:bodyPr/>
                    <a:lstStyle/>
                    <a:p>
                      <a:pPr algn="ctr"/>
                      <a:r>
                        <a:rPr lang="en-US" sz="1000" dirty="0">
                          <a:latin typeface="Arial" panose="020B0604020202020204" pitchFamily="34" charset="0"/>
                          <a:cs typeface="Arial" panose="020B0604020202020204" pitchFamily="34" charset="0"/>
                        </a:rPr>
                        <a:t>-4</a:t>
                      </a:r>
                    </a:p>
                  </a:txBody>
                  <a:tcPr marL="31173" marR="31173" marT="31173" marB="31173" vert="vert" anchor="ctr">
                    <a:lnL w="12700" cap="flat" cmpd="sng" algn="ctr">
                      <a:solidFill>
                        <a:schemeClr val="bg2">
                          <a:lumMod val="90000"/>
                        </a:schemeClr>
                      </a:solidFill>
                      <a:prstDash val="solid"/>
                      <a:round/>
                      <a:headEnd type="none" w="med" len="med"/>
                      <a:tailEnd type="none" w="med" len="med"/>
                    </a:lnL>
                  </a:tcPr>
                </a:tc>
                <a:tc>
                  <a:txBody>
                    <a:bodyPr/>
                    <a:lstStyle/>
                    <a:p>
                      <a:pPr algn="ctr"/>
                      <a:r>
                        <a:rPr lang="en-US" sz="1000" dirty="0">
                          <a:latin typeface="Arial" panose="020B0604020202020204" pitchFamily="34" charset="0"/>
                          <a:cs typeface="Arial" panose="020B0604020202020204" pitchFamily="34" charset="0"/>
                        </a:rPr>
                        <a:t>-3</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2</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1</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0</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1</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2</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3</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4</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5</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6</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7</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8</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9</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10</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11</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12</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13</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14</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15</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16</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17</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18</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19</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20</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21</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22</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23</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24</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25</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26</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27</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28</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29</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30</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31</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32</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33</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34</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35</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36</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37</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38</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39</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40</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41</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42</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43</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44</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45</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46</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47</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48</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49</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50</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51</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52</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53</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54</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55</a:t>
                      </a:r>
                    </a:p>
                  </a:txBody>
                  <a:tcPr marL="31173" marR="31173" marT="31173" marB="31173" vert="vert" anchor="ctr"/>
                </a:tc>
                <a:tc>
                  <a:txBody>
                    <a:bodyPr/>
                    <a:lstStyle/>
                    <a:p>
                      <a:pPr algn="ctr"/>
                      <a:r>
                        <a:rPr lang="en-US" sz="1000" dirty="0">
                          <a:latin typeface="Arial" panose="020B0604020202020204" pitchFamily="34" charset="0"/>
                          <a:cs typeface="Arial" panose="020B0604020202020204" pitchFamily="34" charset="0"/>
                        </a:rPr>
                        <a:t>56</a:t>
                      </a:r>
                    </a:p>
                  </a:txBody>
                  <a:tcPr marL="31173" marR="31173" marT="31173" marB="31173" vert="vert" anchor="ctr">
                    <a:lnR w="12700" cap="flat" cmpd="sng" algn="ctr">
                      <a:solidFill>
                        <a:schemeClr val="bg2">
                          <a:lumMod val="90000"/>
                        </a:schemeClr>
                      </a:solidFill>
                      <a:prstDash val="solid"/>
                      <a:round/>
                      <a:headEnd type="none" w="med" len="med"/>
                      <a:tailEnd type="none" w="med" len="med"/>
                    </a:lnR>
                  </a:tcPr>
                </a:tc>
                <a:extLst>
                  <a:ext uri="{0D108BD9-81ED-4DB2-BD59-A6C34878D82A}">
                    <a16:rowId xmlns:a16="http://schemas.microsoft.com/office/drawing/2014/main" val="1472050340"/>
                  </a:ext>
                </a:extLst>
              </a:tr>
              <a:tr h="207818">
                <a:tc>
                  <a:txBody>
                    <a:bodyPr/>
                    <a:lstStyle/>
                    <a:p>
                      <a:r>
                        <a:rPr lang="en-US" sz="1000" dirty="0">
                          <a:latin typeface="Arial" panose="020B0604020202020204" pitchFamily="34" charset="0"/>
                          <a:cs typeface="Arial" panose="020B0604020202020204" pitchFamily="34" charset="0"/>
                        </a:rPr>
                        <a:t>Anesthesia</a:t>
                      </a:r>
                    </a:p>
                  </a:txBody>
                  <a:tcPr marL="62345" marR="62345" marT="31173" marB="31173">
                    <a:lnR w="12700" cap="flat" cmpd="sng" algn="ctr">
                      <a:solidFill>
                        <a:schemeClr val="bg2">
                          <a:lumMod val="90000"/>
                        </a:schemeClr>
                      </a:solidFill>
                      <a:prstDash val="solid"/>
                      <a:round/>
                      <a:headEnd type="none" w="med" len="med"/>
                      <a:tailEnd type="none" w="med" len="med"/>
                    </a:lnR>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L w="12700" cap="flat" cmpd="sng" algn="ctr">
                      <a:solidFill>
                        <a:schemeClr val="bg2">
                          <a:lumMod val="90000"/>
                        </a:schemeClr>
                      </a:solidFill>
                      <a:prstDash val="solid"/>
                      <a:round/>
                      <a:headEnd type="none" w="med" len="med"/>
                      <a:tailEnd type="none" w="med" len="med"/>
                    </a:lnL>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CC0099"/>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R w="12700" cap="flat" cmpd="sng" algn="ctr">
                      <a:solidFill>
                        <a:schemeClr val="bg2">
                          <a:lumMod val="90000"/>
                        </a:schemeClr>
                      </a:solidFill>
                      <a:prstDash val="solid"/>
                      <a:round/>
                      <a:headEnd type="none" w="med" len="med"/>
                      <a:tailEnd type="none" w="med" len="med"/>
                    </a:lnR>
                    <a:solidFill>
                      <a:schemeClr val="bg1"/>
                    </a:solidFill>
                  </a:tcPr>
                </a:tc>
                <a:extLst>
                  <a:ext uri="{0D108BD9-81ED-4DB2-BD59-A6C34878D82A}">
                    <a16:rowId xmlns:a16="http://schemas.microsoft.com/office/drawing/2014/main" val="3213101175"/>
                  </a:ext>
                </a:extLst>
              </a:tr>
              <a:tr h="207818">
                <a:tc>
                  <a:txBody>
                    <a:bodyPr/>
                    <a:lstStyle/>
                    <a:p>
                      <a:r>
                        <a:rPr lang="en-US" sz="1000" dirty="0">
                          <a:latin typeface="Arial" panose="020B0604020202020204" pitchFamily="34" charset="0"/>
                          <a:cs typeface="Arial" panose="020B0604020202020204" pitchFamily="34" charset="0"/>
                        </a:rPr>
                        <a:t>Plating</a:t>
                      </a:r>
                    </a:p>
                  </a:txBody>
                  <a:tcPr marL="62345" marR="62345" marT="31173" marB="31173">
                    <a:lnR w="12700" cap="flat" cmpd="sng" algn="ctr">
                      <a:solidFill>
                        <a:schemeClr val="bg2">
                          <a:lumMod val="90000"/>
                        </a:schemeClr>
                      </a:solidFill>
                      <a:prstDash val="solid"/>
                      <a:round/>
                      <a:headEnd type="none" w="med" len="med"/>
                      <a:tailEnd type="none" w="med" len="med"/>
                    </a:lnR>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L w="12700" cap="flat" cmpd="sng" algn="ctr">
                      <a:solidFill>
                        <a:schemeClr val="bg2">
                          <a:lumMod val="90000"/>
                        </a:schemeClr>
                      </a:solidFill>
                      <a:prstDash val="solid"/>
                      <a:round/>
                      <a:headEnd type="none" w="med" len="med"/>
                      <a:tailEnd type="none" w="med" len="med"/>
                    </a:lnL>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BDD7EE"/>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R w="12700" cap="flat" cmpd="sng" algn="ctr">
                      <a:solidFill>
                        <a:schemeClr val="bg2">
                          <a:lumMod val="90000"/>
                        </a:schemeClr>
                      </a:solidFill>
                      <a:prstDash val="solid"/>
                      <a:round/>
                      <a:headEnd type="none" w="med" len="med"/>
                      <a:tailEnd type="none" w="med" len="med"/>
                    </a:lnR>
                    <a:solidFill>
                      <a:schemeClr val="bg1"/>
                    </a:solidFill>
                  </a:tcPr>
                </a:tc>
                <a:extLst>
                  <a:ext uri="{0D108BD9-81ED-4DB2-BD59-A6C34878D82A}">
                    <a16:rowId xmlns:a16="http://schemas.microsoft.com/office/drawing/2014/main" val="3141663186"/>
                  </a:ext>
                </a:extLst>
              </a:tr>
              <a:tr h="207818">
                <a:tc>
                  <a:txBody>
                    <a:bodyPr/>
                    <a:lstStyle/>
                    <a:p>
                      <a:r>
                        <a:rPr lang="en-US" sz="1000" dirty="0">
                          <a:latin typeface="Arial" panose="020B0604020202020204" pitchFamily="34" charset="0"/>
                          <a:cs typeface="Arial" panose="020B0604020202020204" pitchFamily="34" charset="0"/>
                        </a:rPr>
                        <a:t>Gait analysis</a:t>
                      </a:r>
                    </a:p>
                  </a:txBody>
                  <a:tcPr marL="62345" marR="62345" marT="31173" marB="31173">
                    <a:lnR w="12700" cap="flat" cmpd="sng" algn="ctr">
                      <a:solidFill>
                        <a:schemeClr val="bg2">
                          <a:lumMod val="90000"/>
                        </a:schemeClr>
                      </a:solidFill>
                      <a:prstDash val="solid"/>
                      <a:round/>
                      <a:headEnd type="none" w="med" len="med"/>
                      <a:tailEnd type="none" w="med" len="med"/>
                    </a:lnR>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L w="12700" cap="flat" cmpd="sng" algn="ctr">
                      <a:solidFill>
                        <a:schemeClr val="bg2">
                          <a:lumMod val="90000"/>
                        </a:schemeClr>
                      </a:solidFill>
                      <a:prstDash val="solid"/>
                      <a:round/>
                      <a:headEnd type="none" w="med" len="med"/>
                      <a:tailEnd type="none" w="med" len="med"/>
                    </a:lnL>
                    <a:solidFill>
                      <a:schemeClr val="accent6">
                        <a:lumMod val="60000"/>
                        <a:lumOff val="40000"/>
                      </a:schemeClr>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accent6">
                        <a:lumMod val="60000"/>
                        <a:lumOff val="40000"/>
                      </a:schemeClr>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accent6">
                        <a:lumMod val="60000"/>
                        <a:lumOff val="40000"/>
                      </a:schemeClr>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accent6"/>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accent6"/>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accent6"/>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accent6"/>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accent6"/>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accent6"/>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accent6"/>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R w="12700" cap="flat" cmpd="sng" algn="ctr">
                      <a:solidFill>
                        <a:schemeClr val="bg2">
                          <a:lumMod val="90000"/>
                        </a:schemeClr>
                      </a:solidFill>
                      <a:prstDash val="solid"/>
                      <a:round/>
                      <a:headEnd type="none" w="med" len="med"/>
                      <a:tailEnd type="none" w="med" len="med"/>
                    </a:lnR>
                    <a:solidFill>
                      <a:schemeClr val="accent6"/>
                    </a:solidFill>
                  </a:tcPr>
                </a:tc>
                <a:extLst>
                  <a:ext uri="{0D108BD9-81ED-4DB2-BD59-A6C34878D82A}">
                    <a16:rowId xmlns:a16="http://schemas.microsoft.com/office/drawing/2014/main" val="1954021368"/>
                  </a:ext>
                </a:extLst>
              </a:tr>
              <a:tr h="207818">
                <a:tc>
                  <a:txBody>
                    <a:bodyPr/>
                    <a:lstStyle/>
                    <a:p>
                      <a:r>
                        <a:rPr lang="en-US" sz="1000" dirty="0">
                          <a:latin typeface="Arial" panose="020B0604020202020204" pitchFamily="34" charset="0"/>
                          <a:cs typeface="Arial" panose="020B0604020202020204" pitchFamily="34" charset="0"/>
                        </a:rPr>
                        <a:t>Weight bearing</a:t>
                      </a:r>
                    </a:p>
                  </a:txBody>
                  <a:tcPr marL="62345" marR="62345" marT="31173" marB="31173">
                    <a:lnR w="12700" cap="flat" cmpd="sng" algn="ctr">
                      <a:solidFill>
                        <a:schemeClr val="bg2">
                          <a:lumMod val="90000"/>
                        </a:schemeClr>
                      </a:solidFill>
                      <a:prstDash val="solid"/>
                      <a:round/>
                      <a:headEnd type="none" w="med" len="med"/>
                      <a:tailEnd type="none" w="med" len="med"/>
                    </a:lnR>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L w="12700" cap="flat" cmpd="sng" algn="ctr">
                      <a:solidFill>
                        <a:schemeClr val="bg2">
                          <a:lumMod val="90000"/>
                        </a:schemeClr>
                      </a:solidFill>
                      <a:prstDash val="solid"/>
                      <a:round/>
                      <a:headEnd type="none" w="med" len="med"/>
                      <a:tailEnd type="none" w="med" len="med"/>
                    </a:lnL>
                    <a:solidFill>
                      <a:srgbClr val="FFE7E7"/>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E7E7"/>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E7E7"/>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BDBD"/>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BDBD"/>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BDBD"/>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BDBD"/>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BDBD"/>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BDBD"/>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BDBD"/>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R w="12700" cap="flat" cmpd="sng" algn="ctr">
                      <a:solidFill>
                        <a:schemeClr val="bg2">
                          <a:lumMod val="90000"/>
                        </a:schemeClr>
                      </a:solidFill>
                      <a:prstDash val="solid"/>
                      <a:round/>
                      <a:headEnd type="none" w="med" len="med"/>
                      <a:tailEnd type="none" w="med" len="med"/>
                    </a:lnR>
                    <a:solidFill>
                      <a:srgbClr val="FFBDBD"/>
                    </a:solidFill>
                  </a:tcPr>
                </a:tc>
                <a:extLst>
                  <a:ext uri="{0D108BD9-81ED-4DB2-BD59-A6C34878D82A}">
                    <a16:rowId xmlns:a16="http://schemas.microsoft.com/office/drawing/2014/main" val="529081779"/>
                  </a:ext>
                </a:extLst>
              </a:tr>
              <a:tr h="207818">
                <a:tc>
                  <a:txBody>
                    <a:bodyPr/>
                    <a:lstStyle/>
                    <a:p>
                      <a:r>
                        <a:rPr lang="en-US" sz="1000" dirty="0">
                          <a:latin typeface="Arial" panose="020B0604020202020204" pitchFamily="34" charset="0"/>
                          <a:cs typeface="Arial" panose="020B0604020202020204" pitchFamily="34" charset="0"/>
                        </a:rPr>
                        <a:t>Von Frey</a:t>
                      </a:r>
                    </a:p>
                  </a:txBody>
                  <a:tcPr marL="62345" marR="62345" marT="31173" marB="31173">
                    <a:lnR w="12700" cap="flat" cmpd="sng" algn="ctr">
                      <a:solidFill>
                        <a:schemeClr val="bg2">
                          <a:lumMod val="90000"/>
                        </a:schemeClr>
                      </a:solidFill>
                      <a:prstDash val="solid"/>
                      <a:round/>
                      <a:headEnd type="none" w="med" len="med"/>
                      <a:tailEnd type="none" w="med" len="med"/>
                    </a:lnR>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L w="12700" cap="flat" cmpd="sng" algn="ctr">
                      <a:solidFill>
                        <a:schemeClr val="bg2">
                          <a:lumMod val="90000"/>
                        </a:schemeClr>
                      </a:solidFill>
                      <a:prstDash val="solid"/>
                      <a:round/>
                      <a:headEnd type="none" w="med" len="med"/>
                      <a:tailEnd type="none" w="med" len="med"/>
                    </a:lnL>
                    <a:solidFill>
                      <a:srgbClr val="B17ED8"/>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B17ED8"/>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B17ED8"/>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B w="12700" cap="flat" cmpd="sng" algn="ctr">
                      <a:solidFill>
                        <a:schemeClr val="bg1">
                          <a:lumMod val="75000"/>
                        </a:schemeClr>
                      </a:solidFill>
                      <a:prstDash val="solid"/>
                      <a:round/>
                      <a:headEnd type="none" w="med" len="med"/>
                      <a:tailEnd type="none" w="med" len="med"/>
                    </a:lnB>
                    <a:solidFill>
                      <a:srgbClr val="7030A0"/>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B w="12700" cap="flat" cmpd="sng" algn="ctr">
                      <a:solidFill>
                        <a:schemeClr val="bg1">
                          <a:lumMod val="75000"/>
                        </a:schemeClr>
                      </a:solidFill>
                      <a:prstDash val="solid"/>
                      <a:round/>
                      <a:headEnd type="none" w="med" len="med"/>
                      <a:tailEnd type="none" w="med" len="med"/>
                    </a:lnB>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B w="12700" cap="flat" cmpd="sng" algn="ctr">
                      <a:solidFill>
                        <a:schemeClr val="bg1">
                          <a:lumMod val="75000"/>
                        </a:schemeClr>
                      </a:solidFill>
                      <a:prstDash val="solid"/>
                      <a:round/>
                      <a:headEnd type="none" w="med" len="med"/>
                      <a:tailEnd type="none" w="med" len="med"/>
                    </a:lnB>
                    <a:solidFill>
                      <a:srgbClr val="7030A0"/>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B w="12700" cap="flat" cmpd="sng" algn="ctr">
                      <a:solidFill>
                        <a:schemeClr val="bg1">
                          <a:lumMod val="75000"/>
                        </a:schemeClr>
                      </a:solidFill>
                      <a:prstDash val="solid"/>
                      <a:round/>
                      <a:headEnd type="none" w="med" len="med"/>
                      <a:tailEnd type="none" w="med" len="med"/>
                    </a:lnB>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B w="12700" cap="flat" cmpd="sng" algn="ctr">
                      <a:solidFill>
                        <a:schemeClr val="bg1">
                          <a:lumMod val="75000"/>
                        </a:schemeClr>
                      </a:solidFill>
                      <a:prstDash val="solid"/>
                      <a:round/>
                      <a:headEnd type="none" w="med" len="med"/>
                      <a:tailEnd type="none" w="med" len="med"/>
                    </a:lnB>
                    <a:solidFill>
                      <a:srgbClr val="7030A0"/>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B w="12700" cap="flat" cmpd="sng" algn="ctr">
                      <a:solidFill>
                        <a:schemeClr val="bg1">
                          <a:lumMod val="75000"/>
                        </a:schemeClr>
                      </a:solidFill>
                      <a:prstDash val="solid"/>
                      <a:round/>
                      <a:headEnd type="none" w="med" len="med"/>
                      <a:tailEnd type="none" w="med" len="med"/>
                    </a:lnB>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B w="12700" cap="flat" cmpd="sng" algn="ctr">
                      <a:solidFill>
                        <a:schemeClr val="bg1">
                          <a:lumMod val="75000"/>
                        </a:schemeClr>
                      </a:solidFill>
                      <a:prstDash val="solid"/>
                      <a:round/>
                      <a:headEnd type="none" w="med" len="med"/>
                      <a:tailEnd type="none" w="med" len="med"/>
                    </a:lnB>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7030A0"/>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7030A0"/>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7030A0"/>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7030A0"/>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R w="12700" cap="flat" cmpd="sng" algn="ctr">
                      <a:solidFill>
                        <a:schemeClr val="bg2">
                          <a:lumMod val="90000"/>
                        </a:schemeClr>
                      </a:solidFill>
                      <a:prstDash val="solid"/>
                      <a:round/>
                      <a:headEnd type="none" w="med" len="med"/>
                      <a:tailEnd type="none" w="med" len="med"/>
                    </a:lnR>
                    <a:solidFill>
                      <a:srgbClr val="7030A0"/>
                    </a:solidFill>
                  </a:tcPr>
                </a:tc>
                <a:extLst>
                  <a:ext uri="{0D108BD9-81ED-4DB2-BD59-A6C34878D82A}">
                    <a16:rowId xmlns:a16="http://schemas.microsoft.com/office/drawing/2014/main" val="3629071315"/>
                  </a:ext>
                </a:extLst>
              </a:tr>
              <a:tr h="207818">
                <a:tc>
                  <a:txBody>
                    <a:bodyPr/>
                    <a:lstStyle/>
                    <a:p>
                      <a:r>
                        <a:rPr lang="en-US" sz="1000" dirty="0">
                          <a:latin typeface="Arial" panose="020B0604020202020204" pitchFamily="34" charset="0"/>
                          <a:cs typeface="Arial" panose="020B0604020202020204" pitchFamily="34" charset="0"/>
                        </a:rPr>
                        <a:t>Blood collection</a:t>
                      </a:r>
                    </a:p>
                  </a:txBody>
                  <a:tcPr marL="62345" marR="62345" marT="31173" marB="31173">
                    <a:lnR w="12700" cap="flat" cmpd="sng" algn="ctr">
                      <a:solidFill>
                        <a:schemeClr val="bg2">
                          <a:lumMod val="90000"/>
                        </a:schemeClr>
                      </a:solidFill>
                      <a:prstDash val="solid"/>
                      <a:round/>
                      <a:headEnd type="none" w="med" len="med"/>
                      <a:tailEnd type="none" w="med" len="med"/>
                    </a:lnR>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L w="12700" cap="flat" cmpd="sng" algn="ctr">
                      <a:solidFill>
                        <a:schemeClr val="bg2">
                          <a:lumMod val="90000"/>
                        </a:schemeClr>
                      </a:solidFill>
                      <a:prstDash val="solid"/>
                      <a:round/>
                      <a:headEnd type="none" w="med" len="med"/>
                      <a:tailEnd type="none" w="med" len="med"/>
                    </a:ln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R w="12700" cap="flat" cmpd="sng" algn="ctr">
                      <a:noFill/>
                      <a:prstDash val="solid"/>
                      <a:round/>
                      <a:headEnd type="none" w="med" len="med"/>
                      <a:tailEnd type="none" w="med" len="med"/>
                    </a:lnR>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L w="12700" cap="flat" cmpd="sng" algn="ctr">
                      <a:noFill/>
                      <a:prstDash val="solid"/>
                      <a:round/>
                      <a:headEnd type="none" w="med" len="med"/>
                      <a:tailEnd type="none" w="med" len="med"/>
                    </a:lnL>
                    <a:lnR>
                      <a:noFill/>
                    </a:lnR>
                    <a:lnT w="12700" cap="flat" cmpd="sng" algn="ctr">
                      <a:solidFill>
                        <a:schemeClr val="bg1">
                          <a:lumMod val="75000"/>
                        </a:schemeClr>
                      </a:solidFill>
                      <a:prstDash val="solid"/>
                      <a:round/>
                      <a:headEnd type="none" w="med" len="med"/>
                      <a:tailEnd type="none" w="med" len="med"/>
                    </a:lnT>
                    <a:lnB w="12700" cap="flat" cmpd="sng" algn="ctr">
                      <a:solidFill>
                        <a:schemeClr val="accent3"/>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L>
                      <a:noFill/>
                    </a:lnL>
                    <a:lnR>
                      <a:noFill/>
                    </a:lnR>
                    <a:lnT w="12700" cap="flat" cmpd="sng" algn="ctr">
                      <a:solidFill>
                        <a:schemeClr val="bg1">
                          <a:lumMod val="75000"/>
                        </a:schemeClr>
                      </a:solidFill>
                      <a:prstDash val="solid"/>
                      <a:round/>
                      <a:headEnd type="none" w="med" len="med"/>
                      <a:tailEnd type="none" w="med" len="med"/>
                    </a:lnT>
                    <a:lnB w="12700" cap="flat" cmpd="sng" algn="ctr">
                      <a:solidFill>
                        <a:schemeClr val="accent3"/>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L>
                      <a:noFill/>
                    </a:lnL>
                    <a:lnR>
                      <a:noFill/>
                    </a:lnR>
                    <a:lnT w="12700" cap="flat" cmpd="sng" algn="ctr">
                      <a:solidFill>
                        <a:schemeClr val="bg1">
                          <a:lumMod val="75000"/>
                        </a:schemeClr>
                      </a:solidFill>
                      <a:prstDash val="solid"/>
                      <a:round/>
                      <a:headEnd type="none" w="med" len="med"/>
                      <a:tailEnd type="none" w="med" len="med"/>
                    </a:lnT>
                    <a:lnB w="12700" cap="flat" cmpd="sng" algn="ctr">
                      <a:solidFill>
                        <a:schemeClr val="accent3"/>
                      </a:solidFill>
                      <a:prstDash val="solid"/>
                      <a:round/>
                      <a:headEnd type="none" w="med" len="med"/>
                      <a:tailEnd type="none" w="med" len="med"/>
                    </a:lnB>
                    <a:lnTlToBr w="12700" cmpd="sng">
                      <a:noFill/>
                      <a:prstDash val="solid"/>
                    </a:lnTlToBr>
                    <a:lnBlToTr w="12700" cmpd="sng">
                      <a:noFill/>
                      <a:prstDash val="solid"/>
                    </a:lnBlToTr>
                    <a:solidFill>
                      <a:srgbClr val="C00000"/>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L>
                      <a:noFill/>
                    </a:lnL>
                    <a:lnR>
                      <a:noFill/>
                    </a:lnR>
                    <a:lnT w="12700" cap="flat" cmpd="sng" algn="ctr">
                      <a:solidFill>
                        <a:schemeClr val="bg1">
                          <a:lumMod val="75000"/>
                        </a:schemeClr>
                      </a:solidFill>
                      <a:prstDash val="solid"/>
                      <a:round/>
                      <a:headEnd type="none" w="med" len="med"/>
                      <a:tailEnd type="none" w="med" len="med"/>
                    </a:lnT>
                    <a:lnB w="12700" cap="flat" cmpd="sng" algn="ctr">
                      <a:solidFill>
                        <a:schemeClr val="accent3"/>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L>
                      <a:noFill/>
                    </a:lnL>
                    <a:lnR>
                      <a:noFill/>
                    </a:lnR>
                    <a:lnT w="12700" cap="flat" cmpd="sng" algn="ctr">
                      <a:solidFill>
                        <a:schemeClr val="bg1">
                          <a:lumMod val="75000"/>
                        </a:schemeClr>
                      </a:solidFill>
                      <a:prstDash val="solid"/>
                      <a:round/>
                      <a:headEnd type="none" w="med" len="med"/>
                      <a:tailEnd type="none" w="med" len="med"/>
                    </a:lnT>
                    <a:lnB w="12700" cap="flat" cmpd="sng" algn="ctr">
                      <a:solidFill>
                        <a:schemeClr val="accent3"/>
                      </a:solidFill>
                      <a:prstDash val="solid"/>
                      <a:round/>
                      <a:headEnd type="none" w="med" len="med"/>
                      <a:tailEnd type="none" w="med" len="med"/>
                    </a:lnB>
                    <a:lnTlToBr w="12700" cmpd="sng">
                      <a:noFill/>
                      <a:prstDash val="solid"/>
                    </a:lnTlToBr>
                    <a:lnBlToTr w="12700" cmpd="sng">
                      <a:noFill/>
                      <a:prstDash val="solid"/>
                    </a:lnBlToTr>
                    <a:solidFill>
                      <a:srgbClr val="C00000"/>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L>
                      <a:noFill/>
                    </a:lnL>
                    <a:lnR>
                      <a:noFill/>
                    </a:lnR>
                    <a:lnT w="12700" cap="flat" cmpd="sng" algn="ctr">
                      <a:solidFill>
                        <a:schemeClr val="bg1">
                          <a:lumMod val="75000"/>
                        </a:schemeClr>
                      </a:solidFill>
                      <a:prstDash val="solid"/>
                      <a:round/>
                      <a:headEnd type="none" w="med" len="med"/>
                      <a:tailEnd type="none" w="med" len="med"/>
                    </a:lnT>
                    <a:lnB w="12700" cap="flat" cmpd="sng" algn="ctr">
                      <a:solidFill>
                        <a:schemeClr val="accent3"/>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L>
                      <a:noFill/>
                    </a:lnL>
                    <a:lnR w="12700" cap="flat" cmpd="sng" algn="ctr">
                      <a:noFill/>
                      <a:prstDash val="solid"/>
                      <a:round/>
                      <a:headEnd type="none" w="med" len="med"/>
                      <a:tailEnd type="none" w="med" len="med"/>
                    </a:lnR>
                    <a:lnT w="12700" cap="flat" cmpd="sng" algn="ctr">
                      <a:solidFill>
                        <a:schemeClr val="bg1">
                          <a:lumMod val="75000"/>
                        </a:schemeClr>
                      </a:solidFill>
                      <a:prstDash val="solid"/>
                      <a:round/>
                      <a:headEnd type="none" w="med" len="med"/>
                      <a:tailEnd type="none" w="med" len="med"/>
                    </a:lnT>
                    <a:lnB w="12700" cap="flat" cmpd="sng" algn="ctr">
                      <a:solidFill>
                        <a:schemeClr val="accent3"/>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L w="12700" cap="flat" cmpd="sng" algn="ctr">
                      <a:noFill/>
                      <a:prstDash val="solid"/>
                      <a:round/>
                      <a:headEnd type="none" w="med" len="med"/>
                      <a:tailEnd type="none" w="med" len="med"/>
                    </a:ln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no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noFill/>
                  </a:tcPr>
                </a:tc>
                <a:tc>
                  <a:txBody>
                    <a:bodyPr/>
                    <a:lstStyle/>
                    <a:p>
                      <a:pPr algn="ctr"/>
                      <a:endParaRPr lang="en-US" sz="100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no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no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R w="12700" cap="flat" cmpd="sng" algn="ctr">
                      <a:solidFill>
                        <a:schemeClr val="bg2">
                          <a:lumMod val="90000"/>
                        </a:schemeClr>
                      </a:solidFill>
                      <a:prstDash val="solid"/>
                      <a:round/>
                      <a:headEnd type="none" w="med" len="med"/>
                      <a:tailEnd type="none" w="med" len="med"/>
                    </a:lnR>
                    <a:noFill/>
                  </a:tcPr>
                </a:tc>
                <a:extLst>
                  <a:ext uri="{0D108BD9-81ED-4DB2-BD59-A6C34878D82A}">
                    <a16:rowId xmlns:a16="http://schemas.microsoft.com/office/drawing/2014/main" val="2858383408"/>
                  </a:ext>
                </a:extLst>
              </a:tr>
              <a:tr h="207818">
                <a:tc>
                  <a:txBody>
                    <a:bodyPr/>
                    <a:lstStyle/>
                    <a:p>
                      <a:r>
                        <a:rPr lang="en-US" sz="1000" dirty="0">
                          <a:latin typeface="Arial" panose="020B0604020202020204" pitchFamily="34" charset="0"/>
                          <a:cs typeface="Arial" panose="020B0604020202020204" pitchFamily="34" charset="0"/>
                        </a:rPr>
                        <a:t>X ray</a:t>
                      </a:r>
                    </a:p>
                  </a:txBody>
                  <a:tcPr marL="62345" marR="62345" marT="31173" marB="31173">
                    <a:lnR w="12700" cap="flat" cmpd="sng" algn="ctr">
                      <a:solidFill>
                        <a:schemeClr val="bg2">
                          <a:lumMod val="90000"/>
                        </a:schemeClr>
                      </a:solidFill>
                      <a:prstDash val="solid"/>
                      <a:round/>
                      <a:headEnd type="none" w="med" len="med"/>
                      <a:tailEnd type="none" w="med" len="med"/>
                    </a:lnR>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L w="12700" cap="flat" cmpd="sng" algn="ctr">
                      <a:solidFill>
                        <a:schemeClr val="bg2">
                          <a:lumMod val="90000"/>
                        </a:schemeClr>
                      </a:solidFill>
                      <a:prstDash val="solid"/>
                      <a:round/>
                      <a:headEnd type="none" w="med" len="med"/>
                      <a:tailEnd type="none" w="med" len="med"/>
                    </a:ln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T w="12700" cap="flat" cmpd="sng" algn="ctr">
                      <a:solidFill>
                        <a:schemeClr val="accent3"/>
                      </a:solidFill>
                      <a:prstDash val="solid"/>
                      <a:round/>
                      <a:headEnd type="none" w="med" len="med"/>
                      <a:tailEnd type="none" w="med" len="med"/>
                    </a:lnT>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T w="12700" cap="flat" cmpd="sng" algn="ctr">
                      <a:solidFill>
                        <a:schemeClr val="accent3"/>
                      </a:solidFill>
                      <a:prstDash val="solid"/>
                      <a:round/>
                      <a:headEnd type="none" w="med" len="med"/>
                      <a:tailEnd type="none" w="med" len="med"/>
                    </a:lnT>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T w="12700" cap="flat" cmpd="sng" algn="ctr">
                      <a:solidFill>
                        <a:schemeClr val="accent3"/>
                      </a:solidFill>
                      <a:prstDash val="solid"/>
                      <a:round/>
                      <a:headEnd type="none" w="med" len="med"/>
                      <a:tailEnd type="none" w="med" len="med"/>
                    </a:lnT>
                    <a:solidFill>
                      <a:schemeClr val="accent2"/>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T w="12700" cap="flat" cmpd="sng" algn="ctr">
                      <a:solidFill>
                        <a:schemeClr val="accent3"/>
                      </a:solidFill>
                      <a:prstDash val="solid"/>
                      <a:round/>
                      <a:headEnd type="none" w="med" len="med"/>
                      <a:tailEnd type="none" w="med" len="med"/>
                    </a:lnT>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T w="12700" cap="flat" cmpd="sng" algn="ctr">
                      <a:solidFill>
                        <a:schemeClr val="accent3"/>
                      </a:solidFill>
                      <a:prstDash val="solid"/>
                      <a:round/>
                      <a:headEnd type="none" w="med" len="med"/>
                      <a:tailEnd type="none" w="med" len="med"/>
                    </a:lnT>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T w="12700" cap="flat" cmpd="sng" algn="ctr">
                      <a:solidFill>
                        <a:schemeClr val="accent3"/>
                      </a:solidFill>
                      <a:prstDash val="solid"/>
                      <a:round/>
                      <a:headEnd type="none" w="med" len="med"/>
                      <a:tailEnd type="none" w="med" len="med"/>
                    </a:lnT>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T w="12700" cap="flat" cmpd="sng" algn="ctr">
                      <a:solidFill>
                        <a:schemeClr val="accent3"/>
                      </a:solidFill>
                      <a:prstDash val="solid"/>
                      <a:round/>
                      <a:headEnd type="none" w="med" len="med"/>
                      <a:tailEnd type="none" w="med" len="med"/>
                    </a:lnT>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R w="12700" cap="flat" cmpd="sng" algn="ctr">
                      <a:solidFill>
                        <a:schemeClr val="bg2">
                          <a:lumMod val="90000"/>
                        </a:schemeClr>
                      </a:solidFill>
                      <a:prstDash val="solid"/>
                      <a:round/>
                      <a:headEnd type="none" w="med" len="med"/>
                      <a:tailEnd type="none" w="med" len="med"/>
                    </a:lnR>
                    <a:solidFill>
                      <a:schemeClr val="bg1"/>
                    </a:solidFill>
                  </a:tcPr>
                </a:tc>
                <a:extLst>
                  <a:ext uri="{0D108BD9-81ED-4DB2-BD59-A6C34878D82A}">
                    <a16:rowId xmlns:a16="http://schemas.microsoft.com/office/drawing/2014/main" val="2221299689"/>
                  </a:ext>
                </a:extLst>
              </a:tr>
              <a:tr h="207818">
                <a:tc>
                  <a:txBody>
                    <a:bodyPr/>
                    <a:lstStyle/>
                    <a:p>
                      <a:r>
                        <a:rPr lang="en-US" sz="1000" dirty="0">
                          <a:latin typeface="Arial" panose="020B0604020202020204" pitchFamily="34" charset="0"/>
                          <a:cs typeface="Arial" panose="020B0604020202020204" pitchFamily="34" charset="0"/>
                        </a:rPr>
                        <a:t>Weighing</a:t>
                      </a:r>
                    </a:p>
                  </a:txBody>
                  <a:tcPr marL="62345" marR="62345" marT="31173" marB="31173">
                    <a:lnR w="12700" cap="flat" cmpd="sng" algn="ctr">
                      <a:solidFill>
                        <a:schemeClr val="bg2">
                          <a:lumMod val="90000"/>
                        </a:schemeClr>
                      </a:solidFill>
                      <a:prstDash val="solid"/>
                      <a:round/>
                      <a:headEnd type="none" w="med" len="med"/>
                      <a:tailEnd type="none" w="med" len="med"/>
                    </a:lnR>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L w="12700" cap="flat" cmpd="sng" algn="ctr">
                      <a:solidFill>
                        <a:schemeClr val="bg2">
                          <a:lumMod val="90000"/>
                        </a:schemeClr>
                      </a:solidFill>
                      <a:prstDash val="solid"/>
                      <a:round/>
                      <a:headEnd type="none" w="med" len="med"/>
                      <a:tailEnd type="none" w="med" len="med"/>
                    </a:lnL>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no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no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no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solidFill>
                          <a:srgbClr val="2E75B6"/>
                        </a:solidFill>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no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solidFill>
                          <a:srgbClr val="2E75B6"/>
                        </a:solidFill>
                        <a:latin typeface="Arial" panose="020B0604020202020204" pitchFamily="34" charset="0"/>
                        <a:cs typeface="Arial" panose="020B0604020202020204" pitchFamily="34" charset="0"/>
                      </a:endParaRPr>
                    </a:p>
                  </a:txBody>
                  <a:tcPr marL="62345" marR="62345" marT="31173" marB="31173" anchor="ctr">
                    <a:solidFill>
                      <a:srgbClr val="4472C4"/>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R w="12700" cap="flat" cmpd="sng" algn="ctr">
                      <a:solidFill>
                        <a:schemeClr val="bg2">
                          <a:lumMod val="90000"/>
                        </a:schemeClr>
                      </a:solidFill>
                      <a:prstDash val="solid"/>
                      <a:round/>
                      <a:headEnd type="none" w="med" len="med"/>
                      <a:tailEnd type="none" w="med" len="med"/>
                    </a:lnR>
                    <a:solidFill>
                      <a:srgbClr val="4472C4"/>
                    </a:solidFill>
                  </a:tcPr>
                </a:tc>
                <a:extLst>
                  <a:ext uri="{0D108BD9-81ED-4DB2-BD59-A6C34878D82A}">
                    <a16:rowId xmlns:a16="http://schemas.microsoft.com/office/drawing/2014/main" val="3895032405"/>
                  </a:ext>
                </a:extLst>
              </a:tr>
              <a:tr h="207818">
                <a:tc>
                  <a:txBody>
                    <a:bodyPr/>
                    <a:lstStyle/>
                    <a:p>
                      <a:r>
                        <a:rPr lang="en-US" sz="1000" dirty="0">
                          <a:latin typeface="Arial" panose="020B0604020202020204" pitchFamily="34" charset="0"/>
                          <a:cs typeface="Arial" panose="020B0604020202020204" pitchFamily="34" charset="0"/>
                        </a:rPr>
                        <a:t>Temperature</a:t>
                      </a:r>
                    </a:p>
                  </a:txBody>
                  <a:tcPr marL="62345" marR="62345" marT="31173" marB="31173">
                    <a:lnR w="12700" cap="flat" cmpd="sng" algn="ctr">
                      <a:solidFill>
                        <a:schemeClr val="bg2">
                          <a:lumMod val="90000"/>
                        </a:schemeClr>
                      </a:solidFill>
                      <a:prstDash val="solid"/>
                      <a:round/>
                      <a:headEnd type="none" w="med" len="med"/>
                      <a:tailEnd type="none" w="med" len="med"/>
                    </a:lnR>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L w="12700" cap="flat" cmpd="sng" algn="ctr">
                      <a:solidFill>
                        <a:schemeClr val="bg2">
                          <a:lumMod val="90000"/>
                        </a:schemeClr>
                      </a:solidFill>
                      <a:prstDash val="solid"/>
                      <a:round/>
                      <a:headEnd type="none" w="med" len="med"/>
                      <a:tailEnd type="none" w="med" len="med"/>
                    </a:lnL>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FFFC93"/>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R w="12700" cap="flat" cmpd="sng" algn="ctr">
                      <a:solidFill>
                        <a:schemeClr val="bg2">
                          <a:lumMod val="90000"/>
                        </a:schemeClr>
                      </a:solidFill>
                      <a:prstDash val="solid"/>
                      <a:round/>
                      <a:headEnd type="none" w="med" len="med"/>
                      <a:tailEnd type="none" w="med" len="med"/>
                    </a:lnR>
                    <a:solidFill>
                      <a:srgbClr val="FFFC93"/>
                    </a:solidFill>
                  </a:tcPr>
                </a:tc>
                <a:extLst>
                  <a:ext uri="{0D108BD9-81ED-4DB2-BD59-A6C34878D82A}">
                    <a16:rowId xmlns:a16="http://schemas.microsoft.com/office/drawing/2014/main" val="1632997651"/>
                  </a:ext>
                </a:extLst>
              </a:tr>
              <a:tr h="207818">
                <a:tc>
                  <a:txBody>
                    <a:bodyPr/>
                    <a:lstStyle/>
                    <a:p>
                      <a:r>
                        <a:rPr lang="en-US" sz="1000" dirty="0">
                          <a:latin typeface="Arial" panose="020B0604020202020204" pitchFamily="34" charset="0"/>
                          <a:cs typeface="Arial" panose="020B0604020202020204" pitchFamily="34" charset="0"/>
                        </a:rPr>
                        <a:t>Euthanasia</a:t>
                      </a:r>
                    </a:p>
                  </a:txBody>
                  <a:tcPr marL="62345" marR="62345" marT="31173" marB="31173">
                    <a:lnR w="12700" cap="flat" cmpd="sng" algn="ctr">
                      <a:solidFill>
                        <a:schemeClr val="bg2">
                          <a:lumMod val="90000"/>
                        </a:schemeClr>
                      </a:solidFill>
                      <a:prstDash val="solid"/>
                      <a:round/>
                      <a:headEnd type="none" w="med" len="med"/>
                      <a:tailEnd type="none" w="med" len="med"/>
                    </a:lnR>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L w="12700" cap="flat" cmpd="sng" algn="ctr">
                      <a:solidFill>
                        <a:schemeClr val="bg2">
                          <a:lumMod val="90000"/>
                        </a:schemeClr>
                      </a:solidFill>
                      <a:prstDash val="solid"/>
                      <a:round/>
                      <a:headEnd type="none" w="med" len="med"/>
                      <a:tailEnd type="none" w="med" len="med"/>
                    </a:lnL>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BFE23E"/>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rgbClr val="BFE23E"/>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solidFill>
                          <a:srgbClr val="BFE23E"/>
                        </a:solidFill>
                        <a:latin typeface="Arial" panose="020B0604020202020204" pitchFamily="34" charset="0"/>
                        <a:cs typeface="Arial" panose="020B0604020202020204" pitchFamily="34" charset="0"/>
                      </a:endParaRPr>
                    </a:p>
                  </a:txBody>
                  <a:tcPr marL="62345" marR="62345" marT="31173" marB="31173" anchor="ctr">
                    <a:solidFill>
                      <a:srgbClr val="BFE23E"/>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solidFill>
                      <a:schemeClr val="bg1"/>
                    </a:solidFill>
                  </a:tcPr>
                </a:tc>
                <a:tc>
                  <a:txBody>
                    <a:bodyPr/>
                    <a:lstStyle/>
                    <a:p>
                      <a:pPr algn="ctr"/>
                      <a:endParaRPr lang="en-US" sz="1000" dirty="0">
                        <a:latin typeface="Arial" panose="020B0604020202020204" pitchFamily="34" charset="0"/>
                        <a:cs typeface="Arial" panose="020B0604020202020204" pitchFamily="34" charset="0"/>
                      </a:endParaRPr>
                    </a:p>
                  </a:txBody>
                  <a:tcPr marL="62345" marR="62345" marT="31173" marB="31173" anchor="ctr">
                    <a:lnR w="12700" cap="flat" cmpd="sng" algn="ctr">
                      <a:solidFill>
                        <a:schemeClr val="bg2">
                          <a:lumMod val="90000"/>
                        </a:schemeClr>
                      </a:solidFill>
                      <a:prstDash val="solid"/>
                      <a:round/>
                      <a:headEnd type="none" w="med" len="med"/>
                      <a:tailEnd type="none" w="med" len="med"/>
                    </a:lnR>
                    <a:solidFill>
                      <a:srgbClr val="BFE23E"/>
                    </a:solidFill>
                  </a:tcPr>
                </a:tc>
                <a:extLst>
                  <a:ext uri="{0D108BD9-81ED-4DB2-BD59-A6C34878D82A}">
                    <a16:rowId xmlns:a16="http://schemas.microsoft.com/office/drawing/2014/main" val="1274887271"/>
                  </a:ext>
                </a:extLst>
              </a:tr>
            </a:tbl>
          </a:graphicData>
        </a:graphic>
      </p:graphicFrame>
      <p:sp>
        <p:nvSpPr>
          <p:cNvPr id="12" name="TextBox 11">
            <a:extLst>
              <a:ext uri="{FF2B5EF4-FFF2-40B4-BE49-F238E27FC236}">
                <a16:creationId xmlns:a16="http://schemas.microsoft.com/office/drawing/2014/main" id="{2378D6D3-8CDB-41E5-88B3-8588ED934EC5}"/>
              </a:ext>
            </a:extLst>
          </p:cNvPr>
          <p:cNvSpPr txBox="1"/>
          <p:nvPr/>
        </p:nvSpPr>
        <p:spPr>
          <a:xfrm>
            <a:off x="985441" y="339884"/>
            <a:ext cx="2475293" cy="512000"/>
          </a:xfrm>
          <a:prstGeom prst="rect">
            <a:avLst/>
          </a:prstGeom>
          <a:noFill/>
        </p:spPr>
        <p:txBody>
          <a:bodyPr wrap="none" rtlCol="0">
            <a:spAutoFit/>
          </a:bodyPr>
          <a:lstStyle/>
          <a:p>
            <a:r>
              <a:rPr lang="en-US" sz="2727" dirty="0">
                <a:latin typeface="Arial" panose="020B0604020202020204" pitchFamily="34" charset="0"/>
                <a:cs typeface="Arial" panose="020B0604020202020204" pitchFamily="34" charset="0"/>
              </a:rPr>
              <a:t>Study Timeline</a:t>
            </a:r>
          </a:p>
        </p:txBody>
      </p:sp>
      <p:sp>
        <p:nvSpPr>
          <p:cNvPr id="3" name="TextBox 2">
            <a:extLst>
              <a:ext uri="{FF2B5EF4-FFF2-40B4-BE49-F238E27FC236}">
                <a16:creationId xmlns:a16="http://schemas.microsoft.com/office/drawing/2014/main" id="{F0C3809E-ABF7-43E6-8012-B216DC1FD7BC}"/>
              </a:ext>
            </a:extLst>
          </p:cNvPr>
          <p:cNvSpPr txBox="1"/>
          <p:nvPr/>
        </p:nvSpPr>
        <p:spPr>
          <a:xfrm rot="19177556">
            <a:off x="2010091" y="1850824"/>
            <a:ext cx="428066" cy="763210"/>
          </a:xfrm>
          <a:prstGeom prst="rect">
            <a:avLst/>
          </a:prstGeom>
          <a:noFill/>
        </p:spPr>
        <p:txBody>
          <a:bodyPr vert="vert" wrap="square" rtlCol="0">
            <a:spAutoFit/>
          </a:bodyPr>
          <a:lstStyle/>
          <a:p>
            <a:pPr algn="ctr"/>
            <a:r>
              <a:rPr lang="en-US" sz="791" dirty="0">
                <a:latin typeface="Arial" panose="020B0604020202020204" pitchFamily="34" charset="0"/>
                <a:cs typeface="Arial" panose="020B0604020202020204" pitchFamily="34" charset="0"/>
              </a:rPr>
              <a:t>Acclimatization </a:t>
            </a:r>
          </a:p>
          <a:p>
            <a:pPr algn="ctr"/>
            <a:r>
              <a:rPr lang="en-US" sz="791" dirty="0">
                <a:latin typeface="Arial" panose="020B0604020202020204" pitchFamily="34" charset="0"/>
                <a:cs typeface="Arial" panose="020B0604020202020204" pitchFamily="34" charset="0"/>
              </a:rPr>
              <a:t>Period</a:t>
            </a:r>
          </a:p>
        </p:txBody>
      </p:sp>
      <p:sp>
        <p:nvSpPr>
          <p:cNvPr id="4" name="Rectangle 3">
            <a:extLst>
              <a:ext uri="{FF2B5EF4-FFF2-40B4-BE49-F238E27FC236}">
                <a16:creationId xmlns:a16="http://schemas.microsoft.com/office/drawing/2014/main" id="{A4010A85-2A2A-4084-8AE8-862E3100B0CB}"/>
              </a:ext>
            </a:extLst>
          </p:cNvPr>
          <p:cNvSpPr/>
          <p:nvPr/>
        </p:nvSpPr>
        <p:spPr>
          <a:xfrm>
            <a:off x="2045597" y="1928928"/>
            <a:ext cx="427372" cy="625338"/>
          </a:xfrm>
          <a:prstGeom prst="rect">
            <a:avLst/>
          </a:prstGeom>
          <a:no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27">
              <a:latin typeface="Arial" panose="020B0604020202020204" pitchFamily="34" charset="0"/>
              <a:cs typeface="Arial" panose="020B0604020202020204" pitchFamily="34" charset="0"/>
            </a:endParaRPr>
          </a:p>
        </p:txBody>
      </p:sp>
      <p:sp>
        <p:nvSpPr>
          <p:cNvPr id="2" name="TextBox 1">
            <a:extLst>
              <a:ext uri="{FF2B5EF4-FFF2-40B4-BE49-F238E27FC236}">
                <a16:creationId xmlns:a16="http://schemas.microsoft.com/office/drawing/2014/main" id="{C4D36DA4-3DCE-4524-9314-E9C6B694F095}"/>
              </a:ext>
            </a:extLst>
          </p:cNvPr>
          <p:cNvSpPr txBox="1"/>
          <p:nvPr/>
        </p:nvSpPr>
        <p:spPr>
          <a:xfrm>
            <a:off x="4358217" y="3194174"/>
            <a:ext cx="4428361" cy="239296"/>
          </a:xfrm>
          <a:prstGeom prst="rect">
            <a:avLst/>
          </a:prstGeom>
          <a:noFill/>
        </p:spPr>
        <p:txBody>
          <a:bodyPr wrap="square" rtlCol="0">
            <a:spAutoFit/>
          </a:bodyPr>
          <a:lstStyle/>
          <a:p>
            <a:r>
              <a:rPr lang="en-US" sz="955" dirty="0">
                <a:latin typeface="Arial" panose="020B0604020202020204" pitchFamily="34" charset="0"/>
                <a:cs typeface="Arial" panose="020B0604020202020204" pitchFamily="34" charset="0"/>
              </a:rPr>
              <a:t>Measurement taken as needed if rats shown signs of decline in wellbeing</a:t>
            </a:r>
          </a:p>
        </p:txBody>
      </p:sp>
      <p:cxnSp>
        <p:nvCxnSpPr>
          <p:cNvPr id="6" name="Straight Arrow Connector 5">
            <a:extLst>
              <a:ext uri="{FF2B5EF4-FFF2-40B4-BE49-F238E27FC236}">
                <a16:creationId xmlns:a16="http://schemas.microsoft.com/office/drawing/2014/main" id="{C9A2E726-5E5C-4291-B03D-658C9FE59ED1}"/>
              </a:ext>
            </a:extLst>
          </p:cNvPr>
          <p:cNvCxnSpPr/>
          <p:nvPr/>
        </p:nvCxnSpPr>
        <p:spPr>
          <a:xfrm flipV="1">
            <a:off x="4691733" y="3496733"/>
            <a:ext cx="0" cy="3850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5" name="Straight Arrow Connector 74">
            <a:extLst>
              <a:ext uri="{FF2B5EF4-FFF2-40B4-BE49-F238E27FC236}">
                <a16:creationId xmlns:a16="http://schemas.microsoft.com/office/drawing/2014/main" id="{16289337-54C0-423F-80B1-861698B22100}"/>
              </a:ext>
            </a:extLst>
          </p:cNvPr>
          <p:cNvCxnSpPr/>
          <p:nvPr/>
        </p:nvCxnSpPr>
        <p:spPr>
          <a:xfrm flipV="1">
            <a:off x="6711848" y="3499789"/>
            <a:ext cx="0" cy="3850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6" name="Straight Arrow Connector 75">
            <a:extLst>
              <a:ext uri="{FF2B5EF4-FFF2-40B4-BE49-F238E27FC236}">
                <a16:creationId xmlns:a16="http://schemas.microsoft.com/office/drawing/2014/main" id="{63FE60AF-F5B9-4169-8345-BE68E225BA31}"/>
              </a:ext>
            </a:extLst>
          </p:cNvPr>
          <p:cNvCxnSpPr/>
          <p:nvPr/>
        </p:nvCxnSpPr>
        <p:spPr>
          <a:xfrm flipV="1">
            <a:off x="8710570" y="3490620"/>
            <a:ext cx="0" cy="3850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7" name="Straight Arrow Connector 76">
            <a:extLst>
              <a:ext uri="{FF2B5EF4-FFF2-40B4-BE49-F238E27FC236}">
                <a16:creationId xmlns:a16="http://schemas.microsoft.com/office/drawing/2014/main" id="{F34B71C8-D885-4369-934C-08CA78F9CAFB}"/>
              </a:ext>
            </a:extLst>
          </p:cNvPr>
          <p:cNvCxnSpPr/>
          <p:nvPr/>
        </p:nvCxnSpPr>
        <p:spPr>
          <a:xfrm flipV="1">
            <a:off x="10727629" y="3490620"/>
            <a:ext cx="0" cy="3850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 name="TextBox 6">
            <a:extLst>
              <a:ext uri="{FF2B5EF4-FFF2-40B4-BE49-F238E27FC236}">
                <a16:creationId xmlns:a16="http://schemas.microsoft.com/office/drawing/2014/main" id="{FE1641C4-0FDA-47FF-8492-26FD269A8ECD}"/>
              </a:ext>
            </a:extLst>
          </p:cNvPr>
          <p:cNvSpPr txBox="1"/>
          <p:nvPr/>
        </p:nvSpPr>
        <p:spPr>
          <a:xfrm>
            <a:off x="4159691" y="3913990"/>
            <a:ext cx="1060156" cy="239296"/>
          </a:xfrm>
          <a:prstGeom prst="rect">
            <a:avLst/>
          </a:prstGeom>
          <a:noFill/>
        </p:spPr>
        <p:txBody>
          <a:bodyPr wrap="square" rtlCol="0">
            <a:spAutoFit/>
          </a:bodyPr>
          <a:lstStyle/>
          <a:p>
            <a:r>
              <a:rPr lang="en-US" sz="955" dirty="0">
                <a:latin typeface="Arial" panose="020B0604020202020204" pitchFamily="34" charset="0"/>
                <a:cs typeface="Arial" panose="020B0604020202020204" pitchFamily="34" charset="0"/>
              </a:rPr>
              <a:t>Groups 1</a:t>
            </a:r>
          </a:p>
        </p:txBody>
      </p:sp>
      <p:sp>
        <p:nvSpPr>
          <p:cNvPr id="16" name="TextBox 15">
            <a:extLst>
              <a:ext uri="{FF2B5EF4-FFF2-40B4-BE49-F238E27FC236}">
                <a16:creationId xmlns:a16="http://schemas.microsoft.com/office/drawing/2014/main" id="{C295B1D4-9D1E-4811-9CB2-468F6A541975}"/>
              </a:ext>
            </a:extLst>
          </p:cNvPr>
          <p:cNvSpPr txBox="1"/>
          <p:nvPr/>
        </p:nvSpPr>
        <p:spPr>
          <a:xfrm>
            <a:off x="6181770" y="3903498"/>
            <a:ext cx="1060156" cy="239296"/>
          </a:xfrm>
          <a:prstGeom prst="rect">
            <a:avLst/>
          </a:prstGeom>
          <a:noFill/>
        </p:spPr>
        <p:txBody>
          <a:bodyPr wrap="square" rtlCol="0">
            <a:spAutoFit/>
          </a:bodyPr>
          <a:lstStyle/>
          <a:p>
            <a:r>
              <a:rPr lang="en-US" sz="955" dirty="0">
                <a:latin typeface="Arial" panose="020B0604020202020204" pitchFamily="34" charset="0"/>
                <a:cs typeface="Arial" panose="020B0604020202020204" pitchFamily="34" charset="0"/>
              </a:rPr>
              <a:t>Groups 2</a:t>
            </a:r>
          </a:p>
        </p:txBody>
      </p:sp>
      <p:sp>
        <p:nvSpPr>
          <p:cNvPr id="17" name="TextBox 16">
            <a:extLst>
              <a:ext uri="{FF2B5EF4-FFF2-40B4-BE49-F238E27FC236}">
                <a16:creationId xmlns:a16="http://schemas.microsoft.com/office/drawing/2014/main" id="{CD211447-8769-40F9-AEDE-3BEE64BA1251}"/>
              </a:ext>
            </a:extLst>
          </p:cNvPr>
          <p:cNvSpPr txBox="1"/>
          <p:nvPr/>
        </p:nvSpPr>
        <p:spPr>
          <a:xfrm>
            <a:off x="8180492" y="3903497"/>
            <a:ext cx="1060156" cy="239296"/>
          </a:xfrm>
          <a:prstGeom prst="rect">
            <a:avLst/>
          </a:prstGeom>
          <a:noFill/>
        </p:spPr>
        <p:txBody>
          <a:bodyPr wrap="square" rtlCol="0">
            <a:spAutoFit/>
          </a:bodyPr>
          <a:lstStyle/>
          <a:p>
            <a:r>
              <a:rPr lang="en-US" sz="955" dirty="0">
                <a:latin typeface="Arial" panose="020B0604020202020204" pitchFamily="34" charset="0"/>
                <a:cs typeface="Arial" panose="020B0604020202020204" pitchFamily="34" charset="0"/>
              </a:rPr>
              <a:t>Groups 3</a:t>
            </a:r>
          </a:p>
        </p:txBody>
      </p:sp>
      <p:sp>
        <p:nvSpPr>
          <p:cNvPr id="18" name="TextBox 17">
            <a:extLst>
              <a:ext uri="{FF2B5EF4-FFF2-40B4-BE49-F238E27FC236}">
                <a16:creationId xmlns:a16="http://schemas.microsoft.com/office/drawing/2014/main" id="{98D65408-F7B4-45A5-BBC0-2F3CFB310E7A}"/>
              </a:ext>
            </a:extLst>
          </p:cNvPr>
          <p:cNvSpPr txBox="1"/>
          <p:nvPr/>
        </p:nvSpPr>
        <p:spPr>
          <a:xfrm>
            <a:off x="9897070" y="3903496"/>
            <a:ext cx="1060156" cy="239296"/>
          </a:xfrm>
          <a:prstGeom prst="rect">
            <a:avLst/>
          </a:prstGeom>
          <a:noFill/>
        </p:spPr>
        <p:txBody>
          <a:bodyPr wrap="square" rtlCol="0">
            <a:spAutoFit/>
          </a:bodyPr>
          <a:lstStyle/>
          <a:p>
            <a:r>
              <a:rPr lang="en-US" sz="955" dirty="0">
                <a:latin typeface="Arial" panose="020B0604020202020204" pitchFamily="34" charset="0"/>
                <a:cs typeface="Arial" panose="020B0604020202020204" pitchFamily="34" charset="0"/>
              </a:rPr>
              <a:t>Groups 4</a:t>
            </a:r>
          </a:p>
        </p:txBody>
      </p:sp>
      <p:sp>
        <p:nvSpPr>
          <p:cNvPr id="5" name="TextBox 4">
            <a:extLst>
              <a:ext uri="{FF2B5EF4-FFF2-40B4-BE49-F238E27FC236}">
                <a16:creationId xmlns:a16="http://schemas.microsoft.com/office/drawing/2014/main" id="{1A1DEA23-EC2C-41B8-AAD7-E3402FD1D103}"/>
              </a:ext>
            </a:extLst>
          </p:cNvPr>
          <p:cNvSpPr txBox="1"/>
          <p:nvPr/>
        </p:nvSpPr>
        <p:spPr>
          <a:xfrm>
            <a:off x="985441" y="4345663"/>
            <a:ext cx="3666578" cy="1345048"/>
          </a:xfrm>
          <a:prstGeom prst="rect">
            <a:avLst/>
          </a:prstGeom>
          <a:noFill/>
        </p:spPr>
        <p:txBody>
          <a:bodyPr wrap="square" rtlCol="0">
            <a:spAutoFit/>
          </a:bodyPr>
          <a:lstStyle/>
          <a:p>
            <a:pPr>
              <a:lnSpc>
                <a:spcPct val="150000"/>
              </a:lnSpc>
            </a:pPr>
            <a:r>
              <a:rPr lang="en-US" sz="1400" dirty="0">
                <a:latin typeface="Arial" panose="020B0604020202020204" pitchFamily="34" charset="0"/>
                <a:cs typeface="Arial" panose="020B0604020202020204" pitchFamily="34" charset="0"/>
              </a:rPr>
              <a:t>Group 1: Week 2 (n=3)</a:t>
            </a:r>
          </a:p>
          <a:p>
            <a:pPr>
              <a:lnSpc>
                <a:spcPct val="150000"/>
              </a:lnSpc>
            </a:pPr>
            <a:r>
              <a:rPr lang="en-US" sz="1400" dirty="0">
                <a:latin typeface="Arial" panose="020B0604020202020204" pitchFamily="34" charset="0"/>
                <a:cs typeface="Arial" panose="020B0604020202020204" pitchFamily="34" charset="0"/>
              </a:rPr>
              <a:t>Group 2: Week 4 (n=4)</a:t>
            </a:r>
          </a:p>
          <a:p>
            <a:pPr>
              <a:lnSpc>
                <a:spcPct val="150000"/>
              </a:lnSpc>
            </a:pPr>
            <a:r>
              <a:rPr lang="en-US" sz="1400" dirty="0">
                <a:latin typeface="Arial" panose="020B0604020202020204" pitchFamily="34" charset="0"/>
                <a:cs typeface="Arial" panose="020B0604020202020204" pitchFamily="34" charset="0"/>
              </a:rPr>
              <a:t>Group 3: Week 6 (n=4)</a:t>
            </a:r>
          </a:p>
          <a:p>
            <a:pPr>
              <a:lnSpc>
                <a:spcPct val="150000"/>
              </a:lnSpc>
            </a:pPr>
            <a:r>
              <a:rPr lang="en-US" sz="1400" dirty="0">
                <a:latin typeface="Arial" panose="020B0604020202020204" pitchFamily="34" charset="0"/>
                <a:cs typeface="Arial" panose="020B0604020202020204" pitchFamily="34" charset="0"/>
              </a:rPr>
              <a:t>Group 4: Week 8 (n=4)</a:t>
            </a:r>
          </a:p>
        </p:txBody>
      </p:sp>
      <p:sp>
        <p:nvSpPr>
          <p:cNvPr id="8" name="TextBox 7">
            <a:extLst>
              <a:ext uri="{FF2B5EF4-FFF2-40B4-BE49-F238E27FC236}">
                <a16:creationId xmlns:a16="http://schemas.microsoft.com/office/drawing/2014/main" id="{641EB1BC-CCB3-4B22-B2DF-6CFF4E885192}"/>
              </a:ext>
            </a:extLst>
          </p:cNvPr>
          <p:cNvSpPr txBox="1"/>
          <p:nvPr/>
        </p:nvSpPr>
        <p:spPr>
          <a:xfrm>
            <a:off x="917352" y="5983492"/>
            <a:ext cx="2234907"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Figure S1. Study timeline.</a:t>
            </a:r>
          </a:p>
        </p:txBody>
      </p:sp>
    </p:spTree>
    <p:extLst>
      <p:ext uri="{BB962C8B-B14F-4D97-AF65-F5344CB8AC3E}">
        <p14:creationId xmlns:p14="http://schemas.microsoft.com/office/powerpoint/2010/main" val="376279633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17FD5EC3-3B22-4144-AE0F-3EEBD7031F40}"/>
              </a:ext>
            </a:extLst>
          </p:cNvPr>
          <p:cNvSpPr/>
          <p:nvPr/>
        </p:nvSpPr>
        <p:spPr>
          <a:xfrm>
            <a:off x="136525" y="5677420"/>
            <a:ext cx="11565466" cy="1002775"/>
          </a:xfrm>
          <a:prstGeom prst="rect">
            <a:avLst/>
          </a:prstGeom>
        </p:spPr>
        <p:txBody>
          <a:bodyPr wrap="square">
            <a:spAutoFit/>
          </a:bodyPr>
          <a:lstStyle/>
          <a:p>
            <a:pPr marL="457200" marR="0">
              <a:lnSpc>
                <a:spcPct val="107000"/>
              </a:lnSpc>
              <a:spcBef>
                <a:spcPts val="0"/>
              </a:spcBef>
              <a:spcAft>
                <a:spcPts val="800"/>
              </a:spcAft>
            </a:pPr>
            <a:r>
              <a:rPr lang="en-US" sz="1400" dirty="0">
                <a:latin typeface="Arial" panose="020B0604020202020204" pitchFamily="34" charset="0"/>
                <a:ea typeface="Calibri" panose="020F0502020204030204" pitchFamily="34" charset="0"/>
                <a:cs typeface="Times New Roman" panose="02020603050405020304" pitchFamily="18" charset="0"/>
              </a:rPr>
              <a:t>Figure S2. Body weight of all rats in the pilot study remained in the vendor-supplied healthy range (+/- 1 standard deviation from the mean) or had a weight above the vendor supplied upper limit. Since we are worried about excessive weight loss as an indicator of decreased animal wellbeing, a body weight slightly above the vendor-supplied curve was viewed as a positive outcome. As indicated in the above figure, diet supplementation was given a couple days after surgery to help rats recover their weight after an observed weight decline.</a:t>
            </a:r>
            <a:endParaRPr lang="en-US" sz="14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7" name="TextBox 3">
            <a:extLst>
              <a:ext uri="{FF2B5EF4-FFF2-40B4-BE49-F238E27FC236}">
                <a16:creationId xmlns:a16="http://schemas.microsoft.com/office/drawing/2014/main" id="{C80CBAB1-9F04-4D4B-A836-AA1208AFA1C8}"/>
              </a:ext>
            </a:extLst>
          </p:cNvPr>
          <p:cNvSpPr txBox="1"/>
          <p:nvPr/>
        </p:nvSpPr>
        <p:spPr>
          <a:xfrm>
            <a:off x="17303749" y="6021646"/>
            <a:ext cx="466725" cy="295275"/>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r>
              <a:rPr lang="en-US" sz="1800">
                <a:latin typeface="Arial" panose="020B0604020202020204" pitchFamily="34" charset="0"/>
                <a:cs typeface="Arial" panose="020B0604020202020204" pitchFamily="34" charset="0"/>
              </a:rPr>
              <a:t>82</a:t>
            </a:r>
          </a:p>
        </p:txBody>
      </p:sp>
      <p:sp>
        <p:nvSpPr>
          <p:cNvPr id="8" name="TextBox 5">
            <a:extLst>
              <a:ext uri="{FF2B5EF4-FFF2-40B4-BE49-F238E27FC236}">
                <a16:creationId xmlns:a16="http://schemas.microsoft.com/office/drawing/2014/main" id="{6F9D08A8-7F5A-41FF-B66B-9C64069E8863}"/>
              </a:ext>
            </a:extLst>
          </p:cNvPr>
          <p:cNvSpPr txBox="1"/>
          <p:nvPr/>
        </p:nvSpPr>
        <p:spPr>
          <a:xfrm>
            <a:off x="17665699" y="6031171"/>
            <a:ext cx="466725" cy="295275"/>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r>
              <a:rPr lang="en-US" sz="1800">
                <a:latin typeface="Arial" panose="020B0604020202020204" pitchFamily="34" charset="0"/>
                <a:cs typeface="Arial" panose="020B0604020202020204" pitchFamily="34" charset="0"/>
              </a:rPr>
              <a:t>88</a:t>
            </a:r>
          </a:p>
        </p:txBody>
      </p:sp>
      <p:grpSp>
        <p:nvGrpSpPr>
          <p:cNvPr id="2" name="Group 1">
            <a:extLst>
              <a:ext uri="{FF2B5EF4-FFF2-40B4-BE49-F238E27FC236}">
                <a16:creationId xmlns:a16="http://schemas.microsoft.com/office/drawing/2014/main" id="{00000000-0008-0000-0300-000008000000}"/>
              </a:ext>
            </a:extLst>
          </p:cNvPr>
          <p:cNvGrpSpPr/>
          <p:nvPr/>
        </p:nvGrpSpPr>
        <p:grpSpPr>
          <a:xfrm>
            <a:off x="2193339" y="88777"/>
            <a:ext cx="7802917" cy="5414084"/>
            <a:chOff x="0" y="0"/>
            <a:chExt cx="7981950" cy="5905500"/>
          </a:xfrm>
        </p:grpSpPr>
        <p:graphicFrame>
          <p:nvGraphicFramePr>
            <p:cNvPr id="3" name="Chart 2">
              <a:extLst>
                <a:ext uri="{FF2B5EF4-FFF2-40B4-BE49-F238E27FC236}">
                  <a16:creationId xmlns:a16="http://schemas.microsoft.com/office/drawing/2014/main" id="{00000000-0008-0000-0300-000003000000}"/>
                </a:ext>
              </a:extLst>
            </p:cNvPr>
            <p:cNvGraphicFramePr/>
            <p:nvPr>
              <p:extLst>
                <p:ext uri="{D42A27DB-BD31-4B8C-83A1-F6EECF244321}">
                  <p14:modId xmlns:p14="http://schemas.microsoft.com/office/powerpoint/2010/main" val="3672549156"/>
                </p:ext>
              </p:extLst>
            </p:nvPr>
          </p:nvGraphicFramePr>
          <p:xfrm>
            <a:off x="0" y="0"/>
            <a:ext cx="7981950" cy="5905500"/>
          </p:xfrm>
          <a:graphic>
            <a:graphicData uri="http://schemas.openxmlformats.org/drawingml/2006/chart">
              <c:chart xmlns:c="http://schemas.openxmlformats.org/drawingml/2006/chart" xmlns:r="http://schemas.openxmlformats.org/officeDocument/2006/relationships" r:id="rId2"/>
            </a:graphicData>
          </a:graphic>
        </p:graphicFrame>
        <p:sp>
          <p:nvSpPr>
            <p:cNvPr id="4" name="TextBox 6">
              <a:extLst>
                <a:ext uri="{FF2B5EF4-FFF2-40B4-BE49-F238E27FC236}">
                  <a16:creationId xmlns:a16="http://schemas.microsoft.com/office/drawing/2014/main" id="{00000000-0008-0000-0300-000007000000}"/>
                </a:ext>
              </a:extLst>
            </p:cNvPr>
            <p:cNvSpPr txBox="1"/>
            <p:nvPr/>
          </p:nvSpPr>
          <p:spPr>
            <a:xfrm>
              <a:off x="5264763" y="1940439"/>
              <a:ext cx="295275" cy="238125"/>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r>
                <a:rPr lang="en-US" sz="1800" b="1" dirty="0">
                  <a:solidFill>
                    <a:srgbClr val="92D050"/>
                  </a:solidFill>
                </a:rPr>
                <a:t>*</a:t>
              </a:r>
            </a:p>
          </p:txBody>
        </p:sp>
      </p:grpSp>
    </p:spTree>
    <p:extLst>
      <p:ext uri="{BB962C8B-B14F-4D97-AF65-F5344CB8AC3E}">
        <p14:creationId xmlns:p14="http://schemas.microsoft.com/office/powerpoint/2010/main" val="209292664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D23A7AFD-2E17-496C-B2F6-42C81C6C9E8C}"/>
              </a:ext>
            </a:extLst>
          </p:cNvPr>
          <p:cNvGrpSpPr/>
          <p:nvPr/>
        </p:nvGrpSpPr>
        <p:grpSpPr>
          <a:xfrm>
            <a:off x="1722366" y="955581"/>
            <a:ext cx="8409379" cy="3843308"/>
            <a:chOff x="2872411" y="1361738"/>
            <a:chExt cx="4979886" cy="1940823"/>
          </a:xfrm>
        </p:grpSpPr>
        <p:pic>
          <p:nvPicPr>
            <p:cNvPr id="4" name="Content Placeholder 4">
              <a:extLst>
                <a:ext uri="{FF2B5EF4-FFF2-40B4-BE49-F238E27FC236}">
                  <a16:creationId xmlns:a16="http://schemas.microsoft.com/office/drawing/2014/main" id="{5A23FDA1-11A7-4832-980F-30DEC8C67957}"/>
                </a:ext>
              </a:extLst>
            </p:cNvPr>
            <p:cNvPicPr>
              <a:picLocks noChangeAspect="1"/>
            </p:cNvPicPr>
            <p:nvPr/>
          </p:nvPicPr>
          <p:blipFill rotWithShape="1">
            <a:blip r:embed="rId2">
              <a:extLst>
                <a:ext uri="{28A0092B-C50C-407E-A947-70E740481C1C}">
                  <a14:useLocalDpi xmlns:a14="http://schemas.microsoft.com/office/drawing/2010/main" val="0"/>
                </a:ext>
              </a:extLst>
            </a:blip>
            <a:srcRect l="69407" t="66103" r="25840" b="24893"/>
            <a:stretch/>
          </p:blipFill>
          <p:spPr>
            <a:xfrm>
              <a:off x="3071417" y="1831283"/>
              <a:ext cx="926935" cy="1461949"/>
            </a:xfrm>
            <a:prstGeom prst="rect">
              <a:avLst/>
            </a:prstGeom>
          </p:spPr>
        </p:pic>
        <p:sp>
          <p:nvSpPr>
            <p:cNvPr id="6" name="Rectangle 5">
              <a:extLst>
                <a:ext uri="{FF2B5EF4-FFF2-40B4-BE49-F238E27FC236}">
                  <a16:creationId xmlns:a16="http://schemas.microsoft.com/office/drawing/2014/main" id="{1CEDAE5F-3DAD-4CEA-8DD4-3C66CDDDE6F5}"/>
                </a:ext>
              </a:extLst>
            </p:cNvPr>
            <p:cNvSpPr/>
            <p:nvPr/>
          </p:nvSpPr>
          <p:spPr>
            <a:xfrm>
              <a:off x="2872411" y="1361738"/>
              <a:ext cx="1130823" cy="186508"/>
            </a:xfrm>
            <a:prstGeom prst="rect">
              <a:avLst/>
            </a:prstGeom>
          </p:spPr>
          <p:txBody>
            <a:bodyPr wrap="square">
              <a:spAutoFit/>
            </a:bodyPr>
            <a:lstStyle/>
            <a:p>
              <a:pPr algn="ctr"/>
              <a:r>
                <a:rPr lang="en-US" dirty="0">
                  <a:latin typeface="Arial" panose="020B0604020202020204" pitchFamily="34" charset="0"/>
                  <a:cs typeface="Arial" panose="020B0604020202020204" pitchFamily="34" charset="0"/>
                </a:rPr>
                <a:t>Day 1</a:t>
              </a:r>
            </a:p>
          </p:txBody>
        </p:sp>
        <p:sp>
          <p:nvSpPr>
            <p:cNvPr id="7" name="Rectangle 6">
              <a:extLst>
                <a:ext uri="{FF2B5EF4-FFF2-40B4-BE49-F238E27FC236}">
                  <a16:creationId xmlns:a16="http://schemas.microsoft.com/office/drawing/2014/main" id="{F1C2CC3F-2EF2-49F1-9DBB-AFCC048D6FAE}"/>
                </a:ext>
              </a:extLst>
            </p:cNvPr>
            <p:cNvSpPr/>
            <p:nvPr/>
          </p:nvSpPr>
          <p:spPr>
            <a:xfrm>
              <a:off x="3677231" y="1371600"/>
              <a:ext cx="1248056" cy="186508"/>
            </a:xfrm>
            <a:prstGeom prst="rect">
              <a:avLst/>
            </a:prstGeom>
          </p:spPr>
          <p:txBody>
            <a:bodyPr wrap="square">
              <a:spAutoFit/>
            </a:bodyPr>
            <a:lstStyle/>
            <a:p>
              <a:pPr lvl="0" algn="ctr">
                <a:defRPr/>
              </a:pPr>
              <a:r>
                <a:rPr lang="en-US" dirty="0">
                  <a:latin typeface="Arial" panose="020B0604020202020204" pitchFamily="34" charset="0"/>
                  <a:cs typeface="Arial" panose="020B0604020202020204" pitchFamily="34" charset="0"/>
                </a:rPr>
                <a:t>Week 2</a:t>
              </a:r>
            </a:p>
          </p:txBody>
        </p:sp>
        <p:pic>
          <p:nvPicPr>
            <p:cNvPr id="8" name="Picture 7">
              <a:extLst>
                <a:ext uri="{FF2B5EF4-FFF2-40B4-BE49-F238E27FC236}">
                  <a16:creationId xmlns:a16="http://schemas.microsoft.com/office/drawing/2014/main" id="{2C983761-DC60-4ACD-B32B-2FCEE6621338}"/>
                </a:ext>
              </a:extLst>
            </p:cNvPr>
            <p:cNvPicPr>
              <a:picLocks noChangeAspect="1"/>
            </p:cNvPicPr>
            <p:nvPr/>
          </p:nvPicPr>
          <p:blipFill rotWithShape="1">
            <a:blip r:embed="rId3">
              <a:extLst>
                <a:ext uri="{28A0092B-C50C-407E-A947-70E740481C1C}">
                  <a14:useLocalDpi xmlns:a14="http://schemas.microsoft.com/office/drawing/2010/main" val="0"/>
                </a:ext>
              </a:extLst>
            </a:blip>
            <a:srcRect l="51109" t="51104" r="44115" b="39809"/>
            <a:stretch/>
          </p:blipFill>
          <p:spPr>
            <a:xfrm>
              <a:off x="4002985" y="1831283"/>
              <a:ext cx="922302" cy="1461949"/>
            </a:xfrm>
            <a:prstGeom prst="rect">
              <a:avLst/>
            </a:prstGeom>
          </p:spPr>
        </p:pic>
        <p:pic>
          <p:nvPicPr>
            <p:cNvPr id="9" name="Picture 8">
              <a:extLst>
                <a:ext uri="{FF2B5EF4-FFF2-40B4-BE49-F238E27FC236}">
                  <a16:creationId xmlns:a16="http://schemas.microsoft.com/office/drawing/2014/main" id="{9B58CE2D-72BF-4EE7-B0D6-BFF4B159353F}"/>
                </a:ext>
              </a:extLst>
            </p:cNvPr>
            <p:cNvPicPr>
              <a:picLocks noChangeAspect="1"/>
            </p:cNvPicPr>
            <p:nvPr/>
          </p:nvPicPr>
          <p:blipFill rotWithShape="1">
            <a:blip r:embed="rId4">
              <a:extLst>
                <a:ext uri="{28A0092B-C50C-407E-A947-70E740481C1C}">
                  <a14:useLocalDpi xmlns:a14="http://schemas.microsoft.com/office/drawing/2010/main" val="0"/>
                </a:ext>
              </a:extLst>
            </a:blip>
            <a:srcRect l="54210" t="43753" r="40514" b="46261"/>
            <a:stretch/>
          </p:blipFill>
          <p:spPr>
            <a:xfrm>
              <a:off x="4925287" y="1831283"/>
              <a:ext cx="926935" cy="1461950"/>
            </a:xfrm>
            <a:prstGeom prst="rect">
              <a:avLst/>
            </a:prstGeom>
          </p:spPr>
        </p:pic>
        <p:sp>
          <p:nvSpPr>
            <p:cNvPr id="10" name="Rectangle 9">
              <a:extLst>
                <a:ext uri="{FF2B5EF4-FFF2-40B4-BE49-F238E27FC236}">
                  <a16:creationId xmlns:a16="http://schemas.microsoft.com/office/drawing/2014/main" id="{8A6CBC7C-C8D8-434F-B626-FD7FFB585B05}"/>
                </a:ext>
              </a:extLst>
            </p:cNvPr>
            <p:cNvSpPr/>
            <p:nvPr/>
          </p:nvSpPr>
          <p:spPr>
            <a:xfrm>
              <a:off x="4604166" y="1381462"/>
              <a:ext cx="1248056" cy="186508"/>
            </a:xfrm>
            <a:prstGeom prst="rect">
              <a:avLst/>
            </a:prstGeom>
          </p:spPr>
          <p:txBody>
            <a:bodyPr wrap="square">
              <a:spAutoFit/>
            </a:bodyPr>
            <a:lstStyle/>
            <a:p>
              <a:pPr lvl="0" algn="ctr">
                <a:defRPr/>
              </a:pPr>
              <a:r>
                <a:rPr lang="en-US" dirty="0">
                  <a:latin typeface="Arial" panose="020B0604020202020204" pitchFamily="34" charset="0"/>
                  <a:cs typeface="Arial" panose="020B0604020202020204" pitchFamily="34" charset="0"/>
                </a:rPr>
                <a:t>Week 4</a:t>
              </a:r>
            </a:p>
          </p:txBody>
        </p:sp>
        <p:sp>
          <p:nvSpPr>
            <p:cNvPr id="11" name="Rectangle 10">
              <a:extLst>
                <a:ext uri="{FF2B5EF4-FFF2-40B4-BE49-F238E27FC236}">
                  <a16:creationId xmlns:a16="http://schemas.microsoft.com/office/drawing/2014/main" id="{59230CA7-6400-40DC-8AD9-4DFFC1E2AB14}"/>
                </a:ext>
              </a:extLst>
            </p:cNvPr>
            <p:cNvSpPr/>
            <p:nvPr/>
          </p:nvSpPr>
          <p:spPr>
            <a:xfrm>
              <a:off x="5599404" y="1371600"/>
              <a:ext cx="1248056" cy="186508"/>
            </a:xfrm>
            <a:prstGeom prst="rect">
              <a:avLst/>
            </a:prstGeom>
          </p:spPr>
          <p:txBody>
            <a:bodyPr wrap="square">
              <a:spAutoFit/>
            </a:bodyPr>
            <a:lstStyle/>
            <a:p>
              <a:pPr lvl="0" algn="ctr">
                <a:defRPr/>
              </a:pPr>
              <a:r>
                <a:rPr lang="en-US" dirty="0">
                  <a:latin typeface="Arial" panose="020B0604020202020204" pitchFamily="34" charset="0"/>
                  <a:cs typeface="Arial" panose="020B0604020202020204" pitchFamily="34" charset="0"/>
                </a:rPr>
                <a:t>Week 6</a:t>
              </a:r>
            </a:p>
          </p:txBody>
        </p:sp>
        <p:pic>
          <p:nvPicPr>
            <p:cNvPr id="12" name="Picture 11">
              <a:extLst>
                <a:ext uri="{FF2B5EF4-FFF2-40B4-BE49-F238E27FC236}">
                  <a16:creationId xmlns:a16="http://schemas.microsoft.com/office/drawing/2014/main" id="{8FCC6155-9FF0-4995-9ED7-EF788BE392D2}"/>
                </a:ext>
              </a:extLst>
            </p:cNvPr>
            <p:cNvPicPr>
              <a:picLocks noChangeAspect="1"/>
            </p:cNvPicPr>
            <p:nvPr/>
          </p:nvPicPr>
          <p:blipFill rotWithShape="1">
            <a:blip r:embed="rId5">
              <a:extLst>
                <a:ext uri="{28A0092B-C50C-407E-A947-70E740481C1C}">
                  <a14:useLocalDpi xmlns:a14="http://schemas.microsoft.com/office/drawing/2010/main" val="0"/>
                </a:ext>
              </a:extLst>
            </a:blip>
            <a:srcRect l="59888" t="57864" r="34476" b="31413"/>
            <a:stretch/>
          </p:blipFill>
          <p:spPr>
            <a:xfrm>
              <a:off x="5845916" y="1840078"/>
              <a:ext cx="919342" cy="1457555"/>
            </a:xfrm>
            <a:prstGeom prst="rect">
              <a:avLst/>
            </a:prstGeom>
          </p:spPr>
        </p:pic>
        <p:sp>
          <p:nvSpPr>
            <p:cNvPr id="13" name="Rectangle 12">
              <a:extLst>
                <a:ext uri="{FF2B5EF4-FFF2-40B4-BE49-F238E27FC236}">
                  <a16:creationId xmlns:a16="http://schemas.microsoft.com/office/drawing/2014/main" id="{351287DB-B5E7-4091-8EC9-1D98CBEEC9EE}"/>
                </a:ext>
              </a:extLst>
            </p:cNvPr>
            <p:cNvSpPr/>
            <p:nvPr/>
          </p:nvSpPr>
          <p:spPr>
            <a:xfrm>
              <a:off x="6604241" y="1391328"/>
              <a:ext cx="1248056" cy="186508"/>
            </a:xfrm>
            <a:prstGeom prst="rect">
              <a:avLst/>
            </a:prstGeom>
          </p:spPr>
          <p:txBody>
            <a:bodyPr wrap="square">
              <a:spAutoFit/>
            </a:bodyPr>
            <a:lstStyle/>
            <a:p>
              <a:pPr lvl="0" algn="ctr">
                <a:defRPr/>
              </a:pPr>
              <a:r>
                <a:rPr lang="en-US" dirty="0">
                  <a:latin typeface="Arial" panose="020B0604020202020204" pitchFamily="34" charset="0"/>
                  <a:cs typeface="Arial" panose="020B0604020202020204" pitchFamily="34" charset="0"/>
                </a:rPr>
                <a:t>Week 8</a:t>
              </a:r>
            </a:p>
          </p:txBody>
        </p:sp>
        <p:pic>
          <p:nvPicPr>
            <p:cNvPr id="14" name="Picture 13">
              <a:extLst>
                <a:ext uri="{FF2B5EF4-FFF2-40B4-BE49-F238E27FC236}">
                  <a16:creationId xmlns:a16="http://schemas.microsoft.com/office/drawing/2014/main" id="{337A54A6-9505-4BDE-AB5A-8F689746B7B2}"/>
                </a:ext>
              </a:extLst>
            </p:cNvPr>
            <p:cNvPicPr>
              <a:picLocks noChangeAspect="1"/>
            </p:cNvPicPr>
            <p:nvPr/>
          </p:nvPicPr>
          <p:blipFill rotWithShape="1">
            <a:blip r:embed="rId5">
              <a:extLst>
                <a:ext uri="{28A0092B-C50C-407E-A947-70E740481C1C}">
                  <a14:useLocalDpi xmlns:a14="http://schemas.microsoft.com/office/drawing/2010/main" val="0"/>
                </a:ext>
              </a:extLst>
            </a:blip>
            <a:srcRect l="60412" t="57429" r="33528" b="30879"/>
            <a:stretch/>
          </p:blipFill>
          <p:spPr>
            <a:xfrm>
              <a:off x="6774523" y="1840078"/>
              <a:ext cx="909619" cy="1462483"/>
            </a:xfrm>
            <a:prstGeom prst="rect">
              <a:avLst/>
            </a:prstGeom>
          </p:spPr>
        </p:pic>
      </p:grpSp>
      <p:sp>
        <p:nvSpPr>
          <p:cNvPr id="3" name="TextBox 2">
            <a:extLst>
              <a:ext uri="{FF2B5EF4-FFF2-40B4-BE49-F238E27FC236}">
                <a16:creationId xmlns:a16="http://schemas.microsoft.com/office/drawing/2014/main" id="{279311A0-6C7D-4535-A42F-E7CC96871547}"/>
              </a:ext>
            </a:extLst>
          </p:cNvPr>
          <p:cNvSpPr txBox="1"/>
          <p:nvPr/>
        </p:nvSpPr>
        <p:spPr>
          <a:xfrm>
            <a:off x="600393" y="5378618"/>
            <a:ext cx="8564845"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Figure S3. Radiographs of the rat tibia at day 1, week 2, 4, 6, and 8. The fracture labeled with white arrow.</a:t>
            </a:r>
          </a:p>
        </p:txBody>
      </p:sp>
      <p:sp>
        <p:nvSpPr>
          <p:cNvPr id="15" name="Arrow: Right 14">
            <a:extLst>
              <a:ext uri="{FF2B5EF4-FFF2-40B4-BE49-F238E27FC236}">
                <a16:creationId xmlns:a16="http://schemas.microsoft.com/office/drawing/2014/main" id="{35AAE1BD-9AC5-414C-890F-5EEB4A5C1D62}"/>
              </a:ext>
            </a:extLst>
          </p:cNvPr>
          <p:cNvSpPr/>
          <p:nvPr/>
        </p:nvSpPr>
        <p:spPr>
          <a:xfrm rot="11560598">
            <a:off x="3081440" y="2876938"/>
            <a:ext cx="111195" cy="210065"/>
          </a:xfrm>
          <a:prstGeom prst="right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16" name="Arrow: Right 15">
            <a:extLst>
              <a:ext uri="{FF2B5EF4-FFF2-40B4-BE49-F238E27FC236}">
                <a16:creationId xmlns:a16="http://schemas.microsoft.com/office/drawing/2014/main" id="{01C8D0D1-3442-4E8D-9EF3-0F38299102C3}"/>
              </a:ext>
            </a:extLst>
          </p:cNvPr>
          <p:cNvSpPr/>
          <p:nvPr/>
        </p:nvSpPr>
        <p:spPr>
          <a:xfrm rot="11560598">
            <a:off x="4721834" y="2914664"/>
            <a:ext cx="111195" cy="210065"/>
          </a:xfrm>
          <a:prstGeom prst="right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17" name="Arrow: Right 16">
            <a:extLst>
              <a:ext uri="{FF2B5EF4-FFF2-40B4-BE49-F238E27FC236}">
                <a16:creationId xmlns:a16="http://schemas.microsoft.com/office/drawing/2014/main" id="{E1666F48-4175-4ECE-9325-40897006C71A}"/>
              </a:ext>
            </a:extLst>
          </p:cNvPr>
          <p:cNvSpPr/>
          <p:nvPr/>
        </p:nvSpPr>
        <p:spPr>
          <a:xfrm rot="11560598">
            <a:off x="6191225" y="3050564"/>
            <a:ext cx="111195" cy="210065"/>
          </a:xfrm>
          <a:prstGeom prst="right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27914130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a:extLst>
              <a:ext uri="{FF2B5EF4-FFF2-40B4-BE49-F238E27FC236}">
                <a16:creationId xmlns:a16="http://schemas.microsoft.com/office/drawing/2014/main" id="{55EF172B-56FB-4EAD-9D63-B7600F88952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94496" y="975616"/>
            <a:ext cx="2853903" cy="3088470"/>
          </a:xfrm>
          <a:prstGeom prst="rect">
            <a:avLst/>
          </a:prstGeom>
        </p:spPr>
      </p:pic>
      <p:sp>
        <p:nvSpPr>
          <p:cNvPr id="17" name="TextBox 16">
            <a:extLst>
              <a:ext uri="{FF2B5EF4-FFF2-40B4-BE49-F238E27FC236}">
                <a16:creationId xmlns:a16="http://schemas.microsoft.com/office/drawing/2014/main" id="{9A7E9778-B74F-438B-8466-19998CDEE672}"/>
              </a:ext>
            </a:extLst>
          </p:cNvPr>
          <p:cNvSpPr txBox="1"/>
          <p:nvPr/>
        </p:nvSpPr>
        <p:spPr>
          <a:xfrm>
            <a:off x="1374312" y="4221455"/>
            <a:ext cx="2056973" cy="646331"/>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Hard callus: green</a:t>
            </a:r>
          </a:p>
          <a:p>
            <a:r>
              <a:rPr lang="en-US" dirty="0">
                <a:latin typeface="Arial" panose="020B0604020202020204" pitchFamily="34" charset="0"/>
                <a:cs typeface="Arial" panose="020B0604020202020204" pitchFamily="34" charset="0"/>
              </a:rPr>
              <a:t>Soft callus: blue</a:t>
            </a:r>
          </a:p>
        </p:txBody>
      </p:sp>
      <p:pic>
        <p:nvPicPr>
          <p:cNvPr id="19" name="Picture 18">
            <a:extLst>
              <a:ext uri="{FF2B5EF4-FFF2-40B4-BE49-F238E27FC236}">
                <a16:creationId xmlns:a16="http://schemas.microsoft.com/office/drawing/2014/main" id="{90CBB976-9CAC-4050-BDD0-9A0C8BEF81F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289197" y="975616"/>
            <a:ext cx="2847480" cy="3088470"/>
          </a:xfrm>
          <a:prstGeom prst="rect">
            <a:avLst/>
          </a:prstGeom>
        </p:spPr>
      </p:pic>
      <p:sp>
        <p:nvSpPr>
          <p:cNvPr id="21" name="Rectangle 20">
            <a:extLst>
              <a:ext uri="{FF2B5EF4-FFF2-40B4-BE49-F238E27FC236}">
                <a16:creationId xmlns:a16="http://schemas.microsoft.com/office/drawing/2014/main" id="{3B05F9A5-F280-4886-A8F0-FDC6BB0A1F7E}"/>
              </a:ext>
            </a:extLst>
          </p:cNvPr>
          <p:cNvSpPr/>
          <p:nvPr/>
        </p:nvSpPr>
        <p:spPr>
          <a:xfrm>
            <a:off x="4081223" y="4242510"/>
            <a:ext cx="3263428" cy="1200329"/>
          </a:xfrm>
          <a:prstGeom prst="rect">
            <a:avLst/>
          </a:prstGeom>
        </p:spPr>
        <p:txBody>
          <a:bodyPr wrap="square">
            <a:spAutoFit/>
          </a:bodyPr>
          <a:lstStyle/>
          <a:p>
            <a:r>
              <a:rPr lang="en-US" dirty="0">
                <a:latin typeface="Arial" panose="020B0604020202020204" pitchFamily="34" charset="0"/>
                <a:cs typeface="Arial" panose="020B0604020202020204" pitchFamily="34" charset="0"/>
              </a:rPr>
              <a:t>Total tissue volume: green + red</a:t>
            </a:r>
          </a:p>
          <a:p>
            <a:r>
              <a:rPr lang="en-US" dirty="0">
                <a:latin typeface="Arial" panose="020B0604020202020204" pitchFamily="34" charset="0"/>
                <a:cs typeface="Arial" panose="020B0604020202020204" pitchFamily="34" charset="0"/>
              </a:rPr>
              <a:t>Total bone volume: red</a:t>
            </a:r>
          </a:p>
          <a:p>
            <a:r>
              <a:rPr lang="en-US" dirty="0">
                <a:latin typeface="Arial" panose="020B0604020202020204" pitchFamily="34" charset="0"/>
                <a:cs typeface="Arial" panose="020B0604020202020204" pitchFamily="34" charset="0"/>
              </a:rPr>
              <a:t>Soft tissue volume: blue</a:t>
            </a:r>
          </a:p>
        </p:txBody>
      </p:sp>
      <p:grpSp>
        <p:nvGrpSpPr>
          <p:cNvPr id="25" name="Group 24">
            <a:extLst>
              <a:ext uri="{FF2B5EF4-FFF2-40B4-BE49-F238E27FC236}">
                <a16:creationId xmlns:a16="http://schemas.microsoft.com/office/drawing/2014/main" id="{217F88A1-7380-47A0-B63B-6EB08099DB9A}"/>
              </a:ext>
            </a:extLst>
          </p:cNvPr>
          <p:cNvGrpSpPr/>
          <p:nvPr/>
        </p:nvGrpSpPr>
        <p:grpSpPr>
          <a:xfrm>
            <a:off x="7185142" y="975615"/>
            <a:ext cx="2476620" cy="3088470"/>
            <a:chOff x="1754684" y="673480"/>
            <a:chExt cx="4208072" cy="5081550"/>
          </a:xfrm>
        </p:grpSpPr>
        <p:pic>
          <p:nvPicPr>
            <p:cNvPr id="26" name="Picture 25">
              <a:extLst>
                <a:ext uri="{FF2B5EF4-FFF2-40B4-BE49-F238E27FC236}">
                  <a16:creationId xmlns:a16="http://schemas.microsoft.com/office/drawing/2014/main" id="{AF602F1F-7E09-48D7-9864-C6E38127EAE8}"/>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754684" y="673480"/>
              <a:ext cx="4208072" cy="5081550"/>
            </a:xfrm>
            <a:prstGeom prst="rect">
              <a:avLst/>
            </a:prstGeom>
          </p:spPr>
        </p:pic>
        <p:cxnSp>
          <p:nvCxnSpPr>
            <p:cNvPr id="27" name="Straight Connector 26">
              <a:extLst>
                <a:ext uri="{FF2B5EF4-FFF2-40B4-BE49-F238E27FC236}">
                  <a16:creationId xmlns:a16="http://schemas.microsoft.com/office/drawing/2014/main" id="{53593466-06B9-4213-B2AE-02D454910F00}"/>
                </a:ext>
              </a:extLst>
            </p:cNvPr>
            <p:cNvCxnSpPr>
              <a:cxnSpLocks/>
            </p:cNvCxnSpPr>
            <p:nvPr/>
          </p:nvCxnSpPr>
          <p:spPr>
            <a:xfrm>
              <a:off x="3105143" y="1241192"/>
              <a:ext cx="2219417" cy="1020932"/>
            </a:xfrm>
            <a:prstGeom prst="line">
              <a:avLst/>
            </a:prstGeom>
            <a:ln>
              <a:solidFill>
                <a:schemeClr val="accent6"/>
              </a:solidFill>
            </a:ln>
          </p:spPr>
          <p:style>
            <a:lnRef idx="1">
              <a:schemeClr val="accent1"/>
            </a:lnRef>
            <a:fillRef idx="0">
              <a:schemeClr val="accent1"/>
            </a:fillRef>
            <a:effectRef idx="0">
              <a:schemeClr val="accent1"/>
            </a:effectRef>
            <a:fontRef idx="minor">
              <a:schemeClr val="tx1"/>
            </a:fontRef>
          </p:style>
        </p:cxnSp>
        <p:cxnSp>
          <p:nvCxnSpPr>
            <p:cNvPr id="28" name="Straight Connector 27">
              <a:extLst>
                <a:ext uri="{FF2B5EF4-FFF2-40B4-BE49-F238E27FC236}">
                  <a16:creationId xmlns:a16="http://schemas.microsoft.com/office/drawing/2014/main" id="{C6866BA4-053E-4F66-883F-D82A28EB8E9A}"/>
                </a:ext>
              </a:extLst>
            </p:cNvPr>
            <p:cNvCxnSpPr/>
            <p:nvPr/>
          </p:nvCxnSpPr>
          <p:spPr>
            <a:xfrm flipV="1">
              <a:off x="2465951" y="3761442"/>
              <a:ext cx="2654423" cy="196317"/>
            </a:xfrm>
            <a:prstGeom prst="line">
              <a:avLst/>
            </a:prstGeom>
            <a:ln>
              <a:solidFill>
                <a:schemeClr val="accent6"/>
              </a:solidFill>
            </a:ln>
          </p:spPr>
          <p:style>
            <a:lnRef idx="1">
              <a:schemeClr val="accent1"/>
            </a:lnRef>
            <a:fillRef idx="0">
              <a:schemeClr val="accent1"/>
            </a:fillRef>
            <a:effectRef idx="0">
              <a:schemeClr val="accent1"/>
            </a:effectRef>
            <a:fontRef idx="minor">
              <a:schemeClr val="tx1"/>
            </a:fontRef>
          </p:style>
        </p:cxnSp>
        <p:sp>
          <p:nvSpPr>
            <p:cNvPr id="29" name="Freeform: Shape 28">
              <a:extLst>
                <a:ext uri="{FF2B5EF4-FFF2-40B4-BE49-F238E27FC236}">
                  <a16:creationId xmlns:a16="http://schemas.microsoft.com/office/drawing/2014/main" id="{F2DE3772-0B5C-40E5-AB9C-9257B559D77C}"/>
                </a:ext>
              </a:extLst>
            </p:cNvPr>
            <p:cNvSpPr/>
            <p:nvPr/>
          </p:nvSpPr>
          <p:spPr>
            <a:xfrm>
              <a:off x="2323908" y="1267825"/>
              <a:ext cx="763480" cy="2718145"/>
            </a:xfrm>
            <a:custGeom>
              <a:avLst/>
              <a:gdLst>
                <a:gd name="connsiteX0" fmla="*/ 763480 w 763480"/>
                <a:gd name="connsiteY0" fmla="*/ 0 h 2718145"/>
                <a:gd name="connsiteX1" fmla="*/ 754602 w 763480"/>
                <a:gd name="connsiteY1" fmla="*/ 53266 h 2718145"/>
                <a:gd name="connsiteX2" fmla="*/ 736847 w 763480"/>
                <a:gd name="connsiteY2" fmla="*/ 79899 h 2718145"/>
                <a:gd name="connsiteX3" fmla="*/ 719091 w 763480"/>
                <a:gd name="connsiteY3" fmla="*/ 115410 h 2718145"/>
                <a:gd name="connsiteX4" fmla="*/ 701336 w 763480"/>
                <a:gd name="connsiteY4" fmla="*/ 168676 h 2718145"/>
                <a:gd name="connsiteX5" fmla="*/ 692458 w 763480"/>
                <a:gd name="connsiteY5" fmla="*/ 195309 h 2718145"/>
                <a:gd name="connsiteX6" fmla="*/ 656948 w 763480"/>
                <a:gd name="connsiteY6" fmla="*/ 257453 h 2718145"/>
                <a:gd name="connsiteX7" fmla="*/ 621437 w 763480"/>
                <a:gd name="connsiteY7" fmla="*/ 310719 h 2718145"/>
                <a:gd name="connsiteX8" fmla="*/ 603682 w 763480"/>
                <a:gd name="connsiteY8" fmla="*/ 363985 h 2718145"/>
                <a:gd name="connsiteX9" fmla="*/ 585926 w 763480"/>
                <a:gd name="connsiteY9" fmla="*/ 399496 h 2718145"/>
                <a:gd name="connsiteX10" fmla="*/ 577048 w 763480"/>
                <a:gd name="connsiteY10" fmla="*/ 426129 h 2718145"/>
                <a:gd name="connsiteX11" fmla="*/ 541538 w 763480"/>
                <a:gd name="connsiteY11" fmla="*/ 479395 h 2718145"/>
                <a:gd name="connsiteX12" fmla="*/ 523782 w 763480"/>
                <a:gd name="connsiteY12" fmla="*/ 506028 h 2718145"/>
                <a:gd name="connsiteX13" fmla="*/ 514905 w 763480"/>
                <a:gd name="connsiteY13" fmla="*/ 532661 h 2718145"/>
                <a:gd name="connsiteX14" fmla="*/ 497149 w 763480"/>
                <a:gd name="connsiteY14" fmla="*/ 559294 h 2718145"/>
                <a:gd name="connsiteX15" fmla="*/ 488272 w 763480"/>
                <a:gd name="connsiteY15" fmla="*/ 594804 h 2718145"/>
                <a:gd name="connsiteX16" fmla="*/ 470516 w 763480"/>
                <a:gd name="connsiteY16" fmla="*/ 612560 h 2718145"/>
                <a:gd name="connsiteX17" fmla="*/ 452761 w 763480"/>
                <a:gd name="connsiteY17" fmla="*/ 648070 h 2718145"/>
                <a:gd name="connsiteX18" fmla="*/ 443883 w 763480"/>
                <a:gd name="connsiteY18" fmla="*/ 674703 h 2718145"/>
                <a:gd name="connsiteX19" fmla="*/ 426128 w 763480"/>
                <a:gd name="connsiteY19" fmla="*/ 701336 h 2718145"/>
                <a:gd name="connsiteX20" fmla="*/ 390617 w 763480"/>
                <a:gd name="connsiteY20" fmla="*/ 781235 h 2718145"/>
                <a:gd name="connsiteX21" fmla="*/ 363984 w 763480"/>
                <a:gd name="connsiteY21" fmla="*/ 825624 h 2718145"/>
                <a:gd name="connsiteX22" fmla="*/ 337351 w 763480"/>
                <a:gd name="connsiteY22" fmla="*/ 870012 h 2718145"/>
                <a:gd name="connsiteX23" fmla="*/ 328474 w 763480"/>
                <a:gd name="connsiteY23" fmla="*/ 905523 h 2718145"/>
                <a:gd name="connsiteX24" fmla="*/ 310718 w 763480"/>
                <a:gd name="connsiteY24" fmla="*/ 923278 h 2718145"/>
                <a:gd name="connsiteX25" fmla="*/ 292963 w 763480"/>
                <a:gd name="connsiteY25" fmla="*/ 976544 h 2718145"/>
                <a:gd name="connsiteX26" fmla="*/ 266330 w 763480"/>
                <a:gd name="connsiteY26" fmla="*/ 1029810 h 2718145"/>
                <a:gd name="connsiteX27" fmla="*/ 230819 w 763480"/>
                <a:gd name="connsiteY27" fmla="*/ 1091954 h 2718145"/>
                <a:gd name="connsiteX28" fmla="*/ 213064 w 763480"/>
                <a:gd name="connsiteY28" fmla="*/ 1145220 h 2718145"/>
                <a:gd name="connsiteX29" fmla="*/ 195309 w 763480"/>
                <a:gd name="connsiteY29" fmla="*/ 1171853 h 2718145"/>
                <a:gd name="connsiteX30" fmla="*/ 186431 w 763480"/>
                <a:gd name="connsiteY30" fmla="*/ 1198486 h 2718145"/>
                <a:gd name="connsiteX31" fmla="*/ 159798 w 763480"/>
                <a:gd name="connsiteY31" fmla="*/ 1225119 h 2718145"/>
                <a:gd name="connsiteX32" fmla="*/ 150920 w 763480"/>
                <a:gd name="connsiteY32" fmla="*/ 1251752 h 2718145"/>
                <a:gd name="connsiteX33" fmla="*/ 115410 w 763480"/>
                <a:gd name="connsiteY33" fmla="*/ 1313896 h 2718145"/>
                <a:gd name="connsiteX34" fmla="*/ 97654 w 763480"/>
                <a:gd name="connsiteY34" fmla="*/ 1376039 h 2718145"/>
                <a:gd name="connsiteX35" fmla="*/ 88777 w 763480"/>
                <a:gd name="connsiteY35" fmla="*/ 1402672 h 2718145"/>
                <a:gd name="connsiteX36" fmla="*/ 79899 w 763480"/>
                <a:gd name="connsiteY36" fmla="*/ 1438183 h 2718145"/>
                <a:gd name="connsiteX37" fmla="*/ 62144 w 763480"/>
                <a:gd name="connsiteY37" fmla="*/ 1491449 h 2718145"/>
                <a:gd name="connsiteX38" fmla="*/ 44388 w 763480"/>
                <a:gd name="connsiteY38" fmla="*/ 1553593 h 2718145"/>
                <a:gd name="connsiteX39" fmla="*/ 35511 w 763480"/>
                <a:gd name="connsiteY39" fmla="*/ 1624614 h 2718145"/>
                <a:gd name="connsiteX40" fmla="*/ 17755 w 763480"/>
                <a:gd name="connsiteY40" fmla="*/ 2032987 h 2718145"/>
                <a:gd name="connsiteX41" fmla="*/ 0 w 763480"/>
                <a:gd name="connsiteY41" fmla="*/ 2095130 h 2718145"/>
                <a:gd name="connsiteX42" fmla="*/ 8878 w 763480"/>
                <a:gd name="connsiteY42" fmla="*/ 2121763 h 2718145"/>
                <a:gd name="connsiteX43" fmla="*/ 26633 w 763480"/>
                <a:gd name="connsiteY43" fmla="*/ 2148396 h 2718145"/>
                <a:gd name="connsiteX44" fmla="*/ 35511 w 763480"/>
                <a:gd name="connsiteY44" fmla="*/ 2459115 h 2718145"/>
                <a:gd name="connsiteX45" fmla="*/ 44388 w 763480"/>
                <a:gd name="connsiteY45" fmla="*/ 2494626 h 2718145"/>
                <a:gd name="connsiteX46" fmla="*/ 53266 w 763480"/>
                <a:gd name="connsiteY46" fmla="*/ 2539014 h 2718145"/>
                <a:gd name="connsiteX47" fmla="*/ 88777 w 763480"/>
                <a:gd name="connsiteY47" fmla="*/ 2636668 h 2718145"/>
                <a:gd name="connsiteX48" fmla="*/ 124287 w 763480"/>
                <a:gd name="connsiteY48" fmla="*/ 2716567 h 2718145"/>
                <a:gd name="connsiteX49" fmla="*/ 142043 w 763480"/>
                <a:gd name="connsiteY49" fmla="*/ 2716567 h 271814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Lst>
              <a:rect l="l" t="t" r="r" b="b"/>
              <a:pathLst>
                <a:path w="763480" h="2718145">
                  <a:moveTo>
                    <a:pt x="763480" y="0"/>
                  </a:moveTo>
                  <a:cubicBezTo>
                    <a:pt x="760521" y="17755"/>
                    <a:pt x="760294" y="36189"/>
                    <a:pt x="754602" y="53266"/>
                  </a:cubicBezTo>
                  <a:cubicBezTo>
                    <a:pt x="751228" y="63388"/>
                    <a:pt x="742141" y="70635"/>
                    <a:pt x="736847" y="79899"/>
                  </a:cubicBezTo>
                  <a:cubicBezTo>
                    <a:pt x="730281" y="91390"/>
                    <a:pt x="724006" y="103122"/>
                    <a:pt x="719091" y="115410"/>
                  </a:cubicBezTo>
                  <a:cubicBezTo>
                    <a:pt x="712140" y="132787"/>
                    <a:pt x="707254" y="150921"/>
                    <a:pt x="701336" y="168676"/>
                  </a:cubicBezTo>
                  <a:cubicBezTo>
                    <a:pt x="698377" y="177554"/>
                    <a:pt x="697649" y="187523"/>
                    <a:pt x="692458" y="195309"/>
                  </a:cubicBezTo>
                  <a:cubicBezTo>
                    <a:pt x="631029" y="287454"/>
                    <a:pt x="724540" y="144799"/>
                    <a:pt x="656948" y="257453"/>
                  </a:cubicBezTo>
                  <a:cubicBezTo>
                    <a:pt x="645969" y="275751"/>
                    <a:pt x="628185" y="290475"/>
                    <a:pt x="621437" y="310719"/>
                  </a:cubicBezTo>
                  <a:cubicBezTo>
                    <a:pt x="615519" y="328474"/>
                    <a:pt x="612052" y="347245"/>
                    <a:pt x="603682" y="363985"/>
                  </a:cubicBezTo>
                  <a:cubicBezTo>
                    <a:pt x="597763" y="375822"/>
                    <a:pt x="591139" y="387332"/>
                    <a:pt x="585926" y="399496"/>
                  </a:cubicBezTo>
                  <a:cubicBezTo>
                    <a:pt x="582240" y="408097"/>
                    <a:pt x="581593" y="417949"/>
                    <a:pt x="577048" y="426129"/>
                  </a:cubicBezTo>
                  <a:cubicBezTo>
                    <a:pt x="566685" y="444783"/>
                    <a:pt x="553375" y="461640"/>
                    <a:pt x="541538" y="479395"/>
                  </a:cubicBezTo>
                  <a:lnTo>
                    <a:pt x="523782" y="506028"/>
                  </a:lnTo>
                  <a:cubicBezTo>
                    <a:pt x="520823" y="514906"/>
                    <a:pt x="519090" y="524291"/>
                    <a:pt x="514905" y="532661"/>
                  </a:cubicBezTo>
                  <a:cubicBezTo>
                    <a:pt x="510133" y="542204"/>
                    <a:pt x="501352" y="549487"/>
                    <a:pt x="497149" y="559294"/>
                  </a:cubicBezTo>
                  <a:cubicBezTo>
                    <a:pt x="492343" y="570508"/>
                    <a:pt x="493728" y="583891"/>
                    <a:pt x="488272" y="594804"/>
                  </a:cubicBezTo>
                  <a:cubicBezTo>
                    <a:pt x="484529" y="602291"/>
                    <a:pt x="475159" y="605596"/>
                    <a:pt x="470516" y="612560"/>
                  </a:cubicBezTo>
                  <a:cubicBezTo>
                    <a:pt x="463175" y="623571"/>
                    <a:pt x="457974" y="635906"/>
                    <a:pt x="452761" y="648070"/>
                  </a:cubicBezTo>
                  <a:cubicBezTo>
                    <a:pt x="449075" y="656671"/>
                    <a:pt x="448068" y="666333"/>
                    <a:pt x="443883" y="674703"/>
                  </a:cubicBezTo>
                  <a:cubicBezTo>
                    <a:pt x="439111" y="684246"/>
                    <a:pt x="430461" y="691586"/>
                    <a:pt x="426128" y="701336"/>
                  </a:cubicBezTo>
                  <a:cubicBezTo>
                    <a:pt x="383872" y="796413"/>
                    <a:pt x="430799" y="720964"/>
                    <a:pt x="390617" y="781235"/>
                  </a:cubicBezTo>
                  <a:cubicBezTo>
                    <a:pt x="365471" y="856680"/>
                    <a:pt x="400542" y="764693"/>
                    <a:pt x="363984" y="825624"/>
                  </a:cubicBezTo>
                  <a:cubicBezTo>
                    <a:pt x="329412" y="883244"/>
                    <a:pt x="382339" y="825026"/>
                    <a:pt x="337351" y="870012"/>
                  </a:cubicBezTo>
                  <a:cubicBezTo>
                    <a:pt x="334392" y="881849"/>
                    <a:pt x="333931" y="894610"/>
                    <a:pt x="328474" y="905523"/>
                  </a:cubicBezTo>
                  <a:cubicBezTo>
                    <a:pt x="324731" y="913009"/>
                    <a:pt x="314461" y="915792"/>
                    <a:pt x="310718" y="923278"/>
                  </a:cubicBezTo>
                  <a:cubicBezTo>
                    <a:pt x="302348" y="940018"/>
                    <a:pt x="303344" y="960971"/>
                    <a:pt x="292963" y="976544"/>
                  </a:cubicBezTo>
                  <a:cubicBezTo>
                    <a:pt x="242080" y="1052870"/>
                    <a:pt x="303085" y="956300"/>
                    <a:pt x="266330" y="1029810"/>
                  </a:cubicBezTo>
                  <a:cubicBezTo>
                    <a:pt x="234303" y="1093864"/>
                    <a:pt x="261944" y="1014142"/>
                    <a:pt x="230819" y="1091954"/>
                  </a:cubicBezTo>
                  <a:cubicBezTo>
                    <a:pt x="223868" y="1109331"/>
                    <a:pt x="223445" y="1129647"/>
                    <a:pt x="213064" y="1145220"/>
                  </a:cubicBezTo>
                  <a:cubicBezTo>
                    <a:pt x="207146" y="1154098"/>
                    <a:pt x="200081" y="1162310"/>
                    <a:pt x="195309" y="1171853"/>
                  </a:cubicBezTo>
                  <a:cubicBezTo>
                    <a:pt x="191124" y="1180223"/>
                    <a:pt x="191622" y="1190700"/>
                    <a:pt x="186431" y="1198486"/>
                  </a:cubicBezTo>
                  <a:cubicBezTo>
                    <a:pt x="179467" y="1208932"/>
                    <a:pt x="168676" y="1216241"/>
                    <a:pt x="159798" y="1225119"/>
                  </a:cubicBezTo>
                  <a:cubicBezTo>
                    <a:pt x="156839" y="1233997"/>
                    <a:pt x="155105" y="1243382"/>
                    <a:pt x="150920" y="1251752"/>
                  </a:cubicBezTo>
                  <a:cubicBezTo>
                    <a:pt x="106342" y="1340908"/>
                    <a:pt x="162101" y="1204949"/>
                    <a:pt x="115410" y="1313896"/>
                  </a:cubicBezTo>
                  <a:cubicBezTo>
                    <a:pt x="106288" y="1335182"/>
                    <a:pt x="104090" y="1353514"/>
                    <a:pt x="97654" y="1376039"/>
                  </a:cubicBezTo>
                  <a:cubicBezTo>
                    <a:pt x="95083" y="1385037"/>
                    <a:pt x="91348" y="1393674"/>
                    <a:pt x="88777" y="1402672"/>
                  </a:cubicBezTo>
                  <a:cubicBezTo>
                    <a:pt x="85425" y="1414404"/>
                    <a:pt x="83405" y="1426496"/>
                    <a:pt x="79899" y="1438183"/>
                  </a:cubicBezTo>
                  <a:cubicBezTo>
                    <a:pt x="74521" y="1456109"/>
                    <a:pt x="66683" y="1473292"/>
                    <a:pt x="62144" y="1491449"/>
                  </a:cubicBezTo>
                  <a:cubicBezTo>
                    <a:pt x="50996" y="1536038"/>
                    <a:pt x="57125" y="1515385"/>
                    <a:pt x="44388" y="1553593"/>
                  </a:cubicBezTo>
                  <a:cubicBezTo>
                    <a:pt x="41429" y="1577267"/>
                    <a:pt x="36525" y="1600778"/>
                    <a:pt x="35511" y="1624614"/>
                  </a:cubicBezTo>
                  <a:cubicBezTo>
                    <a:pt x="29577" y="1764068"/>
                    <a:pt x="42329" y="1897825"/>
                    <a:pt x="17755" y="2032987"/>
                  </a:cubicBezTo>
                  <a:cubicBezTo>
                    <a:pt x="13295" y="2057516"/>
                    <a:pt x="7608" y="2072308"/>
                    <a:pt x="0" y="2095130"/>
                  </a:cubicBezTo>
                  <a:cubicBezTo>
                    <a:pt x="2959" y="2104008"/>
                    <a:pt x="4693" y="2113393"/>
                    <a:pt x="8878" y="2121763"/>
                  </a:cubicBezTo>
                  <a:cubicBezTo>
                    <a:pt x="13650" y="2131306"/>
                    <a:pt x="25793" y="2137760"/>
                    <a:pt x="26633" y="2148396"/>
                  </a:cubicBezTo>
                  <a:cubicBezTo>
                    <a:pt x="34788" y="2251690"/>
                    <a:pt x="30204" y="2355636"/>
                    <a:pt x="35511" y="2459115"/>
                  </a:cubicBezTo>
                  <a:cubicBezTo>
                    <a:pt x="36136" y="2471300"/>
                    <a:pt x="41741" y="2482715"/>
                    <a:pt x="44388" y="2494626"/>
                  </a:cubicBezTo>
                  <a:cubicBezTo>
                    <a:pt x="47661" y="2509356"/>
                    <a:pt x="49873" y="2524311"/>
                    <a:pt x="53266" y="2539014"/>
                  </a:cubicBezTo>
                  <a:cubicBezTo>
                    <a:pt x="71216" y="2616797"/>
                    <a:pt x="58531" y="2591301"/>
                    <a:pt x="88777" y="2636668"/>
                  </a:cubicBezTo>
                  <a:cubicBezTo>
                    <a:pt x="93454" y="2650699"/>
                    <a:pt x="105530" y="2702499"/>
                    <a:pt x="124287" y="2716567"/>
                  </a:cubicBezTo>
                  <a:cubicBezTo>
                    <a:pt x="129022" y="2720118"/>
                    <a:pt x="136124" y="2716567"/>
                    <a:pt x="142043" y="2716567"/>
                  </a:cubicBezTo>
                </a:path>
              </a:pathLst>
            </a:custGeom>
            <a:no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30" name="Freeform: Shape 29">
              <a:extLst>
                <a:ext uri="{FF2B5EF4-FFF2-40B4-BE49-F238E27FC236}">
                  <a16:creationId xmlns:a16="http://schemas.microsoft.com/office/drawing/2014/main" id="{6774EA51-8E80-4277-9493-D2990406181C}"/>
                </a:ext>
              </a:extLst>
            </p:cNvPr>
            <p:cNvSpPr/>
            <p:nvPr/>
          </p:nvSpPr>
          <p:spPr>
            <a:xfrm>
              <a:off x="4929440" y="2279880"/>
              <a:ext cx="386243" cy="1491448"/>
            </a:xfrm>
            <a:custGeom>
              <a:avLst/>
              <a:gdLst>
                <a:gd name="connsiteX0" fmla="*/ 386243 w 386243"/>
                <a:gd name="connsiteY0" fmla="*/ 0 h 1491448"/>
                <a:gd name="connsiteX1" fmla="*/ 341854 w 386243"/>
                <a:gd name="connsiteY1" fmla="*/ 35510 h 1491448"/>
                <a:gd name="connsiteX2" fmla="*/ 315221 w 386243"/>
                <a:gd name="connsiteY2" fmla="*/ 88776 h 1491448"/>
                <a:gd name="connsiteX3" fmla="*/ 297466 w 386243"/>
                <a:gd name="connsiteY3" fmla="*/ 106532 h 1491448"/>
                <a:gd name="connsiteX4" fmla="*/ 253078 w 386243"/>
                <a:gd name="connsiteY4" fmla="*/ 186431 h 1491448"/>
                <a:gd name="connsiteX5" fmla="*/ 235322 w 386243"/>
                <a:gd name="connsiteY5" fmla="*/ 213064 h 1491448"/>
                <a:gd name="connsiteX6" fmla="*/ 208689 w 386243"/>
                <a:gd name="connsiteY6" fmla="*/ 292963 h 1491448"/>
                <a:gd name="connsiteX7" fmla="*/ 199812 w 386243"/>
                <a:gd name="connsiteY7" fmla="*/ 319596 h 1491448"/>
                <a:gd name="connsiteX8" fmla="*/ 182056 w 386243"/>
                <a:gd name="connsiteY8" fmla="*/ 346229 h 1491448"/>
                <a:gd name="connsiteX9" fmla="*/ 164301 w 386243"/>
                <a:gd name="connsiteY9" fmla="*/ 381740 h 1491448"/>
                <a:gd name="connsiteX10" fmla="*/ 137668 w 386243"/>
                <a:gd name="connsiteY10" fmla="*/ 408373 h 1491448"/>
                <a:gd name="connsiteX11" fmla="*/ 111035 w 386243"/>
                <a:gd name="connsiteY11" fmla="*/ 461639 h 1491448"/>
                <a:gd name="connsiteX12" fmla="*/ 102157 w 386243"/>
                <a:gd name="connsiteY12" fmla="*/ 488272 h 1491448"/>
                <a:gd name="connsiteX13" fmla="*/ 66647 w 386243"/>
                <a:gd name="connsiteY13" fmla="*/ 541538 h 1491448"/>
                <a:gd name="connsiteX14" fmla="*/ 48891 w 386243"/>
                <a:gd name="connsiteY14" fmla="*/ 568171 h 1491448"/>
                <a:gd name="connsiteX15" fmla="*/ 13381 w 386243"/>
                <a:gd name="connsiteY15" fmla="*/ 648070 h 1491448"/>
                <a:gd name="connsiteX16" fmla="*/ 13381 w 386243"/>
                <a:gd name="connsiteY16" fmla="*/ 861134 h 1491448"/>
                <a:gd name="connsiteX17" fmla="*/ 40014 w 386243"/>
                <a:gd name="connsiteY17" fmla="*/ 878889 h 1491448"/>
                <a:gd name="connsiteX18" fmla="*/ 48891 w 386243"/>
                <a:gd name="connsiteY18" fmla="*/ 1047565 h 1491448"/>
                <a:gd name="connsiteX19" fmla="*/ 57769 w 386243"/>
                <a:gd name="connsiteY19" fmla="*/ 1083075 h 1491448"/>
                <a:gd name="connsiteX20" fmla="*/ 66647 w 386243"/>
                <a:gd name="connsiteY20" fmla="*/ 1127464 h 1491448"/>
                <a:gd name="connsiteX21" fmla="*/ 84402 w 386243"/>
                <a:gd name="connsiteY21" fmla="*/ 1180730 h 1491448"/>
                <a:gd name="connsiteX22" fmla="*/ 102157 w 386243"/>
                <a:gd name="connsiteY22" fmla="*/ 1260629 h 1491448"/>
                <a:gd name="connsiteX23" fmla="*/ 119913 w 386243"/>
                <a:gd name="connsiteY23" fmla="*/ 1340528 h 1491448"/>
                <a:gd name="connsiteX24" fmla="*/ 137668 w 386243"/>
                <a:gd name="connsiteY24" fmla="*/ 1393794 h 1491448"/>
                <a:gd name="connsiteX25" fmla="*/ 146546 w 386243"/>
                <a:gd name="connsiteY25" fmla="*/ 1420427 h 1491448"/>
                <a:gd name="connsiteX26" fmla="*/ 182056 w 386243"/>
                <a:gd name="connsiteY26" fmla="*/ 1491448 h 149144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Lst>
              <a:rect l="l" t="t" r="r" b="b"/>
              <a:pathLst>
                <a:path w="386243" h="1491448">
                  <a:moveTo>
                    <a:pt x="386243" y="0"/>
                  </a:moveTo>
                  <a:cubicBezTo>
                    <a:pt x="371447" y="11837"/>
                    <a:pt x="355253" y="22112"/>
                    <a:pt x="341854" y="35510"/>
                  </a:cubicBezTo>
                  <a:cubicBezTo>
                    <a:pt x="308184" y="69180"/>
                    <a:pt x="336879" y="52678"/>
                    <a:pt x="315221" y="88776"/>
                  </a:cubicBezTo>
                  <a:cubicBezTo>
                    <a:pt x="310915" y="95953"/>
                    <a:pt x="303384" y="100613"/>
                    <a:pt x="297466" y="106532"/>
                  </a:cubicBezTo>
                  <a:cubicBezTo>
                    <a:pt x="281840" y="153408"/>
                    <a:pt x="293778" y="125381"/>
                    <a:pt x="253078" y="186431"/>
                  </a:cubicBezTo>
                  <a:lnTo>
                    <a:pt x="235322" y="213064"/>
                  </a:lnTo>
                  <a:lnTo>
                    <a:pt x="208689" y="292963"/>
                  </a:lnTo>
                  <a:cubicBezTo>
                    <a:pt x="205730" y="301841"/>
                    <a:pt x="205003" y="311810"/>
                    <a:pt x="199812" y="319596"/>
                  </a:cubicBezTo>
                  <a:cubicBezTo>
                    <a:pt x="193893" y="328474"/>
                    <a:pt x="187350" y="336965"/>
                    <a:pt x="182056" y="346229"/>
                  </a:cubicBezTo>
                  <a:cubicBezTo>
                    <a:pt x="175490" y="357719"/>
                    <a:pt x="171993" y="370971"/>
                    <a:pt x="164301" y="381740"/>
                  </a:cubicBezTo>
                  <a:cubicBezTo>
                    <a:pt x="157004" y="391956"/>
                    <a:pt x="146546" y="399495"/>
                    <a:pt x="137668" y="408373"/>
                  </a:cubicBezTo>
                  <a:cubicBezTo>
                    <a:pt x="115353" y="475316"/>
                    <a:pt x="145454" y="392800"/>
                    <a:pt x="111035" y="461639"/>
                  </a:cubicBezTo>
                  <a:cubicBezTo>
                    <a:pt x="106850" y="470009"/>
                    <a:pt x="106702" y="480092"/>
                    <a:pt x="102157" y="488272"/>
                  </a:cubicBezTo>
                  <a:cubicBezTo>
                    <a:pt x="91794" y="506926"/>
                    <a:pt x="78484" y="523783"/>
                    <a:pt x="66647" y="541538"/>
                  </a:cubicBezTo>
                  <a:lnTo>
                    <a:pt x="48891" y="568171"/>
                  </a:lnTo>
                  <a:cubicBezTo>
                    <a:pt x="27762" y="631559"/>
                    <a:pt x="41517" y="605864"/>
                    <a:pt x="13381" y="648070"/>
                  </a:cubicBezTo>
                  <a:cubicBezTo>
                    <a:pt x="-329" y="730330"/>
                    <a:pt x="-8167" y="753393"/>
                    <a:pt x="13381" y="861134"/>
                  </a:cubicBezTo>
                  <a:cubicBezTo>
                    <a:pt x="15473" y="871596"/>
                    <a:pt x="31136" y="872971"/>
                    <a:pt x="40014" y="878889"/>
                  </a:cubicBezTo>
                  <a:cubicBezTo>
                    <a:pt x="42973" y="935114"/>
                    <a:pt x="44014" y="991474"/>
                    <a:pt x="48891" y="1047565"/>
                  </a:cubicBezTo>
                  <a:cubicBezTo>
                    <a:pt x="49948" y="1059720"/>
                    <a:pt x="55122" y="1071165"/>
                    <a:pt x="57769" y="1083075"/>
                  </a:cubicBezTo>
                  <a:cubicBezTo>
                    <a:pt x="61042" y="1097805"/>
                    <a:pt x="62677" y="1112906"/>
                    <a:pt x="66647" y="1127464"/>
                  </a:cubicBezTo>
                  <a:cubicBezTo>
                    <a:pt x="71571" y="1145520"/>
                    <a:pt x="81325" y="1162269"/>
                    <a:pt x="84402" y="1180730"/>
                  </a:cubicBezTo>
                  <a:cubicBezTo>
                    <a:pt x="108830" y="1327293"/>
                    <a:pt x="80304" y="1173216"/>
                    <a:pt x="102157" y="1260629"/>
                  </a:cubicBezTo>
                  <a:cubicBezTo>
                    <a:pt x="114827" y="1311311"/>
                    <a:pt x="106244" y="1294963"/>
                    <a:pt x="119913" y="1340528"/>
                  </a:cubicBezTo>
                  <a:cubicBezTo>
                    <a:pt x="125291" y="1358454"/>
                    <a:pt x="131750" y="1376039"/>
                    <a:pt x="137668" y="1393794"/>
                  </a:cubicBezTo>
                  <a:cubicBezTo>
                    <a:pt x="140627" y="1402672"/>
                    <a:pt x="141355" y="1412641"/>
                    <a:pt x="146546" y="1420427"/>
                  </a:cubicBezTo>
                  <a:cubicBezTo>
                    <a:pt x="185339" y="1478617"/>
                    <a:pt x="182056" y="1452354"/>
                    <a:pt x="182056" y="1491448"/>
                  </a:cubicBezTo>
                </a:path>
              </a:pathLst>
            </a:custGeom>
            <a:no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31" name="Freeform: Shape 30">
              <a:extLst>
                <a:ext uri="{FF2B5EF4-FFF2-40B4-BE49-F238E27FC236}">
                  <a16:creationId xmlns:a16="http://schemas.microsoft.com/office/drawing/2014/main" id="{709A51F8-AD8D-48A1-AE7E-652C9B8A8C89}"/>
                </a:ext>
              </a:extLst>
            </p:cNvPr>
            <p:cNvSpPr/>
            <p:nvPr/>
          </p:nvSpPr>
          <p:spPr>
            <a:xfrm>
              <a:off x="2768634" y="1304413"/>
              <a:ext cx="778130" cy="1192958"/>
            </a:xfrm>
            <a:custGeom>
              <a:avLst/>
              <a:gdLst>
                <a:gd name="connsiteX0" fmla="*/ 362493 w 778130"/>
                <a:gd name="connsiteY0" fmla="*/ 8816 h 1192958"/>
                <a:gd name="connsiteX1" fmla="*/ 344021 w 778130"/>
                <a:gd name="connsiteY1" fmla="*/ 82707 h 1192958"/>
                <a:gd name="connsiteX2" fmla="*/ 325548 w 778130"/>
                <a:gd name="connsiteY2" fmla="*/ 147362 h 1192958"/>
                <a:gd name="connsiteX3" fmla="*/ 307075 w 778130"/>
                <a:gd name="connsiteY3" fmla="*/ 175071 h 1192958"/>
                <a:gd name="connsiteX4" fmla="*/ 279366 w 778130"/>
                <a:gd name="connsiteY4" fmla="*/ 230489 h 1192958"/>
                <a:gd name="connsiteX5" fmla="*/ 251657 w 778130"/>
                <a:gd name="connsiteY5" fmla="*/ 285907 h 1192958"/>
                <a:gd name="connsiteX6" fmla="*/ 214712 w 778130"/>
                <a:gd name="connsiteY6" fmla="*/ 396744 h 1192958"/>
                <a:gd name="connsiteX7" fmla="*/ 205475 w 778130"/>
                <a:gd name="connsiteY7" fmla="*/ 424453 h 1192958"/>
                <a:gd name="connsiteX8" fmla="*/ 187003 w 778130"/>
                <a:gd name="connsiteY8" fmla="*/ 452162 h 1192958"/>
                <a:gd name="connsiteX9" fmla="*/ 177766 w 778130"/>
                <a:gd name="connsiteY9" fmla="*/ 479871 h 1192958"/>
                <a:gd name="connsiteX10" fmla="*/ 122348 w 778130"/>
                <a:gd name="connsiteY10" fmla="*/ 544526 h 1192958"/>
                <a:gd name="connsiteX11" fmla="*/ 94639 w 778130"/>
                <a:gd name="connsiteY11" fmla="*/ 599944 h 1192958"/>
                <a:gd name="connsiteX12" fmla="*/ 76166 w 778130"/>
                <a:gd name="connsiteY12" fmla="*/ 636889 h 1192958"/>
                <a:gd name="connsiteX13" fmla="*/ 66930 w 778130"/>
                <a:gd name="connsiteY13" fmla="*/ 664598 h 1192958"/>
                <a:gd name="connsiteX14" fmla="*/ 48457 w 778130"/>
                <a:gd name="connsiteY14" fmla="*/ 692307 h 1192958"/>
                <a:gd name="connsiteX15" fmla="*/ 20748 w 778130"/>
                <a:gd name="connsiteY15" fmla="*/ 775435 h 1192958"/>
                <a:gd name="connsiteX16" fmla="*/ 11512 w 778130"/>
                <a:gd name="connsiteY16" fmla="*/ 803144 h 1192958"/>
                <a:gd name="connsiteX17" fmla="*/ 11512 w 778130"/>
                <a:gd name="connsiteY17" fmla="*/ 1034053 h 1192958"/>
                <a:gd name="connsiteX18" fmla="*/ 57693 w 778130"/>
                <a:gd name="connsiteY18" fmla="*/ 1089471 h 1192958"/>
                <a:gd name="connsiteX19" fmla="*/ 140821 w 778130"/>
                <a:gd name="connsiteY19" fmla="*/ 1126416 h 1192958"/>
                <a:gd name="connsiteX20" fmla="*/ 177766 w 778130"/>
                <a:gd name="connsiteY20" fmla="*/ 1135653 h 1192958"/>
                <a:gd name="connsiteX21" fmla="*/ 242421 w 778130"/>
                <a:gd name="connsiteY21" fmla="*/ 1144889 h 1192958"/>
                <a:gd name="connsiteX22" fmla="*/ 279366 w 778130"/>
                <a:gd name="connsiteY22" fmla="*/ 1154126 h 1192958"/>
                <a:gd name="connsiteX23" fmla="*/ 334784 w 778130"/>
                <a:gd name="connsiteY23" fmla="*/ 1172598 h 1192958"/>
                <a:gd name="connsiteX24" fmla="*/ 390203 w 778130"/>
                <a:gd name="connsiteY24" fmla="*/ 1181835 h 1192958"/>
                <a:gd name="connsiteX25" fmla="*/ 408675 w 778130"/>
                <a:gd name="connsiteY25" fmla="*/ 1126416 h 1192958"/>
                <a:gd name="connsiteX26" fmla="*/ 427148 w 778130"/>
                <a:gd name="connsiteY26" fmla="*/ 1089471 h 1192958"/>
                <a:gd name="connsiteX27" fmla="*/ 436384 w 778130"/>
                <a:gd name="connsiteY27" fmla="*/ 1061762 h 1192958"/>
                <a:gd name="connsiteX28" fmla="*/ 454857 w 778130"/>
                <a:gd name="connsiteY28" fmla="*/ 1034053 h 1192958"/>
                <a:gd name="connsiteX29" fmla="*/ 482566 w 778130"/>
                <a:gd name="connsiteY29" fmla="*/ 969398 h 1192958"/>
                <a:gd name="connsiteX30" fmla="*/ 491803 w 778130"/>
                <a:gd name="connsiteY30" fmla="*/ 941689 h 1192958"/>
                <a:gd name="connsiteX31" fmla="*/ 510275 w 778130"/>
                <a:gd name="connsiteY31" fmla="*/ 867798 h 1192958"/>
                <a:gd name="connsiteX32" fmla="*/ 537984 w 778130"/>
                <a:gd name="connsiteY32" fmla="*/ 784671 h 1192958"/>
                <a:gd name="connsiteX33" fmla="*/ 556457 w 778130"/>
                <a:gd name="connsiteY33" fmla="*/ 729253 h 1192958"/>
                <a:gd name="connsiteX34" fmla="*/ 565693 w 778130"/>
                <a:gd name="connsiteY34" fmla="*/ 683071 h 1192958"/>
                <a:gd name="connsiteX35" fmla="*/ 584166 w 778130"/>
                <a:gd name="connsiteY35" fmla="*/ 627653 h 1192958"/>
                <a:gd name="connsiteX36" fmla="*/ 602639 w 778130"/>
                <a:gd name="connsiteY36" fmla="*/ 562998 h 1192958"/>
                <a:gd name="connsiteX37" fmla="*/ 621112 w 778130"/>
                <a:gd name="connsiteY37" fmla="*/ 526053 h 1192958"/>
                <a:gd name="connsiteX38" fmla="*/ 639584 w 778130"/>
                <a:gd name="connsiteY38" fmla="*/ 470635 h 1192958"/>
                <a:gd name="connsiteX39" fmla="*/ 648821 w 778130"/>
                <a:gd name="connsiteY39" fmla="*/ 442926 h 1192958"/>
                <a:gd name="connsiteX40" fmla="*/ 667293 w 778130"/>
                <a:gd name="connsiteY40" fmla="*/ 415216 h 1192958"/>
                <a:gd name="connsiteX41" fmla="*/ 676530 w 778130"/>
                <a:gd name="connsiteY41" fmla="*/ 387507 h 1192958"/>
                <a:gd name="connsiteX42" fmla="*/ 695003 w 778130"/>
                <a:gd name="connsiteY42" fmla="*/ 350562 h 1192958"/>
                <a:gd name="connsiteX43" fmla="*/ 731948 w 778130"/>
                <a:gd name="connsiteY43" fmla="*/ 267435 h 1192958"/>
                <a:gd name="connsiteX44" fmla="*/ 741184 w 778130"/>
                <a:gd name="connsiteY44" fmla="*/ 239726 h 1192958"/>
                <a:gd name="connsiteX45" fmla="*/ 759657 w 778130"/>
                <a:gd name="connsiteY45" fmla="*/ 212016 h 1192958"/>
                <a:gd name="connsiteX46" fmla="*/ 778130 w 778130"/>
                <a:gd name="connsiteY46" fmla="*/ 175071 h 1192958"/>
                <a:gd name="connsiteX47" fmla="*/ 750421 w 778130"/>
                <a:gd name="connsiteY47" fmla="*/ 147362 h 1192958"/>
                <a:gd name="connsiteX48" fmla="*/ 695003 w 778130"/>
                <a:gd name="connsiteY48" fmla="*/ 128889 h 1192958"/>
                <a:gd name="connsiteX49" fmla="*/ 639584 w 778130"/>
                <a:gd name="connsiteY49" fmla="*/ 110416 h 1192958"/>
                <a:gd name="connsiteX50" fmla="*/ 611875 w 778130"/>
                <a:gd name="connsiteY50" fmla="*/ 101180 h 1192958"/>
                <a:gd name="connsiteX51" fmla="*/ 584166 w 778130"/>
                <a:gd name="connsiteY51" fmla="*/ 91944 h 1192958"/>
                <a:gd name="connsiteX52" fmla="*/ 556457 w 778130"/>
                <a:gd name="connsiteY52" fmla="*/ 73471 h 1192958"/>
                <a:gd name="connsiteX53" fmla="*/ 501039 w 778130"/>
                <a:gd name="connsiteY53" fmla="*/ 54998 h 1192958"/>
                <a:gd name="connsiteX54" fmla="*/ 464093 w 778130"/>
                <a:gd name="connsiteY54" fmla="*/ 36526 h 1192958"/>
                <a:gd name="connsiteX55" fmla="*/ 445621 w 778130"/>
                <a:gd name="connsiteY55" fmla="*/ 8816 h 1192958"/>
                <a:gd name="connsiteX56" fmla="*/ 362493 w 778130"/>
                <a:gd name="connsiteY56" fmla="*/ 8816 h 119295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Lst>
              <a:rect l="l" t="t" r="r" b="b"/>
              <a:pathLst>
                <a:path w="778130" h="1192958">
                  <a:moveTo>
                    <a:pt x="362493" y="8816"/>
                  </a:moveTo>
                  <a:cubicBezTo>
                    <a:pt x="345560" y="21131"/>
                    <a:pt x="362953" y="16447"/>
                    <a:pt x="344021" y="82707"/>
                  </a:cubicBezTo>
                  <a:cubicBezTo>
                    <a:pt x="340077" y="96511"/>
                    <a:pt x="332928" y="132603"/>
                    <a:pt x="325548" y="147362"/>
                  </a:cubicBezTo>
                  <a:cubicBezTo>
                    <a:pt x="320584" y="157291"/>
                    <a:pt x="313233" y="165835"/>
                    <a:pt x="307075" y="175071"/>
                  </a:cubicBezTo>
                  <a:cubicBezTo>
                    <a:pt x="283860" y="244718"/>
                    <a:pt x="315176" y="158870"/>
                    <a:pt x="279366" y="230489"/>
                  </a:cubicBezTo>
                  <a:cubicBezTo>
                    <a:pt x="241126" y="306969"/>
                    <a:pt x="304598" y="206496"/>
                    <a:pt x="251657" y="285907"/>
                  </a:cubicBezTo>
                  <a:lnTo>
                    <a:pt x="214712" y="396744"/>
                  </a:lnTo>
                  <a:cubicBezTo>
                    <a:pt x="211633" y="405980"/>
                    <a:pt x="210875" y="416352"/>
                    <a:pt x="205475" y="424453"/>
                  </a:cubicBezTo>
                  <a:cubicBezTo>
                    <a:pt x="199318" y="433689"/>
                    <a:pt x="191967" y="442233"/>
                    <a:pt x="187003" y="452162"/>
                  </a:cubicBezTo>
                  <a:cubicBezTo>
                    <a:pt x="182649" y="460870"/>
                    <a:pt x="182597" y="471418"/>
                    <a:pt x="177766" y="479871"/>
                  </a:cubicBezTo>
                  <a:cubicBezTo>
                    <a:pt x="161968" y="507516"/>
                    <a:pt x="144184" y="522689"/>
                    <a:pt x="122348" y="544526"/>
                  </a:cubicBezTo>
                  <a:cubicBezTo>
                    <a:pt x="105415" y="595327"/>
                    <a:pt x="123286" y="549812"/>
                    <a:pt x="94639" y="599944"/>
                  </a:cubicBezTo>
                  <a:cubicBezTo>
                    <a:pt x="87808" y="611898"/>
                    <a:pt x="81590" y="624234"/>
                    <a:pt x="76166" y="636889"/>
                  </a:cubicBezTo>
                  <a:cubicBezTo>
                    <a:pt x="72331" y="645838"/>
                    <a:pt x="71284" y="655890"/>
                    <a:pt x="66930" y="664598"/>
                  </a:cubicBezTo>
                  <a:cubicBezTo>
                    <a:pt x="61966" y="674527"/>
                    <a:pt x="54615" y="683071"/>
                    <a:pt x="48457" y="692307"/>
                  </a:cubicBezTo>
                  <a:lnTo>
                    <a:pt x="20748" y="775435"/>
                  </a:lnTo>
                  <a:lnTo>
                    <a:pt x="11512" y="803144"/>
                  </a:lnTo>
                  <a:cubicBezTo>
                    <a:pt x="-662" y="900526"/>
                    <a:pt x="-6717" y="912526"/>
                    <a:pt x="11512" y="1034053"/>
                  </a:cubicBezTo>
                  <a:cubicBezTo>
                    <a:pt x="13588" y="1047893"/>
                    <a:pt x="49954" y="1083022"/>
                    <a:pt x="57693" y="1089471"/>
                  </a:cubicBezTo>
                  <a:cubicBezTo>
                    <a:pt x="83688" y="1111133"/>
                    <a:pt x="106298" y="1117785"/>
                    <a:pt x="140821" y="1126416"/>
                  </a:cubicBezTo>
                  <a:cubicBezTo>
                    <a:pt x="153136" y="1129495"/>
                    <a:pt x="165277" y="1133382"/>
                    <a:pt x="177766" y="1135653"/>
                  </a:cubicBezTo>
                  <a:cubicBezTo>
                    <a:pt x="199185" y="1139547"/>
                    <a:pt x="221002" y="1140995"/>
                    <a:pt x="242421" y="1144889"/>
                  </a:cubicBezTo>
                  <a:cubicBezTo>
                    <a:pt x="254910" y="1147160"/>
                    <a:pt x="267207" y="1150478"/>
                    <a:pt x="279366" y="1154126"/>
                  </a:cubicBezTo>
                  <a:cubicBezTo>
                    <a:pt x="298017" y="1159721"/>
                    <a:pt x="334784" y="1172598"/>
                    <a:pt x="334784" y="1172598"/>
                  </a:cubicBezTo>
                  <a:cubicBezTo>
                    <a:pt x="348090" y="1181469"/>
                    <a:pt x="371700" y="1207740"/>
                    <a:pt x="390203" y="1181835"/>
                  </a:cubicBezTo>
                  <a:cubicBezTo>
                    <a:pt x="401521" y="1165990"/>
                    <a:pt x="399967" y="1143832"/>
                    <a:pt x="408675" y="1126416"/>
                  </a:cubicBezTo>
                  <a:cubicBezTo>
                    <a:pt x="414833" y="1114101"/>
                    <a:pt x="421724" y="1102126"/>
                    <a:pt x="427148" y="1089471"/>
                  </a:cubicBezTo>
                  <a:cubicBezTo>
                    <a:pt x="430983" y="1080522"/>
                    <a:pt x="432030" y="1070470"/>
                    <a:pt x="436384" y="1061762"/>
                  </a:cubicBezTo>
                  <a:cubicBezTo>
                    <a:pt x="441348" y="1051833"/>
                    <a:pt x="448699" y="1043289"/>
                    <a:pt x="454857" y="1034053"/>
                  </a:cubicBezTo>
                  <a:cubicBezTo>
                    <a:pt x="474078" y="957166"/>
                    <a:pt x="450674" y="1033179"/>
                    <a:pt x="482566" y="969398"/>
                  </a:cubicBezTo>
                  <a:cubicBezTo>
                    <a:pt x="486920" y="960690"/>
                    <a:pt x="489241" y="951082"/>
                    <a:pt x="491803" y="941689"/>
                  </a:cubicBezTo>
                  <a:cubicBezTo>
                    <a:pt x="498483" y="917195"/>
                    <a:pt x="502246" y="891883"/>
                    <a:pt x="510275" y="867798"/>
                  </a:cubicBezTo>
                  <a:lnTo>
                    <a:pt x="537984" y="784671"/>
                  </a:lnTo>
                  <a:lnTo>
                    <a:pt x="556457" y="729253"/>
                  </a:lnTo>
                  <a:cubicBezTo>
                    <a:pt x="559536" y="713859"/>
                    <a:pt x="561562" y="698217"/>
                    <a:pt x="565693" y="683071"/>
                  </a:cubicBezTo>
                  <a:cubicBezTo>
                    <a:pt x="570816" y="664285"/>
                    <a:pt x="579443" y="646543"/>
                    <a:pt x="584166" y="627653"/>
                  </a:cubicBezTo>
                  <a:cubicBezTo>
                    <a:pt x="588852" y="608911"/>
                    <a:pt x="594690" y="581544"/>
                    <a:pt x="602639" y="562998"/>
                  </a:cubicBezTo>
                  <a:cubicBezTo>
                    <a:pt x="608063" y="550343"/>
                    <a:pt x="615998" y="538837"/>
                    <a:pt x="621112" y="526053"/>
                  </a:cubicBezTo>
                  <a:cubicBezTo>
                    <a:pt x="628344" y="507974"/>
                    <a:pt x="633426" y="489108"/>
                    <a:pt x="639584" y="470635"/>
                  </a:cubicBezTo>
                  <a:cubicBezTo>
                    <a:pt x="642663" y="461399"/>
                    <a:pt x="643421" y="451027"/>
                    <a:pt x="648821" y="442926"/>
                  </a:cubicBezTo>
                  <a:cubicBezTo>
                    <a:pt x="654978" y="433689"/>
                    <a:pt x="662329" y="425145"/>
                    <a:pt x="667293" y="415216"/>
                  </a:cubicBezTo>
                  <a:cubicBezTo>
                    <a:pt x="671647" y="406508"/>
                    <a:pt x="672695" y="396456"/>
                    <a:pt x="676530" y="387507"/>
                  </a:cubicBezTo>
                  <a:cubicBezTo>
                    <a:pt x="681954" y="374852"/>
                    <a:pt x="689889" y="363346"/>
                    <a:pt x="695003" y="350562"/>
                  </a:cubicBezTo>
                  <a:cubicBezTo>
                    <a:pt x="727978" y="268124"/>
                    <a:pt x="696407" y="320746"/>
                    <a:pt x="731948" y="267435"/>
                  </a:cubicBezTo>
                  <a:cubicBezTo>
                    <a:pt x="735027" y="258199"/>
                    <a:pt x="736830" y="248434"/>
                    <a:pt x="741184" y="239726"/>
                  </a:cubicBezTo>
                  <a:cubicBezTo>
                    <a:pt x="746148" y="229797"/>
                    <a:pt x="754149" y="221654"/>
                    <a:pt x="759657" y="212016"/>
                  </a:cubicBezTo>
                  <a:cubicBezTo>
                    <a:pt x="766488" y="200061"/>
                    <a:pt x="771972" y="187386"/>
                    <a:pt x="778130" y="175071"/>
                  </a:cubicBezTo>
                  <a:cubicBezTo>
                    <a:pt x="768894" y="165835"/>
                    <a:pt x="761839" y="153706"/>
                    <a:pt x="750421" y="147362"/>
                  </a:cubicBezTo>
                  <a:cubicBezTo>
                    <a:pt x="733399" y="137906"/>
                    <a:pt x="713476" y="135047"/>
                    <a:pt x="695003" y="128889"/>
                  </a:cubicBezTo>
                  <a:lnTo>
                    <a:pt x="639584" y="110416"/>
                  </a:lnTo>
                  <a:lnTo>
                    <a:pt x="611875" y="101180"/>
                  </a:lnTo>
                  <a:lnTo>
                    <a:pt x="584166" y="91944"/>
                  </a:lnTo>
                  <a:cubicBezTo>
                    <a:pt x="574930" y="85786"/>
                    <a:pt x="566601" y="77980"/>
                    <a:pt x="556457" y="73471"/>
                  </a:cubicBezTo>
                  <a:cubicBezTo>
                    <a:pt x="538663" y="65563"/>
                    <a:pt x="518455" y="63706"/>
                    <a:pt x="501039" y="54998"/>
                  </a:cubicBezTo>
                  <a:lnTo>
                    <a:pt x="464093" y="36526"/>
                  </a:lnTo>
                  <a:cubicBezTo>
                    <a:pt x="457936" y="27289"/>
                    <a:pt x="454289" y="15751"/>
                    <a:pt x="445621" y="8816"/>
                  </a:cubicBezTo>
                  <a:cubicBezTo>
                    <a:pt x="431643" y="-2367"/>
                    <a:pt x="379426" y="-3499"/>
                    <a:pt x="362493" y="8816"/>
                  </a:cubicBezTo>
                  <a:close/>
                </a:path>
              </a:pathLst>
            </a:custGeom>
            <a:solidFill>
              <a:schemeClr val="accent6">
                <a:alpha val="50000"/>
              </a:schemeClr>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32" name="Freeform: Shape 31">
              <a:extLst>
                <a:ext uri="{FF2B5EF4-FFF2-40B4-BE49-F238E27FC236}">
                  <a16:creationId xmlns:a16="http://schemas.microsoft.com/office/drawing/2014/main" id="{22DC9FEE-8C16-4D3A-8F73-E5AFA0BB4299}"/>
                </a:ext>
              </a:extLst>
            </p:cNvPr>
            <p:cNvSpPr/>
            <p:nvPr/>
          </p:nvSpPr>
          <p:spPr>
            <a:xfrm>
              <a:off x="2392218" y="2818757"/>
              <a:ext cx="461819" cy="1154545"/>
            </a:xfrm>
            <a:custGeom>
              <a:avLst/>
              <a:gdLst>
                <a:gd name="connsiteX0" fmla="*/ 27709 w 461819"/>
                <a:gd name="connsiteY0" fmla="*/ 64654 h 1154545"/>
                <a:gd name="connsiteX1" fmla="*/ 18473 w 461819"/>
                <a:gd name="connsiteY1" fmla="*/ 240145 h 1154545"/>
                <a:gd name="connsiteX2" fmla="*/ 9237 w 461819"/>
                <a:gd name="connsiteY2" fmla="*/ 277091 h 1154545"/>
                <a:gd name="connsiteX3" fmla="*/ 0 w 461819"/>
                <a:gd name="connsiteY3" fmla="*/ 341745 h 1154545"/>
                <a:gd name="connsiteX4" fmla="*/ 9237 w 461819"/>
                <a:gd name="connsiteY4" fmla="*/ 1099127 h 1154545"/>
                <a:gd name="connsiteX5" fmla="*/ 27709 w 461819"/>
                <a:gd name="connsiteY5" fmla="*/ 1126836 h 1154545"/>
                <a:gd name="connsiteX6" fmla="*/ 83128 w 461819"/>
                <a:gd name="connsiteY6" fmla="*/ 1154545 h 1154545"/>
                <a:gd name="connsiteX7" fmla="*/ 323273 w 461819"/>
                <a:gd name="connsiteY7" fmla="*/ 1136072 h 1154545"/>
                <a:gd name="connsiteX8" fmla="*/ 378691 w 461819"/>
                <a:gd name="connsiteY8" fmla="*/ 1117600 h 1154545"/>
                <a:gd name="connsiteX9" fmla="*/ 452582 w 461819"/>
                <a:gd name="connsiteY9" fmla="*/ 1099127 h 1154545"/>
                <a:gd name="connsiteX10" fmla="*/ 461819 w 461819"/>
                <a:gd name="connsiteY10" fmla="*/ 1071418 h 1154545"/>
                <a:gd name="connsiteX11" fmla="*/ 443346 w 461819"/>
                <a:gd name="connsiteY11" fmla="*/ 914400 h 1154545"/>
                <a:gd name="connsiteX12" fmla="*/ 415637 w 461819"/>
                <a:gd name="connsiteY12" fmla="*/ 812800 h 1154545"/>
                <a:gd name="connsiteX13" fmla="*/ 415637 w 461819"/>
                <a:gd name="connsiteY13" fmla="*/ 461818 h 1154545"/>
                <a:gd name="connsiteX14" fmla="*/ 406400 w 461819"/>
                <a:gd name="connsiteY14" fmla="*/ 73891 h 1154545"/>
                <a:gd name="connsiteX15" fmla="*/ 387928 w 461819"/>
                <a:gd name="connsiteY15" fmla="*/ 18472 h 1154545"/>
                <a:gd name="connsiteX16" fmla="*/ 360219 w 461819"/>
                <a:gd name="connsiteY16" fmla="*/ 0 h 1154545"/>
                <a:gd name="connsiteX17" fmla="*/ 110837 w 461819"/>
                <a:gd name="connsiteY17" fmla="*/ 18472 h 1154545"/>
                <a:gd name="connsiteX18" fmla="*/ 36946 w 461819"/>
                <a:gd name="connsiteY18" fmla="*/ 36945 h 1154545"/>
                <a:gd name="connsiteX19" fmla="*/ 27709 w 461819"/>
                <a:gd name="connsiteY19" fmla="*/ 64654 h 115454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Lst>
              <a:rect l="l" t="t" r="r" b="b"/>
              <a:pathLst>
                <a:path w="461819" h="1154545">
                  <a:moveTo>
                    <a:pt x="27709" y="64654"/>
                  </a:moveTo>
                  <a:cubicBezTo>
                    <a:pt x="24630" y="98521"/>
                    <a:pt x="23547" y="181787"/>
                    <a:pt x="18473" y="240145"/>
                  </a:cubicBezTo>
                  <a:cubicBezTo>
                    <a:pt x="17373" y="252792"/>
                    <a:pt x="11508" y="264601"/>
                    <a:pt x="9237" y="277091"/>
                  </a:cubicBezTo>
                  <a:cubicBezTo>
                    <a:pt x="5343" y="298510"/>
                    <a:pt x="3079" y="320194"/>
                    <a:pt x="0" y="341745"/>
                  </a:cubicBezTo>
                  <a:cubicBezTo>
                    <a:pt x="3079" y="594206"/>
                    <a:pt x="332" y="846805"/>
                    <a:pt x="9237" y="1099127"/>
                  </a:cubicBezTo>
                  <a:cubicBezTo>
                    <a:pt x="9629" y="1110221"/>
                    <a:pt x="19860" y="1118987"/>
                    <a:pt x="27709" y="1126836"/>
                  </a:cubicBezTo>
                  <a:cubicBezTo>
                    <a:pt x="45614" y="1144741"/>
                    <a:pt x="60591" y="1147033"/>
                    <a:pt x="83128" y="1154545"/>
                  </a:cubicBezTo>
                  <a:cubicBezTo>
                    <a:pt x="111973" y="1152943"/>
                    <a:pt x="266842" y="1148164"/>
                    <a:pt x="323273" y="1136072"/>
                  </a:cubicBezTo>
                  <a:cubicBezTo>
                    <a:pt x="342313" y="1131992"/>
                    <a:pt x="359801" y="1122323"/>
                    <a:pt x="378691" y="1117600"/>
                  </a:cubicBezTo>
                  <a:lnTo>
                    <a:pt x="452582" y="1099127"/>
                  </a:lnTo>
                  <a:cubicBezTo>
                    <a:pt x="455661" y="1089891"/>
                    <a:pt x="461819" y="1081154"/>
                    <a:pt x="461819" y="1071418"/>
                  </a:cubicBezTo>
                  <a:cubicBezTo>
                    <a:pt x="461819" y="1035569"/>
                    <a:pt x="455389" y="958557"/>
                    <a:pt x="443346" y="914400"/>
                  </a:cubicBezTo>
                  <a:cubicBezTo>
                    <a:pt x="408190" y="785496"/>
                    <a:pt x="438139" y="925315"/>
                    <a:pt x="415637" y="812800"/>
                  </a:cubicBezTo>
                  <a:cubicBezTo>
                    <a:pt x="393815" y="463667"/>
                    <a:pt x="415637" y="897965"/>
                    <a:pt x="415637" y="461818"/>
                  </a:cubicBezTo>
                  <a:cubicBezTo>
                    <a:pt x="415637" y="332472"/>
                    <a:pt x="414468" y="202985"/>
                    <a:pt x="406400" y="73891"/>
                  </a:cubicBezTo>
                  <a:cubicBezTo>
                    <a:pt x="405185" y="54457"/>
                    <a:pt x="404130" y="29273"/>
                    <a:pt x="387928" y="18472"/>
                  </a:cubicBezTo>
                  <a:lnTo>
                    <a:pt x="360219" y="0"/>
                  </a:lnTo>
                  <a:cubicBezTo>
                    <a:pt x="236030" y="24837"/>
                    <a:pt x="379474" y="-1427"/>
                    <a:pt x="110837" y="18472"/>
                  </a:cubicBezTo>
                  <a:cubicBezTo>
                    <a:pt x="98469" y="19388"/>
                    <a:pt x="52658" y="29089"/>
                    <a:pt x="36946" y="36945"/>
                  </a:cubicBezTo>
                  <a:cubicBezTo>
                    <a:pt x="33051" y="38892"/>
                    <a:pt x="30788" y="30787"/>
                    <a:pt x="27709" y="64654"/>
                  </a:cubicBezTo>
                  <a:close/>
                </a:path>
              </a:pathLst>
            </a:custGeom>
            <a:solidFill>
              <a:schemeClr val="accent6">
                <a:alpha val="50000"/>
              </a:schemeClr>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33" name="Freeform: Shape 32">
              <a:extLst>
                <a:ext uri="{FF2B5EF4-FFF2-40B4-BE49-F238E27FC236}">
                  <a16:creationId xmlns:a16="http://schemas.microsoft.com/office/drawing/2014/main" id="{C1FC718F-157D-46EE-B924-3CD9AC4F4B7A}"/>
                </a:ext>
              </a:extLst>
            </p:cNvPr>
            <p:cNvSpPr/>
            <p:nvPr/>
          </p:nvSpPr>
          <p:spPr>
            <a:xfrm>
              <a:off x="3463637" y="1617868"/>
              <a:ext cx="674254" cy="1224494"/>
            </a:xfrm>
            <a:custGeom>
              <a:avLst/>
              <a:gdLst>
                <a:gd name="connsiteX0" fmla="*/ 415636 w 674254"/>
                <a:gd name="connsiteY0" fmla="*/ 27871 h 1224494"/>
                <a:gd name="connsiteX1" fmla="*/ 406400 w 674254"/>
                <a:gd name="connsiteY1" fmla="*/ 101761 h 1224494"/>
                <a:gd name="connsiteX2" fmla="*/ 369454 w 674254"/>
                <a:gd name="connsiteY2" fmla="*/ 231071 h 1224494"/>
                <a:gd name="connsiteX3" fmla="*/ 360218 w 674254"/>
                <a:gd name="connsiteY3" fmla="*/ 258780 h 1224494"/>
                <a:gd name="connsiteX4" fmla="*/ 323272 w 674254"/>
                <a:gd name="connsiteY4" fmla="*/ 314198 h 1224494"/>
                <a:gd name="connsiteX5" fmla="*/ 295563 w 674254"/>
                <a:gd name="connsiteY5" fmla="*/ 369616 h 1224494"/>
                <a:gd name="connsiteX6" fmla="*/ 277090 w 674254"/>
                <a:gd name="connsiteY6" fmla="*/ 406561 h 1224494"/>
                <a:gd name="connsiteX7" fmla="*/ 240145 w 674254"/>
                <a:gd name="connsiteY7" fmla="*/ 461980 h 1224494"/>
                <a:gd name="connsiteX8" fmla="*/ 221672 w 674254"/>
                <a:gd name="connsiteY8" fmla="*/ 517398 h 1224494"/>
                <a:gd name="connsiteX9" fmla="*/ 203200 w 674254"/>
                <a:gd name="connsiteY9" fmla="*/ 582052 h 1224494"/>
                <a:gd name="connsiteX10" fmla="*/ 184727 w 674254"/>
                <a:gd name="connsiteY10" fmla="*/ 609761 h 1224494"/>
                <a:gd name="connsiteX11" fmla="*/ 175490 w 674254"/>
                <a:gd name="connsiteY11" fmla="*/ 637471 h 1224494"/>
                <a:gd name="connsiteX12" fmla="*/ 157018 w 674254"/>
                <a:gd name="connsiteY12" fmla="*/ 665180 h 1224494"/>
                <a:gd name="connsiteX13" fmla="*/ 138545 w 674254"/>
                <a:gd name="connsiteY13" fmla="*/ 720598 h 1224494"/>
                <a:gd name="connsiteX14" fmla="*/ 129309 w 674254"/>
                <a:gd name="connsiteY14" fmla="*/ 748307 h 1224494"/>
                <a:gd name="connsiteX15" fmla="*/ 110836 w 674254"/>
                <a:gd name="connsiteY15" fmla="*/ 785252 h 1224494"/>
                <a:gd name="connsiteX16" fmla="*/ 101600 w 674254"/>
                <a:gd name="connsiteY16" fmla="*/ 812961 h 1224494"/>
                <a:gd name="connsiteX17" fmla="*/ 55418 w 674254"/>
                <a:gd name="connsiteY17" fmla="*/ 868380 h 1224494"/>
                <a:gd name="connsiteX18" fmla="*/ 36945 w 674254"/>
                <a:gd name="connsiteY18" fmla="*/ 923798 h 1224494"/>
                <a:gd name="connsiteX19" fmla="*/ 27709 w 674254"/>
                <a:gd name="connsiteY19" fmla="*/ 997689 h 1224494"/>
                <a:gd name="connsiteX20" fmla="*/ 18472 w 674254"/>
                <a:gd name="connsiteY20" fmla="*/ 1034634 h 1224494"/>
                <a:gd name="connsiteX21" fmla="*/ 0 w 674254"/>
                <a:gd name="connsiteY21" fmla="*/ 1145471 h 1224494"/>
                <a:gd name="connsiteX22" fmla="*/ 9236 w 674254"/>
                <a:gd name="connsiteY22" fmla="*/ 1182416 h 1224494"/>
                <a:gd name="connsiteX23" fmla="*/ 64654 w 674254"/>
                <a:gd name="connsiteY23" fmla="*/ 1210125 h 1224494"/>
                <a:gd name="connsiteX24" fmla="*/ 184727 w 674254"/>
                <a:gd name="connsiteY24" fmla="*/ 1191652 h 1224494"/>
                <a:gd name="connsiteX25" fmla="*/ 240145 w 674254"/>
                <a:gd name="connsiteY25" fmla="*/ 1173180 h 1224494"/>
                <a:gd name="connsiteX26" fmla="*/ 267854 w 674254"/>
                <a:gd name="connsiteY26" fmla="*/ 1163943 h 1224494"/>
                <a:gd name="connsiteX27" fmla="*/ 332509 w 674254"/>
                <a:gd name="connsiteY27" fmla="*/ 1191652 h 1224494"/>
                <a:gd name="connsiteX28" fmla="*/ 424872 w 674254"/>
                <a:gd name="connsiteY28" fmla="*/ 1219361 h 1224494"/>
                <a:gd name="connsiteX29" fmla="*/ 581890 w 674254"/>
                <a:gd name="connsiteY29" fmla="*/ 1210125 h 1224494"/>
                <a:gd name="connsiteX30" fmla="*/ 572654 w 674254"/>
                <a:gd name="connsiteY30" fmla="*/ 1126998 h 1224494"/>
                <a:gd name="connsiteX31" fmla="*/ 554181 w 674254"/>
                <a:gd name="connsiteY31" fmla="*/ 1043871 h 1224494"/>
                <a:gd name="connsiteX32" fmla="*/ 544945 w 674254"/>
                <a:gd name="connsiteY32" fmla="*/ 997689 h 1224494"/>
                <a:gd name="connsiteX33" fmla="*/ 535709 w 674254"/>
                <a:gd name="connsiteY33" fmla="*/ 942271 h 1224494"/>
                <a:gd name="connsiteX34" fmla="*/ 517236 w 674254"/>
                <a:gd name="connsiteY34" fmla="*/ 886852 h 1224494"/>
                <a:gd name="connsiteX35" fmla="*/ 508000 w 674254"/>
                <a:gd name="connsiteY35" fmla="*/ 859143 h 1224494"/>
                <a:gd name="connsiteX36" fmla="*/ 498763 w 674254"/>
                <a:gd name="connsiteY36" fmla="*/ 812961 h 1224494"/>
                <a:gd name="connsiteX37" fmla="*/ 508000 w 674254"/>
                <a:gd name="connsiteY37" fmla="*/ 711361 h 1224494"/>
                <a:gd name="connsiteX38" fmla="*/ 517236 w 674254"/>
                <a:gd name="connsiteY38" fmla="*/ 683652 h 1224494"/>
                <a:gd name="connsiteX39" fmla="*/ 544945 w 674254"/>
                <a:gd name="connsiteY39" fmla="*/ 554343 h 1224494"/>
                <a:gd name="connsiteX40" fmla="*/ 554181 w 674254"/>
                <a:gd name="connsiteY40" fmla="*/ 489689 h 1224494"/>
                <a:gd name="connsiteX41" fmla="*/ 563418 w 674254"/>
                <a:gd name="connsiteY41" fmla="*/ 415798 h 1224494"/>
                <a:gd name="connsiteX42" fmla="*/ 581890 w 674254"/>
                <a:gd name="connsiteY42" fmla="*/ 360380 h 1224494"/>
                <a:gd name="connsiteX43" fmla="*/ 591127 w 674254"/>
                <a:gd name="connsiteY43" fmla="*/ 323434 h 1224494"/>
                <a:gd name="connsiteX44" fmla="*/ 609600 w 674254"/>
                <a:gd name="connsiteY44" fmla="*/ 268016 h 1224494"/>
                <a:gd name="connsiteX45" fmla="*/ 628072 w 674254"/>
                <a:gd name="connsiteY45" fmla="*/ 203361 h 1224494"/>
                <a:gd name="connsiteX46" fmla="*/ 674254 w 674254"/>
                <a:gd name="connsiteY46" fmla="*/ 147943 h 1224494"/>
                <a:gd name="connsiteX47" fmla="*/ 665018 w 674254"/>
                <a:gd name="connsiteY47" fmla="*/ 110998 h 1224494"/>
                <a:gd name="connsiteX48" fmla="*/ 600363 w 674254"/>
                <a:gd name="connsiteY48" fmla="*/ 64816 h 1224494"/>
                <a:gd name="connsiteX49" fmla="*/ 544945 w 674254"/>
                <a:gd name="connsiteY49" fmla="*/ 27871 h 1224494"/>
                <a:gd name="connsiteX50" fmla="*/ 471054 w 674254"/>
                <a:gd name="connsiteY50" fmla="*/ 9398 h 1224494"/>
                <a:gd name="connsiteX51" fmla="*/ 443345 w 674254"/>
                <a:gd name="connsiteY51" fmla="*/ 161 h 1224494"/>
                <a:gd name="connsiteX52" fmla="*/ 415636 w 674254"/>
                <a:gd name="connsiteY52" fmla="*/ 27871 h 122449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Lst>
              <a:rect l="l" t="t" r="r" b="b"/>
              <a:pathLst>
                <a:path w="674254" h="1224494">
                  <a:moveTo>
                    <a:pt x="415636" y="27871"/>
                  </a:moveTo>
                  <a:cubicBezTo>
                    <a:pt x="409479" y="44804"/>
                    <a:pt x="410974" y="77364"/>
                    <a:pt x="406400" y="101761"/>
                  </a:cubicBezTo>
                  <a:cubicBezTo>
                    <a:pt x="396459" y="154779"/>
                    <a:pt x="385789" y="182064"/>
                    <a:pt x="369454" y="231071"/>
                  </a:cubicBezTo>
                  <a:cubicBezTo>
                    <a:pt x="366375" y="240307"/>
                    <a:pt x="365619" y="250679"/>
                    <a:pt x="360218" y="258780"/>
                  </a:cubicBezTo>
                  <a:lnTo>
                    <a:pt x="323272" y="314198"/>
                  </a:lnTo>
                  <a:cubicBezTo>
                    <a:pt x="306339" y="364999"/>
                    <a:pt x="324210" y="319484"/>
                    <a:pt x="295563" y="369616"/>
                  </a:cubicBezTo>
                  <a:cubicBezTo>
                    <a:pt x="288732" y="381570"/>
                    <a:pt x="284174" y="394754"/>
                    <a:pt x="277090" y="406561"/>
                  </a:cubicBezTo>
                  <a:cubicBezTo>
                    <a:pt x="265667" y="425599"/>
                    <a:pt x="240145" y="461980"/>
                    <a:pt x="240145" y="461980"/>
                  </a:cubicBezTo>
                  <a:cubicBezTo>
                    <a:pt x="233987" y="480453"/>
                    <a:pt x="226395" y="498507"/>
                    <a:pt x="221672" y="517398"/>
                  </a:cubicBezTo>
                  <a:cubicBezTo>
                    <a:pt x="218713" y="529234"/>
                    <a:pt x="209825" y="568803"/>
                    <a:pt x="203200" y="582052"/>
                  </a:cubicBezTo>
                  <a:cubicBezTo>
                    <a:pt x="198236" y="591981"/>
                    <a:pt x="189691" y="599832"/>
                    <a:pt x="184727" y="609761"/>
                  </a:cubicBezTo>
                  <a:cubicBezTo>
                    <a:pt x="180373" y="618469"/>
                    <a:pt x="179844" y="628763"/>
                    <a:pt x="175490" y="637471"/>
                  </a:cubicBezTo>
                  <a:cubicBezTo>
                    <a:pt x="170526" y="647400"/>
                    <a:pt x="161526" y="655036"/>
                    <a:pt x="157018" y="665180"/>
                  </a:cubicBezTo>
                  <a:cubicBezTo>
                    <a:pt x="149110" y="682974"/>
                    <a:pt x="144703" y="702125"/>
                    <a:pt x="138545" y="720598"/>
                  </a:cubicBezTo>
                  <a:cubicBezTo>
                    <a:pt x="135466" y="729834"/>
                    <a:pt x="133663" y="739599"/>
                    <a:pt x="129309" y="748307"/>
                  </a:cubicBezTo>
                  <a:cubicBezTo>
                    <a:pt x="123151" y="760622"/>
                    <a:pt x="116260" y="772597"/>
                    <a:pt x="110836" y="785252"/>
                  </a:cubicBezTo>
                  <a:cubicBezTo>
                    <a:pt x="107001" y="794201"/>
                    <a:pt x="105954" y="804253"/>
                    <a:pt x="101600" y="812961"/>
                  </a:cubicBezTo>
                  <a:cubicBezTo>
                    <a:pt x="88741" y="838680"/>
                    <a:pt x="75846" y="847952"/>
                    <a:pt x="55418" y="868380"/>
                  </a:cubicBezTo>
                  <a:cubicBezTo>
                    <a:pt x="49260" y="886853"/>
                    <a:pt x="39360" y="904476"/>
                    <a:pt x="36945" y="923798"/>
                  </a:cubicBezTo>
                  <a:cubicBezTo>
                    <a:pt x="33866" y="948428"/>
                    <a:pt x="31790" y="973205"/>
                    <a:pt x="27709" y="997689"/>
                  </a:cubicBezTo>
                  <a:cubicBezTo>
                    <a:pt x="25622" y="1010210"/>
                    <a:pt x="20811" y="1022157"/>
                    <a:pt x="18472" y="1034634"/>
                  </a:cubicBezTo>
                  <a:cubicBezTo>
                    <a:pt x="11569" y="1071448"/>
                    <a:pt x="0" y="1145471"/>
                    <a:pt x="0" y="1145471"/>
                  </a:cubicBezTo>
                  <a:cubicBezTo>
                    <a:pt x="3079" y="1157786"/>
                    <a:pt x="2195" y="1171854"/>
                    <a:pt x="9236" y="1182416"/>
                  </a:cubicBezTo>
                  <a:cubicBezTo>
                    <a:pt x="19468" y="1197764"/>
                    <a:pt x="48847" y="1204856"/>
                    <a:pt x="64654" y="1210125"/>
                  </a:cubicBezTo>
                  <a:cubicBezTo>
                    <a:pt x="123208" y="1203619"/>
                    <a:pt x="137668" y="1205770"/>
                    <a:pt x="184727" y="1191652"/>
                  </a:cubicBezTo>
                  <a:cubicBezTo>
                    <a:pt x="203378" y="1186057"/>
                    <a:pt x="221672" y="1179338"/>
                    <a:pt x="240145" y="1173180"/>
                  </a:cubicBezTo>
                  <a:lnTo>
                    <a:pt x="267854" y="1163943"/>
                  </a:lnTo>
                  <a:cubicBezTo>
                    <a:pt x="365588" y="1188378"/>
                    <a:pt x="250499" y="1155203"/>
                    <a:pt x="332509" y="1191652"/>
                  </a:cubicBezTo>
                  <a:cubicBezTo>
                    <a:pt x="361425" y="1204503"/>
                    <a:pt x="394164" y="1211684"/>
                    <a:pt x="424872" y="1219361"/>
                  </a:cubicBezTo>
                  <a:cubicBezTo>
                    <a:pt x="477211" y="1216282"/>
                    <a:pt x="537430" y="1237913"/>
                    <a:pt x="581890" y="1210125"/>
                  </a:cubicBezTo>
                  <a:cubicBezTo>
                    <a:pt x="605532" y="1195349"/>
                    <a:pt x="576597" y="1154597"/>
                    <a:pt x="572654" y="1126998"/>
                  </a:cubicBezTo>
                  <a:cubicBezTo>
                    <a:pt x="567080" y="1087980"/>
                    <a:pt x="562252" y="1080188"/>
                    <a:pt x="554181" y="1043871"/>
                  </a:cubicBezTo>
                  <a:cubicBezTo>
                    <a:pt x="550775" y="1028546"/>
                    <a:pt x="547753" y="1013135"/>
                    <a:pt x="544945" y="997689"/>
                  </a:cubicBezTo>
                  <a:cubicBezTo>
                    <a:pt x="541595" y="979264"/>
                    <a:pt x="540251" y="960439"/>
                    <a:pt x="535709" y="942271"/>
                  </a:cubicBezTo>
                  <a:cubicBezTo>
                    <a:pt x="530986" y="923380"/>
                    <a:pt x="523394" y="905325"/>
                    <a:pt x="517236" y="886852"/>
                  </a:cubicBezTo>
                  <a:cubicBezTo>
                    <a:pt x="514157" y="877616"/>
                    <a:pt x="509909" y="868690"/>
                    <a:pt x="508000" y="859143"/>
                  </a:cubicBezTo>
                  <a:lnTo>
                    <a:pt x="498763" y="812961"/>
                  </a:lnTo>
                  <a:cubicBezTo>
                    <a:pt x="501842" y="779094"/>
                    <a:pt x="503191" y="745026"/>
                    <a:pt x="508000" y="711361"/>
                  </a:cubicBezTo>
                  <a:cubicBezTo>
                    <a:pt x="509377" y="701723"/>
                    <a:pt x="514561" y="693013"/>
                    <a:pt x="517236" y="683652"/>
                  </a:cubicBezTo>
                  <a:cubicBezTo>
                    <a:pt x="526836" y="650050"/>
                    <a:pt x="541916" y="575544"/>
                    <a:pt x="544945" y="554343"/>
                  </a:cubicBezTo>
                  <a:cubicBezTo>
                    <a:pt x="548024" y="532792"/>
                    <a:pt x="551304" y="511268"/>
                    <a:pt x="554181" y="489689"/>
                  </a:cubicBezTo>
                  <a:cubicBezTo>
                    <a:pt x="557462" y="465085"/>
                    <a:pt x="558217" y="440069"/>
                    <a:pt x="563418" y="415798"/>
                  </a:cubicBezTo>
                  <a:cubicBezTo>
                    <a:pt x="567498" y="396758"/>
                    <a:pt x="577167" y="379270"/>
                    <a:pt x="581890" y="360380"/>
                  </a:cubicBezTo>
                  <a:cubicBezTo>
                    <a:pt x="584969" y="348065"/>
                    <a:pt x="587479" y="335593"/>
                    <a:pt x="591127" y="323434"/>
                  </a:cubicBezTo>
                  <a:cubicBezTo>
                    <a:pt x="596722" y="304783"/>
                    <a:pt x="604877" y="286907"/>
                    <a:pt x="609600" y="268016"/>
                  </a:cubicBezTo>
                  <a:cubicBezTo>
                    <a:pt x="612559" y="256182"/>
                    <a:pt x="621448" y="216609"/>
                    <a:pt x="628072" y="203361"/>
                  </a:cubicBezTo>
                  <a:cubicBezTo>
                    <a:pt x="640930" y="177644"/>
                    <a:pt x="653828" y="168369"/>
                    <a:pt x="674254" y="147943"/>
                  </a:cubicBezTo>
                  <a:cubicBezTo>
                    <a:pt x="671175" y="135628"/>
                    <a:pt x="671316" y="122019"/>
                    <a:pt x="665018" y="110998"/>
                  </a:cubicBezTo>
                  <a:cubicBezTo>
                    <a:pt x="647982" y="81185"/>
                    <a:pt x="627478" y="81085"/>
                    <a:pt x="600363" y="64816"/>
                  </a:cubicBezTo>
                  <a:cubicBezTo>
                    <a:pt x="581325" y="53394"/>
                    <a:pt x="566483" y="33256"/>
                    <a:pt x="544945" y="27871"/>
                  </a:cubicBezTo>
                  <a:cubicBezTo>
                    <a:pt x="520315" y="21713"/>
                    <a:pt x="495139" y="17427"/>
                    <a:pt x="471054" y="9398"/>
                  </a:cubicBezTo>
                  <a:cubicBezTo>
                    <a:pt x="461818" y="6319"/>
                    <a:pt x="452983" y="1538"/>
                    <a:pt x="443345" y="161"/>
                  </a:cubicBezTo>
                  <a:cubicBezTo>
                    <a:pt x="431154" y="-1581"/>
                    <a:pt x="421793" y="10938"/>
                    <a:pt x="415636" y="27871"/>
                  </a:cubicBezTo>
                  <a:close/>
                </a:path>
              </a:pathLst>
            </a:custGeom>
            <a:solidFill>
              <a:schemeClr val="accent6">
                <a:alpha val="50000"/>
              </a:schemeClr>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34" name="Freeform: Shape 33">
              <a:extLst>
                <a:ext uri="{FF2B5EF4-FFF2-40B4-BE49-F238E27FC236}">
                  <a16:creationId xmlns:a16="http://schemas.microsoft.com/office/drawing/2014/main" id="{2455B7E9-FB6C-48AD-A37A-B30658878D65}"/>
                </a:ext>
              </a:extLst>
            </p:cNvPr>
            <p:cNvSpPr/>
            <p:nvPr/>
          </p:nvSpPr>
          <p:spPr>
            <a:xfrm>
              <a:off x="4304146" y="2947869"/>
              <a:ext cx="563418" cy="883772"/>
            </a:xfrm>
            <a:custGeom>
              <a:avLst/>
              <a:gdLst>
                <a:gd name="connsiteX0" fmla="*/ 73891 w 563418"/>
                <a:gd name="connsiteY0" fmla="*/ 197 h 883772"/>
                <a:gd name="connsiteX1" fmla="*/ 9236 w 563418"/>
                <a:gd name="connsiteY1" fmla="*/ 64851 h 883772"/>
                <a:gd name="connsiteX2" fmla="*/ 0 w 563418"/>
                <a:gd name="connsiteY2" fmla="*/ 92560 h 883772"/>
                <a:gd name="connsiteX3" fmla="*/ 9236 w 563418"/>
                <a:gd name="connsiteY3" fmla="*/ 166451 h 883772"/>
                <a:gd name="connsiteX4" fmla="*/ 27709 w 563418"/>
                <a:gd name="connsiteY4" fmla="*/ 194160 h 883772"/>
                <a:gd name="connsiteX5" fmla="*/ 83127 w 563418"/>
                <a:gd name="connsiteY5" fmla="*/ 240342 h 883772"/>
                <a:gd name="connsiteX6" fmla="*/ 120072 w 563418"/>
                <a:gd name="connsiteY6" fmla="*/ 268051 h 883772"/>
                <a:gd name="connsiteX7" fmla="*/ 110836 w 563418"/>
                <a:gd name="connsiteY7" fmla="*/ 323470 h 883772"/>
                <a:gd name="connsiteX8" fmla="*/ 55418 w 563418"/>
                <a:gd name="connsiteY8" fmla="*/ 369651 h 883772"/>
                <a:gd name="connsiteX9" fmla="*/ 36945 w 563418"/>
                <a:gd name="connsiteY9" fmla="*/ 425070 h 883772"/>
                <a:gd name="connsiteX10" fmla="*/ 27709 w 563418"/>
                <a:gd name="connsiteY10" fmla="*/ 452779 h 883772"/>
                <a:gd name="connsiteX11" fmla="*/ 36945 w 563418"/>
                <a:gd name="connsiteY11" fmla="*/ 480488 h 883772"/>
                <a:gd name="connsiteX12" fmla="*/ 64654 w 563418"/>
                <a:gd name="connsiteY12" fmla="*/ 508197 h 883772"/>
                <a:gd name="connsiteX13" fmla="*/ 267854 w 563418"/>
                <a:gd name="connsiteY13" fmla="*/ 535906 h 883772"/>
                <a:gd name="connsiteX14" fmla="*/ 341745 w 563418"/>
                <a:gd name="connsiteY14" fmla="*/ 572851 h 883772"/>
                <a:gd name="connsiteX15" fmla="*/ 350981 w 563418"/>
                <a:gd name="connsiteY15" fmla="*/ 619033 h 883772"/>
                <a:gd name="connsiteX16" fmla="*/ 341745 w 563418"/>
                <a:gd name="connsiteY16" fmla="*/ 692924 h 883772"/>
                <a:gd name="connsiteX17" fmla="*/ 314036 w 563418"/>
                <a:gd name="connsiteY17" fmla="*/ 702160 h 883772"/>
                <a:gd name="connsiteX18" fmla="*/ 175491 w 563418"/>
                <a:gd name="connsiteY18" fmla="*/ 711397 h 883772"/>
                <a:gd name="connsiteX19" fmla="*/ 92363 w 563418"/>
                <a:gd name="connsiteY19" fmla="*/ 720633 h 883772"/>
                <a:gd name="connsiteX20" fmla="*/ 92363 w 563418"/>
                <a:gd name="connsiteY20" fmla="*/ 785288 h 883772"/>
                <a:gd name="connsiteX21" fmla="*/ 147781 w 563418"/>
                <a:gd name="connsiteY21" fmla="*/ 803760 h 883772"/>
                <a:gd name="connsiteX22" fmla="*/ 175491 w 563418"/>
                <a:gd name="connsiteY22" fmla="*/ 812997 h 883772"/>
                <a:gd name="connsiteX23" fmla="*/ 240145 w 563418"/>
                <a:gd name="connsiteY23" fmla="*/ 831470 h 883772"/>
                <a:gd name="connsiteX24" fmla="*/ 267854 w 563418"/>
                <a:gd name="connsiteY24" fmla="*/ 859179 h 883772"/>
                <a:gd name="connsiteX25" fmla="*/ 434109 w 563418"/>
                <a:gd name="connsiteY25" fmla="*/ 868415 h 883772"/>
                <a:gd name="connsiteX26" fmla="*/ 461818 w 563418"/>
                <a:gd name="connsiteY26" fmla="*/ 859179 h 883772"/>
                <a:gd name="connsiteX27" fmla="*/ 563418 w 563418"/>
                <a:gd name="connsiteY27" fmla="*/ 840706 h 883772"/>
                <a:gd name="connsiteX28" fmla="*/ 554181 w 563418"/>
                <a:gd name="connsiteY28" fmla="*/ 692924 h 883772"/>
                <a:gd name="connsiteX29" fmla="*/ 535709 w 563418"/>
                <a:gd name="connsiteY29" fmla="*/ 628270 h 883772"/>
                <a:gd name="connsiteX30" fmla="*/ 517236 w 563418"/>
                <a:gd name="connsiteY30" fmla="*/ 563615 h 883772"/>
                <a:gd name="connsiteX31" fmla="*/ 498763 w 563418"/>
                <a:gd name="connsiteY31" fmla="*/ 535906 h 883772"/>
                <a:gd name="connsiteX32" fmla="*/ 471054 w 563418"/>
                <a:gd name="connsiteY32" fmla="*/ 471251 h 883772"/>
                <a:gd name="connsiteX33" fmla="*/ 443345 w 563418"/>
                <a:gd name="connsiteY33" fmla="*/ 443542 h 883772"/>
                <a:gd name="connsiteX34" fmla="*/ 378691 w 563418"/>
                <a:gd name="connsiteY34" fmla="*/ 360415 h 883772"/>
                <a:gd name="connsiteX35" fmla="*/ 323272 w 563418"/>
                <a:gd name="connsiteY35" fmla="*/ 314233 h 883772"/>
                <a:gd name="connsiteX36" fmla="*/ 267854 w 563418"/>
                <a:gd name="connsiteY36" fmla="*/ 295760 h 883772"/>
                <a:gd name="connsiteX37" fmla="*/ 212436 w 563418"/>
                <a:gd name="connsiteY37" fmla="*/ 268051 h 883772"/>
                <a:gd name="connsiteX38" fmla="*/ 184727 w 563418"/>
                <a:gd name="connsiteY38" fmla="*/ 249579 h 883772"/>
                <a:gd name="connsiteX39" fmla="*/ 147781 w 563418"/>
                <a:gd name="connsiteY39" fmla="*/ 194160 h 883772"/>
                <a:gd name="connsiteX40" fmla="*/ 120072 w 563418"/>
                <a:gd name="connsiteY40" fmla="*/ 111033 h 883772"/>
                <a:gd name="connsiteX41" fmla="*/ 110836 w 563418"/>
                <a:gd name="connsiteY41" fmla="*/ 83324 h 883772"/>
                <a:gd name="connsiteX42" fmla="*/ 73891 w 563418"/>
                <a:gd name="connsiteY42" fmla="*/ 197 h 88377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Lst>
              <a:rect l="l" t="t" r="r" b="b"/>
              <a:pathLst>
                <a:path w="563418" h="883772">
                  <a:moveTo>
                    <a:pt x="73891" y="197"/>
                  </a:moveTo>
                  <a:cubicBezTo>
                    <a:pt x="56958" y="-2882"/>
                    <a:pt x="26390" y="30542"/>
                    <a:pt x="9236" y="64851"/>
                  </a:cubicBezTo>
                  <a:cubicBezTo>
                    <a:pt x="4882" y="73559"/>
                    <a:pt x="3079" y="83324"/>
                    <a:pt x="0" y="92560"/>
                  </a:cubicBezTo>
                  <a:cubicBezTo>
                    <a:pt x="3079" y="117190"/>
                    <a:pt x="2705" y="142504"/>
                    <a:pt x="9236" y="166451"/>
                  </a:cubicBezTo>
                  <a:cubicBezTo>
                    <a:pt x="12157" y="177161"/>
                    <a:pt x="20603" y="185632"/>
                    <a:pt x="27709" y="194160"/>
                  </a:cubicBezTo>
                  <a:cubicBezTo>
                    <a:pt x="53080" y="224605"/>
                    <a:pt x="53207" y="218970"/>
                    <a:pt x="83127" y="240342"/>
                  </a:cubicBezTo>
                  <a:cubicBezTo>
                    <a:pt x="95653" y="249289"/>
                    <a:pt x="107757" y="258815"/>
                    <a:pt x="120072" y="268051"/>
                  </a:cubicBezTo>
                  <a:cubicBezTo>
                    <a:pt x="116993" y="286524"/>
                    <a:pt x="118442" y="306356"/>
                    <a:pt x="110836" y="323470"/>
                  </a:cubicBezTo>
                  <a:cubicBezTo>
                    <a:pt x="103350" y="340314"/>
                    <a:pt x="70139" y="359837"/>
                    <a:pt x="55418" y="369651"/>
                  </a:cubicBezTo>
                  <a:lnTo>
                    <a:pt x="36945" y="425070"/>
                  </a:lnTo>
                  <a:lnTo>
                    <a:pt x="27709" y="452779"/>
                  </a:lnTo>
                  <a:cubicBezTo>
                    <a:pt x="30788" y="462015"/>
                    <a:pt x="31545" y="472387"/>
                    <a:pt x="36945" y="480488"/>
                  </a:cubicBezTo>
                  <a:cubicBezTo>
                    <a:pt x="44191" y="491356"/>
                    <a:pt x="53236" y="501853"/>
                    <a:pt x="64654" y="508197"/>
                  </a:cubicBezTo>
                  <a:cubicBezTo>
                    <a:pt x="120816" y="539398"/>
                    <a:pt x="217439" y="532755"/>
                    <a:pt x="267854" y="535906"/>
                  </a:cubicBezTo>
                  <a:cubicBezTo>
                    <a:pt x="300931" y="542521"/>
                    <a:pt x="324496" y="538353"/>
                    <a:pt x="341745" y="572851"/>
                  </a:cubicBezTo>
                  <a:cubicBezTo>
                    <a:pt x="348766" y="586893"/>
                    <a:pt x="347902" y="603639"/>
                    <a:pt x="350981" y="619033"/>
                  </a:cubicBezTo>
                  <a:cubicBezTo>
                    <a:pt x="347902" y="643663"/>
                    <a:pt x="351826" y="670241"/>
                    <a:pt x="341745" y="692924"/>
                  </a:cubicBezTo>
                  <a:cubicBezTo>
                    <a:pt x="337791" y="701821"/>
                    <a:pt x="323712" y="701085"/>
                    <a:pt x="314036" y="702160"/>
                  </a:cubicBezTo>
                  <a:cubicBezTo>
                    <a:pt x="268035" y="707271"/>
                    <a:pt x="221615" y="707553"/>
                    <a:pt x="175491" y="711397"/>
                  </a:cubicBezTo>
                  <a:cubicBezTo>
                    <a:pt x="147707" y="713712"/>
                    <a:pt x="120072" y="717554"/>
                    <a:pt x="92363" y="720633"/>
                  </a:cubicBezTo>
                  <a:cubicBezTo>
                    <a:pt x="86360" y="738641"/>
                    <a:pt x="71316" y="767248"/>
                    <a:pt x="92363" y="785288"/>
                  </a:cubicBezTo>
                  <a:cubicBezTo>
                    <a:pt x="107147" y="797960"/>
                    <a:pt x="129308" y="797603"/>
                    <a:pt x="147781" y="803760"/>
                  </a:cubicBezTo>
                  <a:cubicBezTo>
                    <a:pt x="157018" y="806839"/>
                    <a:pt x="166045" y="810636"/>
                    <a:pt x="175491" y="812997"/>
                  </a:cubicBezTo>
                  <a:cubicBezTo>
                    <a:pt x="221881" y="824594"/>
                    <a:pt x="200394" y="818219"/>
                    <a:pt x="240145" y="831470"/>
                  </a:cubicBezTo>
                  <a:cubicBezTo>
                    <a:pt x="249381" y="840706"/>
                    <a:pt x="257819" y="850817"/>
                    <a:pt x="267854" y="859179"/>
                  </a:cubicBezTo>
                  <a:cubicBezTo>
                    <a:pt x="321810" y="904142"/>
                    <a:pt x="335623" y="874980"/>
                    <a:pt x="434109" y="868415"/>
                  </a:cubicBezTo>
                  <a:cubicBezTo>
                    <a:pt x="443345" y="865336"/>
                    <a:pt x="452239" y="860921"/>
                    <a:pt x="461818" y="859179"/>
                  </a:cubicBezTo>
                  <a:cubicBezTo>
                    <a:pt x="576701" y="838291"/>
                    <a:pt x="499871" y="861887"/>
                    <a:pt x="563418" y="840706"/>
                  </a:cubicBezTo>
                  <a:cubicBezTo>
                    <a:pt x="560339" y="791445"/>
                    <a:pt x="559092" y="742036"/>
                    <a:pt x="554181" y="692924"/>
                  </a:cubicBezTo>
                  <a:cubicBezTo>
                    <a:pt x="551960" y="670715"/>
                    <a:pt x="541768" y="649475"/>
                    <a:pt x="535709" y="628270"/>
                  </a:cubicBezTo>
                  <a:cubicBezTo>
                    <a:pt x="531765" y="614466"/>
                    <a:pt x="524616" y="578374"/>
                    <a:pt x="517236" y="563615"/>
                  </a:cubicBezTo>
                  <a:cubicBezTo>
                    <a:pt x="512272" y="553686"/>
                    <a:pt x="504921" y="545142"/>
                    <a:pt x="498763" y="535906"/>
                  </a:cubicBezTo>
                  <a:cubicBezTo>
                    <a:pt x="491225" y="513292"/>
                    <a:pt x="485322" y="491226"/>
                    <a:pt x="471054" y="471251"/>
                  </a:cubicBezTo>
                  <a:cubicBezTo>
                    <a:pt x="463462" y="460622"/>
                    <a:pt x="452581" y="452778"/>
                    <a:pt x="443345" y="443542"/>
                  </a:cubicBezTo>
                  <a:cubicBezTo>
                    <a:pt x="425848" y="391050"/>
                    <a:pt x="440993" y="422716"/>
                    <a:pt x="378691" y="360415"/>
                  </a:cubicBezTo>
                  <a:cubicBezTo>
                    <a:pt x="361292" y="343016"/>
                    <a:pt x="346416" y="324520"/>
                    <a:pt x="323272" y="314233"/>
                  </a:cubicBezTo>
                  <a:cubicBezTo>
                    <a:pt x="305478" y="306325"/>
                    <a:pt x="284056" y="306561"/>
                    <a:pt x="267854" y="295760"/>
                  </a:cubicBezTo>
                  <a:cubicBezTo>
                    <a:pt x="188445" y="242822"/>
                    <a:pt x="288916" y="306291"/>
                    <a:pt x="212436" y="268051"/>
                  </a:cubicBezTo>
                  <a:cubicBezTo>
                    <a:pt x="202507" y="263087"/>
                    <a:pt x="193963" y="255736"/>
                    <a:pt x="184727" y="249579"/>
                  </a:cubicBezTo>
                  <a:cubicBezTo>
                    <a:pt x="172412" y="231106"/>
                    <a:pt x="154802" y="215223"/>
                    <a:pt x="147781" y="194160"/>
                  </a:cubicBezTo>
                  <a:lnTo>
                    <a:pt x="120072" y="111033"/>
                  </a:lnTo>
                  <a:cubicBezTo>
                    <a:pt x="116993" y="101797"/>
                    <a:pt x="116237" y="91425"/>
                    <a:pt x="110836" y="83324"/>
                  </a:cubicBezTo>
                  <a:cubicBezTo>
                    <a:pt x="87533" y="48370"/>
                    <a:pt x="90824" y="3276"/>
                    <a:pt x="73891" y="197"/>
                  </a:cubicBezTo>
                  <a:close/>
                </a:path>
              </a:pathLst>
            </a:custGeom>
            <a:solidFill>
              <a:schemeClr val="accent6">
                <a:alpha val="50000"/>
              </a:schemeClr>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grpSp>
      <p:sp>
        <p:nvSpPr>
          <p:cNvPr id="35" name="TextBox 34">
            <a:extLst>
              <a:ext uri="{FF2B5EF4-FFF2-40B4-BE49-F238E27FC236}">
                <a16:creationId xmlns:a16="http://schemas.microsoft.com/office/drawing/2014/main" id="{79AE3222-276C-4655-823E-0F5FE6103213}"/>
              </a:ext>
            </a:extLst>
          </p:cNvPr>
          <p:cNvSpPr txBox="1"/>
          <p:nvPr/>
        </p:nvSpPr>
        <p:spPr>
          <a:xfrm>
            <a:off x="7136677" y="4221455"/>
            <a:ext cx="2902157" cy="923330"/>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Cortical volume: solid green</a:t>
            </a:r>
          </a:p>
          <a:p>
            <a:endParaRPr lang="en-US" dirty="0">
              <a:latin typeface="Arial" panose="020B0604020202020204" pitchFamily="34" charset="0"/>
              <a:cs typeface="Arial" panose="020B0604020202020204" pitchFamily="34" charset="0"/>
            </a:endParaRPr>
          </a:p>
        </p:txBody>
      </p:sp>
      <p:sp>
        <p:nvSpPr>
          <p:cNvPr id="36" name="TextBox 35">
            <a:extLst>
              <a:ext uri="{FF2B5EF4-FFF2-40B4-BE49-F238E27FC236}">
                <a16:creationId xmlns:a16="http://schemas.microsoft.com/office/drawing/2014/main" id="{A5549A56-FBDE-4776-B363-D2F1CBA706AA}"/>
              </a:ext>
            </a:extLst>
          </p:cNvPr>
          <p:cNvSpPr txBox="1"/>
          <p:nvPr/>
        </p:nvSpPr>
        <p:spPr>
          <a:xfrm>
            <a:off x="1350207" y="5507718"/>
            <a:ext cx="4916731"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 Representative frames are of rat 61 (week 2)</a:t>
            </a:r>
          </a:p>
        </p:txBody>
      </p:sp>
      <p:sp>
        <p:nvSpPr>
          <p:cNvPr id="2" name="TextBox 1">
            <a:extLst>
              <a:ext uri="{FF2B5EF4-FFF2-40B4-BE49-F238E27FC236}">
                <a16:creationId xmlns:a16="http://schemas.microsoft.com/office/drawing/2014/main" id="{A0652D98-1014-4895-B380-28252FB8A0F7}"/>
              </a:ext>
            </a:extLst>
          </p:cNvPr>
          <p:cNvSpPr txBox="1"/>
          <p:nvPr/>
        </p:nvSpPr>
        <p:spPr>
          <a:xfrm>
            <a:off x="359764" y="6130977"/>
            <a:ext cx="9073253"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Figure S4. Designation of regions of interest (ROI) for quantification overlaid on a micro-CT image cross-section.</a:t>
            </a:r>
          </a:p>
        </p:txBody>
      </p:sp>
    </p:spTree>
    <p:extLst>
      <p:ext uri="{BB962C8B-B14F-4D97-AF65-F5344CB8AC3E}">
        <p14:creationId xmlns:p14="http://schemas.microsoft.com/office/powerpoint/2010/main" val="6161312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 name="Picture 17">
            <a:extLst>
              <a:ext uri="{FF2B5EF4-FFF2-40B4-BE49-F238E27FC236}">
                <a16:creationId xmlns:a16="http://schemas.microsoft.com/office/drawing/2014/main" id="{858CB8D7-2FAC-42FC-AAC2-9CE83C45B5E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545230" y="858560"/>
            <a:ext cx="3313508" cy="3593939"/>
          </a:xfrm>
          <a:prstGeom prst="rect">
            <a:avLst/>
          </a:prstGeom>
        </p:spPr>
      </p:pic>
      <p:sp>
        <p:nvSpPr>
          <p:cNvPr id="19" name="Rectangle 18">
            <a:extLst>
              <a:ext uri="{FF2B5EF4-FFF2-40B4-BE49-F238E27FC236}">
                <a16:creationId xmlns:a16="http://schemas.microsoft.com/office/drawing/2014/main" id="{6857CF30-50E6-4014-884A-4EE8C2347834}"/>
              </a:ext>
            </a:extLst>
          </p:cNvPr>
          <p:cNvSpPr/>
          <p:nvPr/>
        </p:nvSpPr>
        <p:spPr>
          <a:xfrm>
            <a:off x="1447916" y="4658764"/>
            <a:ext cx="3508136" cy="923330"/>
          </a:xfrm>
          <a:prstGeom prst="rect">
            <a:avLst/>
          </a:prstGeom>
        </p:spPr>
        <p:txBody>
          <a:bodyPr wrap="square">
            <a:spAutoFit/>
          </a:bodyPr>
          <a:lstStyle/>
          <a:p>
            <a:r>
              <a:rPr lang="en-US" dirty="0">
                <a:latin typeface="Arial" panose="020B0604020202020204" pitchFamily="34" charset="0"/>
                <a:cs typeface="Arial" panose="020B0604020202020204" pitchFamily="34" charset="0"/>
              </a:rPr>
              <a:t>Total tissue volume: green + red</a:t>
            </a:r>
          </a:p>
          <a:p>
            <a:r>
              <a:rPr lang="en-US" dirty="0">
                <a:latin typeface="Arial" panose="020B0604020202020204" pitchFamily="34" charset="0"/>
                <a:cs typeface="Arial" panose="020B0604020202020204" pitchFamily="34" charset="0"/>
              </a:rPr>
              <a:t>Total bone volume: red</a:t>
            </a:r>
          </a:p>
          <a:p>
            <a:r>
              <a:rPr lang="en-US" dirty="0">
                <a:latin typeface="Arial" panose="020B0604020202020204" pitchFamily="34" charset="0"/>
                <a:cs typeface="Arial" panose="020B0604020202020204" pitchFamily="34" charset="0"/>
              </a:rPr>
              <a:t>Soft tissue volume: blue</a:t>
            </a:r>
          </a:p>
        </p:txBody>
      </p:sp>
      <p:sp>
        <p:nvSpPr>
          <p:cNvPr id="2" name="TextBox 1">
            <a:extLst>
              <a:ext uri="{FF2B5EF4-FFF2-40B4-BE49-F238E27FC236}">
                <a16:creationId xmlns:a16="http://schemas.microsoft.com/office/drawing/2014/main" id="{A56047C5-B501-4263-A4F8-75D7FCF5B635}"/>
              </a:ext>
            </a:extLst>
          </p:cNvPr>
          <p:cNvSpPr txBox="1"/>
          <p:nvPr/>
        </p:nvSpPr>
        <p:spPr>
          <a:xfrm>
            <a:off x="164838" y="5850858"/>
            <a:ext cx="11557606" cy="523220"/>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Figure S5. Quantitative analyses of tibia at the osteotomy site. Designation of regions of interest for quantification overlaid on a micro-CT image cross-section (a); total tissue volume (b); total bone volume (c) and bone volume fraction (bone volume/total volume) (d).</a:t>
            </a:r>
          </a:p>
        </p:txBody>
      </p:sp>
      <p:graphicFrame>
        <p:nvGraphicFramePr>
          <p:cNvPr id="10" name="Chart 9">
            <a:extLst>
              <a:ext uri="{FF2B5EF4-FFF2-40B4-BE49-F238E27FC236}">
                <a16:creationId xmlns:a16="http://schemas.microsoft.com/office/drawing/2014/main" id="{9B206747-C231-40C9-8DB6-18FC14A74646}"/>
              </a:ext>
            </a:extLst>
          </p:cNvPr>
          <p:cNvGraphicFramePr>
            <a:graphicFrameLocks/>
          </p:cNvGraphicFramePr>
          <p:nvPr/>
        </p:nvGraphicFramePr>
        <p:xfrm>
          <a:off x="5390984" y="535332"/>
          <a:ext cx="4849473" cy="1642631"/>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1" name="Chart 10">
            <a:extLst>
              <a:ext uri="{FF2B5EF4-FFF2-40B4-BE49-F238E27FC236}">
                <a16:creationId xmlns:a16="http://schemas.microsoft.com/office/drawing/2014/main" id="{B04D17D4-A141-4E0A-9AE9-629FDEAE8717}"/>
              </a:ext>
            </a:extLst>
          </p:cNvPr>
          <p:cNvGraphicFramePr>
            <a:graphicFrameLocks/>
          </p:cNvGraphicFramePr>
          <p:nvPr/>
        </p:nvGraphicFramePr>
        <p:xfrm>
          <a:off x="5390984" y="2039436"/>
          <a:ext cx="4692009" cy="1791303"/>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12" name="Chart 11">
            <a:extLst>
              <a:ext uri="{FF2B5EF4-FFF2-40B4-BE49-F238E27FC236}">
                <a16:creationId xmlns:a16="http://schemas.microsoft.com/office/drawing/2014/main" id="{4B07C04C-0257-4A95-BCF5-3FB15F7E2B3A}"/>
              </a:ext>
            </a:extLst>
          </p:cNvPr>
          <p:cNvGraphicFramePr>
            <a:graphicFrameLocks/>
          </p:cNvGraphicFramePr>
          <p:nvPr/>
        </p:nvGraphicFramePr>
        <p:xfrm>
          <a:off x="5335326" y="3830740"/>
          <a:ext cx="4747668" cy="1922608"/>
        </p:xfrm>
        <a:graphic>
          <a:graphicData uri="http://schemas.openxmlformats.org/drawingml/2006/chart">
            <c:chart xmlns:c="http://schemas.openxmlformats.org/drawingml/2006/chart" xmlns:r="http://schemas.openxmlformats.org/officeDocument/2006/relationships" r:id="rId6"/>
          </a:graphicData>
        </a:graphic>
      </p:graphicFrame>
      <p:sp>
        <p:nvSpPr>
          <p:cNvPr id="3" name="TextBox 2">
            <a:extLst>
              <a:ext uri="{FF2B5EF4-FFF2-40B4-BE49-F238E27FC236}">
                <a16:creationId xmlns:a16="http://schemas.microsoft.com/office/drawing/2014/main" id="{FED23766-7D78-438F-8F64-17FE27086FE7}"/>
              </a:ext>
            </a:extLst>
          </p:cNvPr>
          <p:cNvSpPr txBox="1"/>
          <p:nvPr/>
        </p:nvSpPr>
        <p:spPr>
          <a:xfrm>
            <a:off x="4935489" y="480211"/>
            <a:ext cx="46679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sp>
        <p:nvSpPr>
          <p:cNvPr id="13" name="TextBox 12">
            <a:extLst>
              <a:ext uri="{FF2B5EF4-FFF2-40B4-BE49-F238E27FC236}">
                <a16:creationId xmlns:a16="http://schemas.microsoft.com/office/drawing/2014/main" id="{D2C637F8-86B9-4224-A363-0AADD4A9A696}"/>
              </a:ext>
            </a:extLst>
          </p:cNvPr>
          <p:cNvSpPr txBox="1"/>
          <p:nvPr/>
        </p:nvSpPr>
        <p:spPr>
          <a:xfrm>
            <a:off x="9441600" y="542788"/>
            <a:ext cx="46679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sp>
        <p:nvSpPr>
          <p:cNvPr id="14" name="TextBox 13">
            <a:extLst>
              <a:ext uri="{FF2B5EF4-FFF2-40B4-BE49-F238E27FC236}">
                <a16:creationId xmlns:a16="http://schemas.microsoft.com/office/drawing/2014/main" id="{FAC4D770-E4EC-433C-BB14-F90FE97A14B1}"/>
              </a:ext>
            </a:extLst>
          </p:cNvPr>
          <p:cNvSpPr txBox="1"/>
          <p:nvPr/>
        </p:nvSpPr>
        <p:spPr>
          <a:xfrm>
            <a:off x="9441600" y="2057654"/>
            <a:ext cx="453970"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c)</a:t>
            </a:r>
          </a:p>
        </p:txBody>
      </p:sp>
      <p:sp>
        <p:nvSpPr>
          <p:cNvPr id="15" name="TextBox 14">
            <a:extLst>
              <a:ext uri="{FF2B5EF4-FFF2-40B4-BE49-F238E27FC236}">
                <a16:creationId xmlns:a16="http://schemas.microsoft.com/office/drawing/2014/main" id="{81FD8855-CFB5-4D36-8993-AA4197E9722B}"/>
              </a:ext>
            </a:extLst>
          </p:cNvPr>
          <p:cNvSpPr txBox="1"/>
          <p:nvPr/>
        </p:nvSpPr>
        <p:spPr>
          <a:xfrm>
            <a:off x="9441600" y="3743583"/>
            <a:ext cx="46679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185343111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A538271D-3EF6-4F41-BEE9-3DA649A9D989}"/>
              </a:ext>
            </a:extLst>
          </p:cNvPr>
          <p:cNvGraphicFramePr>
            <a:graphicFrameLocks/>
          </p:cNvGraphicFramePr>
          <p:nvPr>
            <p:extLst>
              <p:ext uri="{D42A27DB-BD31-4B8C-83A1-F6EECF244321}">
                <p14:modId xmlns:p14="http://schemas.microsoft.com/office/powerpoint/2010/main" val="3276862805"/>
              </p:ext>
            </p:extLst>
          </p:nvPr>
        </p:nvGraphicFramePr>
        <p:xfrm>
          <a:off x="6483563" y="380110"/>
          <a:ext cx="4440584" cy="2593234"/>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a:extLst>
              <a:ext uri="{FF2B5EF4-FFF2-40B4-BE49-F238E27FC236}">
                <a16:creationId xmlns:a16="http://schemas.microsoft.com/office/drawing/2014/main" id="{D81AD6E3-F80A-4D67-B179-8B0E131A4E1E}"/>
              </a:ext>
            </a:extLst>
          </p:cNvPr>
          <p:cNvGraphicFramePr>
            <a:graphicFrameLocks/>
          </p:cNvGraphicFramePr>
          <p:nvPr>
            <p:extLst>
              <p:ext uri="{D42A27DB-BD31-4B8C-83A1-F6EECF244321}">
                <p14:modId xmlns:p14="http://schemas.microsoft.com/office/powerpoint/2010/main" val="1071784305"/>
              </p:ext>
            </p:extLst>
          </p:nvPr>
        </p:nvGraphicFramePr>
        <p:xfrm>
          <a:off x="6335628" y="3036440"/>
          <a:ext cx="4588519" cy="2807161"/>
        </p:xfrm>
        <a:graphic>
          <a:graphicData uri="http://schemas.openxmlformats.org/drawingml/2006/chart">
            <c:chart xmlns:c="http://schemas.openxmlformats.org/drawingml/2006/chart" xmlns:r="http://schemas.openxmlformats.org/officeDocument/2006/relationships" r:id="rId3"/>
          </a:graphicData>
        </a:graphic>
      </p:graphicFrame>
      <p:pic>
        <p:nvPicPr>
          <p:cNvPr id="6" name="Picture 5">
            <a:extLst>
              <a:ext uri="{FF2B5EF4-FFF2-40B4-BE49-F238E27FC236}">
                <a16:creationId xmlns:a16="http://schemas.microsoft.com/office/drawing/2014/main" id="{2302BEC8-92E0-4D1F-951B-F7FA1B9ED090}"/>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588294" y="474316"/>
            <a:ext cx="4208072" cy="5081550"/>
          </a:xfrm>
          <a:prstGeom prst="rect">
            <a:avLst/>
          </a:prstGeom>
        </p:spPr>
      </p:pic>
      <p:cxnSp>
        <p:nvCxnSpPr>
          <p:cNvPr id="8" name="Straight Connector 7">
            <a:extLst>
              <a:ext uri="{FF2B5EF4-FFF2-40B4-BE49-F238E27FC236}">
                <a16:creationId xmlns:a16="http://schemas.microsoft.com/office/drawing/2014/main" id="{548471EB-FC8B-4486-93C0-ABE43E2A3C38}"/>
              </a:ext>
            </a:extLst>
          </p:cNvPr>
          <p:cNvCxnSpPr>
            <a:cxnSpLocks/>
          </p:cNvCxnSpPr>
          <p:nvPr/>
        </p:nvCxnSpPr>
        <p:spPr>
          <a:xfrm>
            <a:off x="2938753" y="1042028"/>
            <a:ext cx="2219417" cy="1020932"/>
          </a:xfrm>
          <a:prstGeom prst="line">
            <a:avLst/>
          </a:prstGeom>
          <a:ln>
            <a:solidFill>
              <a:schemeClr val="accent6"/>
            </a:solidFill>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581C9C27-23E0-4899-B0B2-19565F8D4BA9}"/>
              </a:ext>
            </a:extLst>
          </p:cNvPr>
          <p:cNvCxnSpPr/>
          <p:nvPr/>
        </p:nvCxnSpPr>
        <p:spPr>
          <a:xfrm flipV="1">
            <a:off x="2299561" y="3562278"/>
            <a:ext cx="2654423" cy="196317"/>
          </a:xfrm>
          <a:prstGeom prst="line">
            <a:avLst/>
          </a:prstGeom>
          <a:ln>
            <a:solidFill>
              <a:schemeClr val="accent6"/>
            </a:solidFill>
          </a:ln>
        </p:spPr>
        <p:style>
          <a:lnRef idx="1">
            <a:schemeClr val="accent1"/>
          </a:lnRef>
          <a:fillRef idx="0">
            <a:schemeClr val="accent1"/>
          </a:fillRef>
          <a:effectRef idx="0">
            <a:schemeClr val="accent1"/>
          </a:effectRef>
          <a:fontRef idx="minor">
            <a:schemeClr val="tx1"/>
          </a:fontRef>
        </p:style>
      </p:cxnSp>
      <p:sp>
        <p:nvSpPr>
          <p:cNvPr id="10" name="Freeform: Shape 9">
            <a:extLst>
              <a:ext uri="{FF2B5EF4-FFF2-40B4-BE49-F238E27FC236}">
                <a16:creationId xmlns:a16="http://schemas.microsoft.com/office/drawing/2014/main" id="{77D9FFBC-58A6-4852-8A7F-CFFC36BDD994}"/>
              </a:ext>
            </a:extLst>
          </p:cNvPr>
          <p:cNvSpPr/>
          <p:nvPr/>
        </p:nvSpPr>
        <p:spPr>
          <a:xfrm>
            <a:off x="2157518" y="1068661"/>
            <a:ext cx="763480" cy="2718145"/>
          </a:xfrm>
          <a:custGeom>
            <a:avLst/>
            <a:gdLst>
              <a:gd name="connsiteX0" fmla="*/ 763480 w 763480"/>
              <a:gd name="connsiteY0" fmla="*/ 0 h 2718145"/>
              <a:gd name="connsiteX1" fmla="*/ 754602 w 763480"/>
              <a:gd name="connsiteY1" fmla="*/ 53266 h 2718145"/>
              <a:gd name="connsiteX2" fmla="*/ 736847 w 763480"/>
              <a:gd name="connsiteY2" fmla="*/ 79899 h 2718145"/>
              <a:gd name="connsiteX3" fmla="*/ 719091 w 763480"/>
              <a:gd name="connsiteY3" fmla="*/ 115410 h 2718145"/>
              <a:gd name="connsiteX4" fmla="*/ 701336 w 763480"/>
              <a:gd name="connsiteY4" fmla="*/ 168676 h 2718145"/>
              <a:gd name="connsiteX5" fmla="*/ 692458 w 763480"/>
              <a:gd name="connsiteY5" fmla="*/ 195309 h 2718145"/>
              <a:gd name="connsiteX6" fmla="*/ 656948 w 763480"/>
              <a:gd name="connsiteY6" fmla="*/ 257453 h 2718145"/>
              <a:gd name="connsiteX7" fmla="*/ 621437 w 763480"/>
              <a:gd name="connsiteY7" fmla="*/ 310719 h 2718145"/>
              <a:gd name="connsiteX8" fmla="*/ 603682 w 763480"/>
              <a:gd name="connsiteY8" fmla="*/ 363985 h 2718145"/>
              <a:gd name="connsiteX9" fmla="*/ 585926 w 763480"/>
              <a:gd name="connsiteY9" fmla="*/ 399496 h 2718145"/>
              <a:gd name="connsiteX10" fmla="*/ 577048 w 763480"/>
              <a:gd name="connsiteY10" fmla="*/ 426129 h 2718145"/>
              <a:gd name="connsiteX11" fmla="*/ 541538 w 763480"/>
              <a:gd name="connsiteY11" fmla="*/ 479395 h 2718145"/>
              <a:gd name="connsiteX12" fmla="*/ 523782 w 763480"/>
              <a:gd name="connsiteY12" fmla="*/ 506028 h 2718145"/>
              <a:gd name="connsiteX13" fmla="*/ 514905 w 763480"/>
              <a:gd name="connsiteY13" fmla="*/ 532661 h 2718145"/>
              <a:gd name="connsiteX14" fmla="*/ 497149 w 763480"/>
              <a:gd name="connsiteY14" fmla="*/ 559294 h 2718145"/>
              <a:gd name="connsiteX15" fmla="*/ 488272 w 763480"/>
              <a:gd name="connsiteY15" fmla="*/ 594804 h 2718145"/>
              <a:gd name="connsiteX16" fmla="*/ 470516 w 763480"/>
              <a:gd name="connsiteY16" fmla="*/ 612560 h 2718145"/>
              <a:gd name="connsiteX17" fmla="*/ 452761 w 763480"/>
              <a:gd name="connsiteY17" fmla="*/ 648070 h 2718145"/>
              <a:gd name="connsiteX18" fmla="*/ 443883 w 763480"/>
              <a:gd name="connsiteY18" fmla="*/ 674703 h 2718145"/>
              <a:gd name="connsiteX19" fmla="*/ 426128 w 763480"/>
              <a:gd name="connsiteY19" fmla="*/ 701336 h 2718145"/>
              <a:gd name="connsiteX20" fmla="*/ 390617 w 763480"/>
              <a:gd name="connsiteY20" fmla="*/ 781235 h 2718145"/>
              <a:gd name="connsiteX21" fmla="*/ 363984 w 763480"/>
              <a:gd name="connsiteY21" fmla="*/ 825624 h 2718145"/>
              <a:gd name="connsiteX22" fmla="*/ 337351 w 763480"/>
              <a:gd name="connsiteY22" fmla="*/ 870012 h 2718145"/>
              <a:gd name="connsiteX23" fmla="*/ 328474 w 763480"/>
              <a:gd name="connsiteY23" fmla="*/ 905523 h 2718145"/>
              <a:gd name="connsiteX24" fmla="*/ 310718 w 763480"/>
              <a:gd name="connsiteY24" fmla="*/ 923278 h 2718145"/>
              <a:gd name="connsiteX25" fmla="*/ 292963 w 763480"/>
              <a:gd name="connsiteY25" fmla="*/ 976544 h 2718145"/>
              <a:gd name="connsiteX26" fmla="*/ 266330 w 763480"/>
              <a:gd name="connsiteY26" fmla="*/ 1029810 h 2718145"/>
              <a:gd name="connsiteX27" fmla="*/ 230819 w 763480"/>
              <a:gd name="connsiteY27" fmla="*/ 1091954 h 2718145"/>
              <a:gd name="connsiteX28" fmla="*/ 213064 w 763480"/>
              <a:gd name="connsiteY28" fmla="*/ 1145220 h 2718145"/>
              <a:gd name="connsiteX29" fmla="*/ 195309 w 763480"/>
              <a:gd name="connsiteY29" fmla="*/ 1171853 h 2718145"/>
              <a:gd name="connsiteX30" fmla="*/ 186431 w 763480"/>
              <a:gd name="connsiteY30" fmla="*/ 1198486 h 2718145"/>
              <a:gd name="connsiteX31" fmla="*/ 159798 w 763480"/>
              <a:gd name="connsiteY31" fmla="*/ 1225119 h 2718145"/>
              <a:gd name="connsiteX32" fmla="*/ 150920 w 763480"/>
              <a:gd name="connsiteY32" fmla="*/ 1251752 h 2718145"/>
              <a:gd name="connsiteX33" fmla="*/ 115410 w 763480"/>
              <a:gd name="connsiteY33" fmla="*/ 1313896 h 2718145"/>
              <a:gd name="connsiteX34" fmla="*/ 97654 w 763480"/>
              <a:gd name="connsiteY34" fmla="*/ 1376039 h 2718145"/>
              <a:gd name="connsiteX35" fmla="*/ 88777 w 763480"/>
              <a:gd name="connsiteY35" fmla="*/ 1402672 h 2718145"/>
              <a:gd name="connsiteX36" fmla="*/ 79899 w 763480"/>
              <a:gd name="connsiteY36" fmla="*/ 1438183 h 2718145"/>
              <a:gd name="connsiteX37" fmla="*/ 62144 w 763480"/>
              <a:gd name="connsiteY37" fmla="*/ 1491449 h 2718145"/>
              <a:gd name="connsiteX38" fmla="*/ 44388 w 763480"/>
              <a:gd name="connsiteY38" fmla="*/ 1553593 h 2718145"/>
              <a:gd name="connsiteX39" fmla="*/ 35511 w 763480"/>
              <a:gd name="connsiteY39" fmla="*/ 1624614 h 2718145"/>
              <a:gd name="connsiteX40" fmla="*/ 17755 w 763480"/>
              <a:gd name="connsiteY40" fmla="*/ 2032987 h 2718145"/>
              <a:gd name="connsiteX41" fmla="*/ 0 w 763480"/>
              <a:gd name="connsiteY41" fmla="*/ 2095130 h 2718145"/>
              <a:gd name="connsiteX42" fmla="*/ 8878 w 763480"/>
              <a:gd name="connsiteY42" fmla="*/ 2121763 h 2718145"/>
              <a:gd name="connsiteX43" fmla="*/ 26633 w 763480"/>
              <a:gd name="connsiteY43" fmla="*/ 2148396 h 2718145"/>
              <a:gd name="connsiteX44" fmla="*/ 35511 w 763480"/>
              <a:gd name="connsiteY44" fmla="*/ 2459115 h 2718145"/>
              <a:gd name="connsiteX45" fmla="*/ 44388 w 763480"/>
              <a:gd name="connsiteY45" fmla="*/ 2494626 h 2718145"/>
              <a:gd name="connsiteX46" fmla="*/ 53266 w 763480"/>
              <a:gd name="connsiteY46" fmla="*/ 2539014 h 2718145"/>
              <a:gd name="connsiteX47" fmla="*/ 88777 w 763480"/>
              <a:gd name="connsiteY47" fmla="*/ 2636668 h 2718145"/>
              <a:gd name="connsiteX48" fmla="*/ 124287 w 763480"/>
              <a:gd name="connsiteY48" fmla="*/ 2716567 h 2718145"/>
              <a:gd name="connsiteX49" fmla="*/ 142043 w 763480"/>
              <a:gd name="connsiteY49" fmla="*/ 2716567 h 271814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Lst>
            <a:rect l="l" t="t" r="r" b="b"/>
            <a:pathLst>
              <a:path w="763480" h="2718145">
                <a:moveTo>
                  <a:pt x="763480" y="0"/>
                </a:moveTo>
                <a:cubicBezTo>
                  <a:pt x="760521" y="17755"/>
                  <a:pt x="760294" y="36189"/>
                  <a:pt x="754602" y="53266"/>
                </a:cubicBezTo>
                <a:cubicBezTo>
                  <a:pt x="751228" y="63388"/>
                  <a:pt x="742141" y="70635"/>
                  <a:pt x="736847" y="79899"/>
                </a:cubicBezTo>
                <a:cubicBezTo>
                  <a:pt x="730281" y="91390"/>
                  <a:pt x="724006" y="103122"/>
                  <a:pt x="719091" y="115410"/>
                </a:cubicBezTo>
                <a:cubicBezTo>
                  <a:pt x="712140" y="132787"/>
                  <a:pt x="707254" y="150921"/>
                  <a:pt x="701336" y="168676"/>
                </a:cubicBezTo>
                <a:cubicBezTo>
                  <a:pt x="698377" y="177554"/>
                  <a:pt x="697649" y="187523"/>
                  <a:pt x="692458" y="195309"/>
                </a:cubicBezTo>
                <a:cubicBezTo>
                  <a:pt x="631029" y="287454"/>
                  <a:pt x="724540" y="144799"/>
                  <a:pt x="656948" y="257453"/>
                </a:cubicBezTo>
                <a:cubicBezTo>
                  <a:pt x="645969" y="275751"/>
                  <a:pt x="628185" y="290475"/>
                  <a:pt x="621437" y="310719"/>
                </a:cubicBezTo>
                <a:cubicBezTo>
                  <a:pt x="615519" y="328474"/>
                  <a:pt x="612052" y="347245"/>
                  <a:pt x="603682" y="363985"/>
                </a:cubicBezTo>
                <a:cubicBezTo>
                  <a:pt x="597763" y="375822"/>
                  <a:pt x="591139" y="387332"/>
                  <a:pt x="585926" y="399496"/>
                </a:cubicBezTo>
                <a:cubicBezTo>
                  <a:pt x="582240" y="408097"/>
                  <a:pt x="581593" y="417949"/>
                  <a:pt x="577048" y="426129"/>
                </a:cubicBezTo>
                <a:cubicBezTo>
                  <a:pt x="566685" y="444783"/>
                  <a:pt x="553375" y="461640"/>
                  <a:pt x="541538" y="479395"/>
                </a:cubicBezTo>
                <a:lnTo>
                  <a:pt x="523782" y="506028"/>
                </a:lnTo>
                <a:cubicBezTo>
                  <a:pt x="520823" y="514906"/>
                  <a:pt x="519090" y="524291"/>
                  <a:pt x="514905" y="532661"/>
                </a:cubicBezTo>
                <a:cubicBezTo>
                  <a:pt x="510133" y="542204"/>
                  <a:pt x="501352" y="549487"/>
                  <a:pt x="497149" y="559294"/>
                </a:cubicBezTo>
                <a:cubicBezTo>
                  <a:pt x="492343" y="570508"/>
                  <a:pt x="493728" y="583891"/>
                  <a:pt x="488272" y="594804"/>
                </a:cubicBezTo>
                <a:cubicBezTo>
                  <a:pt x="484529" y="602291"/>
                  <a:pt x="475159" y="605596"/>
                  <a:pt x="470516" y="612560"/>
                </a:cubicBezTo>
                <a:cubicBezTo>
                  <a:pt x="463175" y="623571"/>
                  <a:pt x="457974" y="635906"/>
                  <a:pt x="452761" y="648070"/>
                </a:cubicBezTo>
                <a:cubicBezTo>
                  <a:pt x="449075" y="656671"/>
                  <a:pt x="448068" y="666333"/>
                  <a:pt x="443883" y="674703"/>
                </a:cubicBezTo>
                <a:cubicBezTo>
                  <a:pt x="439111" y="684246"/>
                  <a:pt x="430461" y="691586"/>
                  <a:pt x="426128" y="701336"/>
                </a:cubicBezTo>
                <a:cubicBezTo>
                  <a:pt x="383872" y="796413"/>
                  <a:pt x="430799" y="720964"/>
                  <a:pt x="390617" y="781235"/>
                </a:cubicBezTo>
                <a:cubicBezTo>
                  <a:pt x="365471" y="856680"/>
                  <a:pt x="400542" y="764693"/>
                  <a:pt x="363984" y="825624"/>
                </a:cubicBezTo>
                <a:cubicBezTo>
                  <a:pt x="329412" y="883244"/>
                  <a:pt x="382339" y="825026"/>
                  <a:pt x="337351" y="870012"/>
                </a:cubicBezTo>
                <a:cubicBezTo>
                  <a:pt x="334392" y="881849"/>
                  <a:pt x="333931" y="894610"/>
                  <a:pt x="328474" y="905523"/>
                </a:cubicBezTo>
                <a:cubicBezTo>
                  <a:pt x="324731" y="913009"/>
                  <a:pt x="314461" y="915792"/>
                  <a:pt x="310718" y="923278"/>
                </a:cubicBezTo>
                <a:cubicBezTo>
                  <a:pt x="302348" y="940018"/>
                  <a:pt x="303344" y="960971"/>
                  <a:pt x="292963" y="976544"/>
                </a:cubicBezTo>
                <a:cubicBezTo>
                  <a:pt x="242080" y="1052870"/>
                  <a:pt x="303085" y="956300"/>
                  <a:pt x="266330" y="1029810"/>
                </a:cubicBezTo>
                <a:cubicBezTo>
                  <a:pt x="234303" y="1093864"/>
                  <a:pt x="261944" y="1014142"/>
                  <a:pt x="230819" y="1091954"/>
                </a:cubicBezTo>
                <a:cubicBezTo>
                  <a:pt x="223868" y="1109331"/>
                  <a:pt x="223445" y="1129647"/>
                  <a:pt x="213064" y="1145220"/>
                </a:cubicBezTo>
                <a:cubicBezTo>
                  <a:pt x="207146" y="1154098"/>
                  <a:pt x="200081" y="1162310"/>
                  <a:pt x="195309" y="1171853"/>
                </a:cubicBezTo>
                <a:cubicBezTo>
                  <a:pt x="191124" y="1180223"/>
                  <a:pt x="191622" y="1190700"/>
                  <a:pt x="186431" y="1198486"/>
                </a:cubicBezTo>
                <a:cubicBezTo>
                  <a:pt x="179467" y="1208932"/>
                  <a:pt x="168676" y="1216241"/>
                  <a:pt x="159798" y="1225119"/>
                </a:cubicBezTo>
                <a:cubicBezTo>
                  <a:pt x="156839" y="1233997"/>
                  <a:pt x="155105" y="1243382"/>
                  <a:pt x="150920" y="1251752"/>
                </a:cubicBezTo>
                <a:cubicBezTo>
                  <a:pt x="106342" y="1340908"/>
                  <a:pt x="162101" y="1204949"/>
                  <a:pt x="115410" y="1313896"/>
                </a:cubicBezTo>
                <a:cubicBezTo>
                  <a:pt x="106288" y="1335182"/>
                  <a:pt x="104090" y="1353514"/>
                  <a:pt x="97654" y="1376039"/>
                </a:cubicBezTo>
                <a:cubicBezTo>
                  <a:pt x="95083" y="1385037"/>
                  <a:pt x="91348" y="1393674"/>
                  <a:pt x="88777" y="1402672"/>
                </a:cubicBezTo>
                <a:cubicBezTo>
                  <a:pt x="85425" y="1414404"/>
                  <a:pt x="83405" y="1426496"/>
                  <a:pt x="79899" y="1438183"/>
                </a:cubicBezTo>
                <a:cubicBezTo>
                  <a:pt x="74521" y="1456109"/>
                  <a:pt x="66683" y="1473292"/>
                  <a:pt x="62144" y="1491449"/>
                </a:cubicBezTo>
                <a:cubicBezTo>
                  <a:pt x="50996" y="1536038"/>
                  <a:pt x="57125" y="1515385"/>
                  <a:pt x="44388" y="1553593"/>
                </a:cubicBezTo>
                <a:cubicBezTo>
                  <a:pt x="41429" y="1577267"/>
                  <a:pt x="36525" y="1600778"/>
                  <a:pt x="35511" y="1624614"/>
                </a:cubicBezTo>
                <a:cubicBezTo>
                  <a:pt x="29577" y="1764068"/>
                  <a:pt x="42329" y="1897825"/>
                  <a:pt x="17755" y="2032987"/>
                </a:cubicBezTo>
                <a:cubicBezTo>
                  <a:pt x="13295" y="2057516"/>
                  <a:pt x="7608" y="2072308"/>
                  <a:pt x="0" y="2095130"/>
                </a:cubicBezTo>
                <a:cubicBezTo>
                  <a:pt x="2959" y="2104008"/>
                  <a:pt x="4693" y="2113393"/>
                  <a:pt x="8878" y="2121763"/>
                </a:cubicBezTo>
                <a:cubicBezTo>
                  <a:pt x="13650" y="2131306"/>
                  <a:pt x="25793" y="2137760"/>
                  <a:pt x="26633" y="2148396"/>
                </a:cubicBezTo>
                <a:cubicBezTo>
                  <a:pt x="34788" y="2251690"/>
                  <a:pt x="30204" y="2355636"/>
                  <a:pt x="35511" y="2459115"/>
                </a:cubicBezTo>
                <a:cubicBezTo>
                  <a:pt x="36136" y="2471300"/>
                  <a:pt x="41741" y="2482715"/>
                  <a:pt x="44388" y="2494626"/>
                </a:cubicBezTo>
                <a:cubicBezTo>
                  <a:pt x="47661" y="2509356"/>
                  <a:pt x="49873" y="2524311"/>
                  <a:pt x="53266" y="2539014"/>
                </a:cubicBezTo>
                <a:cubicBezTo>
                  <a:pt x="71216" y="2616797"/>
                  <a:pt x="58531" y="2591301"/>
                  <a:pt x="88777" y="2636668"/>
                </a:cubicBezTo>
                <a:cubicBezTo>
                  <a:pt x="93454" y="2650699"/>
                  <a:pt x="105530" y="2702499"/>
                  <a:pt x="124287" y="2716567"/>
                </a:cubicBezTo>
                <a:cubicBezTo>
                  <a:pt x="129022" y="2720118"/>
                  <a:pt x="136124" y="2716567"/>
                  <a:pt x="142043" y="2716567"/>
                </a:cubicBezTo>
              </a:path>
            </a:pathLst>
          </a:custGeom>
          <a:no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11" name="Freeform: Shape 10">
            <a:extLst>
              <a:ext uri="{FF2B5EF4-FFF2-40B4-BE49-F238E27FC236}">
                <a16:creationId xmlns:a16="http://schemas.microsoft.com/office/drawing/2014/main" id="{C77BAC7F-D715-4E11-AC5C-F841A30900B9}"/>
              </a:ext>
            </a:extLst>
          </p:cNvPr>
          <p:cNvSpPr/>
          <p:nvPr/>
        </p:nvSpPr>
        <p:spPr>
          <a:xfrm>
            <a:off x="4763050" y="2080716"/>
            <a:ext cx="386243" cy="1491448"/>
          </a:xfrm>
          <a:custGeom>
            <a:avLst/>
            <a:gdLst>
              <a:gd name="connsiteX0" fmla="*/ 386243 w 386243"/>
              <a:gd name="connsiteY0" fmla="*/ 0 h 1491448"/>
              <a:gd name="connsiteX1" fmla="*/ 341854 w 386243"/>
              <a:gd name="connsiteY1" fmla="*/ 35510 h 1491448"/>
              <a:gd name="connsiteX2" fmla="*/ 315221 w 386243"/>
              <a:gd name="connsiteY2" fmla="*/ 88776 h 1491448"/>
              <a:gd name="connsiteX3" fmla="*/ 297466 w 386243"/>
              <a:gd name="connsiteY3" fmla="*/ 106532 h 1491448"/>
              <a:gd name="connsiteX4" fmla="*/ 253078 w 386243"/>
              <a:gd name="connsiteY4" fmla="*/ 186431 h 1491448"/>
              <a:gd name="connsiteX5" fmla="*/ 235322 w 386243"/>
              <a:gd name="connsiteY5" fmla="*/ 213064 h 1491448"/>
              <a:gd name="connsiteX6" fmla="*/ 208689 w 386243"/>
              <a:gd name="connsiteY6" fmla="*/ 292963 h 1491448"/>
              <a:gd name="connsiteX7" fmla="*/ 199812 w 386243"/>
              <a:gd name="connsiteY7" fmla="*/ 319596 h 1491448"/>
              <a:gd name="connsiteX8" fmla="*/ 182056 w 386243"/>
              <a:gd name="connsiteY8" fmla="*/ 346229 h 1491448"/>
              <a:gd name="connsiteX9" fmla="*/ 164301 w 386243"/>
              <a:gd name="connsiteY9" fmla="*/ 381740 h 1491448"/>
              <a:gd name="connsiteX10" fmla="*/ 137668 w 386243"/>
              <a:gd name="connsiteY10" fmla="*/ 408373 h 1491448"/>
              <a:gd name="connsiteX11" fmla="*/ 111035 w 386243"/>
              <a:gd name="connsiteY11" fmla="*/ 461639 h 1491448"/>
              <a:gd name="connsiteX12" fmla="*/ 102157 w 386243"/>
              <a:gd name="connsiteY12" fmla="*/ 488272 h 1491448"/>
              <a:gd name="connsiteX13" fmla="*/ 66647 w 386243"/>
              <a:gd name="connsiteY13" fmla="*/ 541538 h 1491448"/>
              <a:gd name="connsiteX14" fmla="*/ 48891 w 386243"/>
              <a:gd name="connsiteY14" fmla="*/ 568171 h 1491448"/>
              <a:gd name="connsiteX15" fmla="*/ 13381 w 386243"/>
              <a:gd name="connsiteY15" fmla="*/ 648070 h 1491448"/>
              <a:gd name="connsiteX16" fmla="*/ 13381 w 386243"/>
              <a:gd name="connsiteY16" fmla="*/ 861134 h 1491448"/>
              <a:gd name="connsiteX17" fmla="*/ 40014 w 386243"/>
              <a:gd name="connsiteY17" fmla="*/ 878889 h 1491448"/>
              <a:gd name="connsiteX18" fmla="*/ 48891 w 386243"/>
              <a:gd name="connsiteY18" fmla="*/ 1047565 h 1491448"/>
              <a:gd name="connsiteX19" fmla="*/ 57769 w 386243"/>
              <a:gd name="connsiteY19" fmla="*/ 1083075 h 1491448"/>
              <a:gd name="connsiteX20" fmla="*/ 66647 w 386243"/>
              <a:gd name="connsiteY20" fmla="*/ 1127464 h 1491448"/>
              <a:gd name="connsiteX21" fmla="*/ 84402 w 386243"/>
              <a:gd name="connsiteY21" fmla="*/ 1180730 h 1491448"/>
              <a:gd name="connsiteX22" fmla="*/ 102157 w 386243"/>
              <a:gd name="connsiteY22" fmla="*/ 1260629 h 1491448"/>
              <a:gd name="connsiteX23" fmla="*/ 119913 w 386243"/>
              <a:gd name="connsiteY23" fmla="*/ 1340528 h 1491448"/>
              <a:gd name="connsiteX24" fmla="*/ 137668 w 386243"/>
              <a:gd name="connsiteY24" fmla="*/ 1393794 h 1491448"/>
              <a:gd name="connsiteX25" fmla="*/ 146546 w 386243"/>
              <a:gd name="connsiteY25" fmla="*/ 1420427 h 1491448"/>
              <a:gd name="connsiteX26" fmla="*/ 182056 w 386243"/>
              <a:gd name="connsiteY26" fmla="*/ 1491448 h 149144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Lst>
            <a:rect l="l" t="t" r="r" b="b"/>
            <a:pathLst>
              <a:path w="386243" h="1491448">
                <a:moveTo>
                  <a:pt x="386243" y="0"/>
                </a:moveTo>
                <a:cubicBezTo>
                  <a:pt x="371447" y="11837"/>
                  <a:pt x="355253" y="22112"/>
                  <a:pt x="341854" y="35510"/>
                </a:cubicBezTo>
                <a:cubicBezTo>
                  <a:pt x="308184" y="69180"/>
                  <a:pt x="336879" y="52678"/>
                  <a:pt x="315221" y="88776"/>
                </a:cubicBezTo>
                <a:cubicBezTo>
                  <a:pt x="310915" y="95953"/>
                  <a:pt x="303384" y="100613"/>
                  <a:pt x="297466" y="106532"/>
                </a:cubicBezTo>
                <a:cubicBezTo>
                  <a:pt x="281840" y="153408"/>
                  <a:pt x="293778" y="125381"/>
                  <a:pt x="253078" y="186431"/>
                </a:cubicBezTo>
                <a:lnTo>
                  <a:pt x="235322" y="213064"/>
                </a:lnTo>
                <a:lnTo>
                  <a:pt x="208689" y="292963"/>
                </a:lnTo>
                <a:cubicBezTo>
                  <a:pt x="205730" y="301841"/>
                  <a:pt x="205003" y="311810"/>
                  <a:pt x="199812" y="319596"/>
                </a:cubicBezTo>
                <a:cubicBezTo>
                  <a:pt x="193893" y="328474"/>
                  <a:pt x="187350" y="336965"/>
                  <a:pt x="182056" y="346229"/>
                </a:cubicBezTo>
                <a:cubicBezTo>
                  <a:pt x="175490" y="357719"/>
                  <a:pt x="171993" y="370971"/>
                  <a:pt x="164301" y="381740"/>
                </a:cubicBezTo>
                <a:cubicBezTo>
                  <a:pt x="157004" y="391956"/>
                  <a:pt x="146546" y="399495"/>
                  <a:pt x="137668" y="408373"/>
                </a:cubicBezTo>
                <a:cubicBezTo>
                  <a:pt x="115353" y="475316"/>
                  <a:pt x="145454" y="392800"/>
                  <a:pt x="111035" y="461639"/>
                </a:cubicBezTo>
                <a:cubicBezTo>
                  <a:pt x="106850" y="470009"/>
                  <a:pt x="106702" y="480092"/>
                  <a:pt x="102157" y="488272"/>
                </a:cubicBezTo>
                <a:cubicBezTo>
                  <a:pt x="91794" y="506926"/>
                  <a:pt x="78484" y="523783"/>
                  <a:pt x="66647" y="541538"/>
                </a:cubicBezTo>
                <a:lnTo>
                  <a:pt x="48891" y="568171"/>
                </a:lnTo>
                <a:cubicBezTo>
                  <a:pt x="27762" y="631559"/>
                  <a:pt x="41517" y="605864"/>
                  <a:pt x="13381" y="648070"/>
                </a:cubicBezTo>
                <a:cubicBezTo>
                  <a:pt x="-329" y="730330"/>
                  <a:pt x="-8167" y="753393"/>
                  <a:pt x="13381" y="861134"/>
                </a:cubicBezTo>
                <a:cubicBezTo>
                  <a:pt x="15473" y="871596"/>
                  <a:pt x="31136" y="872971"/>
                  <a:pt x="40014" y="878889"/>
                </a:cubicBezTo>
                <a:cubicBezTo>
                  <a:pt x="42973" y="935114"/>
                  <a:pt x="44014" y="991474"/>
                  <a:pt x="48891" y="1047565"/>
                </a:cubicBezTo>
                <a:cubicBezTo>
                  <a:pt x="49948" y="1059720"/>
                  <a:pt x="55122" y="1071165"/>
                  <a:pt x="57769" y="1083075"/>
                </a:cubicBezTo>
                <a:cubicBezTo>
                  <a:pt x="61042" y="1097805"/>
                  <a:pt x="62677" y="1112906"/>
                  <a:pt x="66647" y="1127464"/>
                </a:cubicBezTo>
                <a:cubicBezTo>
                  <a:pt x="71571" y="1145520"/>
                  <a:pt x="81325" y="1162269"/>
                  <a:pt x="84402" y="1180730"/>
                </a:cubicBezTo>
                <a:cubicBezTo>
                  <a:pt x="108830" y="1327293"/>
                  <a:pt x="80304" y="1173216"/>
                  <a:pt x="102157" y="1260629"/>
                </a:cubicBezTo>
                <a:cubicBezTo>
                  <a:pt x="114827" y="1311311"/>
                  <a:pt x="106244" y="1294963"/>
                  <a:pt x="119913" y="1340528"/>
                </a:cubicBezTo>
                <a:cubicBezTo>
                  <a:pt x="125291" y="1358454"/>
                  <a:pt x="131750" y="1376039"/>
                  <a:pt x="137668" y="1393794"/>
                </a:cubicBezTo>
                <a:cubicBezTo>
                  <a:pt x="140627" y="1402672"/>
                  <a:pt x="141355" y="1412641"/>
                  <a:pt x="146546" y="1420427"/>
                </a:cubicBezTo>
                <a:cubicBezTo>
                  <a:pt x="185339" y="1478617"/>
                  <a:pt x="182056" y="1452354"/>
                  <a:pt x="182056" y="1491448"/>
                </a:cubicBezTo>
              </a:path>
            </a:pathLst>
          </a:custGeom>
          <a:no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12" name="Freeform: Shape 11">
            <a:extLst>
              <a:ext uri="{FF2B5EF4-FFF2-40B4-BE49-F238E27FC236}">
                <a16:creationId xmlns:a16="http://schemas.microsoft.com/office/drawing/2014/main" id="{11505493-F6C7-4F01-836C-FC75B17C444B}"/>
              </a:ext>
            </a:extLst>
          </p:cNvPr>
          <p:cNvSpPr/>
          <p:nvPr/>
        </p:nvSpPr>
        <p:spPr>
          <a:xfrm>
            <a:off x="2602244" y="1105249"/>
            <a:ext cx="778130" cy="1192958"/>
          </a:xfrm>
          <a:custGeom>
            <a:avLst/>
            <a:gdLst>
              <a:gd name="connsiteX0" fmla="*/ 362493 w 778130"/>
              <a:gd name="connsiteY0" fmla="*/ 8816 h 1192958"/>
              <a:gd name="connsiteX1" fmla="*/ 344021 w 778130"/>
              <a:gd name="connsiteY1" fmla="*/ 82707 h 1192958"/>
              <a:gd name="connsiteX2" fmla="*/ 325548 w 778130"/>
              <a:gd name="connsiteY2" fmla="*/ 147362 h 1192958"/>
              <a:gd name="connsiteX3" fmla="*/ 307075 w 778130"/>
              <a:gd name="connsiteY3" fmla="*/ 175071 h 1192958"/>
              <a:gd name="connsiteX4" fmla="*/ 279366 w 778130"/>
              <a:gd name="connsiteY4" fmla="*/ 230489 h 1192958"/>
              <a:gd name="connsiteX5" fmla="*/ 251657 w 778130"/>
              <a:gd name="connsiteY5" fmla="*/ 285907 h 1192958"/>
              <a:gd name="connsiteX6" fmla="*/ 214712 w 778130"/>
              <a:gd name="connsiteY6" fmla="*/ 396744 h 1192958"/>
              <a:gd name="connsiteX7" fmla="*/ 205475 w 778130"/>
              <a:gd name="connsiteY7" fmla="*/ 424453 h 1192958"/>
              <a:gd name="connsiteX8" fmla="*/ 187003 w 778130"/>
              <a:gd name="connsiteY8" fmla="*/ 452162 h 1192958"/>
              <a:gd name="connsiteX9" fmla="*/ 177766 w 778130"/>
              <a:gd name="connsiteY9" fmla="*/ 479871 h 1192958"/>
              <a:gd name="connsiteX10" fmla="*/ 122348 w 778130"/>
              <a:gd name="connsiteY10" fmla="*/ 544526 h 1192958"/>
              <a:gd name="connsiteX11" fmla="*/ 94639 w 778130"/>
              <a:gd name="connsiteY11" fmla="*/ 599944 h 1192958"/>
              <a:gd name="connsiteX12" fmla="*/ 76166 w 778130"/>
              <a:gd name="connsiteY12" fmla="*/ 636889 h 1192958"/>
              <a:gd name="connsiteX13" fmla="*/ 66930 w 778130"/>
              <a:gd name="connsiteY13" fmla="*/ 664598 h 1192958"/>
              <a:gd name="connsiteX14" fmla="*/ 48457 w 778130"/>
              <a:gd name="connsiteY14" fmla="*/ 692307 h 1192958"/>
              <a:gd name="connsiteX15" fmla="*/ 20748 w 778130"/>
              <a:gd name="connsiteY15" fmla="*/ 775435 h 1192958"/>
              <a:gd name="connsiteX16" fmla="*/ 11512 w 778130"/>
              <a:gd name="connsiteY16" fmla="*/ 803144 h 1192958"/>
              <a:gd name="connsiteX17" fmla="*/ 11512 w 778130"/>
              <a:gd name="connsiteY17" fmla="*/ 1034053 h 1192958"/>
              <a:gd name="connsiteX18" fmla="*/ 57693 w 778130"/>
              <a:gd name="connsiteY18" fmla="*/ 1089471 h 1192958"/>
              <a:gd name="connsiteX19" fmla="*/ 140821 w 778130"/>
              <a:gd name="connsiteY19" fmla="*/ 1126416 h 1192958"/>
              <a:gd name="connsiteX20" fmla="*/ 177766 w 778130"/>
              <a:gd name="connsiteY20" fmla="*/ 1135653 h 1192958"/>
              <a:gd name="connsiteX21" fmla="*/ 242421 w 778130"/>
              <a:gd name="connsiteY21" fmla="*/ 1144889 h 1192958"/>
              <a:gd name="connsiteX22" fmla="*/ 279366 w 778130"/>
              <a:gd name="connsiteY22" fmla="*/ 1154126 h 1192958"/>
              <a:gd name="connsiteX23" fmla="*/ 334784 w 778130"/>
              <a:gd name="connsiteY23" fmla="*/ 1172598 h 1192958"/>
              <a:gd name="connsiteX24" fmla="*/ 390203 w 778130"/>
              <a:gd name="connsiteY24" fmla="*/ 1181835 h 1192958"/>
              <a:gd name="connsiteX25" fmla="*/ 408675 w 778130"/>
              <a:gd name="connsiteY25" fmla="*/ 1126416 h 1192958"/>
              <a:gd name="connsiteX26" fmla="*/ 427148 w 778130"/>
              <a:gd name="connsiteY26" fmla="*/ 1089471 h 1192958"/>
              <a:gd name="connsiteX27" fmla="*/ 436384 w 778130"/>
              <a:gd name="connsiteY27" fmla="*/ 1061762 h 1192958"/>
              <a:gd name="connsiteX28" fmla="*/ 454857 w 778130"/>
              <a:gd name="connsiteY28" fmla="*/ 1034053 h 1192958"/>
              <a:gd name="connsiteX29" fmla="*/ 482566 w 778130"/>
              <a:gd name="connsiteY29" fmla="*/ 969398 h 1192958"/>
              <a:gd name="connsiteX30" fmla="*/ 491803 w 778130"/>
              <a:gd name="connsiteY30" fmla="*/ 941689 h 1192958"/>
              <a:gd name="connsiteX31" fmla="*/ 510275 w 778130"/>
              <a:gd name="connsiteY31" fmla="*/ 867798 h 1192958"/>
              <a:gd name="connsiteX32" fmla="*/ 537984 w 778130"/>
              <a:gd name="connsiteY32" fmla="*/ 784671 h 1192958"/>
              <a:gd name="connsiteX33" fmla="*/ 556457 w 778130"/>
              <a:gd name="connsiteY33" fmla="*/ 729253 h 1192958"/>
              <a:gd name="connsiteX34" fmla="*/ 565693 w 778130"/>
              <a:gd name="connsiteY34" fmla="*/ 683071 h 1192958"/>
              <a:gd name="connsiteX35" fmla="*/ 584166 w 778130"/>
              <a:gd name="connsiteY35" fmla="*/ 627653 h 1192958"/>
              <a:gd name="connsiteX36" fmla="*/ 602639 w 778130"/>
              <a:gd name="connsiteY36" fmla="*/ 562998 h 1192958"/>
              <a:gd name="connsiteX37" fmla="*/ 621112 w 778130"/>
              <a:gd name="connsiteY37" fmla="*/ 526053 h 1192958"/>
              <a:gd name="connsiteX38" fmla="*/ 639584 w 778130"/>
              <a:gd name="connsiteY38" fmla="*/ 470635 h 1192958"/>
              <a:gd name="connsiteX39" fmla="*/ 648821 w 778130"/>
              <a:gd name="connsiteY39" fmla="*/ 442926 h 1192958"/>
              <a:gd name="connsiteX40" fmla="*/ 667293 w 778130"/>
              <a:gd name="connsiteY40" fmla="*/ 415216 h 1192958"/>
              <a:gd name="connsiteX41" fmla="*/ 676530 w 778130"/>
              <a:gd name="connsiteY41" fmla="*/ 387507 h 1192958"/>
              <a:gd name="connsiteX42" fmla="*/ 695003 w 778130"/>
              <a:gd name="connsiteY42" fmla="*/ 350562 h 1192958"/>
              <a:gd name="connsiteX43" fmla="*/ 731948 w 778130"/>
              <a:gd name="connsiteY43" fmla="*/ 267435 h 1192958"/>
              <a:gd name="connsiteX44" fmla="*/ 741184 w 778130"/>
              <a:gd name="connsiteY44" fmla="*/ 239726 h 1192958"/>
              <a:gd name="connsiteX45" fmla="*/ 759657 w 778130"/>
              <a:gd name="connsiteY45" fmla="*/ 212016 h 1192958"/>
              <a:gd name="connsiteX46" fmla="*/ 778130 w 778130"/>
              <a:gd name="connsiteY46" fmla="*/ 175071 h 1192958"/>
              <a:gd name="connsiteX47" fmla="*/ 750421 w 778130"/>
              <a:gd name="connsiteY47" fmla="*/ 147362 h 1192958"/>
              <a:gd name="connsiteX48" fmla="*/ 695003 w 778130"/>
              <a:gd name="connsiteY48" fmla="*/ 128889 h 1192958"/>
              <a:gd name="connsiteX49" fmla="*/ 639584 w 778130"/>
              <a:gd name="connsiteY49" fmla="*/ 110416 h 1192958"/>
              <a:gd name="connsiteX50" fmla="*/ 611875 w 778130"/>
              <a:gd name="connsiteY50" fmla="*/ 101180 h 1192958"/>
              <a:gd name="connsiteX51" fmla="*/ 584166 w 778130"/>
              <a:gd name="connsiteY51" fmla="*/ 91944 h 1192958"/>
              <a:gd name="connsiteX52" fmla="*/ 556457 w 778130"/>
              <a:gd name="connsiteY52" fmla="*/ 73471 h 1192958"/>
              <a:gd name="connsiteX53" fmla="*/ 501039 w 778130"/>
              <a:gd name="connsiteY53" fmla="*/ 54998 h 1192958"/>
              <a:gd name="connsiteX54" fmla="*/ 464093 w 778130"/>
              <a:gd name="connsiteY54" fmla="*/ 36526 h 1192958"/>
              <a:gd name="connsiteX55" fmla="*/ 445621 w 778130"/>
              <a:gd name="connsiteY55" fmla="*/ 8816 h 1192958"/>
              <a:gd name="connsiteX56" fmla="*/ 362493 w 778130"/>
              <a:gd name="connsiteY56" fmla="*/ 8816 h 119295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Lst>
            <a:rect l="l" t="t" r="r" b="b"/>
            <a:pathLst>
              <a:path w="778130" h="1192958">
                <a:moveTo>
                  <a:pt x="362493" y="8816"/>
                </a:moveTo>
                <a:cubicBezTo>
                  <a:pt x="345560" y="21131"/>
                  <a:pt x="362953" y="16447"/>
                  <a:pt x="344021" y="82707"/>
                </a:cubicBezTo>
                <a:cubicBezTo>
                  <a:pt x="340077" y="96511"/>
                  <a:pt x="332928" y="132603"/>
                  <a:pt x="325548" y="147362"/>
                </a:cubicBezTo>
                <a:cubicBezTo>
                  <a:pt x="320584" y="157291"/>
                  <a:pt x="313233" y="165835"/>
                  <a:pt x="307075" y="175071"/>
                </a:cubicBezTo>
                <a:cubicBezTo>
                  <a:pt x="283860" y="244718"/>
                  <a:pt x="315176" y="158870"/>
                  <a:pt x="279366" y="230489"/>
                </a:cubicBezTo>
                <a:cubicBezTo>
                  <a:pt x="241126" y="306969"/>
                  <a:pt x="304598" y="206496"/>
                  <a:pt x="251657" y="285907"/>
                </a:cubicBezTo>
                <a:lnTo>
                  <a:pt x="214712" y="396744"/>
                </a:lnTo>
                <a:cubicBezTo>
                  <a:pt x="211633" y="405980"/>
                  <a:pt x="210875" y="416352"/>
                  <a:pt x="205475" y="424453"/>
                </a:cubicBezTo>
                <a:cubicBezTo>
                  <a:pt x="199318" y="433689"/>
                  <a:pt x="191967" y="442233"/>
                  <a:pt x="187003" y="452162"/>
                </a:cubicBezTo>
                <a:cubicBezTo>
                  <a:pt x="182649" y="460870"/>
                  <a:pt x="182597" y="471418"/>
                  <a:pt x="177766" y="479871"/>
                </a:cubicBezTo>
                <a:cubicBezTo>
                  <a:pt x="161968" y="507516"/>
                  <a:pt x="144184" y="522689"/>
                  <a:pt x="122348" y="544526"/>
                </a:cubicBezTo>
                <a:cubicBezTo>
                  <a:pt x="105415" y="595327"/>
                  <a:pt x="123286" y="549812"/>
                  <a:pt x="94639" y="599944"/>
                </a:cubicBezTo>
                <a:cubicBezTo>
                  <a:pt x="87808" y="611898"/>
                  <a:pt x="81590" y="624234"/>
                  <a:pt x="76166" y="636889"/>
                </a:cubicBezTo>
                <a:cubicBezTo>
                  <a:pt x="72331" y="645838"/>
                  <a:pt x="71284" y="655890"/>
                  <a:pt x="66930" y="664598"/>
                </a:cubicBezTo>
                <a:cubicBezTo>
                  <a:pt x="61966" y="674527"/>
                  <a:pt x="54615" y="683071"/>
                  <a:pt x="48457" y="692307"/>
                </a:cubicBezTo>
                <a:lnTo>
                  <a:pt x="20748" y="775435"/>
                </a:lnTo>
                <a:lnTo>
                  <a:pt x="11512" y="803144"/>
                </a:lnTo>
                <a:cubicBezTo>
                  <a:pt x="-662" y="900526"/>
                  <a:pt x="-6717" y="912526"/>
                  <a:pt x="11512" y="1034053"/>
                </a:cubicBezTo>
                <a:cubicBezTo>
                  <a:pt x="13588" y="1047893"/>
                  <a:pt x="49954" y="1083022"/>
                  <a:pt x="57693" y="1089471"/>
                </a:cubicBezTo>
                <a:cubicBezTo>
                  <a:pt x="83688" y="1111133"/>
                  <a:pt x="106298" y="1117785"/>
                  <a:pt x="140821" y="1126416"/>
                </a:cubicBezTo>
                <a:cubicBezTo>
                  <a:pt x="153136" y="1129495"/>
                  <a:pt x="165277" y="1133382"/>
                  <a:pt x="177766" y="1135653"/>
                </a:cubicBezTo>
                <a:cubicBezTo>
                  <a:pt x="199185" y="1139547"/>
                  <a:pt x="221002" y="1140995"/>
                  <a:pt x="242421" y="1144889"/>
                </a:cubicBezTo>
                <a:cubicBezTo>
                  <a:pt x="254910" y="1147160"/>
                  <a:pt x="267207" y="1150478"/>
                  <a:pt x="279366" y="1154126"/>
                </a:cubicBezTo>
                <a:cubicBezTo>
                  <a:pt x="298017" y="1159721"/>
                  <a:pt x="334784" y="1172598"/>
                  <a:pt x="334784" y="1172598"/>
                </a:cubicBezTo>
                <a:cubicBezTo>
                  <a:pt x="348090" y="1181469"/>
                  <a:pt x="371700" y="1207740"/>
                  <a:pt x="390203" y="1181835"/>
                </a:cubicBezTo>
                <a:cubicBezTo>
                  <a:pt x="401521" y="1165990"/>
                  <a:pt x="399967" y="1143832"/>
                  <a:pt x="408675" y="1126416"/>
                </a:cubicBezTo>
                <a:cubicBezTo>
                  <a:pt x="414833" y="1114101"/>
                  <a:pt x="421724" y="1102126"/>
                  <a:pt x="427148" y="1089471"/>
                </a:cubicBezTo>
                <a:cubicBezTo>
                  <a:pt x="430983" y="1080522"/>
                  <a:pt x="432030" y="1070470"/>
                  <a:pt x="436384" y="1061762"/>
                </a:cubicBezTo>
                <a:cubicBezTo>
                  <a:pt x="441348" y="1051833"/>
                  <a:pt x="448699" y="1043289"/>
                  <a:pt x="454857" y="1034053"/>
                </a:cubicBezTo>
                <a:cubicBezTo>
                  <a:pt x="474078" y="957166"/>
                  <a:pt x="450674" y="1033179"/>
                  <a:pt x="482566" y="969398"/>
                </a:cubicBezTo>
                <a:cubicBezTo>
                  <a:pt x="486920" y="960690"/>
                  <a:pt x="489241" y="951082"/>
                  <a:pt x="491803" y="941689"/>
                </a:cubicBezTo>
                <a:cubicBezTo>
                  <a:pt x="498483" y="917195"/>
                  <a:pt x="502246" y="891883"/>
                  <a:pt x="510275" y="867798"/>
                </a:cubicBezTo>
                <a:lnTo>
                  <a:pt x="537984" y="784671"/>
                </a:lnTo>
                <a:lnTo>
                  <a:pt x="556457" y="729253"/>
                </a:lnTo>
                <a:cubicBezTo>
                  <a:pt x="559536" y="713859"/>
                  <a:pt x="561562" y="698217"/>
                  <a:pt x="565693" y="683071"/>
                </a:cubicBezTo>
                <a:cubicBezTo>
                  <a:pt x="570816" y="664285"/>
                  <a:pt x="579443" y="646543"/>
                  <a:pt x="584166" y="627653"/>
                </a:cubicBezTo>
                <a:cubicBezTo>
                  <a:pt x="588852" y="608911"/>
                  <a:pt x="594690" y="581544"/>
                  <a:pt x="602639" y="562998"/>
                </a:cubicBezTo>
                <a:cubicBezTo>
                  <a:pt x="608063" y="550343"/>
                  <a:pt x="615998" y="538837"/>
                  <a:pt x="621112" y="526053"/>
                </a:cubicBezTo>
                <a:cubicBezTo>
                  <a:pt x="628344" y="507974"/>
                  <a:pt x="633426" y="489108"/>
                  <a:pt x="639584" y="470635"/>
                </a:cubicBezTo>
                <a:cubicBezTo>
                  <a:pt x="642663" y="461399"/>
                  <a:pt x="643421" y="451027"/>
                  <a:pt x="648821" y="442926"/>
                </a:cubicBezTo>
                <a:cubicBezTo>
                  <a:pt x="654978" y="433689"/>
                  <a:pt x="662329" y="425145"/>
                  <a:pt x="667293" y="415216"/>
                </a:cubicBezTo>
                <a:cubicBezTo>
                  <a:pt x="671647" y="406508"/>
                  <a:pt x="672695" y="396456"/>
                  <a:pt x="676530" y="387507"/>
                </a:cubicBezTo>
                <a:cubicBezTo>
                  <a:pt x="681954" y="374852"/>
                  <a:pt x="689889" y="363346"/>
                  <a:pt x="695003" y="350562"/>
                </a:cubicBezTo>
                <a:cubicBezTo>
                  <a:pt x="727978" y="268124"/>
                  <a:pt x="696407" y="320746"/>
                  <a:pt x="731948" y="267435"/>
                </a:cubicBezTo>
                <a:cubicBezTo>
                  <a:pt x="735027" y="258199"/>
                  <a:pt x="736830" y="248434"/>
                  <a:pt x="741184" y="239726"/>
                </a:cubicBezTo>
                <a:cubicBezTo>
                  <a:pt x="746148" y="229797"/>
                  <a:pt x="754149" y="221654"/>
                  <a:pt x="759657" y="212016"/>
                </a:cubicBezTo>
                <a:cubicBezTo>
                  <a:pt x="766488" y="200061"/>
                  <a:pt x="771972" y="187386"/>
                  <a:pt x="778130" y="175071"/>
                </a:cubicBezTo>
                <a:cubicBezTo>
                  <a:pt x="768894" y="165835"/>
                  <a:pt x="761839" y="153706"/>
                  <a:pt x="750421" y="147362"/>
                </a:cubicBezTo>
                <a:cubicBezTo>
                  <a:pt x="733399" y="137906"/>
                  <a:pt x="713476" y="135047"/>
                  <a:pt x="695003" y="128889"/>
                </a:cubicBezTo>
                <a:lnTo>
                  <a:pt x="639584" y="110416"/>
                </a:lnTo>
                <a:lnTo>
                  <a:pt x="611875" y="101180"/>
                </a:lnTo>
                <a:lnTo>
                  <a:pt x="584166" y="91944"/>
                </a:lnTo>
                <a:cubicBezTo>
                  <a:pt x="574930" y="85786"/>
                  <a:pt x="566601" y="77980"/>
                  <a:pt x="556457" y="73471"/>
                </a:cubicBezTo>
                <a:cubicBezTo>
                  <a:pt x="538663" y="65563"/>
                  <a:pt x="518455" y="63706"/>
                  <a:pt x="501039" y="54998"/>
                </a:cubicBezTo>
                <a:lnTo>
                  <a:pt x="464093" y="36526"/>
                </a:lnTo>
                <a:cubicBezTo>
                  <a:pt x="457936" y="27289"/>
                  <a:pt x="454289" y="15751"/>
                  <a:pt x="445621" y="8816"/>
                </a:cubicBezTo>
                <a:cubicBezTo>
                  <a:pt x="431643" y="-2367"/>
                  <a:pt x="379426" y="-3499"/>
                  <a:pt x="362493" y="8816"/>
                </a:cubicBezTo>
                <a:close/>
              </a:path>
            </a:pathLst>
          </a:custGeom>
          <a:solidFill>
            <a:schemeClr val="accent6">
              <a:alpha val="50000"/>
            </a:schemeClr>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13" name="Freeform: Shape 12">
            <a:extLst>
              <a:ext uri="{FF2B5EF4-FFF2-40B4-BE49-F238E27FC236}">
                <a16:creationId xmlns:a16="http://schemas.microsoft.com/office/drawing/2014/main" id="{BE309507-B20E-4D39-9F81-63AA6623EA00}"/>
              </a:ext>
            </a:extLst>
          </p:cNvPr>
          <p:cNvSpPr/>
          <p:nvPr/>
        </p:nvSpPr>
        <p:spPr>
          <a:xfrm>
            <a:off x="2225828" y="2619593"/>
            <a:ext cx="461819" cy="1154545"/>
          </a:xfrm>
          <a:custGeom>
            <a:avLst/>
            <a:gdLst>
              <a:gd name="connsiteX0" fmla="*/ 27709 w 461819"/>
              <a:gd name="connsiteY0" fmla="*/ 64654 h 1154545"/>
              <a:gd name="connsiteX1" fmla="*/ 18473 w 461819"/>
              <a:gd name="connsiteY1" fmla="*/ 240145 h 1154545"/>
              <a:gd name="connsiteX2" fmla="*/ 9237 w 461819"/>
              <a:gd name="connsiteY2" fmla="*/ 277091 h 1154545"/>
              <a:gd name="connsiteX3" fmla="*/ 0 w 461819"/>
              <a:gd name="connsiteY3" fmla="*/ 341745 h 1154545"/>
              <a:gd name="connsiteX4" fmla="*/ 9237 w 461819"/>
              <a:gd name="connsiteY4" fmla="*/ 1099127 h 1154545"/>
              <a:gd name="connsiteX5" fmla="*/ 27709 w 461819"/>
              <a:gd name="connsiteY5" fmla="*/ 1126836 h 1154545"/>
              <a:gd name="connsiteX6" fmla="*/ 83128 w 461819"/>
              <a:gd name="connsiteY6" fmla="*/ 1154545 h 1154545"/>
              <a:gd name="connsiteX7" fmla="*/ 323273 w 461819"/>
              <a:gd name="connsiteY7" fmla="*/ 1136072 h 1154545"/>
              <a:gd name="connsiteX8" fmla="*/ 378691 w 461819"/>
              <a:gd name="connsiteY8" fmla="*/ 1117600 h 1154545"/>
              <a:gd name="connsiteX9" fmla="*/ 452582 w 461819"/>
              <a:gd name="connsiteY9" fmla="*/ 1099127 h 1154545"/>
              <a:gd name="connsiteX10" fmla="*/ 461819 w 461819"/>
              <a:gd name="connsiteY10" fmla="*/ 1071418 h 1154545"/>
              <a:gd name="connsiteX11" fmla="*/ 443346 w 461819"/>
              <a:gd name="connsiteY11" fmla="*/ 914400 h 1154545"/>
              <a:gd name="connsiteX12" fmla="*/ 415637 w 461819"/>
              <a:gd name="connsiteY12" fmla="*/ 812800 h 1154545"/>
              <a:gd name="connsiteX13" fmla="*/ 415637 w 461819"/>
              <a:gd name="connsiteY13" fmla="*/ 461818 h 1154545"/>
              <a:gd name="connsiteX14" fmla="*/ 406400 w 461819"/>
              <a:gd name="connsiteY14" fmla="*/ 73891 h 1154545"/>
              <a:gd name="connsiteX15" fmla="*/ 387928 w 461819"/>
              <a:gd name="connsiteY15" fmla="*/ 18472 h 1154545"/>
              <a:gd name="connsiteX16" fmla="*/ 360219 w 461819"/>
              <a:gd name="connsiteY16" fmla="*/ 0 h 1154545"/>
              <a:gd name="connsiteX17" fmla="*/ 110837 w 461819"/>
              <a:gd name="connsiteY17" fmla="*/ 18472 h 1154545"/>
              <a:gd name="connsiteX18" fmla="*/ 36946 w 461819"/>
              <a:gd name="connsiteY18" fmla="*/ 36945 h 1154545"/>
              <a:gd name="connsiteX19" fmla="*/ 27709 w 461819"/>
              <a:gd name="connsiteY19" fmla="*/ 64654 h 115454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Lst>
            <a:rect l="l" t="t" r="r" b="b"/>
            <a:pathLst>
              <a:path w="461819" h="1154545">
                <a:moveTo>
                  <a:pt x="27709" y="64654"/>
                </a:moveTo>
                <a:cubicBezTo>
                  <a:pt x="24630" y="98521"/>
                  <a:pt x="23547" y="181787"/>
                  <a:pt x="18473" y="240145"/>
                </a:cubicBezTo>
                <a:cubicBezTo>
                  <a:pt x="17373" y="252792"/>
                  <a:pt x="11508" y="264601"/>
                  <a:pt x="9237" y="277091"/>
                </a:cubicBezTo>
                <a:cubicBezTo>
                  <a:pt x="5343" y="298510"/>
                  <a:pt x="3079" y="320194"/>
                  <a:pt x="0" y="341745"/>
                </a:cubicBezTo>
                <a:cubicBezTo>
                  <a:pt x="3079" y="594206"/>
                  <a:pt x="332" y="846805"/>
                  <a:pt x="9237" y="1099127"/>
                </a:cubicBezTo>
                <a:cubicBezTo>
                  <a:pt x="9629" y="1110221"/>
                  <a:pt x="19860" y="1118987"/>
                  <a:pt x="27709" y="1126836"/>
                </a:cubicBezTo>
                <a:cubicBezTo>
                  <a:pt x="45614" y="1144741"/>
                  <a:pt x="60591" y="1147033"/>
                  <a:pt x="83128" y="1154545"/>
                </a:cubicBezTo>
                <a:cubicBezTo>
                  <a:pt x="111973" y="1152943"/>
                  <a:pt x="266842" y="1148164"/>
                  <a:pt x="323273" y="1136072"/>
                </a:cubicBezTo>
                <a:cubicBezTo>
                  <a:pt x="342313" y="1131992"/>
                  <a:pt x="359801" y="1122323"/>
                  <a:pt x="378691" y="1117600"/>
                </a:cubicBezTo>
                <a:lnTo>
                  <a:pt x="452582" y="1099127"/>
                </a:lnTo>
                <a:cubicBezTo>
                  <a:pt x="455661" y="1089891"/>
                  <a:pt x="461819" y="1081154"/>
                  <a:pt x="461819" y="1071418"/>
                </a:cubicBezTo>
                <a:cubicBezTo>
                  <a:pt x="461819" y="1035569"/>
                  <a:pt x="455389" y="958557"/>
                  <a:pt x="443346" y="914400"/>
                </a:cubicBezTo>
                <a:cubicBezTo>
                  <a:pt x="408190" y="785496"/>
                  <a:pt x="438139" y="925315"/>
                  <a:pt x="415637" y="812800"/>
                </a:cubicBezTo>
                <a:cubicBezTo>
                  <a:pt x="393815" y="463667"/>
                  <a:pt x="415637" y="897965"/>
                  <a:pt x="415637" y="461818"/>
                </a:cubicBezTo>
                <a:cubicBezTo>
                  <a:pt x="415637" y="332472"/>
                  <a:pt x="414468" y="202985"/>
                  <a:pt x="406400" y="73891"/>
                </a:cubicBezTo>
                <a:cubicBezTo>
                  <a:pt x="405185" y="54457"/>
                  <a:pt x="404130" y="29273"/>
                  <a:pt x="387928" y="18472"/>
                </a:cubicBezTo>
                <a:lnTo>
                  <a:pt x="360219" y="0"/>
                </a:lnTo>
                <a:cubicBezTo>
                  <a:pt x="236030" y="24837"/>
                  <a:pt x="379474" y="-1427"/>
                  <a:pt x="110837" y="18472"/>
                </a:cubicBezTo>
                <a:cubicBezTo>
                  <a:pt x="98469" y="19388"/>
                  <a:pt x="52658" y="29089"/>
                  <a:pt x="36946" y="36945"/>
                </a:cubicBezTo>
                <a:cubicBezTo>
                  <a:pt x="33051" y="38892"/>
                  <a:pt x="30788" y="30787"/>
                  <a:pt x="27709" y="64654"/>
                </a:cubicBezTo>
                <a:close/>
              </a:path>
            </a:pathLst>
          </a:custGeom>
          <a:solidFill>
            <a:schemeClr val="accent6">
              <a:alpha val="50000"/>
            </a:schemeClr>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14" name="Freeform: Shape 13">
            <a:extLst>
              <a:ext uri="{FF2B5EF4-FFF2-40B4-BE49-F238E27FC236}">
                <a16:creationId xmlns:a16="http://schemas.microsoft.com/office/drawing/2014/main" id="{780E66C6-B846-423E-9300-2FC82709017F}"/>
              </a:ext>
            </a:extLst>
          </p:cNvPr>
          <p:cNvSpPr/>
          <p:nvPr/>
        </p:nvSpPr>
        <p:spPr>
          <a:xfrm>
            <a:off x="3297247" y="1418704"/>
            <a:ext cx="674254" cy="1224494"/>
          </a:xfrm>
          <a:custGeom>
            <a:avLst/>
            <a:gdLst>
              <a:gd name="connsiteX0" fmla="*/ 415636 w 674254"/>
              <a:gd name="connsiteY0" fmla="*/ 27871 h 1224494"/>
              <a:gd name="connsiteX1" fmla="*/ 406400 w 674254"/>
              <a:gd name="connsiteY1" fmla="*/ 101761 h 1224494"/>
              <a:gd name="connsiteX2" fmla="*/ 369454 w 674254"/>
              <a:gd name="connsiteY2" fmla="*/ 231071 h 1224494"/>
              <a:gd name="connsiteX3" fmla="*/ 360218 w 674254"/>
              <a:gd name="connsiteY3" fmla="*/ 258780 h 1224494"/>
              <a:gd name="connsiteX4" fmla="*/ 323272 w 674254"/>
              <a:gd name="connsiteY4" fmla="*/ 314198 h 1224494"/>
              <a:gd name="connsiteX5" fmla="*/ 295563 w 674254"/>
              <a:gd name="connsiteY5" fmla="*/ 369616 h 1224494"/>
              <a:gd name="connsiteX6" fmla="*/ 277090 w 674254"/>
              <a:gd name="connsiteY6" fmla="*/ 406561 h 1224494"/>
              <a:gd name="connsiteX7" fmla="*/ 240145 w 674254"/>
              <a:gd name="connsiteY7" fmla="*/ 461980 h 1224494"/>
              <a:gd name="connsiteX8" fmla="*/ 221672 w 674254"/>
              <a:gd name="connsiteY8" fmla="*/ 517398 h 1224494"/>
              <a:gd name="connsiteX9" fmla="*/ 203200 w 674254"/>
              <a:gd name="connsiteY9" fmla="*/ 582052 h 1224494"/>
              <a:gd name="connsiteX10" fmla="*/ 184727 w 674254"/>
              <a:gd name="connsiteY10" fmla="*/ 609761 h 1224494"/>
              <a:gd name="connsiteX11" fmla="*/ 175490 w 674254"/>
              <a:gd name="connsiteY11" fmla="*/ 637471 h 1224494"/>
              <a:gd name="connsiteX12" fmla="*/ 157018 w 674254"/>
              <a:gd name="connsiteY12" fmla="*/ 665180 h 1224494"/>
              <a:gd name="connsiteX13" fmla="*/ 138545 w 674254"/>
              <a:gd name="connsiteY13" fmla="*/ 720598 h 1224494"/>
              <a:gd name="connsiteX14" fmla="*/ 129309 w 674254"/>
              <a:gd name="connsiteY14" fmla="*/ 748307 h 1224494"/>
              <a:gd name="connsiteX15" fmla="*/ 110836 w 674254"/>
              <a:gd name="connsiteY15" fmla="*/ 785252 h 1224494"/>
              <a:gd name="connsiteX16" fmla="*/ 101600 w 674254"/>
              <a:gd name="connsiteY16" fmla="*/ 812961 h 1224494"/>
              <a:gd name="connsiteX17" fmla="*/ 55418 w 674254"/>
              <a:gd name="connsiteY17" fmla="*/ 868380 h 1224494"/>
              <a:gd name="connsiteX18" fmla="*/ 36945 w 674254"/>
              <a:gd name="connsiteY18" fmla="*/ 923798 h 1224494"/>
              <a:gd name="connsiteX19" fmla="*/ 27709 w 674254"/>
              <a:gd name="connsiteY19" fmla="*/ 997689 h 1224494"/>
              <a:gd name="connsiteX20" fmla="*/ 18472 w 674254"/>
              <a:gd name="connsiteY20" fmla="*/ 1034634 h 1224494"/>
              <a:gd name="connsiteX21" fmla="*/ 0 w 674254"/>
              <a:gd name="connsiteY21" fmla="*/ 1145471 h 1224494"/>
              <a:gd name="connsiteX22" fmla="*/ 9236 w 674254"/>
              <a:gd name="connsiteY22" fmla="*/ 1182416 h 1224494"/>
              <a:gd name="connsiteX23" fmla="*/ 64654 w 674254"/>
              <a:gd name="connsiteY23" fmla="*/ 1210125 h 1224494"/>
              <a:gd name="connsiteX24" fmla="*/ 184727 w 674254"/>
              <a:gd name="connsiteY24" fmla="*/ 1191652 h 1224494"/>
              <a:gd name="connsiteX25" fmla="*/ 240145 w 674254"/>
              <a:gd name="connsiteY25" fmla="*/ 1173180 h 1224494"/>
              <a:gd name="connsiteX26" fmla="*/ 267854 w 674254"/>
              <a:gd name="connsiteY26" fmla="*/ 1163943 h 1224494"/>
              <a:gd name="connsiteX27" fmla="*/ 332509 w 674254"/>
              <a:gd name="connsiteY27" fmla="*/ 1191652 h 1224494"/>
              <a:gd name="connsiteX28" fmla="*/ 424872 w 674254"/>
              <a:gd name="connsiteY28" fmla="*/ 1219361 h 1224494"/>
              <a:gd name="connsiteX29" fmla="*/ 581890 w 674254"/>
              <a:gd name="connsiteY29" fmla="*/ 1210125 h 1224494"/>
              <a:gd name="connsiteX30" fmla="*/ 572654 w 674254"/>
              <a:gd name="connsiteY30" fmla="*/ 1126998 h 1224494"/>
              <a:gd name="connsiteX31" fmla="*/ 554181 w 674254"/>
              <a:gd name="connsiteY31" fmla="*/ 1043871 h 1224494"/>
              <a:gd name="connsiteX32" fmla="*/ 544945 w 674254"/>
              <a:gd name="connsiteY32" fmla="*/ 997689 h 1224494"/>
              <a:gd name="connsiteX33" fmla="*/ 535709 w 674254"/>
              <a:gd name="connsiteY33" fmla="*/ 942271 h 1224494"/>
              <a:gd name="connsiteX34" fmla="*/ 517236 w 674254"/>
              <a:gd name="connsiteY34" fmla="*/ 886852 h 1224494"/>
              <a:gd name="connsiteX35" fmla="*/ 508000 w 674254"/>
              <a:gd name="connsiteY35" fmla="*/ 859143 h 1224494"/>
              <a:gd name="connsiteX36" fmla="*/ 498763 w 674254"/>
              <a:gd name="connsiteY36" fmla="*/ 812961 h 1224494"/>
              <a:gd name="connsiteX37" fmla="*/ 508000 w 674254"/>
              <a:gd name="connsiteY37" fmla="*/ 711361 h 1224494"/>
              <a:gd name="connsiteX38" fmla="*/ 517236 w 674254"/>
              <a:gd name="connsiteY38" fmla="*/ 683652 h 1224494"/>
              <a:gd name="connsiteX39" fmla="*/ 544945 w 674254"/>
              <a:gd name="connsiteY39" fmla="*/ 554343 h 1224494"/>
              <a:gd name="connsiteX40" fmla="*/ 554181 w 674254"/>
              <a:gd name="connsiteY40" fmla="*/ 489689 h 1224494"/>
              <a:gd name="connsiteX41" fmla="*/ 563418 w 674254"/>
              <a:gd name="connsiteY41" fmla="*/ 415798 h 1224494"/>
              <a:gd name="connsiteX42" fmla="*/ 581890 w 674254"/>
              <a:gd name="connsiteY42" fmla="*/ 360380 h 1224494"/>
              <a:gd name="connsiteX43" fmla="*/ 591127 w 674254"/>
              <a:gd name="connsiteY43" fmla="*/ 323434 h 1224494"/>
              <a:gd name="connsiteX44" fmla="*/ 609600 w 674254"/>
              <a:gd name="connsiteY44" fmla="*/ 268016 h 1224494"/>
              <a:gd name="connsiteX45" fmla="*/ 628072 w 674254"/>
              <a:gd name="connsiteY45" fmla="*/ 203361 h 1224494"/>
              <a:gd name="connsiteX46" fmla="*/ 674254 w 674254"/>
              <a:gd name="connsiteY46" fmla="*/ 147943 h 1224494"/>
              <a:gd name="connsiteX47" fmla="*/ 665018 w 674254"/>
              <a:gd name="connsiteY47" fmla="*/ 110998 h 1224494"/>
              <a:gd name="connsiteX48" fmla="*/ 600363 w 674254"/>
              <a:gd name="connsiteY48" fmla="*/ 64816 h 1224494"/>
              <a:gd name="connsiteX49" fmla="*/ 544945 w 674254"/>
              <a:gd name="connsiteY49" fmla="*/ 27871 h 1224494"/>
              <a:gd name="connsiteX50" fmla="*/ 471054 w 674254"/>
              <a:gd name="connsiteY50" fmla="*/ 9398 h 1224494"/>
              <a:gd name="connsiteX51" fmla="*/ 443345 w 674254"/>
              <a:gd name="connsiteY51" fmla="*/ 161 h 1224494"/>
              <a:gd name="connsiteX52" fmla="*/ 415636 w 674254"/>
              <a:gd name="connsiteY52" fmla="*/ 27871 h 122449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Lst>
            <a:rect l="l" t="t" r="r" b="b"/>
            <a:pathLst>
              <a:path w="674254" h="1224494">
                <a:moveTo>
                  <a:pt x="415636" y="27871"/>
                </a:moveTo>
                <a:cubicBezTo>
                  <a:pt x="409479" y="44804"/>
                  <a:pt x="410974" y="77364"/>
                  <a:pt x="406400" y="101761"/>
                </a:cubicBezTo>
                <a:cubicBezTo>
                  <a:pt x="396459" y="154779"/>
                  <a:pt x="385789" y="182064"/>
                  <a:pt x="369454" y="231071"/>
                </a:cubicBezTo>
                <a:cubicBezTo>
                  <a:pt x="366375" y="240307"/>
                  <a:pt x="365619" y="250679"/>
                  <a:pt x="360218" y="258780"/>
                </a:cubicBezTo>
                <a:lnTo>
                  <a:pt x="323272" y="314198"/>
                </a:lnTo>
                <a:cubicBezTo>
                  <a:pt x="306339" y="364999"/>
                  <a:pt x="324210" y="319484"/>
                  <a:pt x="295563" y="369616"/>
                </a:cubicBezTo>
                <a:cubicBezTo>
                  <a:pt x="288732" y="381570"/>
                  <a:pt x="284174" y="394754"/>
                  <a:pt x="277090" y="406561"/>
                </a:cubicBezTo>
                <a:cubicBezTo>
                  <a:pt x="265667" y="425599"/>
                  <a:pt x="240145" y="461980"/>
                  <a:pt x="240145" y="461980"/>
                </a:cubicBezTo>
                <a:cubicBezTo>
                  <a:pt x="233987" y="480453"/>
                  <a:pt x="226395" y="498507"/>
                  <a:pt x="221672" y="517398"/>
                </a:cubicBezTo>
                <a:cubicBezTo>
                  <a:pt x="218713" y="529234"/>
                  <a:pt x="209825" y="568803"/>
                  <a:pt x="203200" y="582052"/>
                </a:cubicBezTo>
                <a:cubicBezTo>
                  <a:pt x="198236" y="591981"/>
                  <a:pt x="189691" y="599832"/>
                  <a:pt x="184727" y="609761"/>
                </a:cubicBezTo>
                <a:cubicBezTo>
                  <a:pt x="180373" y="618469"/>
                  <a:pt x="179844" y="628763"/>
                  <a:pt x="175490" y="637471"/>
                </a:cubicBezTo>
                <a:cubicBezTo>
                  <a:pt x="170526" y="647400"/>
                  <a:pt x="161526" y="655036"/>
                  <a:pt x="157018" y="665180"/>
                </a:cubicBezTo>
                <a:cubicBezTo>
                  <a:pt x="149110" y="682974"/>
                  <a:pt x="144703" y="702125"/>
                  <a:pt x="138545" y="720598"/>
                </a:cubicBezTo>
                <a:cubicBezTo>
                  <a:pt x="135466" y="729834"/>
                  <a:pt x="133663" y="739599"/>
                  <a:pt x="129309" y="748307"/>
                </a:cubicBezTo>
                <a:cubicBezTo>
                  <a:pt x="123151" y="760622"/>
                  <a:pt x="116260" y="772597"/>
                  <a:pt x="110836" y="785252"/>
                </a:cubicBezTo>
                <a:cubicBezTo>
                  <a:pt x="107001" y="794201"/>
                  <a:pt x="105954" y="804253"/>
                  <a:pt x="101600" y="812961"/>
                </a:cubicBezTo>
                <a:cubicBezTo>
                  <a:pt x="88741" y="838680"/>
                  <a:pt x="75846" y="847952"/>
                  <a:pt x="55418" y="868380"/>
                </a:cubicBezTo>
                <a:cubicBezTo>
                  <a:pt x="49260" y="886853"/>
                  <a:pt x="39360" y="904476"/>
                  <a:pt x="36945" y="923798"/>
                </a:cubicBezTo>
                <a:cubicBezTo>
                  <a:pt x="33866" y="948428"/>
                  <a:pt x="31790" y="973205"/>
                  <a:pt x="27709" y="997689"/>
                </a:cubicBezTo>
                <a:cubicBezTo>
                  <a:pt x="25622" y="1010210"/>
                  <a:pt x="20811" y="1022157"/>
                  <a:pt x="18472" y="1034634"/>
                </a:cubicBezTo>
                <a:cubicBezTo>
                  <a:pt x="11569" y="1071448"/>
                  <a:pt x="0" y="1145471"/>
                  <a:pt x="0" y="1145471"/>
                </a:cubicBezTo>
                <a:cubicBezTo>
                  <a:pt x="3079" y="1157786"/>
                  <a:pt x="2195" y="1171854"/>
                  <a:pt x="9236" y="1182416"/>
                </a:cubicBezTo>
                <a:cubicBezTo>
                  <a:pt x="19468" y="1197764"/>
                  <a:pt x="48847" y="1204856"/>
                  <a:pt x="64654" y="1210125"/>
                </a:cubicBezTo>
                <a:cubicBezTo>
                  <a:pt x="123208" y="1203619"/>
                  <a:pt x="137668" y="1205770"/>
                  <a:pt x="184727" y="1191652"/>
                </a:cubicBezTo>
                <a:cubicBezTo>
                  <a:pt x="203378" y="1186057"/>
                  <a:pt x="221672" y="1179338"/>
                  <a:pt x="240145" y="1173180"/>
                </a:cubicBezTo>
                <a:lnTo>
                  <a:pt x="267854" y="1163943"/>
                </a:lnTo>
                <a:cubicBezTo>
                  <a:pt x="365588" y="1188378"/>
                  <a:pt x="250499" y="1155203"/>
                  <a:pt x="332509" y="1191652"/>
                </a:cubicBezTo>
                <a:cubicBezTo>
                  <a:pt x="361425" y="1204503"/>
                  <a:pt x="394164" y="1211684"/>
                  <a:pt x="424872" y="1219361"/>
                </a:cubicBezTo>
                <a:cubicBezTo>
                  <a:pt x="477211" y="1216282"/>
                  <a:pt x="537430" y="1237913"/>
                  <a:pt x="581890" y="1210125"/>
                </a:cubicBezTo>
                <a:cubicBezTo>
                  <a:pt x="605532" y="1195349"/>
                  <a:pt x="576597" y="1154597"/>
                  <a:pt x="572654" y="1126998"/>
                </a:cubicBezTo>
                <a:cubicBezTo>
                  <a:pt x="567080" y="1087980"/>
                  <a:pt x="562252" y="1080188"/>
                  <a:pt x="554181" y="1043871"/>
                </a:cubicBezTo>
                <a:cubicBezTo>
                  <a:pt x="550775" y="1028546"/>
                  <a:pt x="547753" y="1013135"/>
                  <a:pt x="544945" y="997689"/>
                </a:cubicBezTo>
                <a:cubicBezTo>
                  <a:pt x="541595" y="979264"/>
                  <a:pt x="540251" y="960439"/>
                  <a:pt x="535709" y="942271"/>
                </a:cubicBezTo>
                <a:cubicBezTo>
                  <a:pt x="530986" y="923380"/>
                  <a:pt x="523394" y="905325"/>
                  <a:pt x="517236" y="886852"/>
                </a:cubicBezTo>
                <a:cubicBezTo>
                  <a:pt x="514157" y="877616"/>
                  <a:pt x="509909" y="868690"/>
                  <a:pt x="508000" y="859143"/>
                </a:cubicBezTo>
                <a:lnTo>
                  <a:pt x="498763" y="812961"/>
                </a:lnTo>
                <a:cubicBezTo>
                  <a:pt x="501842" y="779094"/>
                  <a:pt x="503191" y="745026"/>
                  <a:pt x="508000" y="711361"/>
                </a:cubicBezTo>
                <a:cubicBezTo>
                  <a:pt x="509377" y="701723"/>
                  <a:pt x="514561" y="693013"/>
                  <a:pt x="517236" y="683652"/>
                </a:cubicBezTo>
                <a:cubicBezTo>
                  <a:pt x="526836" y="650050"/>
                  <a:pt x="541916" y="575544"/>
                  <a:pt x="544945" y="554343"/>
                </a:cubicBezTo>
                <a:cubicBezTo>
                  <a:pt x="548024" y="532792"/>
                  <a:pt x="551304" y="511268"/>
                  <a:pt x="554181" y="489689"/>
                </a:cubicBezTo>
                <a:cubicBezTo>
                  <a:pt x="557462" y="465085"/>
                  <a:pt x="558217" y="440069"/>
                  <a:pt x="563418" y="415798"/>
                </a:cubicBezTo>
                <a:cubicBezTo>
                  <a:pt x="567498" y="396758"/>
                  <a:pt x="577167" y="379270"/>
                  <a:pt x="581890" y="360380"/>
                </a:cubicBezTo>
                <a:cubicBezTo>
                  <a:pt x="584969" y="348065"/>
                  <a:pt x="587479" y="335593"/>
                  <a:pt x="591127" y="323434"/>
                </a:cubicBezTo>
                <a:cubicBezTo>
                  <a:pt x="596722" y="304783"/>
                  <a:pt x="604877" y="286907"/>
                  <a:pt x="609600" y="268016"/>
                </a:cubicBezTo>
                <a:cubicBezTo>
                  <a:pt x="612559" y="256182"/>
                  <a:pt x="621448" y="216609"/>
                  <a:pt x="628072" y="203361"/>
                </a:cubicBezTo>
                <a:cubicBezTo>
                  <a:pt x="640930" y="177644"/>
                  <a:pt x="653828" y="168369"/>
                  <a:pt x="674254" y="147943"/>
                </a:cubicBezTo>
                <a:cubicBezTo>
                  <a:pt x="671175" y="135628"/>
                  <a:pt x="671316" y="122019"/>
                  <a:pt x="665018" y="110998"/>
                </a:cubicBezTo>
                <a:cubicBezTo>
                  <a:pt x="647982" y="81185"/>
                  <a:pt x="627478" y="81085"/>
                  <a:pt x="600363" y="64816"/>
                </a:cubicBezTo>
                <a:cubicBezTo>
                  <a:pt x="581325" y="53394"/>
                  <a:pt x="566483" y="33256"/>
                  <a:pt x="544945" y="27871"/>
                </a:cubicBezTo>
                <a:cubicBezTo>
                  <a:pt x="520315" y="21713"/>
                  <a:pt x="495139" y="17427"/>
                  <a:pt x="471054" y="9398"/>
                </a:cubicBezTo>
                <a:cubicBezTo>
                  <a:pt x="461818" y="6319"/>
                  <a:pt x="452983" y="1538"/>
                  <a:pt x="443345" y="161"/>
                </a:cubicBezTo>
                <a:cubicBezTo>
                  <a:pt x="431154" y="-1581"/>
                  <a:pt x="421793" y="10938"/>
                  <a:pt x="415636" y="27871"/>
                </a:cubicBezTo>
                <a:close/>
              </a:path>
            </a:pathLst>
          </a:custGeom>
          <a:solidFill>
            <a:schemeClr val="accent6">
              <a:alpha val="50000"/>
            </a:schemeClr>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15" name="Freeform: Shape 14">
            <a:extLst>
              <a:ext uri="{FF2B5EF4-FFF2-40B4-BE49-F238E27FC236}">
                <a16:creationId xmlns:a16="http://schemas.microsoft.com/office/drawing/2014/main" id="{A3AECA81-2D38-4555-A41B-D82E5BBEE793}"/>
              </a:ext>
            </a:extLst>
          </p:cNvPr>
          <p:cNvSpPr/>
          <p:nvPr/>
        </p:nvSpPr>
        <p:spPr>
          <a:xfrm>
            <a:off x="4137756" y="2748705"/>
            <a:ext cx="563418" cy="883772"/>
          </a:xfrm>
          <a:custGeom>
            <a:avLst/>
            <a:gdLst>
              <a:gd name="connsiteX0" fmla="*/ 73891 w 563418"/>
              <a:gd name="connsiteY0" fmla="*/ 197 h 883772"/>
              <a:gd name="connsiteX1" fmla="*/ 9236 w 563418"/>
              <a:gd name="connsiteY1" fmla="*/ 64851 h 883772"/>
              <a:gd name="connsiteX2" fmla="*/ 0 w 563418"/>
              <a:gd name="connsiteY2" fmla="*/ 92560 h 883772"/>
              <a:gd name="connsiteX3" fmla="*/ 9236 w 563418"/>
              <a:gd name="connsiteY3" fmla="*/ 166451 h 883772"/>
              <a:gd name="connsiteX4" fmla="*/ 27709 w 563418"/>
              <a:gd name="connsiteY4" fmla="*/ 194160 h 883772"/>
              <a:gd name="connsiteX5" fmla="*/ 83127 w 563418"/>
              <a:gd name="connsiteY5" fmla="*/ 240342 h 883772"/>
              <a:gd name="connsiteX6" fmla="*/ 120072 w 563418"/>
              <a:gd name="connsiteY6" fmla="*/ 268051 h 883772"/>
              <a:gd name="connsiteX7" fmla="*/ 110836 w 563418"/>
              <a:gd name="connsiteY7" fmla="*/ 323470 h 883772"/>
              <a:gd name="connsiteX8" fmla="*/ 55418 w 563418"/>
              <a:gd name="connsiteY8" fmla="*/ 369651 h 883772"/>
              <a:gd name="connsiteX9" fmla="*/ 36945 w 563418"/>
              <a:gd name="connsiteY9" fmla="*/ 425070 h 883772"/>
              <a:gd name="connsiteX10" fmla="*/ 27709 w 563418"/>
              <a:gd name="connsiteY10" fmla="*/ 452779 h 883772"/>
              <a:gd name="connsiteX11" fmla="*/ 36945 w 563418"/>
              <a:gd name="connsiteY11" fmla="*/ 480488 h 883772"/>
              <a:gd name="connsiteX12" fmla="*/ 64654 w 563418"/>
              <a:gd name="connsiteY12" fmla="*/ 508197 h 883772"/>
              <a:gd name="connsiteX13" fmla="*/ 267854 w 563418"/>
              <a:gd name="connsiteY13" fmla="*/ 535906 h 883772"/>
              <a:gd name="connsiteX14" fmla="*/ 341745 w 563418"/>
              <a:gd name="connsiteY14" fmla="*/ 572851 h 883772"/>
              <a:gd name="connsiteX15" fmla="*/ 350981 w 563418"/>
              <a:gd name="connsiteY15" fmla="*/ 619033 h 883772"/>
              <a:gd name="connsiteX16" fmla="*/ 341745 w 563418"/>
              <a:gd name="connsiteY16" fmla="*/ 692924 h 883772"/>
              <a:gd name="connsiteX17" fmla="*/ 314036 w 563418"/>
              <a:gd name="connsiteY17" fmla="*/ 702160 h 883772"/>
              <a:gd name="connsiteX18" fmla="*/ 175491 w 563418"/>
              <a:gd name="connsiteY18" fmla="*/ 711397 h 883772"/>
              <a:gd name="connsiteX19" fmla="*/ 92363 w 563418"/>
              <a:gd name="connsiteY19" fmla="*/ 720633 h 883772"/>
              <a:gd name="connsiteX20" fmla="*/ 92363 w 563418"/>
              <a:gd name="connsiteY20" fmla="*/ 785288 h 883772"/>
              <a:gd name="connsiteX21" fmla="*/ 147781 w 563418"/>
              <a:gd name="connsiteY21" fmla="*/ 803760 h 883772"/>
              <a:gd name="connsiteX22" fmla="*/ 175491 w 563418"/>
              <a:gd name="connsiteY22" fmla="*/ 812997 h 883772"/>
              <a:gd name="connsiteX23" fmla="*/ 240145 w 563418"/>
              <a:gd name="connsiteY23" fmla="*/ 831470 h 883772"/>
              <a:gd name="connsiteX24" fmla="*/ 267854 w 563418"/>
              <a:gd name="connsiteY24" fmla="*/ 859179 h 883772"/>
              <a:gd name="connsiteX25" fmla="*/ 434109 w 563418"/>
              <a:gd name="connsiteY25" fmla="*/ 868415 h 883772"/>
              <a:gd name="connsiteX26" fmla="*/ 461818 w 563418"/>
              <a:gd name="connsiteY26" fmla="*/ 859179 h 883772"/>
              <a:gd name="connsiteX27" fmla="*/ 563418 w 563418"/>
              <a:gd name="connsiteY27" fmla="*/ 840706 h 883772"/>
              <a:gd name="connsiteX28" fmla="*/ 554181 w 563418"/>
              <a:gd name="connsiteY28" fmla="*/ 692924 h 883772"/>
              <a:gd name="connsiteX29" fmla="*/ 535709 w 563418"/>
              <a:gd name="connsiteY29" fmla="*/ 628270 h 883772"/>
              <a:gd name="connsiteX30" fmla="*/ 517236 w 563418"/>
              <a:gd name="connsiteY30" fmla="*/ 563615 h 883772"/>
              <a:gd name="connsiteX31" fmla="*/ 498763 w 563418"/>
              <a:gd name="connsiteY31" fmla="*/ 535906 h 883772"/>
              <a:gd name="connsiteX32" fmla="*/ 471054 w 563418"/>
              <a:gd name="connsiteY32" fmla="*/ 471251 h 883772"/>
              <a:gd name="connsiteX33" fmla="*/ 443345 w 563418"/>
              <a:gd name="connsiteY33" fmla="*/ 443542 h 883772"/>
              <a:gd name="connsiteX34" fmla="*/ 378691 w 563418"/>
              <a:gd name="connsiteY34" fmla="*/ 360415 h 883772"/>
              <a:gd name="connsiteX35" fmla="*/ 323272 w 563418"/>
              <a:gd name="connsiteY35" fmla="*/ 314233 h 883772"/>
              <a:gd name="connsiteX36" fmla="*/ 267854 w 563418"/>
              <a:gd name="connsiteY36" fmla="*/ 295760 h 883772"/>
              <a:gd name="connsiteX37" fmla="*/ 212436 w 563418"/>
              <a:gd name="connsiteY37" fmla="*/ 268051 h 883772"/>
              <a:gd name="connsiteX38" fmla="*/ 184727 w 563418"/>
              <a:gd name="connsiteY38" fmla="*/ 249579 h 883772"/>
              <a:gd name="connsiteX39" fmla="*/ 147781 w 563418"/>
              <a:gd name="connsiteY39" fmla="*/ 194160 h 883772"/>
              <a:gd name="connsiteX40" fmla="*/ 120072 w 563418"/>
              <a:gd name="connsiteY40" fmla="*/ 111033 h 883772"/>
              <a:gd name="connsiteX41" fmla="*/ 110836 w 563418"/>
              <a:gd name="connsiteY41" fmla="*/ 83324 h 883772"/>
              <a:gd name="connsiteX42" fmla="*/ 73891 w 563418"/>
              <a:gd name="connsiteY42" fmla="*/ 197 h 88377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Lst>
            <a:rect l="l" t="t" r="r" b="b"/>
            <a:pathLst>
              <a:path w="563418" h="883772">
                <a:moveTo>
                  <a:pt x="73891" y="197"/>
                </a:moveTo>
                <a:cubicBezTo>
                  <a:pt x="56958" y="-2882"/>
                  <a:pt x="26390" y="30542"/>
                  <a:pt x="9236" y="64851"/>
                </a:cubicBezTo>
                <a:cubicBezTo>
                  <a:pt x="4882" y="73559"/>
                  <a:pt x="3079" y="83324"/>
                  <a:pt x="0" y="92560"/>
                </a:cubicBezTo>
                <a:cubicBezTo>
                  <a:pt x="3079" y="117190"/>
                  <a:pt x="2705" y="142504"/>
                  <a:pt x="9236" y="166451"/>
                </a:cubicBezTo>
                <a:cubicBezTo>
                  <a:pt x="12157" y="177161"/>
                  <a:pt x="20603" y="185632"/>
                  <a:pt x="27709" y="194160"/>
                </a:cubicBezTo>
                <a:cubicBezTo>
                  <a:pt x="53080" y="224605"/>
                  <a:pt x="53207" y="218970"/>
                  <a:pt x="83127" y="240342"/>
                </a:cubicBezTo>
                <a:cubicBezTo>
                  <a:pt x="95653" y="249289"/>
                  <a:pt x="107757" y="258815"/>
                  <a:pt x="120072" y="268051"/>
                </a:cubicBezTo>
                <a:cubicBezTo>
                  <a:pt x="116993" y="286524"/>
                  <a:pt x="118442" y="306356"/>
                  <a:pt x="110836" y="323470"/>
                </a:cubicBezTo>
                <a:cubicBezTo>
                  <a:pt x="103350" y="340314"/>
                  <a:pt x="70139" y="359837"/>
                  <a:pt x="55418" y="369651"/>
                </a:cubicBezTo>
                <a:lnTo>
                  <a:pt x="36945" y="425070"/>
                </a:lnTo>
                <a:lnTo>
                  <a:pt x="27709" y="452779"/>
                </a:lnTo>
                <a:cubicBezTo>
                  <a:pt x="30788" y="462015"/>
                  <a:pt x="31545" y="472387"/>
                  <a:pt x="36945" y="480488"/>
                </a:cubicBezTo>
                <a:cubicBezTo>
                  <a:pt x="44191" y="491356"/>
                  <a:pt x="53236" y="501853"/>
                  <a:pt x="64654" y="508197"/>
                </a:cubicBezTo>
                <a:cubicBezTo>
                  <a:pt x="120816" y="539398"/>
                  <a:pt x="217439" y="532755"/>
                  <a:pt x="267854" y="535906"/>
                </a:cubicBezTo>
                <a:cubicBezTo>
                  <a:pt x="300931" y="542521"/>
                  <a:pt x="324496" y="538353"/>
                  <a:pt x="341745" y="572851"/>
                </a:cubicBezTo>
                <a:cubicBezTo>
                  <a:pt x="348766" y="586893"/>
                  <a:pt x="347902" y="603639"/>
                  <a:pt x="350981" y="619033"/>
                </a:cubicBezTo>
                <a:cubicBezTo>
                  <a:pt x="347902" y="643663"/>
                  <a:pt x="351826" y="670241"/>
                  <a:pt x="341745" y="692924"/>
                </a:cubicBezTo>
                <a:cubicBezTo>
                  <a:pt x="337791" y="701821"/>
                  <a:pt x="323712" y="701085"/>
                  <a:pt x="314036" y="702160"/>
                </a:cubicBezTo>
                <a:cubicBezTo>
                  <a:pt x="268035" y="707271"/>
                  <a:pt x="221615" y="707553"/>
                  <a:pt x="175491" y="711397"/>
                </a:cubicBezTo>
                <a:cubicBezTo>
                  <a:pt x="147707" y="713712"/>
                  <a:pt x="120072" y="717554"/>
                  <a:pt x="92363" y="720633"/>
                </a:cubicBezTo>
                <a:cubicBezTo>
                  <a:pt x="86360" y="738641"/>
                  <a:pt x="71316" y="767248"/>
                  <a:pt x="92363" y="785288"/>
                </a:cubicBezTo>
                <a:cubicBezTo>
                  <a:pt x="107147" y="797960"/>
                  <a:pt x="129308" y="797603"/>
                  <a:pt x="147781" y="803760"/>
                </a:cubicBezTo>
                <a:cubicBezTo>
                  <a:pt x="157018" y="806839"/>
                  <a:pt x="166045" y="810636"/>
                  <a:pt x="175491" y="812997"/>
                </a:cubicBezTo>
                <a:cubicBezTo>
                  <a:pt x="221881" y="824594"/>
                  <a:pt x="200394" y="818219"/>
                  <a:pt x="240145" y="831470"/>
                </a:cubicBezTo>
                <a:cubicBezTo>
                  <a:pt x="249381" y="840706"/>
                  <a:pt x="257819" y="850817"/>
                  <a:pt x="267854" y="859179"/>
                </a:cubicBezTo>
                <a:cubicBezTo>
                  <a:pt x="321810" y="904142"/>
                  <a:pt x="335623" y="874980"/>
                  <a:pt x="434109" y="868415"/>
                </a:cubicBezTo>
                <a:cubicBezTo>
                  <a:pt x="443345" y="865336"/>
                  <a:pt x="452239" y="860921"/>
                  <a:pt x="461818" y="859179"/>
                </a:cubicBezTo>
                <a:cubicBezTo>
                  <a:pt x="576701" y="838291"/>
                  <a:pt x="499871" y="861887"/>
                  <a:pt x="563418" y="840706"/>
                </a:cubicBezTo>
                <a:cubicBezTo>
                  <a:pt x="560339" y="791445"/>
                  <a:pt x="559092" y="742036"/>
                  <a:pt x="554181" y="692924"/>
                </a:cubicBezTo>
                <a:cubicBezTo>
                  <a:pt x="551960" y="670715"/>
                  <a:pt x="541768" y="649475"/>
                  <a:pt x="535709" y="628270"/>
                </a:cubicBezTo>
                <a:cubicBezTo>
                  <a:pt x="531765" y="614466"/>
                  <a:pt x="524616" y="578374"/>
                  <a:pt x="517236" y="563615"/>
                </a:cubicBezTo>
                <a:cubicBezTo>
                  <a:pt x="512272" y="553686"/>
                  <a:pt x="504921" y="545142"/>
                  <a:pt x="498763" y="535906"/>
                </a:cubicBezTo>
                <a:cubicBezTo>
                  <a:pt x="491225" y="513292"/>
                  <a:pt x="485322" y="491226"/>
                  <a:pt x="471054" y="471251"/>
                </a:cubicBezTo>
                <a:cubicBezTo>
                  <a:pt x="463462" y="460622"/>
                  <a:pt x="452581" y="452778"/>
                  <a:pt x="443345" y="443542"/>
                </a:cubicBezTo>
                <a:cubicBezTo>
                  <a:pt x="425848" y="391050"/>
                  <a:pt x="440993" y="422716"/>
                  <a:pt x="378691" y="360415"/>
                </a:cubicBezTo>
                <a:cubicBezTo>
                  <a:pt x="361292" y="343016"/>
                  <a:pt x="346416" y="324520"/>
                  <a:pt x="323272" y="314233"/>
                </a:cubicBezTo>
                <a:cubicBezTo>
                  <a:pt x="305478" y="306325"/>
                  <a:pt x="284056" y="306561"/>
                  <a:pt x="267854" y="295760"/>
                </a:cubicBezTo>
                <a:cubicBezTo>
                  <a:pt x="188445" y="242822"/>
                  <a:pt x="288916" y="306291"/>
                  <a:pt x="212436" y="268051"/>
                </a:cubicBezTo>
                <a:cubicBezTo>
                  <a:pt x="202507" y="263087"/>
                  <a:pt x="193963" y="255736"/>
                  <a:pt x="184727" y="249579"/>
                </a:cubicBezTo>
                <a:cubicBezTo>
                  <a:pt x="172412" y="231106"/>
                  <a:pt x="154802" y="215223"/>
                  <a:pt x="147781" y="194160"/>
                </a:cubicBezTo>
                <a:lnTo>
                  <a:pt x="120072" y="111033"/>
                </a:lnTo>
                <a:cubicBezTo>
                  <a:pt x="116993" y="101797"/>
                  <a:pt x="116237" y="91425"/>
                  <a:pt x="110836" y="83324"/>
                </a:cubicBezTo>
                <a:cubicBezTo>
                  <a:pt x="87533" y="48370"/>
                  <a:pt x="90824" y="3276"/>
                  <a:pt x="73891" y="197"/>
                </a:cubicBezTo>
                <a:close/>
              </a:path>
            </a:pathLst>
          </a:custGeom>
          <a:solidFill>
            <a:schemeClr val="accent6">
              <a:alpha val="50000"/>
            </a:schemeClr>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449EB8E4-9345-4926-9E06-ADEB0C9B0F67}"/>
              </a:ext>
            </a:extLst>
          </p:cNvPr>
          <p:cNvSpPr txBox="1"/>
          <p:nvPr/>
        </p:nvSpPr>
        <p:spPr>
          <a:xfrm>
            <a:off x="2299561" y="5692240"/>
            <a:ext cx="3031599" cy="646331"/>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Cortical volume: solid green</a:t>
            </a:r>
          </a:p>
          <a:p>
            <a:endParaRPr lang="en-US" dirty="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26B073FC-18F0-4AC1-9955-B3C73A26529F}"/>
              </a:ext>
            </a:extLst>
          </p:cNvPr>
          <p:cNvSpPr txBox="1"/>
          <p:nvPr/>
        </p:nvSpPr>
        <p:spPr>
          <a:xfrm>
            <a:off x="5830195" y="195444"/>
            <a:ext cx="46679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sp>
        <p:nvSpPr>
          <p:cNvPr id="19" name="TextBox 18">
            <a:extLst>
              <a:ext uri="{FF2B5EF4-FFF2-40B4-BE49-F238E27FC236}">
                <a16:creationId xmlns:a16="http://schemas.microsoft.com/office/drawing/2014/main" id="{402EABC6-B4A3-4F86-A7FD-2C4A92402354}"/>
              </a:ext>
            </a:extLst>
          </p:cNvPr>
          <p:cNvSpPr txBox="1"/>
          <p:nvPr/>
        </p:nvSpPr>
        <p:spPr>
          <a:xfrm>
            <a:off x="10947818" y="245850"/>
            <a:ext cx="46679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sp>
        <p:nvSpPr>
          <p:cNvPr id="20" name="TextBox 19">
            <a:extLst>
              <a:ext uri="{FF2B5EF4-FFF2-40B4-BE49-F238E27FC236}">
                <a16:creationId xmlns:a16="http://schemas.microsoft.com/office/drawing/2014/main" id="{C7F07FB0-467D-46A7-8A51-8EB77DE72D7D}"/>
              </a:ext>
            </a:extLst>
          </p:cNvPr>
          <p:cNvSpPr txBox="1"/>
          <p:nvPr/>
        </p:nvSpPr>
        <p:spPr>
          <a:xfrm>
            <a:off x="10960642" y="3036440"/>
            <a:ext cx="453970"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c)</a:t>
            </a:r>
          </a:p>
        </p:txBody>
      </p:sp>
      <p:sp>
        <p:nvSpPr>
          <p:cNvPr id="21" name="TextBox 20">
            <a:extLst>
              <a:ext uri="{FF2B5EF4-FFF2-40B4-BE49-F238E27FC236}">
                <a16:creationId xmlns:a16="http://schemas.microsoft.com/office/drawing/2014/main" id="{77C87795-6001-4F24-97DE-52417B860DB3}"/>
              </a:ext>
            </a:extLst>
          </p:cNvPr>
          <p:cNvSpPr txBox="1"/>
          <p:nvPr/>
        </p:nvSpPr>
        <p:spPr>
          <a:xfrm>
            <a:off x="283508" y="6131336"/>
            <a:ext cx="11810635" cy="523220"/>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Figure S6. Quantitative analyses of tibia at the osteotomy site. Designation of regions of interest for quantification overlaid on a micro-CT image cross-section (a); cortical volume (b); mean cortical bone density (c).</a:t>
            </a:r>
          </a:p>
        </p:txBody>
      </p:sp>
    </p:spTree>
    <p:extLst>
      <p:ext uri="{BB962C8B-B14F-4D97-AF65-F5344CB8AC3E}">
        <p14:creationId xmlns:p14="http://schemas.microsoft.com/office/powerpoint/2010/main" val="404735837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69EF9708-7ED0-44FA-B4FB-F1B5257ED877}"/>
              </a:ext>
            </a:extLst>
          </p:cNvPr>
          <p:cNvSpPr/>
          <p:nvPr/>
        </p:nvSpPr>
        <p:spPr>
          <a:xfrm>
            <a:off x="1249961" y="5926931"/>
            <a:ext cx="10360402" cy="523220"/>
          </a:xfrm>
          <a:prstGeom prst="rect">
            <a:avLst/>
          </a:prstGeom>
        </p:spPr>
        <p:txBody>
          <a:bodyPr wrap="square">
            <a:spAutoFit/>
          </a:bodyPr>
          <a:lstStyle/>
          <a:p>
            <a:r>
              <a:rPr lang="en-US" sz="1400" dirty="0">
                <a:latin typeface="Arial" panose="020B0604020202020204" pitchFamily="34" charset="0"/>
                <a:cs typeface="Arial" panose="020B0604020202020204" pitchFamily="34" charset="0"/>
              </a:rPr>
              <a:t>Figure S7. Weight bearing </a:t>
            </a:r>
            <a:r>
              <a:rPr lang="en-US" sz="1400" dirty="0" err="1">
                <a:latin typeface="Arial" panose="020B0604020202020204" pitchFamily="34" charset="0"/>
                <a:cs typeface="Arial" panose="020B0604020202020204" pitchFamily="34" charset="0"/>
              </a:rPr>
              <a:t>right:left</a:t>
            </a:r>
            <a:r>
              <a:rPr lang="en-US" sz="1400" dirty="0">
                <a:latin typeface="Arial" panose="020B0604020202020204" pitchFamily="34" charset="0"/>
                <a:cs typeface="Arial" panose="020B0604020202020204" pitchFamily="34" charset="0"/>
              </a:rPr>
              <a:t> (</a:t>
            </a:r>
            <a:r>
              <a:rPr lang="en-US" sz="1400" dirty="0" err="1">
                <a:latin typeface="Arial" panose="020B0604020202020204" pitchFamily="34" charset="0"/>
                <a:cs typeface="Arial" panose="020B0604020202020204" pitchFamily="34" charset="0"/>
              </a:rPr>
              <a:t>surgical:non-surgical</a:t>
            </a:r>
            <a:r>
              <a:rPr lang="en-US" sz="1400" dirty="0">
                <a:latin typeface="Arial" panose="020B0604020202020204" pitchFamily="34" charset="0"/>
                <a:cs typeface="Arial" panose="020B0604020202020204" pitchFamily="34" charset="0"/>
              </a:rPr>
              <a:t>) ratio for hind limbs. Asterisks indicate difference relative to </a:t>
            </a:r>
            <a:r>
              <a:rPr lang="en-US" sz="1400">
                <a:latin typeface="Arial" panose="020B0604020202020204" pitchFamily="34" charset="0"/>
                <a:cs typeface="Arial" panose="020B0604020202020204" pitchFamily="34" charset="0"/>
              </a:rPr>
              <a:t>the baseline (</a:t>
            </a:r>
            <a:r>
              <a:rPr lang="en-US" sz="1400" dirty="0">
                <a:latin typeface="Arial" panose="020B0604020202020204" pitchFamily="34" charset="0"/>
                <a:cs typeface="Arial" panose="020B0604020202020204" pitchFamily="34" charset="0"/>
              </a:rPr>
              <a:t>p&lt;0.05). Shaded area is the margin of error from database of healthy animals. Error bars are +/- 1 SD.</a:t>
            </a:r>
          </a:p>
        </p:txBody>
      </p:sp>
      <p:graphicFrame>
        <p:nvGraphicFramePr>
          <p:cNvPr id="5" name="Chart 4">
            <a:extLst>
              <a:ext uri="{FF2B5EF4-FFF2-40B4-BE49-F238E27FC236}">
                <a16:creationId xmlns:a16="http://schemas.microsoft.com/office/drawing/2014/main" id="{097530F3-2031-4425-B086-AB4A71C9D790}"/>
              </a:ext>
            </a:extLst>
          </p:cNvPr>
          <p:cNvGraphicFramePr>
            <a:graphicFrameLocks/>
          </p:cNvGraphicFramePr>
          <p:nvPr/>
        </p:nvGraphicFramePr>
        <p:xfrm>
          <a:off x="2505074" y="931068"/>
          <a:ext cx="7181851" cy="4995863"/>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135904607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Group 12">
            <a:extLst>
              <a:ext uri="{FF2B5EF4-FFF2-40B4-BE49-F238E27FC236}">
                <a16:creationId xmlns:a16="http://schemas.microsoft.com/office/drawing/2014/main" id="{54A8823C-377B-65EF-92CB-BCB6B04F535F}"/>
              </a:ext>
            </a:extLst>
          </p:cNvPr>
          <p:cNvGrpSpPr/>
          <p:nvPr/>
        </p:nvGrpSpPr>
        <p:grpSpPr>
          <a:xfrm>
            <a:off x="647699" y="693296"/>
            <a:ext cx="10896601" cy="5000626"/>
            <a:chOff x="647699" y="693296"/>
            <a:chExt cx="10896601" cy="5000626"/>
          </a:xfrm>
        </p:grpSpPr>
        <p:sp>
          <p:nvSpPr>
            <p:cNvPr id="7" name="Rectangle 6">
              <a:extLst>
                <a:ext uri="{FF2B5EF4-FFF2-40B4-BE49-F238E27FC236}">
                  <a16:creationId xmlns:a16="http://schemas.microsoft.com/office/drawing/2014/main" id="{69A68FE7-5DD7-EEEF-C868-A208192E758D}"/>
                </a:ext>
              </a:extLst>
            </p:cNvPr>
            <p:cNvSpPr/>
            <p:nvPr/>
          </p:nvSpPr>
          <p:spPr>
            <a:xfrm>
              <a:off x="647699" y="693296"/>
              <a:ext cx="10896599" cy="5000625"/>
            </a:xfrm>
            <a:prstGeom prst="rect">
              <a:avLst/>
            </a:prstGeom>
            <a:ln w="38100"/>
          </p:spPr>
          <p:style>
            <a:lnRef idx="2">
              <a:schemeClr val="dk1"/>
            </a:lnRef>
            <a:fillRef idx="1">
              <a:schemeClr val="lt1"/>
            </a:fillRef>
            <a:effectRef idx="0">
              <a:schemeClr val="dk1"/>
            </a:effectRef>
            <a:fontRef idx="minor">
              <a:schemeClr val="dk1"/>
            </a:fontRef>
          </p:style>
          <p:txBody>
            <a:bodyPr rtlCol="0" anchor="ctr"/>
            <a:lstStyle/>
            <a:p>
              <a:pPr algn="ctr"/>
              <a:endParaRPr lang="en-US"/>
            </a:p>
          </p:txBody>
        </p:sp>
        <p:pic>
          <p:nvPicPr>
            <p:cNvPr id="12" name="Picture 11" descr="A screenshot of a data&#10;&#10;Description automatically generated">
              <a:extLst>
                <a:ext uri="{FF2B5EF4-FFF2-40B4-BE49-F238E27FC236}">
                  <a16:creationId xmlns:a16="http://schemas.microsoft.com/office/drawing/2014/main" id="{91CD3EEB-D14B-AD91-E52B-CE3D8938092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47700" y="693297"/>
              <a:ext cx="10896600" cy="5000625"/>
            </a:xfrm>
            <a:prstGeom prst="rect">
              <a:avLst/>
            </a:prstGeom>
          </p:spPr>
        </p:pic>
      </p:grpSp>
      <p:sp>
        <p:nvSpPr>
          <p:cNvPr id="14" name="TextBox 13">
            <a:extLst>
              <a:ext uri="{FF2B5EF4-FFF2-40B4-BE49-F238E27FC236}">
                <a16:creationId xmlns:a16="http://schemas.microsoft.com/office/drawing/2014/main" id="{8291E092-EB37-1C49-354C-4D50F0F2FF7A}"/>
              </a:ext>
            </a:extLst>
          </p:cNvPr>
          <p:cNvSpPr txBox="1"/>
          <p:nvPr/>
        </p:nvSpPr>
        <p:spPr>
          <a:xfrm>
            <a:off x="647699" y="5980037"/>
            <a:ext cx="4915000" cy="369332"/>
          </a:xfrm>
          <a:prstGeom prst="rect">
            <a:avLst/>
          </a:prstGeom>
          <a:noFill/>
        </p:spPr>
        <p:txBody>
          <a:bodyPr wrap="none" rtlCol="0">
            <a:spAutoFit/>
          </a:bodyPr>
          <a:lstStyle/>
          <a:p>
            <a:r>
              <a:rPr lang="en-US" dirty="0"/>
              <a:t>Figure S8. The correlation between all parameters.</a:t>
            </a:r>
          </a:p>
        </p:txBody>
      </p:sp>
    </p:spTree>
    <p:extLst>
      <p:ext uri="{BB962C8B-B14F-4D97-AF65-F5344CB8AC3E}">
        <p14:creationId xmlns:p14="http://schemas.microsoft.com/office/powerpoint/2010/main" val="88360032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5.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6.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otalTime>7107</TotalTime>
  <Words>825</Words>
  <Application>Microsoft Office PowerPoint</Application>
  <PresentationFormat>Widescreen</PresentationFormat>
  <Paragraphs>141</Paragraphs>
  <Slides>8</Slides>
  <Notes>3</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8</vt:i4>
      </vt:variant>
    </vt:vector>
  </HeadingPairs>
  <TitlesOfParts>
    <vt:vector size="12"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Oral, Ebru</dc:creator>
  <cp:lastModifiedBy>Fan, Yingfang,MD, MSC, PhD</cp:lastModifiedBy>
  <cp:revision>43</cp:revision>
  <dcterms:created xsi:type="dcterms:W3CDTF">2020-05-05T19:22:23Z</dcterms:created>
  <dcterms:modified xsi:type="dcterms:W3CDTF">2023-08-23T20:06:51Z</dcterms:modified>
</cp:coreProperties>
</file>